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1887200" cy="1828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48"/>
    <p:restoredTop sz="96327"/>
  </p:normalViewPr>
  <p:slideViewPr>
    <p:cSldViewPr snapToGrid="0">
      <p:cViewPr>
        <p:scale>
          <a:sx n="110" d="100"/>
          <a:sy n="110" d="100"/>
        </p:scale>
        <p:origin x="184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lbutler\Desktop\Work\Research\Daratumumab\Heart\stella%202025%20rptlongitudinal-2409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lbutler\Desktop\Work\Research\Daratumumab\Heart\ulloa%202025%20rptlongitudinal-240923.xls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lbutler\Desktop\Work\Research\Daratumumab\Heart\vu,%20leanne%202025%20rptlongitudinal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/>
              <a:t>Case 1: All Antibodi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Neat dates truncated'!$A$3</c:f>
              <c:strCache>
                <c:ptCount val="1"/>
                <c:pt idx="0">
                  <c:v>A*11:0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:$AU$3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2749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4BC-6F4B-99EC-EA0E3F634294}"/>
            </c:ext>
          </c:extLst>
        </c:ser>
        <c:ser>
          <c:idx val="1"/>
          <c:order val="1"/>
          <c:tx>
            <c:strRef>
              <c:f>'Neat dates truncated'!$A$4</c:f>
              <c:strCache>
                <c:ptCount val="1"/>
                <c:pt idx="0">
                  <c:v>A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:$AU$4</c:f>
              <c:numCache>
                <c:formatCode>General</c:formatCode>
                <c:ptCount val="46"/>
                <c:pt idx="0">
                  <c:v>20846</c:v>
                </c:pt>
                <c:pt idx="1">
                  <c:v>19045</c:v>
                </c:pt>
                <c:pt idx="2">
                  <c:v>18619</c:v>
                </c:pt>
                <c:pt idx="3">
                  <c:v>16669</c:v>
                </c:pt>
                <c:pt idx="4">
                  <c:v>17999</c:v>
                </c:pt>
                <c:pt idx="5">
                  <c:v>12823</c:v>
                </c:pt>
                <c:pt idx="6">
                  <c:v>15455</c:v>
                </c:pt>
                <c:pt idx="7">
                  <c:v>9519</c:v>
                </c:pt>
                <c:pt idx="8">
                  <c:v>8792</c:v>
                </c:pt>
                <c:pt idx="9">
                  <c:v>7999</c:v>
                </c:pt>
                <c:pt idx="10">
                  <c:v>8304</c:v>
                </c:pt>
                <c:pt idx="11">
                  <c:v>5052</c:v>
                </c:pt>
                <c:pt idx="12">
                  <c:v>5235</c:v>
                </c:pt>
                <c:pt idx="13">
                  <c:v>5026</c:v>
                </c:pt>
                <c:pt idx="14">
                  <c:v>4562</c:v>
                </c:pt>
                <c:pt idx="15">
                  <c:v>3157</c:v>
                </c:pt>
                <c:pt idx="16">
                  <c:v>3055</c:v>
                </c:pt>
                <c:pt idx="17">
                  <c:v>2967</c:v>
                </c:pt>
                <c:pt idx="18">
                  <c:v>1786</c:v>
                </c:pt>
                <c:pt idx="19">
                  <c:v>3314</c:v>
                </c:pt>
                <c:pt idx="20">
                  <c:v>1860</c:v>
                </c:pt>
                <c:pt idx="21">
                  <c:v>2223</c:v>
                </c:pt>
                <c:pt idx="22">
                  <c:v>3032</c:v>
                </c:pt>
                <c:pt idx="23">
                  <c:v>2849</c:v>
                </c:pt>
                <c:pt idx="24">
                  <c:v>1679</c:v>
                </c:pt>
                <c:pt idx="25">
                  <c:v>1613</c:v>
                </c:pt>
                <c:pt idx="26">
                  <c:v>1760</c:v>
                </c:pt>
                <c:pt idx="27">
                  <c:v>1793</c:v>
                </c:pt>
                <c:pt idx="28">
                  <c:v>9650</c:v>
                </c:pt>
                <c:pt idx="29">
                  <c:v>7198</c:v>
                </c:pt>
                <c:pt idx="30">
                  <c:v>8097</c:v>
                </c:pt>
                <c:pt idx="31">
                  <c:v>4444</c:v>
                </c:pt>
                <c:pt idx="32">
                  <c:v>4399</c:v>
                </c:pt>
                <c:pt idx="33">
                  <c:v>5304</c:v>
                </c:pt>
                <c:pt idx="34">
                  <c:v>3666</c:v>
                </c:pt>
                <c:pt idx="35">
                  <c:v>3172</c:v>
                </c:pt>
                <c:pt idx="36">
                  <c:v>3773</c:v>
                </c:pt>
                <c:pt idx="37">
                  <c:v>2412</c:v>
                </c:pt>
                <c:pt idx="38">
                  <c:v>1336</c:v>
                </c:pt>
                <c:pt idx="39">
                  <c:v>2025</c:v>
                </c:pt>
                <c:pt idx="40">
                  <c:v>1764</c:v>
                </c:pt>
                <c:pt idx="41">
                  <c:v>1414</c:v>
                </c:pt>
                <c:pt idx="42">
                  <c:v>0</c:v>
                </c:pt>
                <c:pt idx="43">
                  <c:v>1323</c:v>
                </c:pt>
                <c:pt idx="44">
                  <c:v>1227</c:v>
                </c:pt>
                <c:pt idx="45">
                  <c:v>12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4BC-6F4B-99EC-EA0E3F634294}"/>
            </c:ext>
          </c:extLst>
        </c:ser>
        <c:ser>
          <c:idx val="2"/>
          <c:order val="2"/>
          <c:tx>
            <c:strRef>
              <c:f>'Neat dates truncated'!$A$5</c:f>
              <c:strCache>
                <c:ptCount val="1"/>
                <c:pt idx="0">
                  <c:v>A2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:$AU$5</c:f>
              <c:numCache>
                <c:formatCode>General</c:formatCode>
                <c:ptCount val="46"/>
                <c:pt idx="0">
                  <c:v>14088</c:v>
                </c:pt>
                <c:pt idx="1">
                  <c:v>6850</c:v>
                </c:pt>
                <c:pt idx="2">
                  <c:v>10737</c:v>
                </c:pt>
                <c:pt idx="3">
                  <c:v>7093</c:v>
                </c:pt>
                <c:pt idx="4">
                  <c:v>10618</c:v>
                </c:pt>
                <c:pt idx="5">
                  <c:v>15297</c:v>
                </c:pt>
                <c:pt idx="6">
                  <c:v>12944</c:v>
                </c:pt>
                <c:pt idx="7">
                  <c:v>13835</c:v>
                </c:pt>
                <c:pt idx="8">
                  <c:v>15454</c:v>
                </c:pt>
                <c:pt idx="9">
                  <c:v>11100</c:v>
                </c:pt>
                <c:pt idx="10">
                  <c:v>14657</c:v>
                </c:pt>
                <c:pt idx="11">
                  <c:v>9517</c:v>
                </c:pt>
                <c:pt idx="12">
                  <c:v>16678</c:v>
                </c:pt>
                <c:pt idx="13">
                  <c:v>16351</c:v>
                </c:pt>
                <c:pt idx="14">
                  <c:v>22837</c:v>
                </c:pt>
                <c:pt idx="15">
                  <c:v>18998</c:v>
                </c:pt>
                <c:pt idx="16">
                  <c:v>21619</c:v>
                </c:pt>
                <c:pt idx="17">
                  <c:v>22604</c:v>
                </c:pt>
                <c:pt idx="18">
                  <c:v>22323</c:v>
                </c:pt>
                <c:pt idx="19">
                  <c:v>22819</c:v>
                </c:pt>
                <c:pt idx="20">
                  <c:v>22862</c:v>
                </c:pt>
                <c:pt idx="21">
                  <c:v>24473</c:v>
                </c:pt>
                <c:pt idx="22">
                  <c:v>21557</c:v>
                </c:pt>
                <c:pt idx="23">
                  <c:v>27095</c:v>
                </c:pt>
                <c:pt idx="24">
                  <c:v>22087</c:v>
                </c:pt>
                <c:pt idx="25">
                  <c:v>23703</c:v>
                </c:pt>
                <c:pt idx="26">
                  <c:v>23179</c:v>
                </c:pt>
                <c:pt idx="27">
                  <c:v>18547</c:v>
                </c:pt>
                <c:pt idx="28">
                  <c:v>19016</c:v>
                </c:pt>
                <c:pt idx="29">
                  <c:v>18874</c:v>
                </c:pt>
                <c:pt idx="30">
                  <c:v>21623</c:v>
                </c:pt>
                <c:pt idx="31">
                  <c:v>18047</c:v>
                </c:pt>
                <c:pt idx="32">
                  <c:v>18051</c:v>
                </c:pt>
                <c:pt idx="33">
                  <c:v>20650</c:v>
                </c:pt>
                <c:pt idx="34">
                  <c:v>18977</c:v>
                </c:pt>
                <c:pt idx="35">
                  <c:v>18386</c:v>
                </c:pt>
                <c:pt idx="36">
                  <c:v>22474</c:v>
                </c:pt>
                <c:pt idx="37">
                  <c:v>18503</c:v>
                </c:pt>
                <c:pt idx="38">
                  <c:v>12976</c:v>
                </c:pt>
                <c:pt idx="39">
                  <c:v>18039</c:v>
                </c:pt>
                <c:pt idx="40">
                  <c:v>15131</c:v>
                </c:pt>
                <c:pt idx="41">
                  <c:v>13248</c:v>
                </c:pt>
                <c:pt idx="42">
                  <c:v>12933</c:v>
                </c:pt>
                <c:pt idx="43">
                  <c:v>13964</c:v>
                </c:pt>
                <c:pt idx="44">
                  <c:v>13860</c:v>
                </c:pt>
                <c:pt idx="45">
                  <c:v>155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4BC-6F4B-99EC-EA0E3F634294}"/>
            </c:ext>
          </c:extLst>
        </c:ser>
        <c:ser>
          <c:idx val="3"/>
          <c:order val="3"/>
          <c:tx>
            <c:strRef>
              <c:f>'Neat dates truncated'!$A$6</c:f>
              <c:strCache>
                <c:ptCount val="1"/>
                <c:pt idx="0">
                  <c:v>A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:$AU$6</c:f>
              <c:numCache>
                <c:formatCode>General</c:formatCode>
                <c:ptCount val="46"/>
                <c:pt idx="0">
                  <c:v>14337</c:v>
                </c:pt>
                <c:pt idx="1">
                  <c:v>7331</c:v>
                </c:pt>
                <c:pt idx="2">
                  <c:v>10936</c:v>
                </c:pt>
                <c:pt idx="3">
                  <c:v>7182</c:v>
                </c:pt>
                <c:pt idx="4">
                  <c:v>11024</c:v>
                </c:pt>
                <c:pt idx="5">
                  <c:v>15695</c:v>
                </c:pt>
                <c:pt idx="6">
                  <c:v>13140</c:v>
                </c:pt>
                <c:pt idx="7">
                  <c:v>13788</c:v>
                </c:pt>
                <c:pt idx="8">
                  <c:v>15552</c:v>
                </c:pt>
                <c:pt idx="9">
                  <c:v>11361</c:v>
                </c:pt>
                <c:pt idx="10">
                  <c:v>15079</c:v>
                </c:pt>
                <c:pt idx="11">
                  <c:v>10032</c:v>
                </c:pt>
                <c:pt idx="12">
                  <c:v>17017</c:v>
                </c:pt>
                <c:pt idx="13">
                  <c:v>17185</c:v>
                </c:pt>
                <c:pt idx="14">
                  <c:v>22672</c:v>
                </c:pt>
                <c:pt idx="15">
                  <c:v>19944</c:v>
                </c:pt>
                <c:pt idx="16">
                  <c:v>22342</c:v>
                </c:pt>
                <c:pt idx="17">
                  <c:v>22082</c:v>
                </c:pt>
                <c:pt idx="18">
                  <c:v>21079</c:v>
                </c:pt>
                <c:pt idx="19">
                  <c:v>22698</c:v>
                </c:pt>
                <c:pt idx="20">
                  <c:v>21933</c:v>
                </c:pt>
                <c:pt idx="21">
                  <c:v>23878</c:v>
                </c:pt>
                <c:pt idx="22">
                  <c:v>21899</c:v>
                </c:pt>
                <c:pt idx="23">
                  <c:v>25999</c:v>
                </c:pt>
                <c:pt idx="24">
                  <c:v>22302</c:v>
                </c:pt>
                <c:pt idx="25">
                  <c:v>22398</c:v>
                </c:pt>
                <c:pt idx="26">
                  <c:v>22164</c:v>
                </c:pt>
                <c:pt idx="27">
                  <c:v>17411</c:v>
                </c:pt>
                <c:pt idx="28">
                  <c:v>16431</c:v>
                </c:pt>
                <c:pt idx="29">
                  <c:v>16456</c:v>
                </c:pt>
                <c:pt idx="30">
                  <c:v>18926</c:v>
                </c:pt>
                <c:pt idx="31">
                  <c:v>15505</c:v>
                </c:pt>
                <c:pt idx="32">
                  <c:v>15618</c:v>
                </c:pt>
                <c:pt idx="33">
                  <c:v>18810</c:v>
                </c:pt>
                <c:pt idx="34">
                  <c:v>16895</c:v>
                </c:pt>
                <c:pt idx="35">
                  <c:v>16137</c:v>
                </c:pt>
                <c:pt idx="36">
                  <c:v>19692</c:v>
                </c:pt>
                <c:pt idx="37">
                  <c:v>15684</c:v>
                </c:pt>
                <c:pt idx="38">
                  <c:v>10844</c:v>
                </c:pt>
                <c:pt idx="39">
                  <c:v>15155</c:v>
                </c:pt>
                <c:pt idx="40">
                  <c:v>13647</c:v>
                </c:pt>
                <c:pt idx="41">
                  <c:v>10813</c:v>
                </c:pt>
                <c:pt idx="42">
                  <c:v>11013</c:v>
                </c:pt>
                <c:pt idx="43">
                  <c:v>11985</c:v>
                </c:pt>
                <c:pt idx="44">
                  <c:v>11680</c:v>
                </c:pt>
                <c:pt idx="45">
                  <c:v>12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4BC-6F4B-99EC-EA0E3F634294}"/>
            </c:ext>
          </c:extLst>
        </c:ser>
        <c:ser>
          <c:idx val="4"/>
          <c:order val="4"/>
          <c:tx>
            <c:strRef>
              <c:f>'Neat dates truncated'!$A$7</c:f>
              <c:strCache>
                <c:ptCount val="1"/>
                <c:pt idx="0">
                  <c:v>A2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:$AU$7</c:f>
              <c:numCache>
                <c:formatCode>General</c:formatCode>
                <c:ptCount val="46"/>
                <c:pt idx="0">
                  <c:v>20236</c:v>
                </c:pt>
                <c:pt idx="1">
                  <c:v>17952</c:v>
                </c:pt>
                <c:pt idx="2">
                  <c:v>13926</c:v>
                </c:pt>
                <c:pt idx="3">
                  <c:v>11766</c:v>
                </c:pt>
                <c:pt idx="4">
                  <c:v>11351</c:v>
                </c:pt>
                <c:pt idx="5">
                  <c:v>7857</c:v>
                </c:pt>
                <c:pt idx="6">
                  <c:v>7945</c:v>
                </c:pt>
                <c:pt idx="7">
                  <c:v>4613</c:v>
                </c:pt>
                <c:pt idx="8">
                  <c:v>4004</c:v>
                </c:pt>
                <c:pt idx="9">
                  <c:v>3023</c:v>
                </c:pt>
                <c:pt idx="10">
                  <c:v>3061</c:v>
                </c:pt>
                <c:pt idx="11">
                  <c:v>1924</c:v>
                </c:pt>
                <c:pt idx="12">
                  <c:v>1701</c:v>
                </c:pt>
                <c:pt idx="13">
                  <c:v>1695</c:v>
                </c:pt>
                <c:pt idx="14">
                  <c:v>160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50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4BC-6F4B-99EC-EA0E3F634294}"/>
            </c:ext>
          </c:extLst>
        </c:ser>
        <c:ser>
          <c:idx val="5"/>
          <c:order val="5"/>
          <c:tx>
            <c:strRef>
              <c:f>'Neat dates truncated'!$A$8</c:f>
              <c:strCache>
                <c:ptCount val="1"/>
                <c:pt idx="0">
                  <c:v>A2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8:$AU$8</c:f>
              <c:numCache>
                <c:formatCode>General</c:formatCode>
                <c:ptCount val="46"/>
                <c:pt idx="0">
                  <c:v>18887</c:v>
                </c:pt>
                <c:pt idx="1">
                  <c:v>17077</c:v>
                </c:pt>
                <c:pt idx="2">
                  <c:v>12741</c:v>
                </c:pt>
                <c:pt idx="3">
                  <c:v>11096</c:v>
                </c:pt>
                <c:pt idx="4">
                  <c:v>10287</c:v>
                </c:pt>
                <c:pt idx="5">
                  <c:v>7089</c:v>
                </c:pt>
                <c:pt idx="6">
                  <c:v>7440</c:v>
                </c:pt>
                <c:pt idx="7">
                  <c:v>4440</c:v>
                </c:pt>
                <c:pt idx="8">
                  <c:v>3634</c:v>
                </c:pt>
                <c:pt idx="9">
                  <c:v>2882</c:v>
                </c:pt>
                <c:pt idx="10">
                  <c:v>3030</c:v>
                </c:pt>
                <c:pt idx="11">
                  <c:v>1972</c:v>
                </c:pt>
                <c:pt idx="12">
                  <c:v>1672</c:v>
                </c:pt>
                <c:pt idx="13">
                  <c:v>1666</c:v>
                </c:pt>
                <c:pt idx="14">
                  <c:v>145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291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4BC-6F4B-99EC-EA0E3F634294}"/>
            </c:ext>
          </c:extLst>
        </c:ser>
        <c:ser>
          <c:idx val="6"/>
          <c:order val="6"/>
          <c:tx>
            <c:strRef>
              <c:f>'Neat dates truncated'!$A$9</c:f>
              <c:strCache>
                <c:ptCount val="1"/>
                <c:pt idx="0">
                  <c:v>A29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9:$AU$9</c:f>
              <c:numCache>
                <c:formatCode>General</c:formatCode>
                <c:ptCount val="46"/>
                <c:pt idx="0">
                  <c:v>18216</c:v>
                </c:pt>
                <c:pt idx="1">
                  <c:v>16743</c:v>
                </c:pt>
                <c:pt idx="2">
                  <c:v>11631</c:v>
                </c:pt>
                <c:pt idx="3">
                  <c:v>9906</c:v>
                </c:pt>
                <c:pt idx="4">
                  <c:v>9401</c:v>
                </c:pt>
                <c:pt idx="5">
                  <c:v>6335</c:v>
                </c:pt>
                <c:pt idx="6">
                  <c:v>6478</c:v>
                </c:pt>
                <c:pt idx="7">
                  <c:v>3982</c:v>
                </c:pt>
                <c:pt idx="8">
                  <c:v>3410</c:v>
                </c:pt>
                <c:pt idx="9">
                  <c:v>2637</c:v>
                </c:pt>
                <c:pt idx="10">
                  <c:v>2712</c:v>
                </c:pt>
                <c:pt idx="11">
                  <c:v>1937</c:v>
                </c:pt>
                <c:pt idx="12">
                  <c:v>1712</c:v>
                </c:pt>
                <c:pt idx="13">
                  <c:v>1558</c:v>
                </c:pt>
                <c:pt idx="14">
                  <c:v>143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52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1481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4BC-6F4B-99EC-EA0E3F634294}"/>
            </c:ext>
          </c:extLst>
        </c:ser>
        <c:ser>
          <c:idx val="7"/>
          <c:order val="7"/>
          <c:tx>
            <c:strRef>
              <c:f>'Neat dates truncated'!$A$10</c:f>
              <c:strCache>
                <c:ptCount val="1"/>
                <c:pt idx="0">
                  <c:v>A3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0:$AU$10</c:f>
              <c:numCache>
                <c:formatCode>General</c:formatCode>
                <c:ptCount val="46"/>
                <c:pt idx="0">
                  <c:v>5029</c:v>
                </c:pt>
                <c:pt idx="1">
                  <c:v>4348</c:v>
                </c:pt>
                <c:pt idx="2">
                  <c:v>2150</c:v>
                </c:pt>
                <c:pt idx="3">
                  <c:v>2000</c:v>
                </c:pt>
                <c:pt idx="4">
                  <c:v>2122</c:v>
                </c:pt>
                <c:pt idx="5">
                  <c:v>0</c:v>
                </c:pt>
                <c:pt idx="6">
                  <c:v>1266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4BC-6F4B-99EC-EA0E3F634294}"/>
            </c:ext>
          </c:extLst>
        </c:ser>
        <c:ser>
          <c:idx val="8"/>
          <c:order val="8"/>
          <c:tx>
            <c:strRef>
              <c:f>'Neat dates truncated'!$A$11</c:f>
              <c:strCache>
                <c:ptCount val="1"/>
                <c:pt idx="0">
                  <c:v>A30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1:$AU$11</c:f>
              <c:numCache>
                <c:formatCode>General</c:formatCode>
                <c:ptCount val="46"/>
                <c:pt idx="0">
                  <c:v>8049</c:v>
                </c:pt>
                <c:pt idx="1">
                  <c:v>6606</c:v>
                </c:pt>
                <c:pt idx="2">
                  <c:v>3522</c:v>
                </c:pt>
                <c:pt idx="3">
                  <c:v>2912</c:v>
                </c:pt>
                <c:pt idx="4">
                  <c:v>3123</c:v>
                </c:pt>
                <c:pt idx="5">
                  <c:v>1290</c:v>
                </c:pt>
                <c:pt idx="6">
                  <c:v>167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4BC-6F4B-99EC-EA0E3F634294}"/>
            </c:ext>
          </c:extLst>
        </c:ser>
        <c:ser>
          <c:idx val="9"/>
          <c:order val="9"/>
          <c:tx>
            <c:strRef>
              <c:f>'Neat dates truncated'!$A$12</c:f>
              <c:strCache>
                <c:ptCount val="1"/>
                <c:pt idx="0">
                  <c:v>A31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2:$AU$12</c:f>
              <c:numCache>
                <c:formatCode>General</c:formatCode>
                <c:ptCount val="46"/>
                <c:pt idx="0">
                  <c:v>12600</c:v>
                </c:pt>
                <c:pt idx="1">
                  <c:v>12235</c:v>
                </c:pt>
                <c:pt idx="2">
                  <c:v>7692</c:v>
                </c:pt>
                <c:pt idx="3">
                  <c:v>6525</c:v>
                </c:pt>
                <c:pt idx="4">
                  <c:v>6474</c:v>
                </c:pt>
                <c:pt idx="5">
                  <c:v>3694</c:v>
                </c:pt>
                <c:pt idx="6">
                  <c:v>4057</c:v>
                </c:pt>
                <c:pt idx="7">
                  <c:v>2164</c:v>
                </c:pt>
                <c:pt idx="8">
                  <c:v>1907</c:v>
                </c:pt>
                <c:pt idx="9">
                  <c:v>1584</c:v>
                </c:pt>
                <c:pt idx="10">
                  <c:v>1568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4BC-6F4B-99EC-EA0E3F634294}"/>
            </c:ext>
          </c:extLst>
        </c:ser>
        <c:ser>
          <c:idx val="10"/>
          <c:order val="10"/>
          <c:tx>
            <c:strRef>
              <c:f>'Neat dates truncated'!$A$13</c:f>
              <c:strCache>
                <c:ptCount val="1"/>
                <c:pt idx="0">
                  <c:v>A32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3:$AU$13</c:f>
              <c:numCache>
                <c:formatCode>General</c:formatCode>
                <c:ptCount val="46"/>
                <c:pt idx="0">
                  <c:v>9930</c:v>
                </c:pt>
                <c:pt idx="1">
                  <c:v>9068</c:v>
                </c:pt>
                <c:pt idx="2">
                  <c:v>4837</c:v>
                </c:pt>
                <c:pt idx="3">
                  <c:v>3714</c:v>
                </c:pt>
                <c:pt idx="4">
                  <c:v>3709</c:v>
                </c:pt>
                <c:pt idx="5">
                  <c:v>1748</c:v>
                </c:pt>
                <c:pt idx="6">
                  <c:v>181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4BC-6F4B-99EC-EA0E3F634294}"/>
            </c:ext>
          </c:extLst>
        </c:ser>
        <c:ser>
          <c:idx val="11"/>
          <c:order val="11"/>
          <c:tx>
            <c:strRef>
              <c:f>'Neat dates truncated'!$A$14</c:f>
              <c:strCache>
                <c:ptCount val="1"/>
                <c:pt idx="0">
                  <c:v>A33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4:$AU$14</c:f>
              <c:numCache>
                <c:formatCode>General</c:formatCode>
                <c:ptCount val="46"/>
                <c:pt idx="0">
                  <c:v>23515</c:v>
                </c:pt>
                <c:pt idx="1">
                  <c:v>19533</c:v>
                </c:pt>
                <c:pt idx="2">
                  <c:v>20957</c:v>
                </c:pt>
                <c:pt idx="3">
                  <c:v>18018</c:v>
                </c:pt>
                <c:pt idx="4">
                  <c:v>22007</c:v>
                </c:pt>
                <c:pt idx="5">
                  <c:v>20722</c:v>
                </c:pt>
                <c:pt idx="6">
                  <c:v>21862</c:v>
                </c:pt>
                <c:pt idx="7">
                  <c:v>17595</c:v>
                </c:pt>
                <c:pt idx="8">
                  <c:v>16240</c:v>
                </c:pt>
                <c:pt idx="9">
                  <c:v>13585</c:v>
                </c:pt>
                <c:pt idx="10">
                  <c:v>14448</c:v>
                </c:pt>
                <c:pt idx="11">
                  <c:v>10800</c:v>
                </c:pt>
                <c:pt idx="12">
                  <c:v>9240</c:v>
                </c:pt>
                <c:pt idx="13">
                  <c:v>9600</c:v>
                </c:pt>
                <c:pt idx="14">
                  <c:v>8035</c:v>
                </c:pt>
                <c:pt idx="15">
                  <c:v>6900</c:v>
                </c:pt>
                <c:pt idx="16">
                  <c:v>6375</c:v>
                </c:pt>
                <c:pt idx="17">
                  <c:v>5617</c:v>
                </c:pt>
                <c:pt idx="18">
                  <c:v>3702</c:v>
                </c:pt>
                <c:pt idx="19">
                  <c:v>5335</c:v>
                </c:pt>
                <c:pt idx="20">
                  <c:v>3305</c:v>
                </c:pt>
                <c:pt idx="21">
                  <c:v>4147</c:v>
                </c:pt>
                <c:pt idx="22">
                  <c:v>4314</c:v>
                </c:pt>
                <c:pt idx="23">
                  <c:v>4091</c:v>
                </c:pt>
                <c:pt idx="24">
                  <c:v>2422</c:v>
                </c:pt>
                <c:pt idx="25">
                  <c:v>2602</c:v>
                </c:pt>
                <c:pt idx="26">
                  <c:v>2466</c:v>
                </c:pt>
                <c:pt idx="27">
                  <c:v>2135</c:v>
                </c:pt>
                <c:pt idx="28">
                  <c:v>1606</c:v>
                </c:pt>
                <c:pt idx="29">
                  <c:v>1323</c:v>
                </c:pt>
                <c:pt idx="30">
                  <c:v>1827</c:v>
                </c:pt>
                <c:pt idx="31">
                  <c:v>1350</c:v>
                </c:pt>
                <c:pt idx="32">
                  <c:v>1434</c:v>
                </c:pt>
                <c:pt idx="33">
                  <c:v>1853</c:v>
                </c:pt>
                <c:pt idx="34">
                  <c:v>1814</c:v>
                </c:pt>
                <c:pt idx="35">
                  <c:v>1744</c:v>
                </c:pt>
                <c:pt idx="36">
                  <c:v>2225</c:v>
                </c:pt>
                <c:pt idx="37">
                  <c:v>1626</c:v>
                </c:pt>
                <c:pt idx="38">
                  <c:v>0</c:v>
                </c:pt>
                <c:pt idx="39">
                  <c:v>1649</c:v>
                </c:pt>
                <c:pt idx="40">
                  <c:v>1368</c:v>
                </c:pt>
                <c:pt idx="41">
                  <c:v>1276</c:v>
                </c:pt>
                <c:pt idx="42">
                  <c:v>0</c:v>
                </c:pt>
                <c:pt idx="43">
                  <c:v>1313</c:v>
                </c:pt>
                <c:pt idx="44">
                  <c:v>1273</c:v>
                </c:pt>
                <c:pt idx="45">
                  <c:v>14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4BC-6F4B-99EC-EA0E3F634294}"/>
            </c:ext>
          </c:extLst>
        </c:ser>
        <c:ser>
          <c:idx val="12"/>
          <c:order val="12"/>
          <c:tx>
            <c:strRef>
              <c:f>'Neat dates truncated'!$A$15</c:f>
              <c:strCache>
                <c:ptCount val="1"/>
                <c:pt idx="0">
                  <c:v>A34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5:$AU$15</c:f>
              <c:numCache>
                <c:formatCode>General</c:formatCode>
                <c:ptCount val="46"/>
                <c:pt idx="0">
                  <c:v>23526</c:v>
                </c:pt>
                <c:pt idx="1">
                  <c:v>21155</c:v>
                </c:pt>
                <c:pt idx="2">
                  <c:v>19354</c:v>
                </c:pt>
                <c:pt idx="3">
                  <c:v>17258</c:v>
                </c:pt>
                <c:pt idx="4">
                  <c:v>17643</c:v>
                </c:pt>
                <c:pt idx="5">
                  <c:v>13538</c:v>
                </c:pt>
                <c:pt idx="6">
                  <c:v>13799</c:v>
                </c:pt>
                <c:pt idx="7">
                  <c:v>9220</c:v>
                </c:pt>
                <c:pt idx="8">
                  <c:v>7787</c:v>
                </c:pt>
                <c:pt idx="9">
                  <c:v>6196</c:v>
                </c:pt>
                <c:pt idx="10">
                  <c:v>6568</c:v>
                </c:pt>
                <c:pt idx="11">
                  <c:v>4368</c:v>
                </c:pt>
                <c:pt idx="12">
                  <c:v>3836</c:v>
                </c:pt>
                <c:pt idx="13">
                  <c:v>4204</c:v>
                </c:pt>
                <c:pt idx="14">
                  <c:v>4174</c:v>
                </c:pt>
                <c:pt idx="15">
                  <c:v>3041</c:v>
                </c:pt>
                <c:pt idx="16">
                  <c:v>3027</c:v>
                </c:pt>
                <c:pt idx="17">
                  <c:v>2636</c:v>
                </c:pt>
                <c:pt idx="18">
                  <c:v>1756</c:v>
                </c:pt>
                <c:pt idx="19">
                  <c:v>2917</c:v>
                </c:pt>
                <c:pt idx="20">
                  <c:v>1758</c:v>
                </c:pt>
                <c:pt idx="21">
                  <c:v>2010</c:v>
                </c:pt>
                <c:pt idx="22">
                  <c:v>2542</c:v>
                </c:pt>
                <c:pt idx="23">
                  <c:v>2825</c:v>
                </c:pt>
                <c:pt idx="24">
                  <c:v>1492</c:v>
                </c:pt>
                <c:pt idx="25">
                  <c:v>1411</c:v>
                </c:pt>
                <c:pt idx="26">
                  <c:v>1363</c:v>
                </c:pt>
                <c:pt idx="27">
                  <c:v>1519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506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14BC-6F4B-99EC-EA0E3F634294}"/>
            </c:ext>
          </c:extLst>
        </c:ser>
        <c:ser>
          <c:idx val="13"/>
          <c:order val="13"/>
          <c:tx>
            <c:strRef>
              <c:f>'Neat dates truncated'!$A$16</c:f>
              <c:strCache>
                <c:ptCount val="1"/>
                <c:pt idx="0">
                  <c:v>A36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solidFill>
                  <a:schemeClr val="accent2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6:$AU$16</c:f>
              <c:numCache>
                <c:formatCode>General</c:formatCode>
                <c:ptCount val="46"/>
                <c:pt idx="0">
                  <c:v>3266</c:v>
                </c:pt>
                <c:pt idx="1">
                  <c:v>207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14BC-6F4B-99EC-EA0E3F634294}"/>
            </c:ext>
          </c:extLst>
        </c:ser>
        <c:ser>
          <c:idx val="14"/>
          <c:order val="14"/>
          <c:tx>
            <c:strRef>
              <c:f>'Neat dates truncated'!$A$17</c:f>
              <c:strCache>
                <c:ptCount val="1"/>
                <c:pt idx="0">
                  <c:v>A43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  <a:lumOff val="20000"/>
                </a:schemeClr>
              </a:solidFill>
              <a:ln w="9525">
                <a:solidFill>
                  <a:schemeClr val="accent3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7:$AU$17</c:f>
              <c:numCache>
                <c:formatCode>General</c:formatCode>
                <c:ptCount val="46"/>
                <c:pt idx="0">
                  <c:v>3545</c:v>
                </c:pt>
                <c:pt idx="1">
                  <c:v>5895</c:v>
                </c:pt>
                <c:pt idx="2">
                  <c:v>2902</c:v>
                </c:pt>
                <c:pt idx="3">
                  <c:v>2491</c:v>
                </c:pt>
                <c:pt idx="4">
                  <c:v>2561</c:v>
                </c:pt>
                <c:pt idx="5">
                  <c:v>1352</c:v>
                </c:pt>
                <c:pt idx="6">
                  <c:v>125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14BC-6F4B-99EC-EA0E3F634294}"/>
            </c:ext>
          </c:extLst>
        </c:ser>
        <c:ser>
          <c:idx val="15"/>
          <c:order val="15"/>
          <c:tx>
            <c:strRef>
              <c:f>'Neat dates truncated'!$A$18</c:f>
              <c:strCache>
                <c:ptCount val="1"/>
                <c:pt idx="0">
                  <c:v>A66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  <a:lumOff val="20000"/>
                </a:schemeClr>
              </a:solidFill>
              <a:ln w="9525">
                <a:solidFill>
                  <a:schemeClr val="accent4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8:$AU$18</c:f>
              <c:numCache>
                <c:formatCode>General</c:formatCode>
                <c:ptCount val="46"/>
                <c:pt idx="0">
                  <c:v>20901</c:v>
                </c:pt>
                <c:pt idx="1">
                  <c:v>18556</c:v>
                </c:pt>
                <c:pt idx="2">
                  <c:v>14856</c:v>
                </c:pt>
                <c:pt idx="3">
                  <c:v>13059</c:v>
                </c:pt>
                <c:pt idx="4">
                  <c:v>12312</c:v>
                </c:pt>
                <c:pt idx="5">
                  <c:v>8680</c:v>
                </c:pt>
                <c:pt idx="6">
                  <c:v>9065</c:v>
                </c:pt>
                <c:pt idx="7">
                  <c:v>5578</c:v>
                </c:pt>
                <c:pt idx="8">
                  <c:v>4708</c:v>
                </c:pt>
                <c:pt idx="9">
                  <c:v>3711</c:v>
                </c:pt>
                <c:pt idx="10">
                  <c:v>3918</c:v>
                </c:pt>
                <c:pt idx="11">
                  <c:v>2602</c:v>
                </c:pt>
                <c:pt idx="12">
                  <c:v>2377</c:v>
                </c:pt>
                <c:pt idx="13">
                  <c:v>2531</c:v>
                </c:pt>
                <c:pt idx="14">
                  <c:v>2512</c:v>
                </c:pt>
                <c:pt idx="15">
                  <c:v>2487</c:v>
                </c:pt>
                <c:pt idx="16">
                  <c:v>2589</c:v>
                </c:pt>
                <c:pt idx="17">
                  <c:v>2252</c:v>
                </c:pt>
                <c:pt idx="18">
                  <c:v>1560</c:v>
                </c:pt>
                <c:pt idx="19">
                  <c:v>1875</c:v>
                </c:pt>
                <c:pt idx="20">
                  <c:v>1473</c:v>
                </c:pt>
                <c:pt idx="21">
                  <c:v>1692</c:v>
                </c:pt>
                <c:pt idx="22">
                  <c:v>1722</c:v>
                </c:pt>
                <c:pt idx="23">
                  <c:v>1888</c:v>
                </c:pt>
                <c:pt idx="24">
                  <c:v>1290</c:v>
                </c:pt>
                <c:pt idx="25">
                  <c:v>1230</c:v>
                </c:pt>
                <c:pt idx="26">
                  <c:v>1188</c:v>
                </c:pt>
                <c:pt idx="27">
                  <c:v>1591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14BC-6F4B-99EC-EA0E3F634294}"/>
            </c:ext>
          </c:extLst>
        </c:ser>
        <c:ser>
          <c:idx val="16"/>
          <c:order val="16"/>
          <c:tx>
            <c:strRef>
              <c:f>'Neat dates truncated'!$A$19</c:f>
              <c:strCache>
                <c:ptCount val="1"/>
                <c:pt idx="0">
                  <c:v>A68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  <a:lumOff val="20000"/>
                </a:schemeClr>
              </a:solidFill>
              <a:ln w="9525">
                <a:solidFill>
                  <a:schemeClr val="accent5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19:$AU$19</c:f>
              <c:numCache>
                <c:formatCode>General</c:formatCode>
                <c:ptCount val="46"/>
                <c:pt idx="0">
                  <c:v>23184</c:v>
                </c:pt>
                <c:pt idx="1">
                  <c:v>16637</c:v>
                </c:pt>
                <c:pt idx="2">
                  <c:v>18422</c:v>
                </c:pt>
                <c:pt idx="3">
                  <c:v>15811</c:v>
                </c:pt>
                <c:pt idx="4">
                  <c:v>20300</c:v>
                </c:pt>
                <c:pt idx="5">
                  <c:v>18241</c:v>
                </c:pt>
                <c:pt idx="6">
                  <c:v>20187</c:v>
                </c:pt>
                <c:pt idx="7">
                  <c:v>14604</c:v>
                </c:pt>
                <c:pt idx="8">
                  <c:v>13330</c:v>
                </c:pt>
                <c:pt idx="9">
                  <c:v>11468</c:v>
                </c:pt>
                <c:pt idx="10">
                  <c:v>11484</c:v>
                </c:pt>
                <c:pt idx="11">
                  <c:v>8174</c:v>
                </c:pt>
                <c:pt idx="12">
                  <c:v>7557</c:v>
                </c:pt>
                <c:pt idx="13">
                  <c:v>7729</c:v>
                </c:pt>
                <c:pt idx="14">
                  <c:v>7250</c:v>
                </c:pt>
                <c:pt idx="15">
                  <c:v>5586</c:v>
                </c:pt>
                <c:pt idx="16">
                  <c:v>5530</c:v>
                </c:pt>
                <c:pt idx="17">
                  <c:v>4972</c:v>
                </c:pt>
                <c:pt idx="18">
                  <c:v>3193</c:v>
                </c:pt>
                <c:pt idx="19">
                  <c:v>5241</c:v>
                </c:pt>
                <c:pt idx="20">
                  <c:v>3263</c:v>
                </c:pt>
                <c:pt idx="21">
                  <c:v>3748</c:v>
                </c:pt>
                <c:pt idx="22">
                  <c:v>4628</c:v>
                </c:pt>
                <c:pt idx="23">
                  <c:v>4340</c:v>
                </c:pt>
                <c:pt idx="24">
                  <c:v>2712</c:v>
                </c:pt>
                <c:pt idx="25">
                  <c:v>2687</c:v>
                </c:pt>
                <c:pt idx="26">
                  <c:v>2772</c:v>
                </c:pt>
                <c:pt idx="27">
                  <c:v>2344</c:v>
                </c:pt>
                <c:pt idx="28">
                  <c:v>6622</c:v>
                </c:pt>
                <c:pt idx="29">
                  <c:v>4412</c:v>
                </c:pt>
                <c:pt idx="30">
                  <c:v>5792</c:v>
                </c:pt>
                <c:pt idx="31">
                  <c:v>3228</c:v>
                </c:pt>
                <c:pt idx="32">
                  <c:v>3101</c:v>
                </c:pt>
                <c:pt idx="33">
                  <c:v>4113</c:v>
                </c:pt>
                <c:pt idx="34">
                  <c:v>3243</c:v>
                </c:pt>
                <c:pt idx="35">
                  <c:v>2901</c:v>
                </c:pt>
                <c:pt idx="36">
                  <c:v>3510</c:v>
                </c:pt>
                <c:pt idx="37">
                  <c:v>2416</c:v>
                </c:pt>
                <c:pt idx="38">
                  <c:v>1486</c:v>
                </c:pt>
                <c:pt idx="39">
                  <c:v>2317</c:v>
                </c:pt>
                <c:pt idx="40">
                  <c:v>2168</c:v>
                </c:pt>
                <c:pt idx="41">
                  <c:v>1701</c:v>
                </c:pt>
                <c:pt idx="42">
                  <c:v>1900</c:v>
                </c:pt>
                <c:pt idx="43">
                  <c:v>1793</c:v>
                </c:pt>
                <c:pt idx="44">
                  <c:v>1660</c:v>
                </c:pt>
                <c:pt idx="45">
                  <c:v>16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14BC-6F4B-99EC-EA0E3F634294}"/>
            </c:ext>
          </c:extLst>
        </c:ser>
        <c:ser>
          <c:idx val="17"/>
          <c:order val="17"/>
          <c:tx>
            <c:strRef>
              <c:f>'Neat dates truncated'!$A$20</c:f>
              <c:strCache>
                <c:ptCount val="1"/>
                <c:pt idx="0">
                  <c:v>A69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0:$AU$20</c:f>
              <c:numCache>
                <c:formatCode>General</c:formatCode>
                <c:ptCount val="46"/>
                <c:pt idx="0">
                  <c:v>22836</c:v>
                </c:pt>
                <c:pt idx="1">
                  <c:v>16296</c:v>
                </c:pt>
                <c:pt idx="2">
                  <c:v>18605</c:v>
                </c:pt>
                <c:pt idx="3">
                  <c:v>15454</c:v>
                </c:pt>
                <c:pt idx="4">
                  <c:v>19835</c:v>
                </c:pt>
                <c:pt idx="5">
                  <c:v>18843</c:v>
                </c:pt>
                <c:pt idx="6">
                  <c:v>20832</c:v>
                </c:pt>
                <c:pt idx="7">
                  <c:v>15565</c:v>
                </c:pt>
                <c:pt idx="8">
                  <c:v>14013</c:v>
                </c:pt>
                <c:pt idx="9">
                  <c:v>12429</c:v>
                </c:pt>
                <c:pt idx="10">
                  <c:v>13110</c:v>
                </c:pt>
                <c:pt idx="11">
                  <c:v>9077</c:v>
                </c:pt>
                <c:pt idx="12">
                  <c:v>8396</c:v>
                </c:pt>
                <c:pt idx="13">
                  <c:v>8249</c:v>
                </c:pt>
                <c:pt idx="14">
                  <c:v>7236</c:v>
                </c:pt>
                <c:pt idx="15">
                  <c:v>5722</c:v>
                </c:pt>
                <c:pt idx="16">
                  <c:v>5342</c:v>
                </c:pt>
                <c:pt idx="17">
                  <c:v>4909</c:v>
                </c:pt>
                <c:pt idx="18">
                  <c:v>3305</c:v>
                </c:pt>
                <c:pt idx="19">
                  <c:v>5308</c:v>
                </c:pt>
                <c:pt idx="20">
                  <c:v>3127</c:v>
                </c:pt>
                <c:pt idx="21">
                  <c:v>3901</c:v>
                </c:pt>
                <c:pt idx="22">
                  <c:v>4726</c:v>
                </c:pt>
                <c:pt idx="23">
                  <c:v>4428</c:v>
                </c:pt>
                <c:pt idx="24">
                  <c:v>2682</c:v>
                </c:pt>
                <c:pt idx="25">
                  <c:v>2785</c:v>
                </c:pt>
                <c:pt idx="26">
                  <c:v>2747</c:v>
                </c:pt>
                <c:pt idx="27">
                  <c:v>2443</c:v>
                </c:pt>
                <c:pt idx="28">
                  <c:v>8071</c:v>
                </c:pt>
                <c:pt idx="29">
                  <c:v>4787</c:v>
                </c:pt>
                <c:pt idx="30">
                  <c:v>6824</c:v>
                </c:pt>
                <c:pt idx="31">
                  <c:v>3961</c:v>
                </c:pt>
                <c:pt idx="32">
                  <c:v>3549</c:v>
                </c:pt>
                <c:pt idx="33">
                  <c:v>4946</c:v>
                </c:pt>
                <c:pt idx="34">
                  <c:v>3739</c:v>
                </c:pt>
                <c:pt idx="35">
                  <c:v>3336</c:v>
                </c:pt>
                <c:pt idx="36">
                  <c:v>3841</c:v>
                </c:pt>
                <c:pt idx="37">
                  <c:v>2723</c:v>
                </c:pt>
                <c:pt idx="38">
                  <c:v>1543</c:v>
                </c:pt>
                <c:pt idx="39">
                  <c:v>2028</c:v>
                </c:pt>
                <c:pt idx="40">
                  <c:v>2233</c:v>
                </c:pt>
                <c:pt idx="41">
                  <c:v>1542</c:v>
                </c:pt>
                <c:pt idx="42">
                  <c:v>1977</c:v>
                </c:pt>
                <c:pt idx="43">
                  <c:v>1890</c:v>
                </c:pt>
                <c:pt idx="44">
                  <c:v>1743</c:v>
                </c:pt>
                <c:pt idx="45">
                  <c:v>17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14BC-6F4B-99EC-EA0E3F634294}"/>
            </c:ext>
          </c:extLst>
        </c:ser>
        <c:ser>
          <c:idx val="18"/>
          <c:order val="18"/>
          <c:tx>
            <c:strRef>
              <c:f>'Neat dates truncated'!$A$21</c:f>
              <c:strCache>
                <c:ptCount val="1"/>
                <c:pt idx="0">
                  <c:v>A74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</a:schemeClr>
              </a:solidFill>
              <a:ln w="9525">
                <a:solidFill>
                  <a:schemeClr val="accent1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1:$AU$21</c:f>
              <c:numCache>
                <c:formatCode>General</c:formatCode>
                <c:ptCount val="46"/>
                <c:pt idx="0">
                  <c:v>9571</c:v>
                </c:pt>
                <c:pt idx="1">
                  <c:v>8913</c:v>
                </c:pt>
                <c:pt idx="2">
                  <c:v>4963</c:v>
                </c:pt>
                <c:pt idx="3">
                  <c:v>4174</c:v>
                </c:pt>
                <c:pt idx="4">
                  <c:v>4171</c:v>
                </c:pt>
                <c:pt idx="5">
                  <c:v>2190</c:v>
                </c:pt>
                <c:pt idx="6">
                  <c:v>2318</c:v>
                </c:pt>
                <c:pt idx="7">
                  <c:v>1292</c:v>
                </c:pt>
                <c:pt idx="8">
                  <c:v>1187</c:v>
                </c:pt>
                <c:pt idx="9">
                  <c:v>0</c:v>
                </c:pt>
                <c:pt idx="10">
                  <c:v>1166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14BC-6F4B-99EC-EA0E3F634294}"/>
            </c:ext>
          </c:extLst>
        </c:ser>
        <c:ser>
          <c:idx val="19"/>
          <c:order val="19"/>
          <c:tx>
            <c:strRef>
              <c:f>'Neat dates truncated'!$A$22</c:f>
              <c:strCache>
                <c:ptCount val="1"/>
                <c:pt idx="0">
                  <c:v>A80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2:$AU$22</c:f>
              <c:numCache>
                <c:formatCode>General</c:formatCode>
                <c:ptCount val="46"/>
                <c:pt idx="0">
                  <c:v>22634</c:v>
                </c:pt>
                <c:pt idx="1">
                  <c:v>18777</c:v>
                </c:pt>
                <c:pt idx="2">
                  <c:v>18493</c:v>
                </c:pt>
                <c:pt idx="3">
                  <c:v>15608</c:v>
                </c:pt>
                <c:pt idx="4">
                  <c:v>15864</c:v>
                </c:pt>
                <c:pt idx="5">
                  <c:v>11822</c:v>
                </c:pt>
                <c:pt idx="6">
                  <c:v>12756</c:v>
                </c:pt>
                <c:pt idx="7">
                  <c:v>8308</c:v>
                </c:pt>
                <c:pt idx="8">
                  <c:v>6526</c:v>
                </c:pt>
                <c:pt idx="9">
                  <c:v>5635</c:v>
                </c:pt>
                <c:pt idx="10">
                  <c:v>5548</c:v>
                </c:pt>
                <c:pt idx="11">
                  <c:v>3920</c:v>
                </c:pt>
                <c:pt idx="12">
                  <c:v>3208</c:v>
                </c:pt>
                <c:pt idx="13">
                  <c:v>3290</c:v>
                </c:pt>
                <c:pt idx="14">
                  <c:v>3043</c:v>
                </c:pt>
                <c:pt idx="15">
                  <c:v>1997</c:v>
                </c:pt>
                <c:pt idx="16">
                  <c:v>1843</c:v>
                </c:pt>
                <c:pt idx="17">
                  <c:v>1756</c:v>
                </c:pt>
                <c:pt idx="18">
                  <c:v>1284</c:v>
                </c:pt>
                <c:pt idx="19">
                  <c:v>2142</c:v>
                </c:pt>
                <c:pt idx="20">
                  <c:v>1217</c:v>
                </c:pt>
                <c:pt idx="21">
                  <c:v>1478</c:v>
                </c:pt>
                <c:pt idx="22">
                  <c:v>1797</c:v>
                </c:pt>
                <c:pt idx="23">
                  <c:v>199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1386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14BC-6F4B-99EC-EA0E3F634294}"/>
            </c:ext>
          </c:extLst>
        </c:ser>
        <c:ser>
          <c:idx val="20"/>
          <c:order val="20"/>
          <c:tx>
            <c:strRef>
              <c:f>'Neat dates truncated'!$A$23</c:f>
              <c:strCache>
                <c:ptCount val="1"/>
                <c:pt idx="0">
                  <c:v>B*27:08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</a:schemeClr>
              </a:solidFill>
              <a:ln w="9525">
                <a:solidFill>
                  <a:schemeClr val="accent3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3:$AU$23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3816</c:v>
                </c:pt>
                <c:pt idx="8">
                  <c:v>11857</c:v>
                </c:pt>
                <c:pt idx="9">
                  <c:v>9372</c:v>
                </c:pt>
                <c:pt idx="10">
                  <c:v>9948</c:v>
                </c:pt>
                <c:pt idx="11">
                  <c:v>0</c:v>
                </c:pt>
                <c:pt idx="12">
                  <c:v>6241</c:v>
                </c:pt>
                <c:pt idx="13">
                  <c:v>5980</c:v>
                </c:pt>
                <c:pt idx="14">
                  <c:v>4941</c:v>
                </c:pt>
                <c:pt idx="15">
                  <c:v>3677</c:v>
                </c:pt>
                <c:pt idx="16">
                  <c:v>3463</c:v>
                </c:pt>
                <c:pt idx="17">
                  <c:v>3017</c:v>
                </c:pt>
                <c:pt idx="18">
                  <c:v>0</c:v>
                </c:pt>
                <c:pt idx="19">
                  <c:v>3232</c:v>
                </c:pt>
                <c:pt idx="20">
                  <c:v>2160</c:v>
                </c:pt>
                <c:pt idx="21">
                  <c:v>2544</c:v>
                </c:pt>
                <c:pt idx="22">
                  <c:v>2633</c:v>
                </c:pt>
                <c:pt idx="23">
                  <c:v>2936</c:v>
                </c:pt>
                <c:pt idx="24">
                  <c:v>1453</c:v>
                </c:pt>
                <c:pt idx="25">
                  <c:v>1433</c:v>
                </c:pt>
                <c:pt idx="26">
                  <c:v>1355</c:v>
                </c:pt>
                <c:pt idx="27">
                  <c:v>1782</c:v>
                </c:pt>
                <c:pt idx="28">
                  <c:v>15479</c:v>
                </c:pt>
                <c:pt idx="29">
                  <c:v>9021</c:v>
                </c:pt>
                <c:pt idx="30">
                  <c:v>8625</c:v>
                </c:pt>
                <c:pt idx="31">
                  <c:v>4783</c:v>
                </c:pt>
                <c:pt idx="32">
                  <c:v>5261</c:v>
                </c:pt>
                <c:pt idx="33">
                  <c:v>5036</c:v>
                </c:pt>
                <c:pt idx="34">
                  <c:v>3394</c:v>
                </c:pt>
                <c:pt idx="35">
                  <c:v>2791</c:v>
                </c:pt>
                <c:pt idx="36">
                  <c:v>3429</c:v>
                </c:pt>
                <c:pt idx="37">
                  <c:v>2191</c:v>
                </c:pt>
                <c:pt idx="38">
                  <c:v>1276</c:v>
                </c:pt>
                <c:pt idx="39">
                  <c:v>1782</c:v>
                </c:pt>
                <c:pt idx="40">
                  <c:v>0</c:v>
                </c:pt>
                <c:pt idx="41">
                  <c:v>1313</c:v>
                </c:pt>
                <c:pt idx="42">
                  <c:v>0</c:v>
                </c:pt>
                <c:pt idx="43">
                  <c:v>1177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14BC-6F4B-99EC-EA0E3F634294}"/>
            </c:ext>
          </c:extLst>
        </c:ser>
        <c:ser>
          <c:idx val="21"/>
          <c:order val="21"/>
          <c:tx>
            <c:strRef>
              <c:f>'Neat dates truncated'!$A$24</c:f>
              <c:strCache>
                <c:ptCount val="1"/>
                <c:pt idx="0">
                  <c:v>B13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4:$AU$24</c:f>
              <c:numCache>
                <c:formatCode>General</c:formatCode>
                <c:ptCount val="46"/>
                <c:pt idx="0">
                  <c:v>10668</c:v>
                </c:pt>
                <c:pt idx="1">
                  <c:v>12687</c:v>
                </c:pt>
                <c:pt idx="2">
                  <c:v>8863</c:v>
                </c:pt>
                <c:pt idx="3">
                  <c:v>7884</c:v>
                </c:pt>
                <c:pt idx="4">
                  <c:v>7500</c:v>
                </c:pt>
                <c:pt idx="5">
                  <c:v>5450</c:v>
                </c:pt>
                <c:pt idx="6">
                  <c:v>5572</c:v>
                </c:pt>
                <c:pt idx="7">
                  <c:v>3868</c:v>
                </c:pt>
                <c:pt idx="8">
                  <c:v>3480</c:v>
                </c:pt>
                <c:pt idx="9">
                  <c:v>3187</c:v>
                </c:pt>
                <c:pt idx="10">
                  <c:v>3746</c:v>
                </c:pt>
                <c:pt idx="11">
                  <c:v>2816</c:v>
                </c:pt>
                <c:pt idx="12">
                  <c:v>2651</c:v>
                </c:pt>
                <c:pt idx="13">
                  <c:v>2745</c:v>
                </c:pt>
                <c:pt idx="14">
                  <c:v>2554</c:v>
                </c:pt>
                <c:pt idx="15">
                  <c:v>1883</c:v>
                </c:pt>
                <c:pt idx="16">
                  <c:v>1828</c:v>
                </c:pt>
                <c:pt idx="17">
                  <c:v>1738</c:v>
                </c:pt>
                <c:pt idx="18">
                  <c:v>1284</c:v>
                </c:pt>
                <c:pt idx="19">
                  <c:v>1991</c:v>
                </c:pt>
                <c:pt idx="20">
                  <c:v>1455</c:v>
                </c:pt>
                <c:pt idx="21">
                  <c:v>1456</c:v>
                </c:pt>
                <c:pt idx="22">
                  <c:v>2074</c:v>
                </c:pt>
                <c:pt idx="23">
                  <c:v>2197</c:v>
                </c:pt>
                <c:pt idx="24">
                  <c:v>1321</c:v>
                </c:pt>
                <c:pt idx="25">
                  <c:v>1444</c:v>
                </c:pt>
                <c:pt idx="26">
                  <c:v>1370</c:v>
                </c:pt>
                <c:pt idx="27">
                  <c:v>1734</c:v>
                </c:pt>
                <c:pt idx="28">
                  <c:v>1250</c:v>
                </c:pt>
                <c:pt idx="29">
                  <c:v>0</c:v>
                </c:pt>
                <c:pt idx="30">
                  <c:v>1302</c:v>
                </c:pt>
                <c:pt idx="31">
                  <c:v>0</c:v>
                </c:pt>
                <c:pt idx="32">
                  <c:v>0</c:v>
                </c:pt>
                <c:pt idx="33">
                  <c:v>1282</c:v>
                </c:pt>
                <c:pt idx="34">
                  <c:v>1223</c:v>
                </c:pt>
                <c:pt idx="35">
                  <c:v>0</c:v>
                </c:pt>
                <c:pt idx="36">
                  <c:v>1597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14BC-6F4B-99EC-EA0E3F634294}"/>
            </c:ext>
          </c:extLst>
        </c:ser>
        <c:ser>
          <c:idx val="22"/>
          <c:order val="22"/>
          <c:tx>
            <c:strRef>
              <c:f>'Neat dates truncated'!$A$25</c:f>
              <c:strCache>
                <c:ptCount val="1"/>
                <c:pt idx="0">
                  <c:v>B18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</a:schemeClr>
              </a:solidFill>
              <a:ln w="9525">
                <a:solidFill>
                  <a:schemeClr val="accent5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5:$AU$25</c:f>
              <c:numCache>
                <c:formatCode>General</c:formatCode>
                <c:ptCount val="46"/>
                <c:pt idx="0">
                  <c:v>20913</c:v>
                </c:pt>
                <c:pt idx="1">
                  <c:v>13765</c:v>
                </c:pt>
                <c:pt idx="2">
                  <c:v>19309</c:v>
                </c:pt>
                <c:pt idx="3">
                  <c:v>16860</c:v>
                </c:pt>
                <c:pt idx="4">
                  <c:v>21485</c:v>
                </c:pt>
                <c:pt idx="5">
                  <c:v>21806</c:v>
                </c:pt>
                <c:pt idx="6">
                  <c:v>20250</c:v>
                </c:pt>
                <c:pt idx="7">
                  <c:v>15538</c:v>
                </c:pt>
                <c:pt idx="8">
                  <c:v>12667</c:v>
                </c:pt>
                <c:pt idx="9">
                  <c:v>10587</c:v>
                </c:pt>
                <c:pt idx="10">
                  <c:v>10942</c:v>
                </c:pt>
                <c:pt idx="11">
                  <c:v>8799</c:v>
                </c:pt>
                <c:pt idx="12">
                  <c:v>6775</c:v>
                </c:pt>
                <c:pt idx="13">
                  <c:v>6651</c:v>
                </c:pt>
                <c:pt idx="14">
                  <c:v>5507</c:v>
                </c:pt>
                <c:pt idx="15">
                  <c:v>4221</c:v>
                </c:pt>
                <c:pt idx="16">
                  <c:v>4001</c:v>
                </c:pt>
                <c:pt idx="17">
                  <c:v>3475</c:v>
                </c:pt>
                <c:pt idx="18">
                  <c:v>2406</c:v>
                </c:pt>
                <c:pt idx="19">
                  <c:v>3443</c:v>
                </c:pt>
                <c:pt idx="20">
                  <c:v>2408</c:v>
                </c:pt>
                <c:pt idx="21">
                  <c:v>2771</c:v>
                </c:pt>
                <c:pt idx="22">
                  <c:v>2946</c:v>
                </c:pt>
                <c:pt idx="23">
                  <c:v>3005</c:v>
                </c:pt>
                <c:pt idx="24">
                  <c:v>1600</c:v>
                </c:pt>
                <c:pt idx="25">
                  <c:v>1711</c:v>
                </c:pt>
                <c:pt idx="26">
                  <c:v>1689</c:v>
                </c:pt>
                <c:pt idx="27">
                  <c:v>1564</c:v>
                </c:pt>
                <c:pt idx="28">
                  <c:v>13422</c:v>
                </c:pt>
                <c:pt idx="29">
                  <c:v>7786</c:v>
                </c:pt>
                <c:pt idx="30">
                  <c:v>7700</c:v>
                </c:pt>
                <c:pt idx="31">
                  <c:v>4271</c:v>
                </c:pt>
                <c:pt idx="32">
                  <c:v>4692</c:v>
                </c:pt>
                <c:pt idx="33">
                  <c:v>4497</c:v>
                </c:pt>
                <c:pt idx="34">
                  <c:v>2885</c:v>
                </c:pt>
                <c:pt idx="35">
                  <c:v>2402</c:v>
                </c:pt>
                <c:pt idx="36">
                  <c:v>2914</c:v>
                </c:pt>
                <c:pt idx="37">
                  <c:v>2001</c:v>
                </c:pt>
                <c:pt idx="38">
                  <c:v>0</c:v>
                </c:pt>
                <c:pt idx="39">
                  <c:v>1655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14BC-6F4B-99EC-EA0E3F634294}"/>
            </c:ext>
          </c:extLst>
        </c:ser>
        <c:ser>
          <c:idx val="23"/>
          <c:order val="23"/>
          <c:tx>
            <c:strRef>
              <c:f>'Neat dates truncated'!$A$26</c:f>
              <c:strCache>
                <c:ptCount val="1"/>
                <c:pt idx="0">
                  <c:v>B27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</a:schemeClr>
              </a:solidFill>
              <a:ln w="9525">
                <a:solidFill>
                  <a:schemeClr val="accent6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6:$AU$26</c:f>
              <c:numCache>
                <c:formatCode>General</c:formatCode>
                <c:ptCount val="46"/>
                <c:pt idx="0">
                  <c:v>14620</c:v>
                </c:pt>
                <c:pt idx="1">
                  <c:v>12196</c:v>
                </c:pt>
                <c:pt idx="2">
                  <c:v>12069</c:v>
                </c:pt>
                <c:pt idx="3">
                  <c:v>10566</c:v>
                </c:pt>
                <c:pt idx="4">
                  <c:v>12110</c:v>
                </c:pt>
                <c:pt idx="5">
                  <c:v>11014</c:v>
                </c:pt>
                <c:pt idx="6">
                  <c:v>9961</c:v>
                </c:pt>
                <c:pt idx="7">
                  <c:v>13816</c:v>
                </c:pt>
                <c:pt idx="8">
                  <c:v>11857</c:v>
                </c:pt>
                <c:pt idx="9">
                  <c:v>0</c:v>
                </c:pt>
                <c:pt idx="10">
                  <c:v>0</c:v>
                </c:pt>
                <c:pt idx="11">
                  <c:v>743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2264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14BC-6F4B-99EC-EA0E3F634294}"/>
            </c:ext>
          </c:extLst>
        </c:ser>
        <c:ser>
          <c:idx val="24"/>
          <c:order val="24"/>
          <c:tx>
            <c:strRef>
              <c:f>'Neat dates truncated'!$A$27</c:f>
              <c:strCache>
                <c:ptCount val="1"/>
                <c:pt idx="0">
                  <c:v>B35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7:$AU$27</c:f>
              <c:numCache>
                <c:formatCode>General</c:formatCode>
                <c:ptCount val="46"/>
                <c:pt idx="0">
                  <c:v>24369</c:v>
                </c:pt>
                <c:pt idx="1">
                  <c:v>18638</c:v>
                </c:pt>
                <c:pt idx="2">
                  <c:v>21419</c:v>
                </c:pt>
                <c:pt idx="3">
                  <c:v>19385</c:v>
                </c:pt>
                <c:pt idx="4">
                  <c:v>22477</c:v>
                </c:pt>
                <c:pt idx="5">
                  <c:v>21104</c:v>
                </c:pt>
                <c:pt idx="6">
                  <c:v>19430</c:v>
                </c:pt>
                <c:pt idx="7">
                  <c:v>14413</c:v>
                </c:pt>
                <c:pt idx="8">
                  <c:v>12055</c:v>
                </c:pt>
                <c:pt idx="9">
                  <c:v>9593</c:v>
                </c:pt>
                <c:pt idx="10">
                  <c:v>10542</c:v>
                </c:pt>
                <c:pt idx="11">
                  <c:v>8054</c:v>
                </c:pt>
                <c:pt idx="12">
                  <c:v>6479</c:v>
                </c:pt>
                <c:pt idx="13">
                  <c:v>6262</c:v>
                </c:pt>
                <c:pt idx="14">
                  <c:v>5115</c:v>
                </c:pt>
                <c:pt idx="15">
                  <c:v>3716</c:v>
                </c:pt>
                <c:pt idx="16">
                  <c:v>3732</c:v>
                </c:pt>
                <c:pt idx="17">
                  <c:v>3210</c:v>
                </c:pt>
                <c:pt idx="18">
                  <c:v>2376</c:v>
                </c:pt>
                <c:pt idx="19">
                  <c:v>3241</c:v>
                </c:pt>
                <c:pt idx="20">
                  <c:v>2262</c:v>
                </c:pt>
                <c:pt idx="21">
                  <c:v>2650</c:v>
                </c:pt>
                <c:pt idx="22">
                  <c:v>2840</c:v>
                </c:pt>
                <c:pt idx="23">
                  <c:v>2876</c:v>
                </c:pt>
                <c:pt idx="24">
                  <c:v>1507</c:v>
                </c:pt>
                <c:pt idx="25">
                  <c:v>1596</c:v>
                </c:pt>
                <c:pt idx="26">
                  <c:v>1525</c:v>
                </c:pt>
                <c:pt idx="27">
                  <c:v>1506</c:v>
                </c:pt>
                <c:pt idx="28">
                  <c:v>14188</c:v>
                </c:pt>
                <c:pt idx="29">
                  <c:v>8495</c:v>
                </c:pt>
                <c:pt idx="30">
                  <c:v>8146</c:v>
                </c:pt>
                <c:pt idx="31">
                  <c:v>4722</c:v>
                </c:pt>
                <c:pt idx="32">
                  <c:v>5043</c:v>
                </c:pt>
                <c:pt idx="33">
                  <c:v>4753</c:v>
                </c:pt>
                <c:pt idx="34">
                  <c:v>3253</c:v>
                </c:pt>
                <c:pt idx="35">
                  <c:v>2760</c:v>
                </c:pt>
                <c:pt idx="36">
                  <c:v>3374</c:v>
                </c:pt>
                <c:pt idx="37">
                  <c:v>2135</c:v>
                </c:pt>
                <c:pt idx="38">
                  <c:v>1217</c:v>
                </c:pt>
                <c:pt idx="39">
                  <c:v>1738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4BC-6F4B-99EC-EA0E3F634294}"/>
            </c:ext>
          </c:extLst>
        </c:ser>
        <c:ser>
          <c:idx val="25"/>
          <c:order val="25"/>
          <c:tx>
            <c:strRef>
              <c:f>'Neat dates truncated'!$A$28</c:f>
              <c:strCache>
                <c:ptCount val="1"/>
                <c:pt idx="0">
                  <c:v>B37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8:$AU$28</c:f>
              <c:numCache>
                <c:formatCode>General</c:formatCode>
                <c:ptCount val="46"/>
                <c:pt idx="0">
                  <c:v>5768</c:v>
                </c:pt>
                <c:pt idx="1">
                  <c:v>5311</c:v>
                </c:pt>
                <c:pt idx="2">
                  <c:v>2691</c:v>
                </c:pt>
                <c:pt idx="3">
                  <c:v>2715</c:v>
                </c:pt>
                <c:pt idx="4">
                  <c:v>2457</c:v>
                </c:pt>
                <c:pt idx="5">
                  <c:v>1568</c:v>
                </c:pt>
                <c:pt idx="6">
                  <c:v>158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14BC-6F4B-99EC-EA0E3F634294}"/>
            </c:ext>
          </c:extLst>
        </c:ser>
        <c:ser>
          <c:idx val="26"/>
          <c:order val="26"/>
          <c:tx>
            <c:strRef>
              <c:f>'Neat dates truncated'!$A$29</c:f>
              <c:strCache>
                <c:ptCount val="1"/>
                <c:pt idx="0">
                  <c:v>B38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accent3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29:$AU$29</c:f>
              <c:numCache>
                <c:formatCode>General</c:formatCode>
                <c:ptCount val="46"/>
                <c:pt idx="0">
                  <c:v>12897</c:v>
                </c:pt>
                <c:pt idx="1">
                  <c:v>13525</c:v>
                </c:pt>
                <c:pt idx="2">
                  <c:v>9280</c:v>
                </c:pt>
                <c:pt idx="3">
                  <c:v>7982</c:v>
                </c:pt>
                <c:pt idx="4">
                  <c:v>8087</c:v>
                </c:pt>
                <c:pt idx="5">
                  <c:v>5836</c:v>
                </c:pt>
                <c:pt idx="6">
                  <c:v>5034</c:v>
                </c:pt>
                <c:pt idx="7">
                  <c:v>3170</c:v>
                </c:pt>
                <c:pt idx="8">
                  <c:v>2595</c:v>
                </c:pt>
                <c:pt idx="9">
                  <c:v>1993</c:v>
                </c:pt>
                <c:pt idx="10">
                  <c:v>2083</c:v>
                </c:pt>
                <c:pt idx="11">
                  <c:v>1443</c:v>
                </c:pt>
                <c:pt idx="12">
                  <c:v>1256</c:v>
                </c:pt>
                <c:pt idx="13">
                  <c:v>1122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14BC-6F4B-99EC-EA0E3F634294}"/>
            </c:ext>
          </c:extLst>
        </c:ser>
        <c:ser>
          <c:idx val="27"/>
          <c:order val="27"/>
          <c:tx>
            <c:strRef>
              <c:f>'Neat dates truncated'!$A$30</c:f>
              <c:strCache>
                <c:ptCount val="1"/>
                <c:pt idx="0">
                  <c:v>B39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0:$AU$30</c:f>
              <c:numCache>
                <c:formatCode>General</c:formatCode>
                <c:ptCount val="46"/>
                <c:pt idx="0">
                  <c:v>22411</c:v>
                </c:pt>
                <c:pt idx="1">
                  <c:v>16095</c:v>
                </c:pt>
                <c:pt idx="2">
                  <c:v>19584</c:v>
                </c:pt>
                <c:pt idx="3">
                  <c:v>17465</c:v>
                </c:pt>
                <c:pt idx="4">
                  <c:v>22299</c:v>
                </c:pt>
                <c:pt idx="5">
                  <c:v>21584</c:v>
                </c:pt>
                <c:pt idx="6">
                  <c:v>20417</c:v>
                </c:pt>
                <c:pt idx="7">
                  <c:v>14806</c:v>
                </c:pt>
                <c:pt idx="8">
                  <c:v>13148</c:v>
                </c:pt>
                <c:pt idx="9">
                  <c:v>10641</c:v>
                </c:pt>
                <c:pt idx="10">
                  <c:v>11054</c:v>
                </c:pt>
                <c:pt idx="11">
                  <c:v>8582</c:v>
                </c:pt>
                <c:pt idx="12">
                  <c:v>7255</c:v>
                </c:pt>
                <c:pt idx="13">
                  <c:v>6773</c:v>
                </c:pt>
                <c:pt idx="14">
                  <c:v>5926</c:v>
                </c:pt>
                <c:pt idx="15">
                  <c:v>4458</c:v>
                </c:pt>
                <c:pt idx="16">
                  <c:v>4274</c:v>
                </c:pt>
                <c:pt idx="17">
                  <c:v>3697</c:v>
                </c:pt>
                <c:pt idx="18">
                  <c:v>2497</c:v>
                </c:pt>
                <c:pt idx="19">
                  <c:v>3794</c:v>
                </c:pt>
                <c:pt idx="20">
                  <c:v>2580</c:v>
                </c:pt>
                <c:pt idx="21">
                  <c:v>3082</c:v>
                </c:pt>
                <c:pt idx="22">
                  <c:v>3347</c:v>
                </c:pt>
                <c:pt idx="23">
                  <c:v>3298</c:v>
                </c:pt>
                <c:pt idx="24">
                  <c:v>1801</c:v>
                </c:pt>
                <c:pt idx="25">
                  <c:v>1879</c:v>
                </c:pt>
                <c:pt idx="26">
                  <c:v>1799</c:v>
                </c:pt>
                <c:pt idx="27">
                  <c:v>1631</c:v>
                </c:pt>
                <c:pt idx="28">
                  <c:v>15875</c:v>
                </c:pt>
                <c:pt idx="29">
                  <c:v>9423</c:v>
                </c:pt>
                <c:pt idx="30">
                  <c:v>8822</c:v>
                </c:pt>
                <c:pt idx="31">
                  <c:v>5061</c:v>
                </c:pt>
                <c:pt idx="32">
                  <c:v>5416</c:v>
                </c:pt>
                <c:pt idx="33">
                  <c:v>5277</c:v>
                </c:pt>
                <c:pt idx="34">
                  <c:v>3509</c:v>
                </c:pt>
                <c:pt idx="35">
                  <c:v>3057</c:v>
                </c:pt>
                <c:pt idx="36">
                  <c:v>3710</c:v>
                </c:pt>
                <c:pt idx="37">
                  <c:v>2363</c:v>
                </c:pt>
                <c:pt idx="38">
                  <c:v>1371</c:v>
                </c:pt>
                <c:pt idx="39">
                  <c:v>1974</c:v>
                </c:pt>
                <c:pt idx="40">
                  <c:v>0</c:v>
                </c:pt>
                <c:pt idx="41">
                  <c:v>1374</c:v>
                </c:pt>
                <c:pt idx="42">
                  <c:v>0</c:v>
                </c:pt>
                <c:pt idx="43">
                  <c:v>1324</c:v>
                </c:pt>
                <c:pt idx="44">
                  <c:v>1186</c:v>
                </c:pt>
                <c:pt idx="45">
                  <c:v>12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14BC-6F4B-99EC-EA0E3F634294}"/>
            </c:ext>
          </c:extLst>
        </c:ser>
        <c:ser>
          <c:idx val="28"/>
          <c:order val="28"/>
          <c:tx>
            <c:strRef>
              <c:f>'Neat dates truncated'!$A$31</c:f>
              <c:strCache>
                <c:ptCount val="1"/>
                <c:pt idx="0">
                  <c:v>B41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1:$AU$31</c:f>
              <c:numCache>
                <c:formatCode>General</c:formatCode>
                <c:ptCount val="46"/>
                <c:pt idx="0">
                  <c:v>23326</c:v>
                </c:pt>
                <c:pt idx="1">
                  <c:v>16799</c:v>
                </c:pt>
                <c:pt idx="2">
                  <c:v>19914</c:v>
                </c:pt>
                <c:pt idx="3">
                  <c:v>16902</c:v>
                </c:pt>
                <c:pt idx="4">
                  <c:v>22159</c:v>
                </c:pt>
                <c:pt idx="5">
                  <c:v>22703</c:v>
                </c:pt>
                <c:pt idx="6">
                  <c:v>21785</c:v>
                </c:pt>
                <c:pt idx="7">
                  <c:v>16601</c:v>
                </c:pt>
                <c:pt idx="8">
                  <c:v>14775</c:v>
                </c:pt>
                <c:pt idx="9">
                  <c:v>12004</c:v>
                </c:pt>
                <c:pt idx="10">
                  <c:v>13264</c:v>
                </c:pt>
                <c:pt idx="11">
                  <c:v>10588</c:v>
                </c:pt>
                <c:pt idx="12">
                  <c:v>8988</c:v>
                </c:pt>
                <c:pt idx="13">
                  <c:v>8529</c:v>
                </c:pt>
                <c:pt idx="14">
                  <c:v>7375</c:v>
                </c:pt>
                <c:pt idx="15">
                  <c:v>6209</c:v>
                </c:pt>
                <c:pt idx="16">
                  <c:v>5681</c:v>
                </c:pt>
                <c:pt idx="17">
                  <c:v>5290</c:v>
                </c:pt>
                <c:pt idx="18">
                  <c:v>3380</c:v>
                </c:pt>
                <c:pt idx="19">
                  <c:v>4930</c:v>
                </c:pt>
                <c:pt idx="20">
                  <c:v>3522</c:v>
                </c:pt>
                <c:pt idx="21">
                  <c:v>4343</c:v>
                </c:pt>
                <c:pt idx="22">
                  <c:v>4609</c:v>
                </c:pt>
                <c:pt idx="23">
                  <c:v>4497</c:v>
                </c:pt>
                <c:pt idx="24">
                  <c:v>2662</c:v>
                </c:pt>
                <c:pt idx="25">
                  <c:v>2828</c:v>
                </c:pt>
                <c:pt idx="26">
                  <c:v>2761</c:v>
                </c:pt>
                <c:pt idx="27">
                  <c:v>2604</c:v>
                </c:pt>
                <c:pt idx="28">
                  <c:v>13880</c:v>
                </c:pt>
                <c:pt idx="29">
                  <c:v>8293</c:v>
                </c:pt>
                <c:pt idx="30">
                  <c:v>8496</c:v>
                </c:pt>
                <c:pt idx="31">
                  <c:v>4715</c:v>
                </c:pt>
                <c:pt idx="32">
                  <c:v>5223</c:v>
                </c:pt>
                <c:pt idx="33">
                  <c:v>5245</c:v>
                </c:pt>
                <c:pt idx="34">
                  <c:v>3645</c:v>
                </c:pt>
                <c:pt idx="35">
                  <c:v>3234</c:v>
                </c:pt>
                <c:pt idx="36">
                  <c:v>3954</c:v>
                </c:pt>
                <c:pt idx="37">
                  <c:v>2665</c:v>
                </c:pt>
                <c:pt idx="38">
                  <c:v>1774</c:v>
                </c:pt>
                <c:pt idx="39">
                  <c:v>2508</c:v>
                </c:pt>
                <c:pt idx="40">
                  <c:v>2195</c:v>
                </c:pt>
                <c:pt idx="41">
                  <c:v>1792</c:v>
                </c:pt>
                <c:pt idx="42">
                  <c:v>0</c:v>
                </c:pt>
                <c:pt idx="43">
                  <c:v>1682</c:v>
                </c:pt>
                <c:pt idx="44">
                  <c:v>1618</c:v>
                </c:pt>
                <c:pt idx="45">
                  <c:v>17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14BC-6F4B-99EC-EA0E3F634294}"/>
            </c:ext>
          </c:extLst>
        </c:ser>
        <c:ser>
          <c:idx val="29"/>
          <c:order val="29"/>
          <c:tx>
            <c:strRef>
              <c:f>'Neat dates truncated'!$A$32</c:f>
              <c:strCache>
                <c:ptCount val="1"/>
                <c:pt idx="0">
                  <c:v>B42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accent6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2:$AU$32</c:f>
              <c:numCache>
                <c:formatCode>General</c:formatCode>
                <c:ptCount val="46"/>
                <c:pt idx="0">
                  <c:v>21876</c:v>
                </c:pt>
                <c:pt idx="1">
                  <c:v>13913</c:v>
                </c:pt>
                <c:pt idx="2">
                  <c:v>18260</c:v>
                </c:pt>
                <c:pt idx="3">
                  <c:v>15296</c:v>
                </c:pt>
                <c:pt idx="4">
                  <c:v>21798</c:v>
                </c:pt>
                <c:pt idx="5">
                  <c:v>22711</c:v>
                </c:pt>
                <c:pt idx="6">
                  <c:v>21299</c:v>
                </c:pt>
                <c:pt idx="7">
                  <c:v>16962</c:v>
                </c:pt>
                <c:pt idx="8">
                  <c:v>15139</c:v>
                </c:pt>
                <c:pt idx="9">
                  <c:v>12081</c:v>
                </c:pt>
                <c:pt idx="10">
                  <c:v>12909</c:v>
                </c:pt>
                <c:pt idx="11">
                  <c:v>10384</c:v>
                </c:pt>
                <c:pt idx="12">
                  <c:v>8549</c:v>
                </c:pt>
                <c:pt idx="13">
                  <c:v>8174</c:v>
                </c:pt>
                <c:pt idx="14">
                  <c:v>6838</c:v>
                </c:pt>
                <c:pt idx="15">
                  <c:v>5805</c:v>
                </c:pt>
                <c:pt idx="16">
                  <c:v>5036</c:v>
                </c:pt>
                <c:pt idx="17">
                  <c:v>4624</c:v>
                </c:pt>
                <c:pt idx="18">
                  <c:v>3348</c:v>
                </c:pt>
                <c:pt idx="19">
                  <c:v>4526</c:v>
                </c:pt>
                <c:pt idx="20">
                  <c:v>3134</c:v>
                </c:pt>
                <c:pt idx="21">
                  <c:v>3759</c:v>
                </c:pt>
                <c:pt idx="22">
                  <c:v>4079</c:v>
                </c:pt>
                <c:pt idx="23">
                  <c:v>3984</c:v>
                </c:pt>
                <c:pt idx="24">
                  <c:v>2233</c:v>
                </c:pt>
                <c:pt idx="25">
                  <c:v>2339</c:v>
                </c:pt>
                <c:pt idx="26">
                  <c:v>2214</c:v>
                </c:pt>
                <c:pt idx="27">
                  <c:v>2192</c:v>
                </c:pt>
                <c:pt idx="28">
                  <c:v>15888</c:v>
                </c:pt>
                <c:pt idx="29">
                  <c:v>9560</c:v>
                </c:pt>
                <c:pt idx="30">
                  <c:v>9395</c:v>
                </c:pt>
                <c:pt idx="31">
                  <c:v>5288</c:v>
                </c:pt>
                <c:pt idx="32">
                  <c:v>5773</c:v>
                </c:pt>
                <c:pt idx="33">
                  <c:v>5504</c:v>
                </c:pt>
                <c:pt idx="34">
                  <c:v>3669</c:v>
                </c:pt>
                <c:pt idx="35">
                  <c:v>3084</c:v>
                </c:pt>
                <c:pt idx="36">
                  <c:v>3948</c:v>
                </c:pt>
                <c:pt idx="37">
                  <c:v>2527</c:v>
                </c:pt>
                <c:pt idx="38">
                  <c:v>1503</c:v>
                </c:pt>
                <c:pt idx="39">
                  <c:v>2158</c:v>
                </c:pt>
                <c:pt idx="40">
                  <c:v>1460</c:v>
                </c:pt>
                <c:pt idx="41">
                  <c:v>1494</c:v>
                </c:pt>
                <c:pt idx="42">
                  <c:v>0</c:v>
                </c:pt>
                <c:pt idx="43">
                  <c:v>1419</c:v>
                </c:pt>
                <c:pt idx="44">
                  <c:v>1344</c:v>
                </c:pt>
                <c:pt idx="45">
                  <c:v>14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14BC-6F4B-99EC-EA0E3F634294}"/>
            </c:ext>
          </c:extLst>
        </c:ser>
        <c:ser>
          <c:idx val="30"/>
          <c:order val="30"/>
          <c:tx>
            <c:strRef>
              <c:f>'Neat dates truncated'!$A$33</c:f>
              <c:strCache>
                <c:ptCount val="1"/>
                <c:pt idx="0">
                  <c:v>B44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3:$AU$33</c:f>
              <c:numCache>
                <c:formatCode>General</c:formatCode>
                <c:ptCount val="46"/>
                <c:pt idx="0">
                  <c:v>21413</c:v>
                </c:pt>
                <c:pt idx="1">
                  <c:v>19716</c:v>
                </c:pt>
                <c:pt idx="2">
                  <c:v>19000</c:v>
                </c:pt>
                <c:pt idx="3">
                  <c:v>17166</c:v>
                </c:pt>
                <c:pt idx="4">
                  <c:v>19861</c:v>
                </c:pt>
                <c:pt idx="5">
                  <c:v>19766</c:v>
                </c:pt>
                <c:pt idx="6">
                  <c:v>19957</c:v>
                </c:pt>
                <c:pt idx="7">
                  <c:v>18157</c:v>
                </c:pt>
                <c:pt idx="8">
                  <c:v>18727</c:v>
                </c:pt>
                <c:pt idx="9">
                  <c:v>17198</c:v>
                </c:pt>
                <c:pt idx="10">
                  <c:v>18218</c:v>
                </c:pt>
                <c:pt idx="11">
                  <c:v>15318</c:v>
                </c:pt>
                <c:pt idx="12">
                  <c:v>14543</c:v>
                </c:pt>
                <c:pt idx="13">
                  <c:v>14729</c:v>
                </c:pt>
                <c:pt idx="14">
                  <c:v>12912</c:v>
                </c:pt>
                <c:pt idx="15">
                  <c:v>11176</c:v>
                </c:pt>
                <c:pt idx="16">
                  <c:v>10574</c:v>
                </c:pt>
                <c:pt idx="17">
                  <c:v>10116</c:v>
                </c:pt>
                <c:pt idx="18">
                  <c:v>6841</c:v>
                </c:pt>
                <c:pt idx="19">
                  <c:v>10236</c:v>
                </c:pt>
                <c:pt idx="20">
                  <c:v>7516</c:v>
                </c:pt>
                <c:pt idx="21">
                  <c:v>8750</c:v>
                </c:pt>
                <c:pt idx="22">
                  <c:v>9941</c:v>
                </c:pt>
                <c:pt idx="23">
                  <c:v>9651</c:v>
                </c:pt>
                <c:pt idx="24">
                  <c:v>6715</c:v>
                </c:pt>
                <c:pt idx="25">
                  <c:v>7439</c:v>
                </c:pt>
                <c:pt idx="26">
                  <c:v>8091</c:v>
                </c:pt>
                <c:pt idx="27">
                  <c:v>6817</c:v>
                </c:pt>
                <c:pt idx="28">
                  <c:v>6753</c:v>
                </c:pt>
                <c:pt idx="29">
                  <c:v>6102</c:v>
                </c:pt>
                <c:pt idx="30">
                  <c:v>7779</c:v>
                </c:pt>
                <c:pt idx="31">
                  <c:v>6371</c:v>
                </c:pt>
                <c:pt idx="32">
                  <c:v>6410</c:v>
                </c:pt>
                <c:pt idx="33">
                  <c:v>8722</c:v>
                </c:pt>
                <c:pt idx="34">
                  <c:v>8555</c:v>
                </c:pt>
                <c:pt idx="35">
                  <c:v>8037</c:v>
                </c:pt>
                <c:pt idx="36">
                  <c:v>10393</c:v>
                </c:pt>
                <c:pt idx="37">
                  <c:v>7809</c:v>
                </c:pt>
                <c:pt idx="38">
                  <c:v>6901</c:v>
                </c:pt>
                <c:pt idx="39">
                  <c:v>10612</c:v>
                </c:pt>
                <c:pt idx="40">
                  <c:v>9361</c:v>
                </c:pt>
                <c:pt idx="41">
                  <c:v>8464</c:v>
                </c:pt>
                <c:pt idx="42">
                  <c:v>8330</c:v>
                </c:pt>
                <c:pt idx="43">
                  <c:v>8401</c:v>
                </c:pt>
                <c:pt idx="44">
                  <c:v>8537</c:v>
                </c:pt>
                <c:pt idx="45">
                  <c:v>88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14BC-6F4B-99EC-EA0E3F634294}"/>
            </c:ext>
          </c:extLst>
        </c:ser>
        <c:ser>
          <c:idx val="31"/>
          <c:order val="31"/>
          <c:tx>
            <c:strRef>
              <c:f>'Neat dates truncated'!$A$34</c:f>
              <c:strCache>
                <c:ptCount val="1"/>
                <c:pt idx="0">
                  <c:v>B45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4:$AU$34</c:f>
              <c:numCache>
                <c:formatCode>General</c:formatCode>
                <c:ptCount val="46"/>
                <c:pt idx="0">
                  <c:v>20152</c:v>
                </c:pt>
                <c:pt idx="1">
                  <c:v>11398</c:v>
                </c:pt>
                <c:pt idx="2">
                  <c:v>14919</c:v>
                </c:pt>
                <c:pt idx="3">
                  <c:v>9961</c:v>
                </c:pt>
                <c:pt idx="4">
                  <c:v>16688</c:v>
                </c:pt>
                <c:pt idx="5">
                  <c:v>19594</c:v>
                </c:pt>
                <c:pt idx="6">
                  <c:v>19492</c:v>
                </c:pt>
                <c:pt idx="7">
                  <c:v>21189</c:v>
                </c:pt>
                <c:pt idx="8">
                  <c:v>24145</c:v>
                </c:pt>
                <c:pt idx="9">
                  <c:v>20479</c:v>
                </c:pt>
                <c:pt idx="10">
                  <c:v>23866</c:v>
                </c:pt>
                <c:pt idx="11">
                  <c:v>21334</c:v>
                </c:pt>
                <c:pt idx="12">
                  <c:v>21090</c:v>
                </c:pt>
                <c:pt idx="13">
                  <c:v>20367</c:v>
                </c:pt>
                <c:pt idx="14">
                  <c:v>18883</c:v>
                </c:pt>
                <c:pt idx="15">
                  <c:v>16839</c:v>
                </c:pt>
                <c:pt idx="16">
                  <c:v>15991</c:v>
                </c:pt>
                <c:pt idx="17">
                  <c:v>15042</c:v>
                </c:pt>
                <c:pt idx="18">
                  <c:v>10433</c:v>
                </c:pt>
                <c:pt idx="19">
                  <c:v>14850</c:v>
                </c:pt>
                <c:pt idx="20">
                  <c:v>11538</c:v>
                </c:pt>
                <c:pt idx="21">
                  <c:v>13472</c:v>
                </c:pt>
                <c:pt idx="22">
                  <c:v>14163</c:v>
                </c:pt>
                <c:pt idx="23">
                  <c:v>14032</c:v>
                </c:pt>
                <c:pt idx="24">
                  <c:v>10029</c:v>
                </c:pt>
                <c:pt idx="25">
                  <c:v>11087</c:v>
                </c:pt>
                <c:pt idx="26">
                  <c:v>11961</c:v>
                </c:pt>
                <c:pt idx="27">
                  <c:v>10065</c:v>
                </c:pt>
                <c:pt idx="28">
                  <c:v>16842</c:v>
                </c:pt>
                <c:pt idx="29">
                  <c:v>12007</c:v>
                </c:pt>
                <c:pt idx="30">
                  <c:v>13291</c:v>
                </c:pt>
                <c:pt idx="31">
                  <c:v>9453</c:v>
                </c:pt>
                <c:pt idx="32">
                  <c:v>9936</c:v>
                </c:pt>
                <c:pt idx="33">
                  <c:v>12238</c:v>
                </c:pt>
                <c:pt idx="34">
                  <c:v>10610</c:v>
                </c:pt>
                <c:pt idx="35">
                  <c:v>10561</c:v>
                </c:pt>
                <c:pt idx="36">
                  <c:v>12826</c:v>
                </c:pt>
                <c:pt idx="37">
                  <c:v>9501</c:v>
                </c:pt>
                <c:pt idx="38">
                  <c:v>8002</c:v>
                </c:pt>
                <c:pt idx="39">
                  <c:v>12238</c:v>
                </c:pt>
                <c:pt idx="40">
                  <c:v>10383</c:v>
                </c:pt>
                <c:pt idx="41">
                  <c:v>9501</c:v>
                </c:pt>
                <c:pt idx="42">
                  <c:v>9387</c:v>
                </c:pt>
                <c:pt idx="43">
                  <c:v>9767</c:v>
                </c:pt>
                <c:pt idx="44">
                  <c:v>9750</c:v>
                </c:pt>
                <c:pt idx="45">
                  <c:v>102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14BC-6F4B-99EC-EA0E3F634294}"/>
            </c:ext>
          </c:extLst>
        </c:ser>
        <c:ser>
          <c:idx val="32"/>
          <c:order val="32"/>
          <c:tx>
            <c:strRef>
              <c:f>'Neat dates truncated'!$A$35</c:f>
              <c:strCache>
                <c:ptCount val="1"/>
                <c:pt idx="0">
                  <c:v>B47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accent3">
                    <a:lumMod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5:$AU$35</c:f>
              <c:numCache>
                <c:formatCode>General</c:formatCode>
                <c:ptCount val="46"/>
                <c:pt idx="0">
                  <c:v>7934</c:v>
                </c:pt>
                <c:pt idx="1">
                  <c:v>9280</c:v>
                </c:pt>
                <c:pt idx="2">
                  <c:v>5727</c:v>
                </c:pt>
                <c:pt idx="3">
                  <c:v>5122</c:v>
                </c:pt>
                <c:pt idx="4">
                  <c:v>5163</c:v>
                </c:pt>
                <c:pt idx="5">
                  <c:v>3248</c:v>
                </c:pt>
                <c:pt idx="6">
                  <c:v>3278</c:v>
                </c:pt>
                <c:pt idx="7">
                  <c:v>2192</c:v>
                </c:pt>
                <c:pt idx="8">
                  <c:v>1929</c:v>
                </c:pt>
                <c:pt idx="9">
                  <c:v>1811</c:v>
                </c:pt>
                <c:pt idx="10">
                  <c:v>2022</c:v>
                </c:pt>
                <c:pt idx="11">
                  <c:v>1583</c:v>
                </c:pt>
                <c:pt idx="12">
                  <c:v>1526</c:v>
                </c:pt>
                <c:pt idx="13">
                  <c:v>1413</c:v>
                </c:pt>
                <c:pt idx="14">
                  <c:v>132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37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14BC-6F4B-99EC-EA0E3F634294}"/>
            </c:ext>
          </c:extLst>
        </c:ser>
        <c:ser>
          <c:idx val="33"/>
          <c:order val="33"/>
          <c:tx>
            <c:strRef>
              <c:f>'Neat dates truncated'!$A$36</c:f>
              <c:strCache>
                <c:ptCount val="1"/>
                <c:pt idx="0">
                  <c:v>B48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6:$AU$36</c:f>
              <c:numCache>
                <c:formatCode>General</c:formatCode>
                <c:ptCount val="46"/>
                <c:pt idx="0">
                  <c:v>23928</c:v>
                </c:pt>
                <c:pt idx="1">
                  <c:v>18674</c:v>
                </c:pt>
                <c:pt idx="2">
                  <c:v>21521</c:v>
                </c:pt>
                <c:pt idx="3">
                  <c:v>18726</c:v>
                </c:pt>
                <c:pt idx="4">
                  <c:v>20434</c:v>
                </c:pt>
                <c:pt idx="5">
                  <c:v>19681</c:v>
                </c:pt>
                <c:pt idx="6">
                  <c:v>17515</c:v>
                </c:pt>
                <c:pt idx="7">
                  <c:v>12871</c:v>
                </c:pt>
                <c:pt idx="8">
                  <c:v>10534</c:v>
                </c:pt>
                <c:pt idx="9">
                  <c:v>8142</c:v>
                </c:pt>
                <c:pt idx="10">
                  <c:v>8710</c:v>
                </c:pt>
                <c:pt idx="11">
                  <c:v>7280</c:v>
                </c:pt>
                <c:pt idx="12">
                  <c:v>5834</c:v>
                </c:pt>
                <c:pt idx="13">
                  <c:v>5458</c:v>
                </c:pt>
                <c:pt idx="14">
                  <c:v>4144</c:v>
                </c:pt>
                <c:pt idx="15">
                  <c:v>3418</c:v>
                </c:pt>
                <c:pt idx="16">
                  <c:v>3249</c:v>
                </c:pt>
                <c:pt idx="17">
                  <c:v>2697</c:v>
                </c:pt>
                <c:pt idx="18">
                  <c:v>2031</c:v>
                </c:pt>
                <c:pt idx="19">
                  <c:v>2704</c:v>
                </c:pt>
                <c:pt idx="20">
                  <c:v>1955</c:v>
                </c:pt>
                <c:pt idx="21">
                  <c:v>2313</c:v>
                </c:pt>
                <c:pt idx="22">
                  <c:v>2599</c:v>
                </c:pt>
                <c:pt idx="23">
                  <c:v>2847</c:v>
                </c:pt>
                <c:pt idx="24">
                  <c:v>1417</c:v>
                </c:pt>
                <c:pt idx="25">
                  <c:v>1428</c:v>
                </c:pt>
                <c:pt idx="26">
                  <c:v>1274</c:v>
                </c:pt>
                <c:pt idx="27">
                  <c:v>1735</c:v>
                </c:pt>
                <c:pt idx="28">
                  <c:v>13355</c:v>
                </c:pt>
                <c:pt idx="29">
                  <c:v>7376</c:v>
                </c:pt>
                <c:pt idx="30">
                  <c:v>7559</c:v>
                </c:pt>
                <c:pt idx="31">
                  <c:v>3827</c:v>
                </c:pt>
                <c:pt idx="32">
                  <c:v>4209</c:v>
                </c:pt>
                <c:pt idx="33">
                  <c:v>3971</c:v>
                </c:pt>
                <c:pt idx="34">
                  <c:v>2625</c:v>
                </c:pt>
                <c:pt idx="35">
                  <c:v>2034</c:v>
                </c:pt>
                <c:pt idx="36">
                  <c:v>2514</c:v>
                </c:pt>
                <c:pt idx="37">
                  <c:v>1631</c:v>
                </c:pt>
                <c:pt idx="38">
                  <c:v>0</c:v>
                </c:pt>
                <c:pt idx="39">
                  <c:v>1417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14BC-6F4B-99EC-EA0E3F634294}"/>
            </c:ext>
          </c:extLst>
        </c:ser>
        <c:ser>
          <c:idx val="34"/>
          <c:order val="34"/>
          <c:tx>
            <c:strRef>
              <c:f>'Neat dates truncated'!$A$37</c:f>
              <c:strCache>
                <c:ptCount val="1"/>
                <c:pt idx="0">
                  <c:v>B49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</a:schemeClr>
              </a:solidFill>
              <a:ln w="9525">
                <a:solidFill>
                  <a:schemeClr val="accent5">
                    <a:lumMod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7:$AU$37</c:f>
              <c:numCache>
                <c:formatCode>General</c:formatCode>
                <c:ptCount val="46"/>
                <c:pt idx="0">
                  <c:v>9298</c:v>
                </c:pt>
                <c:pt idx="1">
                  <c:v>10763</c:v>
                </c:pt>
                <c:pt idx="2">
                  <c:v>6939</c:v>
                </c:pt>
                <c:pt idx="3">
                  <c:v>6240</c:v>
                </c:pt>
                <c:pt idx="4">
                  <c:v>6205</c:v>
                </c:pt>
                <c:pt idx="5">
                  <c:v>3847</c:v>
                </c:pt>
                <c:pt idx="6">
                  <c:v>4064</c:v>
                </c:pt>
                <c:pt idx="7">
                  <c:v>2634</c:v>
                </c:pt>
                <c:pt idx="8">
                  <c:v>2443</c:v>
                </c:pt>
                <c:pt idx="9">
                  <c:v>2124</c:v>
                </c:pt>
                <c:pt idx="10">
                  <c:v>2516</c:v>
                </c:pt>
                <c:pt idx="11">
                  <c:v>1757</c:v>
                </c:pt>
                <c:pt idx="12">
                  <c:v>1747</c:v>
                </c:pt>
                <c:pt idx="13">
                  <c:v>1731</c:v>
                </c:pt>
                <c:pt idx="14">
                  <c:v>1634</c:v>
                </c:pt>
                <c:pt idx="15">
                  <c:v>1123</c:v>
                </c:pt>
                <c:pt idx="16">
                  <c:v>1136</c:v>
                </c:pt>
                <c:pt idx="17">
                  <c:v>0</c:v>
                </c:pt>
                <c:pt idx="18">
                  <c:v>0</c:v>
                </c:pt>
                <c:pt idx="19">
                  <c:v>1198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207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14BC-6F4B-99EC-EA0E3F634294}"/>
            </c:ext>
          </c:extLst>
        </c:ser>
        <c:ser>
          <c:idx val="35"/>
          <c:order val="35"/>
          <c:tx>
            <c:strRef>
              <c:f>'Neat dates truncated'!$A$38</c:f>
              <c:strCache>
                <c:ptCount val="1"/>
                <c:pt idx="0">
                  <c:v>B50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8:$AU$38</c:f>
              <c:numCache>
                <c:formatCode>General</c:formatCode>
                <c:ptCount val="46"/>
                <c:pt idx="0">
                  <c:v>23771</c:v>
                </c:pt>
                <c:pt idx="1">
                  <c:v>18841</c:v>
                </c:pt>
                <c:pt idx="2">
                  <c:v>21481</c:v>
                </c:pt>
                <c:pt idx="3">
                  <c:v>18758</c:v>
                </c:pt>
                <c:pt idx="4">
                  <c:v>21433</c:v>
                </c:pt>
                <c:pt idx="5">
                  <c:v>19910</c:v>
                </c:pt>
                <c:pt idx="6">
                  <c:v>17722</c:v>
                </c:pt>
                <c:pt idx="7">
                  <c:v>12887</c:v>
                </c:pt>
                <c:pt idx="8">
                  <c:v>11079</c:v>
                </c:pt>
                <c:pt idx="9">
                  <c:v>9151</c:v>
                </c:pt>
                <c:pt idx="10">
                  <c:v>9707</c:v>
                </c:pt>
                <c:pt idx="11">
                  <c:v>7550</c:v>
                </c:pt>
                <c:pt idx="12">
                  <c:v>6199</c:v>
                </c:pt>
                <c:pt idx="13">
                  <c:v>5952</c:v>
                </c:pt>
                <c:pt idx="14">
                  <c:v>5131</c:v>
                </c:pt>
                <c:pt idx="15">
                  <c:v>3760</c:v>
                </c:pt>
                <c:pt idx="16">
                  <c:v>3552</c:v>
                </c:pt>
                <c:pt idx="17">
                  <c:v>3189</c:v>
                </c:pt>
                <c:pt idx="18">
                  <c:v>2207</c:v>
                </c:pt>
                <c:pt idx="19">
                  <c:v>3291</c:v>
                </c:pt>
                <c:pt idx="20">
                  <c:v>2241</c:v>
                </c:pt>
                <c:pt idx="21">
                  <c:v>2598</c:v>
                </c:pt>
                <c:pt idx="22">
                  <c:v>2752</c:v>
                </c:pt>
                <c:pt idx="23">
                  <c:v>2882</c:v>
                </c:pt>
                <c:pt idx="24">
                  <c:v>1594</c:v>
                </c:pt>
                <c:pt idx="25">
                  <c:v>1726</c:v>
                </c:pt>
                <c:pt idx="26">
                  <c:v>1767</c:v>
                </c:pt>
                <c:pt idx="27">
                  <c:v>1596</c:v>
                </c:pt>
                <c:pt idx="28">
                  <c:v>12198</c:v>
                </c:pt>
                <c:pt idx="29">
                  <c:v>7077</c:v>
                </c:pt>
                <c:pt idx="30">
                  <c:v>6941</c:v>
                </c:pt>
                <c:pt idx="31">
                  <c:v>3578</c:v>
                </c:pt>
                <c:pt idx="32">
                  <c:v>3931</c:v>
                </c:pt>
                <c:pt idx="33">
                  <c:v>3850</c:v>
                </c:pt>
                <c:pt idx="34">
                  <c:v>2618</c:v>
                </c:pt>
                <c:pt idx="35">
                  <c:v>2165</c:v>
                </c:pt>
                <c:pt idx="36">
                  <c:v>2579</c:v>
                </c:pt>
                <c:pt idx="37">
                  <c:v>1688</c:v>
                </c:pt>
                <c:pt idx="38">
                  <c:v>0</c:v>
                </c:pt>
                <c:pt idx="39">
                  <c:v>1491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14BC-6F4B-99EC-EA0E3F634294}"/>
            </c:ext>
          </c:extLst>
        </c:ser>
        <c:ser>
          <c:idx val="36"/>
          <c:order val="36"/>
          <c:tx>
            <c:strRef>
              <c:f>'Neat dates truncated'!$A$39</c:f>
              <c:strCache>
                <c:ptCount val="1"/>
                <c:pt idx="0">
                  <c:v>B51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  <a:lumOff val="30000"/>
                </a:schemeClr>
              </a:solidFill>
              <a:ln w="9525">
                <a:solidFill>
                  <a:schemeClr val="accent1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39:$AU$39</c:f>
              <c:numCache>
                <c:formatCode>General</c:formatCode>
                <c:ptCount val="46"/>
                <c:pt idx="0">
                  <c:v>4580</c:v>
                </c:pt>
                <c:pt idx="1">
                  <c:v>3688</c:v>
                </c:pt>
                <c:pt idx="2">
                  <c:v>4116</c:v>
                </c:pt>
                <c:pt idx="3">
                  <c:v>1998</c:v>
                </c:pt>
                <c:pt idx="4">
                  <c:v>2100</c:v>
                </c:pt>
                <c:pt idx="5">
                  <c:v>2156</c:v>
                </c:pt>
                <c:pt idx="6">
                  <c:v>187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14BC-6F4B-99EC-EA0E3F634294}"/>
            </c:ext>
          </c:extLst>
        </c:ser>
        <c:ser>
          <c:idx val="37"/>
          <c:order val="37"/>
          <c:tx>
            <c:strRef>
              <c:f>'Neat dates truncated'!$A$40</c:f>
              <c:strCache>
                <c:ptCount val="1"/>
                <c:pt idx="0">
                  <c:v>B54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0:$AU$40</c:f>
              <c:numCache>
                <c:formatCode>General</c:formatCode>
                <c:ptCount val="46"/>
                <c:pt idx="0">
                  <c:v>23371</c:v>
                </c:pt>
                <c:pt idx="1">
                  <c:v>18094</c:v>
                </c:pt>
                <c:pt idx="2">
                  <c:v>20831</c:v>
                </c:pt>
                <c:pt idx="3">
                  <c:v>18184</c:v>
                </c:pt>
                <c:pt idx="4">
                  <c:v>21764</c:v>
                </c:pt>
                <c:pt idx="5">
                  <c:v>21000</c:v>
                </c:pt>
                <c:pt idx="6">
                  <c:v>18664</c:v>
                </c:pt>
                <c:pt idx="7">
                  <c:v>13821</c:v>
                </c:pt>
                <c:pt idx="8">
                  <c:v>11410</c:v>
                </c:pt>
                <c:pt idx="9">
                  <c:v>8991</c:v>
                </c:pt>
                <c:pt idx="10">
                  <c:v>9589</c:v>
                </c:pt>
                <c:pt idx="11">
                  <c:v>7265</c:v>
                </c:pt>
                <c:pt idx="12">
                  <c:v>5979</c:v>
                </c:pt>
                <c:pt idx="13">
                  <c:v>5676</c:v>
                </c:pt>
                <c:pt idx="14">
                  <c:v>4662</c:v>
                </c:pt>
                <c:pt idx="15">
                  <c:v>3625</c:v>
                </c:pt>
                <c:pt idx="16">
                  <c:v>3305</c:v>
                </c:pt>
                <c:pt idx="17">
                  <c:v>2919</c:v>
                </c:pt>
                <c:pt idx="18">
                  <c:v>2082</c:v>
                </c:pt>
                <c:pt idx="19">
                  <c:v>3011</c:v>
                </c:pt>
                <c:pt idx="20">
                  <c:v>2035</c:v>
                </c:pt>
                <c:pt idx="21">
                  <c:v>2454</c:v>
                </c:pt>
                <c:pt idx="22">
                  <c:v>2560</c:v>
                </c:pt>
                <c:pt idx="23">
                  <c:v>2688</c:v>
                </c:pt>
                <c:pt idx="24">
                  <c:v>1406</c:v>
                </c:pt>
                <c:pt idx="25">
                  <c:v>1488</c:v>
                </c:pt>
                <c:pt idx="26">
                  <c:v>1356</c:v>
                </c:pt>
                <c:pt idx="27">
                  <c:v>1478</c:v>
                </c:pt>
                <c:pt idx="28">
                  <c:v>13825</c:v>
                </c:pt>
                <c:pt idx="29">
                  <c:v>7864</c:v>
                </c:pt>
                <c:pt idx="30">
                  <c:v>7536</c:v>
                </c:pt>
                <c:pt idx="31">
                  <c:v>4169</c:v>
                </c:pt>
                <c:pt idx="32">
                  <c:v>4475</c:v>
                </c:pt>
                <c:pt idx="33">
                  <c:v>4316</c:v>
                </c:pt>
                <c:pt idx="34">
                  <c:v>2770</c:v>
                </c:pt>
                <c:pt idx="35">
                  <c:v>2260</c:v>
                </c:pt>
                <c:pt idx="36">
                  <c:v>2835</c:v>
                </c:pt>
                <c:pt idx="37">
                  <c:v>1819</c:v>
                </c:pt>
                <c:pt idx="38">
                  <c:v>0</c:v>
                </c:pt>
                <c:pt idx="39">
                  <c:v>1483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14BC-6F4B-99EC-EA0E3F634294}"/>
            </c:ext>
          </c:extLst>
        </c:ser>
        <c:ser>
          <c:idx val="38"/>
          <c:order val="38"/>
          <c:tx>
            <c:strRef>
              <c:f>'Neat dates truncated'!$A$41</c:f>
              <c:strCache>
                <c:ptCount val="1"/>
                <c:pt idx="0">
                  <c:v>B55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  <a:lumOff val="30000"/>
                </a:schemeClr>
              </a:solidFill>
              <a:ln w="9525">
                <a:solidFill>
                  <a:schemeClr val="accent3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1:$AU$41</c:f>
              <c:numCache>
                <c:formatCode>General</c:formatCode>
                <c:ptCount val="46"/>
                <c:pt idx="0">
                  <c:v>22150</c:v>
                </c:pt>
                <c:pt idx="1">
                  <c:v>14716</c:v>
                </c:pt>
                <c:pt idx="2">
                  <c:v>19148</c:v>
                </c:pt>
                <c:pt idx="3">
                  <c:v>16020</c:v>
                </c:pt>
                <c:pt idx="4">
                  <c:v>21916</c:v>
                </c:pt>
                <c:pt idx="5">
                  <c:v>21579</c:v>
                </c:pt>
                <c:pt idx="6">
                  <c:v>19866</c:v>
                </c:pt>
                <c:pt idx="7">
                  <c:v>15394</c:v>
                </c:pt>
                <c:pt idx="8">
                  <c:v>12978</c:v>
                </c:pt>
                <c:pt idx="9">
                  <c:v>10411</c:v>
                </c:pt>
                <c:pt idx="10">
                  <c:v>11138</c:v>
                </c:pt>
                <c:pt idx="11">
                  <c:v>8503</c:v>
                </c:pt>
                <c:pt idx="12">
                  <c:v>6925</c:v>
                </c:pt>
                <c:pt idx="13">
                  <c:v>6649</c:v>
                </c:pt>
                <c:pt idx="14">
                  <c:v>5575</c:v>
                </c:pt>
                <c:pt idx="15">
                  <c:v>4516</c:v>
                </c:pt>
                <c:pt idx="16">
                  <c:v>4060</c:v>
                </c:pt>
                <c:pt idx="17">
                  <c:v>3505</c:v>
                </c:pt>
                <c:pt idx="18">
                  <c:v>2512</c:v>
                </c:pt>
                <c:pt idx="19">
                  <c:v>3571</c:v>
                </c:pt>
                <c:pt idx="20">
                  <c:v>2420</c:v>
                </c:pt>
                <c:pt idx="21">
                  <c:v>2850</c:v>
                </c:pt>
                <c:pt idx="22">
                  <c:v>3039</c:v>
                </c:pt>
                <c:pt idx="23">
                  <c:v>3062</c:v>
                </c:pt>
                <c:pt idx="24">
                  <c:v>1621</c:v>
                </c:pt>
                <c:pt idx="25">
                  <c:v>1636</c:v>
                </c:pt>
                <c:pt idx="26">
                  <c:v>1639</c:v>
                </c:pt>
                <c:pt idx="27">
                  <c:v>1650</c:v>
                </c:pt>
                <c:pt idx="28">
                  <c:v>14451</c:v>
                </c:pt>
                <c:pt idx="29">
                  <c:v>8407</c:v>
                </c:pt>
                <c:pt idx="30">
                  <c:v>8336</c:v>
                </c:pt>
                <c:pt idx="31">
                  <c:v>4478</c:v>
                </c:pt>
                <c:pt idx="32">
                  <c:v>4941</c:v>
                </c:pt>
                <c:pt idx="33">
                  <c:v>4730</c:v>
                </c:pt>
                <c:pt idx="34">
                  <c:v>3138</c:v>
                </c:pt>
                <c:pt idx="35">
                  <c:v>2678</c:v>
                </c:pt>
                <c:pt idx="36">
                  <c:v>3440</c:v>
                </c:pt>
                <c:pt idx="37">
                  <c:v>2089</c:v>
                </c:pt>
                <c:pt idx="38">
                  <c:v>1247</c:v>
                </c:pt>
                <c:pt idx="39">
                  <c:v>1794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1203</c:v>
                </c:pt>
                <c:pt idx="44">
                  <c:v>1117</c:v>
                </c:pt>
                <c:pt idx="45">
                  <c:v>11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14BC-6F4B-99EC-EA0E3F634294}"/>
            </c:ext>
          </c:extLst>
        </c:ser>
        <c:ser>
          <c:idx val="39"/>
          <c:order val="39"/>
          <c:tx>
            <c:strRef>
              <c:f>'Neat dates truncated'!$A$42</c:f>
              <c:strCache>
                <c:ptCount val="1"/>
                <c:pt idx="0">
                  <c:v>B56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2:$AU$42</c:f>
              <c:numCache>
                <c:formatCode>General</c:formatCode>
                <c:ptCount val="46"/>
                <c:pt idx="0">
                  <c:v>24092</c:v>
                </c:pt>
                <c:pt idx="1">
                  <c:v>19207</c:v>
                </c:pt>
                <c:pt idx="2">
                  <c:v>21539</c:v>
                </c:pt>
                <c:pt idx="3">
                  <c:v>19993</c:v>
                </c:pt>
                <c:pt idx="4">
                  <c:v>21527</c:v>
                </c:pt>
                <c:pt idx="5">
                  <c:v>20581</c:v>
                </c:pt>
                <c:pt idx="6">
                  <c:v>17430</c:v>
                </c:pt>
                <c:pt idx="7">
                  <c:v>13537</c:v>
                </c:pt>
                <c:pt idx="8">
                  <c:v>11268</c:v>
                </c:pt>
                <c:pt idx="9">
                  <c:v>8863</c:v>
                </c:pt>
                <c:pt idx="10">
                  <c:v>9484</c:v>
                </c:pt>
                <c:pt idx="11">
                  <c:v>7316</c:v>
                </c:pt>
                <c:pt idx="12">
                  <c:v>5883</c:v>
                </c:pt>
                <c:pt idx="13">
                  <c:v>5611</c:v>
                </c:pt>
                <c:pt idx="14">
                  <c:v>4609</c:v>
                </c:pt>
                <c:pt idx="15">
                  <c:v>3438</c:v>
                </c:pt>
                <c:pt idx="16">
                  <c:v>3451</c:v>
                </c:pt>
                <c:pt idx="17">
                  <c:v>2912</c:v>
                </c:pt>
                <c:pt idx="18">
                  <c:v>2118</c:v>
                </c:pt>
                <c:pt idx="19">
                  <c:v>3058</c:v>
                </c:pt>
                <c:pt idx="20">
                  <c:v>2040</c:v>
                </c:pt>
                <c:pt idx="21">
                  <c:v>2456</c:v>
                </c:pt>
                <c:pt idx="22">
                  <c:v>2641</c:v>
                </c:pt>
                <c:pt idx="23">
                  <c:v>2673</c:v>
                </c:pt>
                <c:pt idx="24">
                  <c:v>1398</c:v>
                </c:pt>
                <c:pt idx="25">
                  <c:v>1460</c:v>
                </c:pt>
                <c:pt idx="26">
                  <c:v>1351</c:v>
                </c:pt>
                <c:pt idx="27">
                  <c:v>1394</c:v>
                </c:pt>
                <c:pt idx="28">
                  <c:v>14715</c:v>
                </c:pt>
                <c:pt idx="29">
                  <c:v>8392</c:v>
                </c:pt>
                <c:pt idx="30">
                  <c:v>8201</c:v>
                </c:pt>
                <c:pt idx="31">
                  <c:v>4549</c:v>
                </c:pt>
                <c:pt idx="32">
                  <c:v>4991</c:v>
                </c:pt>
                <c:pt idx="33">
                  <c:v>4659</c:v>
                </c:pt>
                <c:pt idx="34">
                  <c:v>3011</c:v>
                </c:pt>
                <c:pt idx="35">
                  <c:v>2615</c:v>
                </c:pt>
                <c:pt idx="36">
                  <c:v>3200</c:v>
                </c:pt>
                <c:pt idx="37">
                  <c:v>2033</c:v>
                </c:pt>
                <c:pt idx="38">
                  <c:v>1198</c:v>
                </c:pt>
                <c:pt idx="39">
                  <c:v>1709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14BC-6F4B-99EC-EA0E3F634294}"/>
            </c:ext>
          </c:extLst>
        </c:ser>
        <c:ser>
          <c:idx val="40"/>
          <c:order val="40"/>
          <c:tx>
            <c:strRef>
              <c:f>'Neat dates truncated'!$A$43</c:f>
              <c:strCache>
                <c:ptCount val="1"/>
                <c:pt idx="0">
                  <c:v>B59</c:v>
                </c:pt>
              </c:strCache>
            </c:strRef>
          </c:tx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70000"/>
                  <a:lumOff val="30000"/>
                </a:schemeClr>
              </a:solidFill>
              <a:ln w="9525">
                <a:solidFill>
                  <a:schemeClr val="accent5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3:$AU$43</c:f>
              <c:numCache>
                <c:formatCode>General</c:formatCode>
                <c:ptCount val="46"/>
                <c:pt idx="0">
                  <c:v>6677</c:v>
                </c:pt>
                <c:pt idx="1">
                  <c:v>7111</c:v>
                </c:pt>
                <c:pt idx="2">
                  <c:v>4311</c:v>
                </c:pt>
                <c:pt idx="3">
                  <c:v>3985</c:v>
                </c:pt>
                <c:pt idx="4">
                  <c:v>4341</c:v>
                </c:pt>
                <c:pt idx="5">
                  <c:v>2556</c:v>
                </c:pt>
                <c:pt idx="6">
                  <c:v>2397</c:v>
                </c:pt>
                <c:pt idx="7">
                  <c:v>1496</c:v>
                </c:pt>
                <c:pt idx="8">
                  <c:v>1206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14BC-6F4B-99EC-EA0E3F634294}"/>
            </c:ext>
          </c:extLst>
        </c:ser>
        <c:ser>
          <c:idx val="41"/>
          <c:order val="41"/>
          <c:tx>
            <c:strRef>
              <c:f>'Neat dates truncated'!$A$44</c:f>
              <c:strCache>
                <c:ptCount val="1"/>
                <c:pt idx="0">
                  <c:v>B60</c:v>
                </c:pt>
              </c:strCache>
            </c:strRef>
          </c:tx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0000"/>
                  <a:lumOff val="30000"/>
                </a:schemeClr>
              </a:solidFill>
              <a:ln w="9525">
                <a:solidFill>
                  <a:schemeClr val="accent6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4:$AU$44</c:f>
              <c:numCache>
                <c:formatCode>General</c:formatCode>
                <c:ptCount val="46"/>
                <c:pt idx="0">
                  <c:v>23793</c:v>
                </c:pt>
                <c:pt idx="1">
                  <c:v>17970</c:v>
                </c:pt>
                <c:pt idx="2">
                  <c:v>20581</c:v>
                </c:pt>
                <c:pt idx="3">
                  <c:v>18595</c:v>
                </c:pt>
                <c:pt idx="4">
                  <c:v>22297</c:v>
                </c:pt>
                <c:pt idx="5">
                  <c:v>21027</c:v>
                </c:pt>
                <c:pt idx="6">
                  <c:v>19552</c:v>
                </c:pt>
                <c:pt idx="7">
                  <c:v>14261</c:v>
                </c:pt>
                <c:pt idx="8">
                  <c:v>12539</c:v>
                </c:pt>
                <c:pt idx="9">
                  <c:v>10050</c:v>
                </c:pt>
                <c:pt idx="10">
                  <c:v>10987</c:v>
                </c:pt>
                <c:pt idx="11">
                  <c:v>8534</c:v>
                </c:pt>
                <c:pt idx="12">
                  <c:v>7161</c:v>
                </c:pt>
                <c:pt idx="13">
                  <c:v>6795</c:v>
                </c:pt>
                <c:pt idx="14">
                  <c:v>5681</c:v>
                </c:pt>
                <c:pt idx="15">
                  <c:v>4263</c:v>
                </c:pt>
                <c:pt idx="16">
                  <c:v>4067</c:v>
                </c:pt>
                <c:pt idx="17">
                  <c:v>3644</c:v>
                </c:pt>
                <c:pt idx="18">
                  <c:v>2600</c:v>
                </c:pt>
                <c:pt idx="19">
                  <c:v>3776</c:v>
                </c:pt>
                <c:pt idx="20">
                  <c:v>2578</c:v>
                </c:pt>
                <c:pt idx="21">
                  <c:v>3084</c:v>
                </c:pt>
                <c:pt idx="22">
                  <c:v>3543</c:v>
                </c:pt>
                <c:pt idx="23">
                  <c:v>3604</c:v>
                </c:pt>
                <c:pt idx="24">
                  <c:v>1954</c:v>
                </c:pt>
                <c:pt idx="25">
                  <c:v>2031</c:v>
                </c:pt>
                <c:pt idx="26">
                  <c:v>1928</c:v>
                </c:pt>
                <c:pt idx="27">
                  <c:v>2401</c:v>
                </c:pt>
                <c:pt idx="28">
                  <c:v>13159</c:v>
                </c:pt>
                <c:pt idx="29">
                  <c:v>7414</c:v>
                </c:pt>
                <c:pt idx="30">
                  <c:v>7564</c:v>
                </c:pt>
                <c:pt idx="31">
                  <c:v>4104</c:v>
                </c:pt>
                <c:pt idx="32">
                  <c:v>4495</c:v>
                </c:pt>
                <c:pt idx="33">
                  <c:v>4256</c:v>
                </c:pt>
                <c:pt idx="34">
                  <c:v>2893</c:v>
                </c:pt>
                <c:pt idx="35">
                  <c:v>2422</c:v>
                </c:pt>
                <c:pt idx="36">
                  <c:v>2721</c:v>
                </c:pt>
                <c:pt idx="37">
                  <c:v>1977</c:v>
                </c:pt>
                <c:pt idx="38">
                  <c:v>0</c:v>
                </c:pt>
                <c:pt idx="39">
                  <c:v>168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14BC-6F4B-99EC-EA0E3F634294}"/>
            </c:ext>
          </c:extLst>
        </c:ser>
        <c:ser>
          <c:idx val="42"/>
          <c:order val="42"/>
          <c:tx>
            <c:strRef>
              <c:f>'Neat dates truncated'!$A$45</c:f>
              <c:strCache>
                <c:ptCount val="1"/>
                <c:pt idx="0">
                  <c:v>B61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5:$AU$45</c:f>
              <c:numCache>
                <c:formatCode>General</c:formatCode>
                <c:ptCount val="46"/>
                <c:pt idx="0">
                  <c:v>24225</c:v>
                </c:pt>
                <c:pt idx="1">
                  <c:v>18971</c:v>
                </c:pt>
                <c:pt idx="2">
                  <c:v>21227</c:v>
                </c:pt>
                <c:pt idx="3">
                  <c:v>18876</c:v>
                </c:pt>
                <c:pt idx="4">
                  <c:v>22301</c:v>
                </c:pt>
                <c:pt idx="5">
                  <c:v>21358</c:v>
                </c:pt>
                <c:pt idx="6">
                  <c:v>19861</c:v>
                </c:pt>
                <c:pt idx="7">
                  <c:v>14840</c:v>
                </c:pt>
                <c:pt idx="8">
                  <c:v>12790</c:v>
                </c:pt>
                <c:pt idx="9">
                  <c:v>10425</c:v>
                </c:pt>
                <c:pt idx="10">
                  <c:v>11223</c:v>
                </c:pt>
                <c:pt idx="11">
                  <c:v>8723</c:v>
                </c:pt>
                <c:pt idx="12">
                  <c:v>7509</c:v>
                </c:pt>
                <c:pt idx="13">
                  <c:v>7056</c:v>
                </c:pt>
                <c:pt idx="14">
                  <c:v>5806</c:v>
                </c:pt>
                <c:pt idx="15">
                  <c:v>4789</c:v>
                </c:pt>
                <c:pt idx="16">
                  <c:v>4542</c:v>
                </c:pt>
                <c:pt idx="17">
                  <c:v>3946</c:v>
                </c:pt>
                <c:pt idx="18">
                  <c:v>2655</c:v>
                </c:pt>
                <c:pt idx="19">
                  <c:v>3908</c:v>
                </c:pt>
                <c:pt idx="20">
                  <c:v>2740</c:v>
                </c:pt>
                <c:pt idx="21">
                  <c:v>3213</c:v>
                </c:pt>
                <c:pt idx="22">
                  <c:v>3685</c:v>
                </c:pt>
                <c:pt idx="23">
                  <c:v>3698</c:v>
                </c:pt>
                <c:pt idx="24">
                  <c:v>2045</c:v>
                </c:pt>
                <c:pt idx="25">
                  <c:v>2120</c:v>
                </c:pt>
                <c:pt idx="26">
                  <c:v>2073</c:v>
                </c:pt>
                <c:pt idx="27">
                  <c:v>2310</c:v>
                </c:pt>
                <c:pt idx="28">
                  <c:v>13359</c:v>
                </c:pt>
                <c:pt idx="29">
                  <c:v>7704</c:v>
                </c:pt>
                <c:pt idx="30">
                  <c:v>7913</c:v>
                </c:pt>
                <c:pt idx="31">
                  <c:v>4163</c:v>
                </c:pt>
                <c:pt idx="32">
                  <c:v>4604</c:v>
                </c:pt>
                <c:pt idx="33">
                  <c:v>4509</c:v>
                </c:pt>
                <c:pt idx="34">
                  <c:v>3166</c:v>
                </c:pt>
                <c:pt idx="35">
                  <c:v>2481</c:v>
                </c:pt>
                <c:pt idx="36">
                  <c:v>2897</c:v>
                </c:pt>
                <c:pt idx="37">
                  <c:v>2136</c:v>
                </c:pt>
                <c:pt idx="38">
                  <c:v>1276</c:v>
                </c:pt>
                <c:pt idx="39">
                  <c:v>1846</c:v>
                </c:pt>
                <c:pt idx="40">
                  <c:v>1356</c:v>
                </c:pt>
                <c:pt idx="41">
                  <c:v>1383</c:v>
                </c:pt>
                <c:pt idx="42">
                  <c:v>0</c:v>
                </c:pt>
                <c:pt idx="43">
                  <c:v>1305</c:v>
                </c:pt>
                <c:pt idx="44">
                  <c:v>1229</c:v>
                </c:pt>
                <c:pt idx="45">
                  <c:v>13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14BC-6F4B-99EC-EA0E3F634294}"/>
            </c:ext>
          </c:extLst>
        </c:ser>
        <c:ser>
          <c:idx val="43"/>
          <c:order val="43"/>
          <c:tx>
            <c:strRef>
              <c:f>'Neat dates truncated'!$A$46</c:f>
              <c:strCache>
                <c:ptCount val="1"/>
                <c:pt idx="0">
                  <c:v>B62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6:$AU$46</c:f>
              <c:numCache>
                <c:formatCode>General</c:formatCode>
                <c:ptCount val="46"/>
                <c:pt idx="0">
                  <c:v>24617</c:v>
                </c:pt>
                <c:pt idx="1">
                  <c:v>18583</c:v>
                </c:pt>
                <c:pt idx="2">
                  <c:v>22264</c:v>
                </c:pt>
                <c:pt idx="3">
                  <c:v>19563</c:v>
                </c:pt>
                <c:pt idx="4">
                  <c:v>22024</c:v>
                </c:pt>
                <c:pt idx="5">
                  <c:v>19843</c:v>
                </c:pt>
                <c:pt idx="6">
                  <c:v>17516</c:v>
                </c:pt>
                <c:pt idx="7">
                  <c:v>12853</c:v>
                </c:pt>
                <c:pt idx="8">
                  <c:v>10214</c:v>
                </c:pt>
                <c:pt idx="9">
                  <c:v>8242</c:v>
                </c:pt>
                <c:pt idx="10">
                  <c:v>8576</c:v>
                </c:pt>
                <c:pt idx="11">
                  <c:v>6530</c:v>
                </c:pt>
                <c:pt idx="12">
                  <c:v>5327</c:v>
                </c:pt>
                <c:pt idx="13">
                  <c:v>5165</c:v>
                </c:pt>
                <c:pt idx="14">
                  <c:v>4364</c:v>
                </c:pt>
                <c:pt idx="15">
                  <c:v>3014</c:v>
                </c:pt>
                <c:pt idx="16">
                  <c:v>3186</c:v>
                </c:pt>
                <c:pt idx="17">
                  <c:v>2681</c:v>
                </c:pt>
                <c:pt idx="18">
                  <c:v>1957</c:v>
                </c:pt>
                <c:pt idx="19">
                  <c:v>2728</c:v>
                </c:pt>
                <c:pt idx="20">
                  <c:v>1848</c:v>
                </c:pt>
                <c:pt idx="21">
                  <c:v>2245</c:v>
                </c:pt>
                <c:pt idx="22">
                  <c:v>2342</c:v>
                </c:pt>
                <c:pt idx="23">
                  <c:v>2255</c:v>
                </c:pt>
                <c:pt idx="24">
                  <c:v>1197</c:v>
                </c:pt>
                <c:pt idx="25">
                  <c:v>1286</c:v>
                </c:pt>
                <c:pt idx="26">
                  <c:v>1226</c:v>
                </c:pt>
                <c:pt idx="27">
                  <c:v>1152</c:v>
                </c:pt>
                <c:pt idx="28">
                  <c:v>13269</c:v>
                </c:pt>
                <c:pt idx="29">
                  <c:v>7658</c:v>
                </c:pt>
                <c:pt idx="30">
                  <c:v>7633</c:v>
                </c:pt>
                <c:pt idx="31">
                  <c:v>4078</c:v>
                </c:pt>
                <c:pt idx="32">
                  <c:v>4528</c:v>
                </c:pt>
                <c:pt idx="33">
                  <c:v>4206</c:v>
                </c:pt>
                <c:pt idx="34">
                  <c:v>2680</c:v>
                </c:pt>
                <c:pt idx="35">
                  <c:v>2330</c:v>
                </c:pt>
                <c:pt idx="36">
                  <c:v>2906</c:v>
                </c:pt>
                <c:pt idx="37">
                  <c:v>1805</c:v>
                </c:pt>
                <c:pt idx="38">
                  <c:v>0</c:v>
                </c:pt>
                <c:pt idx="39">
                  <c:v>1463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14BC-6F4B-99EC-EA0E3F634294}"/>
            </c:ext>
          </c:extLst>
        </c:ser>
        <c:ser>
          <c:idx val="44"/>
          <c:order val="44"/>
          <c:tx>
            <c:strRef>
              <c:f>'Neat dates truncated'!$A$47</c:f>
              <c:strCache>
                <c:ptCount val="1"/>
                <c:pt idx="0">
                  <c:v>B63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</a:schemeClr>
              </a:solidFill>
              <a:ln w="9525">
                <a:solidFill>
                  <a:schemeClr val="accent3">
                    <a:lumMod val="7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7:$AU$47</c:f>
              <c:numCache>
                <c:formatCode>General</c:formatCode>
                <c:ptCount val="46"/>
                <c:pt idx="0">
                  <c:v>224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14BC-6F4B-99EC-EA0E3F634294}"/>
            </c:ext>
          </c:extLst>
        </c:ser>
        <c:ser>
          <c:idx val="45"/>
          <c:order val="45"/>
          <c:tx>
            <c:strRef>
              <c:f>'Neat dates truncated'!$A$48</c:f>
              <c:strCache>
                <c:ptCount val="1"/>
                <c:pt idx="0">
                  <c:v>B64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</a:schemeClr>
              </a:solidFill>
              <a:ln w="9525">
                <a:solidFill>
                  <a:schemeClr val="accent4">
                    <a:lumMod val="7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8:$AU$48</c:f>
              <c:numCache>
                <c:formatCode>General</c:formatCode>
                <c:ptCount val="46"/>
                <c:pt idx="0">
                  <c:v>23415</c:v>
                </c:pt>
                <c:pt idx="1">
                  <c:v>17616</c:v>
                </c:pt>
                <c:pt idx="2">
                  <c:v>20569</c:v>
                </c:pt>
                <c:pt idx="3">
                  <c:v>18333</c:v>
                </c:pt>
                <c:pt idx="4">
                  <c:v>21008</c:v>
                </c:pt>
                <c:pt idx="5">
                  <c:v>19117</c:v>
                </c:pt>
                <c:pt idx="6">
                  <c:v>18025</c:v>
                </c:pt>
                <c:pt idx="7">
                  <c:v>13006</c:v>
                </c:pt>
                <c:pt idx="8">
                  <c:v>10593</c:v>
                </c:pt>
                <c:pt idx="9">
                  <c:v>8678</c:v>
                </c:pt>
                <c:pt idx="10">
                  <c:v>8773</c:v>
                </c:pt>
                <c:pt idx="11">
                  <c:v>6625</c:v>
                </c:pt>
                <c:pt idx="12">
                  <c:v>5463</c:v>
                </c:pt>
                <c:pt idx="13">
                  <c:v>5123</c:v>
                </c:pt>
                <c:pt idx="14">
                  <c:v>4271</c:v>
                </c:pt>
                <c:pt idx="15">
                  <c:v>3289</c:v>
                </c:pt>
                <c:pt idx="16">
                  <c:v>3188</c:v>
                </c:pt>
                <c:pt idx="17">
                  <c:v>2640</c:v>
                </c:pt>
                <c:pt idx="18">
                  <c:v>1860</c:v>
                </c:pt>
                <c:pt idx="19">
                  <c:v>2674</c:v>
                </c:pt>
                <c:pt idx="20">
                  <c:v>1781</c:v>
                </c:pt>
                <c:pt idx="21">
                  <c:v>2161</c:v>
                </c:pt>
                <c:pt idx="22">
                  <c:v>2257</c:v>
                </c:pt>
                <c:pt idx="23">
                  <c:v>2227</c:v>
                </c:pt>
                <c:pt idx="24">
                  <c:v>1218</c:v>
                </c:pt>
                <c:pt idx="25">
                  <c:v>1286</c:v>
                </c:pt>
                <c:pt idx="26">
                  <c:v>1203</c:v>
                </c:pt>
                <c:pt idx="27">
                  <c:v>1264</c:v>
                </c:pt>
                <c:pt idx="28">
                  <c:v>12768</c:v>
                </c:pt>
                <c:pt idx="29">
                  <c:v>6644</c:v>
                </c:pt>
                <c:pt idx="30">
                  <c:v>6751</c:v>
                </c:pt>
                <c:pt idx="31">
                  <c:v>3326</c:v>
                </c:pt>
                <c:pt idx="32">
                  <c:v>3780</c:v>
                </c:pt>
                <c:pt idx="33">
                  <c:v>3472</c:v>
                </c:pt>
                <c:pt idx="34">
                  <c:v>2389</c:v>
                </c:pt>
                <c:pt idx="35">
                  <c:v>1869</c:v>
                </c:pt>
                <c:pt idx="36">
                  <c:v>2248</c:v>
                </c:pt>
                <c:pt idx="37">
                  <c:v>1439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14BC-6F4B-99EC-EA0E3F634294}"/>
            </c:ext>
          </c:extLst>
        </c:ser>
        <c:ser>
          <c:idx val="46"/>
          <c:order val="46"/>
          <c:tx>
            <c:strRef>
              <c:f>'Neat dates truncated'!$A$49</c:f>
              <c:strCache>
                <c:ptCount val="1"/>
                <c:pt idx="0">
                  <c:v>B65</c:v>
                </c:pt>
              </c:strCache>
            </c:strRef>
          </c:tx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70000"/>
                </a:schemeClr>
              </a:solidFill>
              <a:ln w="9525">
                <a:solidFill>
                  <a:schemeClr val="accent5">
                    <a:lumMod val="7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49:$AU$49</c:f>
              <c:numCache>
                <c:formatCode>General</c:formatCode>
                <c:ptCount val="46"/>
                <c:pt idx="0">
                  <c:v>22682</c:v>
                </c:pt>
                <c:pt idx="1">
                  <c:v>20538</c:v>
                </c:pt>
                <c:pt idx="2">
                  <c:v>18166</c:v>
                </c:pt>
                <c:pt idx="3">
                  <c:v>16033</c:v>
                </c:pt>
                <c:pt idx="4">
                  <c:v>16318</c:v>
                </c:pt>
                <c:pt idx="5">
                  <c:v>13370</c:v>
                </c:pt>
                <c:pt idx="6">
                  <c:v>11754</c:v>
                </c:pt>
                <c:pt idx="7">
                  <c:v>8285</c:v>
                </c:pt>
                <c:pt idx="8">
                  <c:v>7018</c:v>
                </c:pt>
                <c:pt idx="9">
                  <c:v>5530</c:v>
                </c:pt>
                <c:pt idx="10">
                  <c:v>5297</c:v>
                </c:pt>
                <c:pt idx="11">
                  <c:v>3991</c:v>
                </c:pt>
                <c:pt idx="12">
                  <c:v>3453</c:v>
                </c:pt>
                <c:pt idx="13">
                  <c:v>3127</c:v>
                </c:pt>
                <c:pt idx="14">
                  <c:v>2782</c:v>
                </c:pt>
                <c:pt idx="15">
                  <c:v>1693</c:v>
                </c:pt>
                <c:pt idx="16">
                  <c:v>1884</c:v>
                </c:pt>
                <c:pt idx="17">
                  <c:v>1645</c:v>
                </c:pt>
                <c:pt idx="18">
                  <c:v>0</c:v>
                </c:pt>
                <c:pt idx="19">
                  <c:v>1710</c:v>
                </c:pt>
                <c:pt idx="20">
                  <c:v>0</c:v>
                </c:pt>
                <c:pt idx="21">
                  <c:v>1272</c:v>
                </c:pt>
                <c:pt idx="22">
                  <c:v>1475</c:v>
                </c:pt>
                <c:pt idx="23">
                  <c:v>1539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10076</c:v>
                </c:pt>
                <c:pt idx="29">
                  <c:v>4928</c:v>
                </c:pt>
                <c:pt idx="30">
                  <c:v>4896</c:v>
                </c:pt>
                <c:pt idx="31">
                  <c:v>2509</c:v>
                </c:pt>
                <c:pt idx="32">
                  <c:v>2688</c:v>
                </c:pt>
                <c:pt idx="33">
                  <c:v>2734</c:v>
                </c:pt>
                <c:pt idx="34">
                  <c:v>1733</c:v>
                </c:pt>
                <c:pt idx="35">
                  <c:v>1482</c:v>
                </c:pt>
                <c:pt idx="36">
                  <c:v>1748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14BC-6F4B-99EC-EA0E3F634294}"/>
            </c:ext>
          </c:extLst>
        </c:ser>
        <c:ser>
          <c:idx val="47"/>
          <c:order val="47"/>
          <c:tx>
            <c:strRef>
              <c:f>'Neat dates truncated'!$A$50</c:f>
              <c:strCache>
                <c:ptCount val="1"/>
                <c:pt idx="0">
                  <c:v>B67</c:v>
                </c:pt>
              </c:strCache>
            </c:strRef>
          </c:tx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0000"/>
                </a:schemeClr>
              </a:solidFill>
              <a:ln w="9525">
                <a:solidFill>
                  <a:schemeClr val="accent6">
                    <a:lumMod val="7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0:$AU$50</c:f>
              <c:numCache>
                <c:formatCode>General</c:formatCode>
                <c:ptCount val="46"/>
                <c:pt idx="0">
                  <c:v>19574</c:v>
                </c:pt>
                <c:pt idx="1">
                  <c:v>12514</c:v>
                </c:pt>
                <c:pt idx="2">
                  <c:v>17079</c:v>
                </c:pt>
                <c:pt idx="3">
                  <c:v>14111</c:v>
                </c:pt>
                <c:pt idx="4">
                  <c:v>20824</c:v>
                </c:pt>
                <c:pt idx="5">
                  <c:v>23457</c:v>
                </c:pt>
                <c:pt idx="6">
                  <c:v>22811</c:v>
                </c:pt>
                <c:pt idx="7">
                  <c:v>17918</c:v>
                </c:pt>
                <c:pt idx="8">
                  <c:v>15560</c:v>
                </c:pt>
                <c:pt idx="9">
                  <c:v>12321</c:v>
                </c:pt>
                <c:pt idx="10">
                  <c:v>13258</c:v>
                </c:pt>
                <c:pt idx="11">
                  <c:v>10499</c:v>
                </c:pt>
                <c:pt idx="12">
                  <c:v>8495</c:v>
                </c:pt>
                <c:pt idx="13">
                  <c:v>8241</c:v>
                </c:pt>
                <c:pt idx="14">
                  <c:v>7132</c:v>
                </c:pt>
                <c:pt idx="15">
                  <c:v>5294</c:v>
                </c:pt>
                <c:pt idx="16">
                  <c:v>5383</c:v>
                </c:pt>
                <c:pt idx="17">
                  <c:v>4575</c:v>
                </c:pt>
                <c:pt idx="18">
                  <c:v>3405</c:v>
                </c:pt>
                <c:pt idx="19">
                  <c:v>4668</c:v>
                </c:pt>
                <c:pt idx="20">
                  <c:v>3329</c:v>
                </c:pt>
                <c:pt idx="21">
                  <c:v>3892</c:v>
                </c:pt>
                <c:pt idx="22">
                  <c:v>4152</c:v>
                </c:pt>
                <c:pt idx="23">
                  <c:v>4239</c:v>
                </c:pt>
                <c:pt idx="24">
                  <c:v>2368</c:v>
                </c:pt>
                <c:pt idx="25">
                  <c:v>2393</c:v>
                </c:pt>
                <c:pt idx="26">
                  <c:v>2283</c:v>
                </c:pt>
                <c:pt idx="27">
                  <c:v>2366</c:v>
                </c:pt>
                <c:pt idx="28">
                  <c:v>16565</c:v>
                </c:pt>
                <c:pt idx="29">
                  <c:v>10653</c:v>
                </c:pt>
                <c:pt idx="30">
                  <c:v>9736</c:v>
                </c:pt>
                <c:pt idx="31">
                  <c:v>6125</c:v>
                </c:pt>
                <c:pt idx="32">
                  <c:v>6767</c:v>
                </c:pt>
                <c:pt idx="33">
                  <c:v>6272</c:v>
                </c:pt>
                <c:pt idx="34">
                  <c:v>4228</c:v>
                </c:pt>
                <c:pt idx="35">
                  <c:v>3627</c:v>
                </c:pt>
                <c:pt idx="36">
                  <c:v>4635</c:v>
                </c:pt>
                <c:pt idx="37">
                  <c:v>2900</c:v>
                </c:pt>
                <c:pt idx="38">
                  <c:v>1930</c:v>
                </c:pt>
                <c:pt idx="39">
                  <c:v>2703</c:v>
                </c:pt>
                <c:pt idx="40">
                  <c:v>1799</c:v>
                </c:pt>
                <c:pt idx="41">
                  <c:v>1814</c:v>
                </c:pt>
                <c:pt idx="42">
                  <c:v>0</c:v>
                </c:pt>
                <c:pt idx="43">
                  <c:v>1820</c:v>
                </c:pt>
                <c:pt idx="44">
                  <c:v>1789</c:v>
                </c:pt>
                <c:pt idx="45">
                  <c:v>18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14BC-6F4B-99EC-EA0E3F634294}"/>
            </c:ext>
          </c:extLst>
        </c:ser>
        <c:ser>
          <c:idx val="48"/>
          <c:order val="48"/>
          <c:tx>
            <c:strRef>
              <c:f>'Neat dates truncated'!$A$51</c:f>
              <c:strCache>
                <c:ptCount val="1"/>
                <c:pt idx="0">
                  <c:v>B7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  <a:lumOff val="50000"/>
                </a:schemeClr>
              </a:solidFill>
              <a:ln w="9525">
                <a:solidFill>
                  <a:schemeClr val="accent1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1:$AU$51</c:f>
              <c:numCache>
                <c:formatCode>General</c:formatCode>
                <c:ptCount val="46"/>
                <c:pt idx="0">
                  <c:v>22859</c:v>
                </c:pt>
                <c:pt idx="1">
                  <c:v>17522</c:v>
                </c:pt>
                <c:pt idx="2">
                  <c:v>20810</c:v>
                </c:pt>
                <c:pt idx="3">
                  <c:v>18498</c:v>
                </c:pt>
                <c:pt idx="4">
                  <c:v>22397</c:v>
                </c:pt>
                <c:pt idx="5">
                  <c:v>21895</c:v>
                </c:pt>
                <c:pt idx="6">
                  <c:v>19341</c:v>
                </c:pt>
                <c:pt idx="7">
                  <c:v>14848</c:v>
                </c:pt>
                <c:pt idx="8">
                  <c:v>12312</c:v>
                </c:pt>
                <c:pt idx="9">
                  <c:v>9424</c:v>
                </c:pt>
                <c:pt idx="10">
                  <c:v>10458</c:v>
                </c:pt>
                <c:pt idx="11">
                  <c:v>8149</c:v>
                </c:pt>
                <c:pt idx="12">
                  <c:v>6696</c:v>
                </c:pt>
                <c:pt idx="13">
                  <c:v>6180</c:v>
                </c:pt>
                <c:pt idx="14">
                  <c:v>5180</c:v>
                </c:pt>
                <c:pt idx="15">
                  <c:v>3943</c:v>
                </c:pt>
                <c:pt idx="16">
                  <c:v>3729</c:v>
                </c:pt>
                <c:pt idx="17">
                  <c:v>3211</c:v>
                </c:pt>
                <c:pt idx="18">
                  <c:v>2332</c:v>
                </c:pt>
                <c:pt idx="19">
                  <c:v>3422</c:v>
                </c:pt>
                <c:pt idx="20">
                  <c:v>2279</c:v>
                </c:pt>
                <c:pt idx="21">
                  <c:v>2731</c:v>
                </c:pt>
                <c:pt idx="22">
                  <c:v>2959</c:v>
                </c:pt>
                <c:pt idx="23">
                  <c:v>3242</c:v>
                </c:pt>
                <c:pt idx="24">
                  <c:v>1549</c:v>
                </c:pt>
                <c:pt idx="25">
                  <c:v>1552</c:v>
                </c:pt>
                <c:pt idx="26">
                  <c:v>1423</c:v>
                </c:pt>
                <c:pt idx="27">
                  <c:v>2221</c:v>
                </c:pt>
                <c:pt idx="28">
                  <c:v>15135</c:v>
                </c:pt>
                <c:pt idx="29">
                  <c:v>8971</c:v>
                </c:pt>
                <c:pt idx="30">
                  <c:v>8775</c:v>
                </c:pt>
                <c:pt idx="31">
                  <c:v>4887</c:v>
                </c:pt>
                <c:pt idx="32">
                  <c:v>5350</c:v>
                </c:pt>
                <c:pt idx="33">
                  <c:v>5071</c:v>
                </c:pt>
                <c:pt idx="34">
                  <c:v>3245</c:v>
                </c:pt>
                <c:pt idx="35">
                  <c:v>2705</c:v>
                </c:pt>
                <c:pt idx="36">
                  <c:v>3289</c:v>
                </c:pt>
                <c:pt idx="37">
                  <c:v>1967</c:v>
                </c:pt>
                <c:pt idx="38">
                  <c:v>1251</c:v>
                </c:pt>
                <c:pt idx="39">
                  <c:v>1704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14BC-6F4B-99EC-EA0E3F634294}"/>
            </c:ext>
          </c:extLst>
        </c:ser>
        <c:ser>
          <c:idx val="49"/>
          <c:order val="49"/>
          <c:tx>
            <c:strRef>
              <c:f>'Neat dates truncated'!$A$52</c:f>
              <c:strCache>
                <c:ptCount val="1"/>
                <c:pt idx="0">
                  <c:v>B71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  <a:lumOff val="50000"/>
                </a:schemeClr>
              </a:solidFill>
              <a:ln w="9525">
                <a:solidFill>
                  <a:schemeClr val="accent2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2:$AU$52</c:f>
              <c:numCache>
                <c:formatCode>General</c:formatCode>
                <c:ptCount val="46"/>
                <c:pt idx="0">
                  <c:v>24279</c:v>
                </c:pt>
                <c:pt idx="1">
                  <c:v>19501</c:v>
                </c:pt>
                <c:pt idx="2">
                  <c:v>21691</c:v>
                </c:pt>
                <c:pt idx="3">
                  <c:v>19698</c:v>
                </c:pt>
                <c:pt idx="4">
                  <c:v>22107</c:v>
                </c:pt>
                <c:pt idx="5">
                  <c:v>20035</c:v>
                </c:pt>
                <c:pt idx="6">
                  <c:v>17774</c:v>
                </c:pt>
                <c:pt idx="7">
                  <c:v>13146</c:v>
                </c:pt>
                <c:pt idx="8">
                  <c:v>10856</c:v>
                </c:pt>
                <c:pt idx="9">
                  <c:v>8517</c:v>
                </c:pt>
                <c:pt idx="10">
                  <c:v>9178</c:v>
                </c:pt>
                <c:pt idx="11">
                  <c:v>7009</c:v>
                </c:pt>
                <c:pt idx="12">
                  <c:v>5676</c:v>
                </c:pt>
                <c:pt idx="13">
                  <c:v>5447</c:v>
                </c:pt>
                <c:pt idx="14">
                  <c:v>4457</c:v>
                </c:pt>
                <c:pt idx="15">
                  <c:v>3392</c:v>
                </c:pt>
                <c:pt idx="16">
                  <c:v>3207</c:v>
                </c:pt>
                <c:pt idx="17">
                  <c:v>2737</c:v>
                </c:pt>
                <c:pt idx="18">
                  <c:v>1898</c:v>
                </c:pt>
                <c:pt idx="19">
                  <c:v>2736</c:v>
                </c:pt>
                <c:pt idx="20">
                  <c:v>1897</c:v>
                </c:pt>
                <c:pt idx="21">
                  <c:v>2194</c:v>
                </c:pt>
                <c:pt idx="22">
                  <c:v>2372</c:v>
                </c:pt>
                <c:pt idx="23">
                  <c:v>2421</c:v>
                </c:pt>
                <c:pt idx="24">
                  <c:v>1263</c:v>
                </c:pt>
                <c:pt idx="25">
                  <c:v>1361</c:v>
                </c:pt>
                <c:pt idx="26">
                  <c:v>1287</c:v>
                </c:pt>
                <c:pt idx="27">
                  <c:v>1292</c:v>
                </c:pt>
                <c:pt idx="28">
                  <c:v>14556</c:v>
                </c:pt>
                <c:pt idx="29">
                  <c:v>8335</c:v>
                </c:pt>
                <c:pt idx="30">
                  <c:v>8381</c:v>
                </c:pt>
                <c:pt idx="31">
                  <c:v>4480</c:v>
                </c:pt>
                <c:pt idx="32">
                  <c:v>5056</c:v>
                </c:pt>
                <c:pt idx="33">
                  <c:v>4786</c:v>
                </c:pt>
                <c:pt idx="34">
                  <c:v>3077</c:v>
                </c:pt>
                <c:pt idx="35">
                  <c:v>2604</c:v>
                </c:pt>
                <c:pt idx="36">
                  <c:v>3198</c:v>
                </c:pt>
                <c:pt idx="37">
                  <c:v>2062</c:v>
                </c:pt>
                <c:pt idx="38">
                  <c:v>0</c:v>
                </c:pt>
                <c:pt idx="39">
                  <c:v>1671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14BC-6F4B-99EC-EA0E3F634294}"/>
            </c:ext>
          </c:extLst>
        </c:ser>
        <c:ser>
          <c:idx val="50"/>
          <c:order val="50"/>
          <c:tx>
            <c:strRef>
              <c:f>'Neat dates truncated'!$A$53</c:f>
              <c:strCache>
                <c:ptCount val="1"/>
                <c:pt idx="0">
                  <c:v>B72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3:$AU$53</c:f>
              <c:numCache>
                <c:formatCode>General</c:formatCode>
                <c:ptCount val="46"/>
                <c:pt idx="0">
                  <c:v>24682</c:v>
                </c:pt>
                <c:pt idx="1">
                  <c:v>18849</c:v>
                </c:pt>
                <c:pt idx="2">
                  <c:v>22456</c:v>
                </c:pt>
                <c:pt idx="3">
                  <c:v>19483</c:v>
                </c:pt>
                <c:pt idx="4">
                  <c:v>21766</c:v>
                </c:pt>
                <c:pt idx="5">
                  <c:v>19568</c:v>
                </c:pt>
                <c:pt idx="6">
                  <c:v>16913</c:v>
                </c:pt>
                <c:pt idx="7">
                  <c:v>12875</c:v>
                </c:pt>
                <c:pt idx="8">
                  <c:v>10551</c:v>
                </c:pt>
                <c:pt idx="9">
                  <c:v>8086</c:v>
                </c:pt>
                <c:pt idx="10">
                  <c:v>8627</c:v>
                </c:pt>
                <c:pt idx="11">
                  <c:v>6507</c:v>
                </c:pt>
                <c:pt idx="12">
                  <c:v>5499</c:v>
                </c:pt>
                <c:pt idx="13">
                  <c:v>5047</c:v>
                </c:pt>
                <c:pt idx="14">
                  <c:v>4219</c:v>
                </c:pt>
                <c:pt idx="15">
                  <c:v>3201</c:v>
                </c:pt>
                <c:pt idx="16">
                  <c:v>3079</c:v>
                </c:pt>
                <c:pt idx="17">
                  <c:v>2635</c:v>
                </c:pt>
                <c:pt idx="18">
                  <c:v>1849</c:v>
                </c:pt>
                <c:pt idx="19">
                  <c:v>2668</c:v>
                </c:pt>
                <c:pt idx="20">
                  <c:v>1860</c:v>
                </c:pt>
                <c:pt idx="21">
                  <c:v>2215</c:v>
                </c:pt>
                <c:pt idx="22">
                  <c:v>2296</c:v>
                </c:pt>
                <c:pt idx="23">
                  <c:v>2261</c:v>
                </c:pt>
                <c:pt idx="24">
                  <c:v>1201</c:v>
                </c:pt>
                <c:pt idx="25">
                  <c:v>1240</c:v>
                </c:pt>
                <c:pt idx="26">
                  <c:v>1232</c:v>
                </c:pt>
                <c:pt idx="27">
                  <c:v>0</c:v>
                </c:pt>
                <c:pt idx="28">
                  <c:v>13230</c:v>
                </c:pt>
                <c:pt idx="29">
                  <c:v>7293</c:v>
                </c:pt>
                <c:pt idx="30">
                  <c:v>7396</c:v>
                </c:pt>
                <c:pt idx="31">
                  <c:v>3937</c:v>
                </c:pt>
                <c:pt idx="32">
                  <c:v>4327</c:v>
                </c:pt>
                <c:pt idx="33">
                  <c:v>4029</c:v>
                </c:pt>
                <c:pt idx="34">
                  <c:v>2636</c:v>
                </c:pt>
                <c:pt idx="35">
                  <c:v>2308</c:v>
                </c:pt>
                <c:pt idx="36">
                  <c:v>2845</c:v>
                </c:pt>
                <c:pt idx="37">
                  <c:v>1801</c:v>
                </c:pt>
                <c:pt idx="38">
                  <c:v>0</c:v>
                </c:pt>
                <c:pt idx="39">
                  <c:v>1571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14BC-6F4B-99EC-EA0E3F634294}"/>
            </c:ext>
          </c:extLst>
        </c:ser>
        <c:ser>
          <c:idx val="51"/>
          <c:order val="51"/>
          <c:tx>
            <c:strRef>
              <c:f>'Neat dates truncated'!$A$54</c:f>
              <c:strCache>
                <c:ptCount val="1"/>
                <c:pt idx="0">
                  <c:v>B73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  <a:lumOff val="50000"/>
                </a:schemeClr>
              </a:solidFill>
              <a:ln w="9525">
                <a:solidFill>
                  <a:schemeClr val="accent4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4:$AU$54</c:f>
              <c:numCache>
                <c:formatCode>General</c:formatCode>
                <c:ptCount val="46"/>
                <c:pt idx="0">
                  <c:v>4677</c:v>
                </c:pt>
                <c:pt idx="1">
                  <c:v>4387</c:v>
                </c:pt>
                <c:pt idx="2">
                  <c:v>2174</c:v>
                </c:pt>
                <c:pt idx="3">
                  <c:v>2078</c:v>
                </c:pt>
                <c:pt idx="4">
                  <c:v>2215</c:v>
                </c:pt>
                <c:pt idx="5">
                  <c:v>121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3-14BC-6F4B-99EC-EA0E3F634294}"/>
            </c:ext>
          </c:extLst>
        </c:ser>
        <c:ser>
          <c:idx val="52"/>
          <c:order val="52"/>
          <c:tx>
            <c:strRef>
              <c:f>'Neat dates truncated'!$A$55</c:f>
              <c:strCache>
                <c:ptCount val="1"/>
                <c:pt idx="0">
                  <c:v>B75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  <a:lumOff val="50000"/>
                </a:schemeClr>
              </a:solidFill>
              <a:ln w="9525">
                <a:solidFill>
                  <a:schemeClr val="accent5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5:$AU$55</c:f>
              <c:numCache>
                <c:formatCode>General</c:formatCode>
                <c:ptCount val="46"/>
                <c:pt idx="0">
                  <c:v>24133</c:v>
                </c:pt>
                <c:pt idx="1">
                  <c:v>20380</c:v>
                </c:pt>
                <c:pt idx="2">
                  <c:v>21012</c:v>
                </c:pt>
                <c:pt idx="3">
                  <c:v>19101</c:v>
                </c:pt>
                <c:pt idx="4">
                  <c:v>20437</c:v>
                </c:pt>
                <c:pt idx="5">
                  <c:v>18286</c:v>
                </c:pt>
                <c:pt idx="6">
                  <c:v>16283</c:v>
                </c:pt>
                <c:pt idx="7">
                  <c:v>11682</c:v>
                </c:pt>
                <c:pt idx="8">
                  <c:v>9771</c:v>
                </c:pt>
                <c:pt idx="9">
                  <c:v>7802</c:v>
                </c:pt>
                <c:pt idx="10">
                  <c:v>8169</c:v>
                </c:pt>
                <c:pt idx="11">
                  <c:v>6455</c:v>
                </c:pt>
                <c:pt idx="12">
                  <c:v>5150</c:v>
                </c:pt>
                <c:pt idx="13">
                  <c:v>4749</c:v>
                </c:pt>
                <c:pt idx="14">
                  <c:v>4009</c:v>
                </c:pt>
                <c:pt idx="15">
                  <c:v>3163</c:v>
                </c:pt>
                <c:pt idx="16">
                  <c:v>2999</c:v>
                </c:pt>
                <c:pt idx="17">
                  <c:v>2535</c:v>
                </c:pt>
                <c:pt idx="18">
                  <c:v>1875</c:v>
                </c:pt>
                <c:pt idx="19">
                  <c:v>2587</c:v>
                </c:pt>
                <c:pt idx="20">
                  <c:v>1955</c:v>
                </c:pt>
                <c:pt idx="21">
                  <c:v>2197</c:v>
                </c:pt>
                <c:pt idx="22">
                  <c:v>2402</c:v>
                </c:pt>
                <c:pt idx="23">
                  <c:v>2492</c:v>
                </c:pt>
                <c:pt idx="24">
                  <c:v>1824</c:v>
                </c:pt>
                <c:pt idx="25">
                  <c:v>1682</c:v>
                </c:pt>
                <c:pt idx="26">
                  <c:v>1655</c:v>
                </c:pt>
                <c:pt idx="27">
                  <c:v>2010</c:v>
                </c:pt>
                <c:pt idx="28">
                  <c:v>12048</c:v>
                </c:pt>
                <c:pt idx="29">
                  <c:v>6265</c:v>
                </c:pt>
                <c:pt idx="30">
                  <c:v>6675</c:v>
                </c:pt>
                <c:pt idx="31">
                  <c:v>3499</c:v>
                </c:pt>
                <c:pt idx="32">
                  <c:v>3850</c:v>
                </c:pt>
                <c:pt idx="33">
                  <c:v>3744</c:v>
                </c:pt>
                <c:pt idx="34">
                  <c:v>2657</c:v>
                </c:pt>
                <c:pt idx="35">
                  <c:v>2128</c:v>
                </c:pt>
                <c:pt idx="36">
                  <c:v>2428</c:v>
                </c:pt>
                <c:pt idx="37">
                  <c:v>2120</c:v>
                </c:pt>
                <c:pt idx="38">
                  <c:v>1254</c:v>
                </c:pt>
                <c:pt idx="39">
                  <c:v>1777</c:v>
                </c:pt>
                <c:pt idx="40">
                  <c:v>1482</c:v>
                </c:pt>
                <c:pt idx="41">
                  <c:v>1341</c:v>
                </c:pt>
                <c:pt idx="42">
                  <c:v>0</c:v>
                </c:pt>
                <c:pt idx="43">
                  <c:v>1317</c:v>
                </c:pt>
                <c:pt idx="44">
                  <c:v>1226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4-14BC-6F4B-99EC-EA0E3F634294}"/>
            </c:ext>
          </c:extLst>
        </c:ser>
        <c:ser>
          <c:idx val="53"/>
          <c:order val="53"/>
          <c:tx>
            <c:strRef>
              <c:f>'Neat dates truncated'!$A$56</c:f>
              <c:strCache>
                <c:ptCount val="1"/>
                <c:pt idx="0">
                  <c:v>B76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  <a:lumOff val="50000"/>
                </a:schemeClr>
              </a:solidFill>
              <a:ln w="9525">
                <a:solidFill>
                  <a:schemeClr val="accent6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6:$AU$56</c:f>
              <c:numCache>
                <c:formatCode>General</c:formatCode>
                <c:ptCount val="46"/>
                <c:pt idx="0">
                  <c:v>22363</c:v>
                </c:pt>
                <c:pt idx="1">
                  <c:v>14408</c:v>
                </c:pt>
                <c:pt idx="2">
                  <c:v>17671</c:v>
                </c:pt>
                <c:pt idx="3">
                  <c:v>13477</c:v>
                </c:pt>
                <c:pt idx="4">
                  <c:v>19713</c:v>
                </c:pt>
                <c:pt idx="5">
                  <c:v>21878</c:v>
                </c:pt>
                <c:pt idx="6">
                  <c:v>21957</c:v>
                </c:pt>
                <c:pt idx="7">
                  <c:v>20645</c:v>
                </c:pt>
                <c:pt idx="8">
                  <c:v>20777</c:v>
                </c:pt>
                <c:pt idx="9">
                  <c:v>18565</c:v>
                </c:pt>
                <c:pt idx="10">
                  <c:v>19069</c:v>
                </c:pt>
                <c:pt idx="11">
                  <c:v>15555</c:v>
                </c:pt>
                <c:pt idx="12">
                  <c:v>14480</c:v>
                </c:pt>
                <c:pt idx="13">
                  <c:v>13843</c:v>
                </c:pt>
                <c:pt idx="14">
                  <c:v>12589</c:v>
                </c:pt>
                <c:pt idx="15">
                  <c:v>9888</c:v>
                </c:pt>
                <c:pt idx="16">
                  <c:v>9431</c:v>
                </c:pt>
                <c:pt idx="17">
                  <c:v>8679</c:v>
                </c:pt>
                <c:pt idx="18">
                  <c:v>6562</c:v>
                </c:pt>
                <c:pt idx="19">
                  <c:v>9467</c:v>
                </c:pt>
                <c:pt idx="20">
                  <c:v>6696</c:v>
                </c:pt>
                <c:pt idx="21">
                  <c:v>7491</c:v>
                </c:pt>
                <c:pt idx="22">
                  <c:v>8406</c:v>
                </c:pt>
                <c:pt idx="23">
                  <c:v>8000</c:v>
                </c:pt>
                <c:pt idx="24">
                  <c:v>5762</c:v>
                </c:pt>
                <c:pt idx="25">
                  <c:v>5758</c:v>
                </c:pt>
                <c:pt idx="26">
                  <c:v>6109</c:v>
                </c:pt>
                <c:pt idx="27">
                  <c:v>5417</c:v>
                </c:pt>
                <c:pt idx="28">
                  <c:v>15052</c:v>
                </c:pt>
                <c:pt idx="29">
                  <c:v>9633</c:v>
                </c:pt>
                <c:pt idx="30">
                  <c:v>10280</c:v>
                </c:pt>
                <c:pt idx="31">
                  <c:v>6886</c:v>
                </c:pt>
                <c:pt idx="32">
                  <c:v>7259</c:v>
                </c:pt>
                <c:pt idx="33">
                  <c:v>8138</c:v>
                </c:pt>
                <c:pt idx="34">
                  <c:v>6893</c:v>
                </c:pt>
                <c:pt idx="35">
                  <c:v>6427</c:v>
                </c:pt>
                <c:pt idx="36">
                  <c:v>8075</c:v>
                </c:pt>
                <c:pt idx="37">
                  <c:v>5685</c:v>
                </c:pt>
                <c:pt idx="38">
                  <c:v>5533</c:v>
                </c:pt>
                <c:pt idx="39">
                  <c:v>8577</c:v>
                </c:pt>
                <c:pt idx="40">
                  <c:v>7315</c:v>
                </c:pt>
                <c:pt idx="41">
                  <c:v>6502</c:v>
                </c:pt>
                <c:pt idx="42">
                  <c:v>6531</c:v>
                </c:pt>
                <c:pt idx="43">
                  <c:v>6530</c:v>
                </c:pt>
                <c:pt idx="44">
                  <c:v>6381</c:v>
                </c:pt>
                <c:pt idx="45">
                  <c:v>64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5-14BC-6F4B-99EC-EA0E3F634294}"/>
            </c:ext>
          </c:extLst>
        </c:ser>
        <c:ser>
          <c:idx val="54"/>
          <c:order val="54"/>
          <c:tx>
            <c:strRef>
              <c:f>'Neat dates truncated'!$A$57</c:f>
              <c:strCache>
                <c:ptCount val="1"/>
                <c:pt idx="0">
                  <c:v>B7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7:$AU$57</c:f>
              <c:numCache>
                <c:formatCode>General</c:formatCode>
                <c:ptCount val="46"/>
                <c:pt idx="0">
                  <c:v>24608</c:v>
                </c:pt>
                <c:pt idx="1">
                  <c:v>22058</c:v>
                </c:pt>
                <c:pt idx="2">
                  <c:v>21552</c:v>
                </c:pt>
                <c:pt idx="3">
                  <c:v>19501</c:v>
                </c:pt>
                <c:pt idx="4">
                  <c:v>19876</c:v>
                </c:pt>
                <c:pt idx="5">
                  <c:v>17644</c:v>
                </c:pt>
                <c:pt idx="6">
                  <c:v>14927</c:v>
                </c:pt>
                <c:pt idx="7">
                  <c:v>10728</c:v>
                </c:pt>
                <c:pt idx="8">
                  <c:v>8986</c:v>
                </c:pt>
                <c:pt idx="9">
                  <c:v>7050</c:v>
                </c:pt>
                <c:pt idx="10">
                  <c:v>7204</c:v>
                </c:pt>
                <c:pt idx="11">
                  <c:v>5406</c:v>
                </c:pt>
                <c:pt idx="12">
                  <c:v>4466</c:v>
                </c:pt>
                <c:pt idx="13">
                  <c:v>3975</c:v>
                </c:pt>
                <c:pt idx="14">
                  <c:v>3250</c:v>
                </c:pt>
                <c:pt idx="15">
                  <c:v>2513</c:v>
                </c:pt>
                <c:pt idx="16">
                  <c:v>2443</c:v>
                </c:pt>
                <c:pt idx="17">
                  <c:v>2025</c:v>
                </c:pt>
                <c:pt idx="18">
                  <c:v>1439</c:v>
                </c:pt>
                <c:pt idx="19">
                  <c:v>2084</c:v>
                </c:pt>
                <c:pt idx="20">
                  <c:v>1409</c:v>
                </c:pt>
                <c:pt idx="21">
                  <c:v>1596</c:v>
                </c:pt>
                <c:pt idx="22">
                  <c:v>1766</c:v>
                </c:pt>
                <c:pt idx="23">
                  <c:v>1737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12496</c:v>
                </c:pt>
                <c:pt idx="29">
                  <c:v>6592</c:v>
                </c:pt>
                <c:pt idx="30">
                  <c:v>6741</c:v>
                </c:pt>
                <c:pt idx="31">
                  <c:v>3393</c:v>
                </c:pt>
                <c:pt idx="32">
                  <c:v>3655</c:v>
                </c:pt>
                <c:pt idx="33">
                  <c:v>3509</c:v>
                </c:pt>
                <c:pt idx="34">
                  <c:v>2264</c:v>
                </c:pt>
                <c:pt idx="35">
                  <c:v>1856</c:v>
                </c:pt>
                <c:pt idx="36">
                  <c:v>2286</c:v>
                </c:pt>
                <c:pt idx="37">
                  <c:v>1457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6-14BC-6F4B-99EC-EA0E3F634294}"/>
            </c:ext>
          </c:extLst>
        </c:ser>
        <c:ser>
          <c:idx val="55"/>
          <c:order val="55"/>
          <c:tx>
            <c:strRef>
              <c:f>'Neat dates truncated'!$A$58</c:f>
              <c:strCache>
                <c:ptCount val="1"/>
                <c:pt idx="0">
                  <c:v>B8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8:$AU$58</c:f>
              <c:numCache>
                <c:formatCode>General</c:formatCode>
                <c:ptCount val="46"/>
                <c:pt idx="0">
                  <c:v>17570</c:v>
                </c:pt>
                <c:pt idx="1">
                  <c:v>10656</c:v>
                </c:pt>
                <c:pt idx="2">
                  <c:v>15437</c:v>
                </c:pt>
                <c:pt idx="3">
                  <c:v>12477</c:v>
                </c:pt>
                <c:pt idx="4">
                  <c:v>19394</c:v>
                </c:pt>
                <c:pt idx="5">
                  <c:v>21653</c:v>
                </c:pt>
                <c:pt idx="6">
                  <c:v>20778</c:v>
                </c:pt>
                <c:pt idx="7">
                  <c:v>17064</c:v>
                </c:pt>
                <c:pt idx="8">
                  <c:v>14276</c:v>
                </c:pt>
                <c:pt idx="9">
                  <c:v>11265</c:v>
                </c:pt>
                <c:pt idx="10">
                  <c:v>12150</c:v>
                </c:pt>
                <c:pt idx="11">
                  <c:v>10183</c:v>
                </c:pt>
                <c:pt idx="12">
                  <c:v>8294</c:v>
                </c:pt>
                <c:pt idx="13">
                  <c:v>7625</c:v>
                </c:pt>
                <c:pt idx="14">
                  <c:v>6433</c:v>
                </c:pt>
                <c:pt idx="15">
                  <c:v>5168</c:v>
                </c:pt>
                <c:pt idx="16">
                  <c:v>5030</c:v>
                </c:pt>
                <c:pt idx="17">
                  <c:v>4249</c:v>
                </c:pt>
                <c:pt idx="18">
                  <c:v>3195</c:v>
                </c:pt>
                <c:pt idx="19">
                  <c:v>4427</c:v>
                </c:pt>
                <c:pt idx="20">
                  <c:v>3053</c:v>
                </c:pt>
                <c:pt idx="21">
                  <c:v>3683</c:v>
                </c:pt>
                <c:pt idx="22">
                  <c:v>3888</c:v>
                </c:pt>
                <c:pt idx="23">
                  <c:v>4028</c:v>
                </c:pt>
                <c:pt idx="24">
                  <c:v>2292</c:v>
                </c:pt>
                <c:pt idx="25">
                  <c:v>2300</c:v>
                </c:pt>
                <c:pt idx="26">
                  <c:v>2122</c:v>
                </c:pt>
                <c:pt idx="27">
                  <c:v>2502</c:v>
                </c:pt>
                <c:pt idx="28">
                  <c:v>17685</c:v>
                </c:pt>
                <c:pt idx="29">
                  <c:v>10885</c:v>
                </c:pt>
                <c:pt idx="30">
                  <c:v>10136</c:v>
                </c:pt>
                <c:pt idx="31">
                  <c:v>5748</c:v>
                </c:pt>
                <c:pt idx="32">
                  <c:v>6682</c:v>
                </c:pt>
                <c:pt idx="33">
                  <c:v>5990</c:v>
                </c:pt>
                <c:pt idx="34">
                  <c:v>4011</c:v>
                </c:pt>
                <c:pt idx="35">
                  <c:v>3413</c:v>
                </c:pt>
                <c:pt idx="36">
                  <c:v>4144</c:v>
                </c:pt>
                <c:pt idx="37">
                  <c:v>2571</c:v>
                </c:pt>
                <c:pt idx="38">
                  <c:v>1554</c:v>
                </c:pt>
                <c:pt idx="39">
                  <c:v>2205</c:v>
                </c:pt>
                <c:pt idx="40">
                  <c:v>1305</c:v>
                </c:pt>
                <c:pt idx="41">
                  <c:v>1402</c:v>
                </c:pt>
                <c:pt idx="42">
                  <c:v>0</c:v>
                </c:pt>
                <c:pt idx="43">
                  <c:v>1427</c:v>
                </c:pt>
                <c:pt idx="44">
                  <c:v>1384</c:v>
                </c:pt>
                <c:pt idx="45">
                  <c:v>14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7-14BC-6F4B-99EC-EA0E3F634294}"/>
            </c:ext>
          </c:extLst>
        </c:ser>
        <c:ser>
          <c:idx val="56"/>
          <c:order val="56"/>
          <c:tx>
            <c:strRef>
              <c:f>'Neat dates truncated'!$A$59</c:f>
              <c:strCache>
                <c:ptCount val="1"/>
                <c:pt idx="0">
                  <c:v>B8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59:$AU$59</c:f>
              <c:numCache>
                <c:formatCode>General</c:formatCode>
                <c:ptCount val="46"/>
                <c:pt idx="0">
                  <c:v>24094</c:v>
                </c:pt>
                <c:pt idx="1">
                  <c:v>17959</c:v>
                </c:pt>
                <c:pt idx="2">
                  <c:v>20573</c:v>
                </c:pt>
                <c:pt idx="3">
                  <c:v>18254</c:v>
                </c:pt>
                <c:pt idx="4">
                  <c:v>21230</c:v>
                </c:pt>
                <c:pt idx="5">
                  <c:v>20240</c:v>
                </c:pt>
                <c:pt idx="6">
                  <c:v>18168</c:v>
                </c:pt>
                <c:pt idx="7">
                  <c:v>13387</c:v>
                </c:pt>
                <c:pt idx="8">
                  <c:v>11202</c:v>
                </c:pt>
                <c:pt idx="9">
                  <c:v>8752</c:v>
                </c:pt>
                <c:pt idx="10">
                  <c:v>9738</c:v>
                </c:pt>
                <c:pt idx="11">
                  <c:v>7742</c:v>
                </c:pt>
                <c:pt idx="12">
                  <c:v>6321</c:v>
                </c:pt>
                <c:pt idx="13">
                  <c:v>5803</c:v>
                </c:pt>
                <c:pt idx="14">
                  <c:v>4730</c:v>
                </c:pt>
                <c:pt idx="15">
                  <c:v>3688</c:v>
                </c:pt>
                <c:pt idx="16">
                  <c:v>3408</c:v>
                </c:pt>
                <c:pt idx="17">
                  <c:v>2919</c:v>
                </c:pt>
                <c:pt idx="18">
                  <c:v>2265</c:v>
                </c:pt>
                <c:pt idx="19">
                  <c:v>3049</c:v>
                </c:pt>
                <c:pt idx="20">
                  <c:v>2008</c:v>
                </c:pt>
                <c:pt idx="21">
                  <c:v>2417</c:v>
                </c:pt>
                <c:pt idx="22">
                  <c:v>2702</c:v>
                </c:pt>
                <c:pt idx="23">
                  <c:v>3094</c:v>
                </c:pt>
                <c:pt idx="24">
                  <c:v>1437</c:v>
                </c:pt>
                <c:pt idx="25">
                  <c:v>1460</c:v>
                </c:pt>
                <c:pt idx="26">
                  <c:v>1294</c:v>
                </c:pt>
                <c:pt idx="27">
                  <c:v>2023</c:v>
                </c:pt>
                <c:pt idx="28">
                  <c:v>13905</c:v>
                </c:pt>
                <c:pt idx="29">
                  <c:v>7556</c:v>
                </c:pt>
                <c:pt idx="30">
                  <c:v>7652</c:v>
                </c:pt>
                <c:pt idx="31">
                  <c:v>4070</c:v>
                </c:pt>
                <c:pt idx="32">
                  <c:v>4364</c:v>
                </c:pt>
                <c:pt idx="33">
                  <c:v>4062</c:v>
                </c:pt>
                <c:pt idx="34">
                  <c:v>2685</c:v>
                </c:pt>
                <c:pt idx="35">
                  <c:v>2129</c:v>
                </c:pt>
                <c:pt idx="36">
                  <c:v>2631</c:v>
                </c:pt>
                <c:pt idx="37">
                  <c:v>1603</c:v>
                </c:pt>
                <c:pt idx="38">
                  <c:v>0</c:v>
                </c:pt>
                <c:pt idx="39">
                  <c:v>1407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8-14BC-6F4B-99EC-EA0E3F634294}"/>
            </c:ext>
          </c:extLst>
        </c:ser>
        <c:ser>
          <c:idx val="57"/>
          <c:order val="57"/>
          <c:tx>
            <c:strRef>
              <c:f>'Neat dates truncated'!$A$60</c:f>
              <c:strCache>
                <c:ptCount val="1"/>
                <c:pt idx="0">
                  <c:v>B82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0:$AU$60</c:f>
              <c:numCache>
                <c:formatCode>General</c:formatCode>
                <c:ptCount val="46"/>
                <c:pt idx="0">
                  <c:v>22952</c:v>
                </c:pt>
                <c:pt idx="1">
                  <c:v>17388</c:v>
                </c:pt>
                <c:pt idx="2">
                  <c:v>18410</c:v>
                </c:pt>
                <c:pt idx="3">
                  <c:v>15532</c:v>
                </c:pt>
                <c:pt idx="4">
                  <c:v>19737</c:v>
                </c:pt>
                <c:pt idx="5">
                  <c:v>19163</c:v>
                </c:pt>
                <c:pt idx="6">
                  <c:v>19921</c:v>
                </c:pt>
                <c:pt idx="7">
                  <c:v>16284</c:v>
                </c:pt>
                <c:pt idx="8">
                  <c:v>16288</c:v>
                </c:pt>
                <c:pt idx="9">
                  <c:v>13855</c:v>
                </c:pt>
                <c:pt idx="10">
                  <c:v>14677</c:v>
                </c:pt>
                <c:pt idx="11">
                  <c:v>12007</c:v>
                </c:pt>
                <c:pt idx="12">
                  <c:v>11128</c:v>
                </c:pt>
                <c:pt idx="13">
                  <c:v>10982</c:v>
                </c:pt>
                <c:pt idx="14">
                  <c:v>10326</c:v>
                </c:pt>
                <c:pt idx="15">
                  <c:v>7964</c:v>
                </c:pt>
                <c:pt idx="16">
                  <c:v>7916</c:v>
                </c:pt>
                <c:pt idx="17">
                  <c:v>7262</c:v>
                </c:pt>
                <c:pt idx="18">
                  <c:v>5609</c:v>
                </c:pt>
                <c:pt idx="19">
                  <c:v>8242</c:v>
                </c:pt>
                <c:pt idx="20">
                  <c:v>6046</c:v>
                </c:pt>
                <c:pt idx="21">
                  <c:v>6649</c:v>
                </c:pt>
                <c:pt idx="22">
                  <c:v>7831</c:v>
                </c:pt>
                <c:pt idx="23">
                  <c:v>7604</c:v>
                </c:pt>
                <c:pt idx="24">
                  <c:v>5545</c:v>
                </c:pt>
                <c:pt idx="25">
                  <c:v>5837</c:v>
                </c:pt>
                <c:pt idx="26">
                  <c:v>6408</c:v>
                </c:pt>
                <c:pt idx="27">
                  <c:v>5208</c:v>
                </c:pt>
                <c:pt idx="28">
                  <c:v>15148</c:v>
                </c:pt>
                <c:pt idx="29">
                  <c:v>9445</c:v>
                </c:pt>
                <c:pt idx="30">
                  <c:v>10429</c:v>
                </c:pt>
                <c:pt idx="31">
                  <c:v>7442</c:v>
                </c:pt>
                <c:pt idx="32">
                  <c:v>7605</c:v>
                </c:pt>
                <c:pt idx="33">
                  <c:v>8752</c:v>
                </c:pt>
                <c:pt idx="34">
                  <c:v>7582</c:v>
                </c:pt>
                <c:pt idx="35">
                  <c:v>7257</c:v>
                </c:pt>
                <c:pt idx="36">
                  <c:v>8983</c:v>
                </c:pt>
                <c:pt idx="37">
                  <c:v>6434</c:v>
                </c:pt>
                <c:pt idx="38">
                  <c:v>5758</c:v>
                </c:pt>
                <c:pt idx="39">
                  <c:v>8612</c:v>
                </c:pt>
                <c:pt idx="40">
                  <c:v>7903</c:v>
                </c:pt>
                <c:pt idx="41">
                  <c:v>6677</c:v>
                </c:pt>
                <c:pt idx="42">
                  <c:v>7172</c:v>
                </c:pt>
                <c:pt idx="43">
                  <c:v>7545</c:v>
                </c:pt>
                <c:pt idx="44">
                  <c:v>7167</c:v>
                </c:pt>
                <c:pt idx="45">
                  <c:v>71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9-14BC-6F4B-99EC-EA0E3F634294}"/>
            </c:ext>
          </c:extLst>
        </c:ser>
        <c:ser>
          <c:idx val="58"/>
          <c:order val="58"/>
          <c:tx>
            <c:strRef>
              <c:f>'Neat dates truncated'!$A$61</c:f>
              <c:strCache>
                <c:ptCount val="1"/>
                <c:pt idx="0">
                  <c:v>BW6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1:$AU$61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182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A-14BC-6F4B-99EC-EA0E3F634294}"/>
            </c:ext>
          </c:extLst>
        </c:ser>
        <c:ser>
          <c:idx val="59"/>
          <c:order val="59"/>
          <c:tx>
            <c:strRef>
              <c:f>'Neat dates truncated'!$A$62</c:f>
              <c:strCache>
                <c:ptCount val="1"/>
                <c:pt idx="0">
                  <c:v>Cw15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2:$AU$62</c:f>
              <c:numCache>
                <c:formatCode>General</c:formatCode>
                <c:ptCount val="46"/>
                <c:pt idx="0">
                  <c:v>11350</c:v>
                </c:pt>
                <c:pt idx="1">
                  <c:v>10573</c:v>
                </c:pt>
                <c:pt idx="2">
                  <c:v>6601</c:v>
                </c:pt>
                <c:pt idx="3">
                  <c:v>5502</c:v>
                </c:pt>
                <c:pt idx="4">
                  <c:v>4995</c:v>
                </c:pt>
                <c:pt idx="5">
                  <c:v>3070</c:v>
                </c:pt>
                <c:pt idx="6">
                  <c:v>294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B-14BC-6F4B-99EC-EA0E3F634294}"/>
            </c:ext>
          </c:extLst>
        </c:ser>
        <c:ser>
          <c:idx val="60"/>
          <c:order val="60"/>
          <c:tx>
            <c:strRef>
              <c:f>'Neat dates truncated'!$A$63</c:f>
              <c:strCache>
                <c:ptCount val="1"/>
                <c:pt idx="0">
                  <c:v>Cw1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3:$AU$63</c:f>
              <c:numCache>
                <c:formatCode>General</c:formatCode>
                <c:ptCount val="46"/>
                <c:pt idx="0">
                  <c:v>12338</c:v>
                </c:pt>
                <c:pt idx="1">
                  <c:v>12134</c:v>
                </c:pt>
                <c:pt idx="2">
                  <c:v>7930</c:v>
                </c:pt>
                <c:pt idx="3">
                  <c:v>6791</c:v>
                </c:pt>
                <c:pt idx="4">
                  <c:v>6100</c:v>
                </c:pt>
                <c:pt idx="5">
                  <c:v>4506</c:v>
                </c:pt>
                <c:pt idx="6">
                  <c:v>4105</c:v>
                </c:pt>
                <c:pt idx="7">
                  <c:v>3321</c:v>
                </c:pt>
                <c:pt idx="8">
                  <c:v>2935</c:v>
                </c:pt>
                <c:pt idx="9">
                  <c:v>2792</c:v>
                </c:pt>
                <c:pt idx="10">
                  <c:v>3079</c:v>
                </c:pt>
                <c:pt idx="11">
                  <c:v>2810</c:v>
                </c:pt>
                <c:pt idx="12">
                  <c:v>2589</c:v>
                </c:pt>
                <c:pt idx="13">
                  <c:v>0</c:v>
                </c:pt>
                <c:pt idx="14">
                  <c:v>2326</c:v>
                </c:pt>
                <c:pt idx="15">
                  <c:v>0</c:v>
                </c:pt>
                <c:pt idx="16">
                  <c:v>0</c:v>
                </c:pt>
                <c:pt idx="17">
                  <c:v>1799</c:v>
                </c:pt>
                <c:pt idx="18">
                  <c:v>1680</c:v>
                </c:pt>
                <c:pt idx="19">
                  <c:v>2577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2077</c:v>
                </c:pt>
                <c:pt idx="41">
                  <c:v>0</c:v>
                </c:pt>
                <c:pt idx="42">
                  <c:v>0</c:v>
                </c:pt>
                <c:pt idx="43">
                  <c:v>5412</c:v>
                </c:pt>
                <c:pt idx="44">
                  <c:v>3594</c:v>
                </c:pt>
                <c:pt idx="45">
                  <c:v>19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C-14BC-6F4B-99EC-EA0E3F634294}"/>
            </c:ext>
          </c:extLst>
        </c:ser>
        <c:ser>
          <c:idx val="61"/>
          <c:order val="61"/>
          <c:tx>
            <c:strRef>
              <c:f>'Neat dates truncated'!$A$64</c:f>
              <c:strCache>
                <c:ptCount val="1"/>
                <c:pt idx="0">
                  <c:v>Cw1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4:$AU$64</c:f>
              <c:numCache>
                <c:formatCode>General</c:formatCode>
                <c:ptCount val="46"/>
                <c:pt idx="0">
                  <c:v>14765</c:v>
                </c:pt>
                <c:pt idx="1">
                  <c:v>13815</c:v>
                </c:pt>
                <c:pt idx="2">
                  <c:v>9243</c:v>
                </c:pt>
                <c:pt idx="3">
                  <c:v>7625</c:v>
                </c:pt>
                <c:pt idx="4">
                  <c:v>6513</c:v>
                </c:pt>
                <c:pt idx="5">
                  <c:v>4994</c:v>
                </c:pt>
                <c:pt idx="6">
                  <c:v>4291</c:v>
                </c:pt>
                <c:pt idx="7">
                  <c:v>3066</c:v>
                </c:pt>
                <c:pt idx="8">
                  <c:v>2116</c:v>
                </c:pt>
                <c:pt idx="9">
                  <c:v>0</c:v>
                </c:pt>
                <c:pt idx="10">
                  <c:v>0</c:v>
                </c:pt>
                <c:pt idx="11">
                  <c:v>187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5486</c:v>
                </c:pt>
                <c:pt idx="44">
                  <c:v>2931</c:v>
                </c:pt>
                <c:pt idx="45">
                  <c:v>17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D-14BC-6F4B-99EC-EA0E3F634294}"/>
            </c:ext>
          </c:extLst>
        </c:ser>
        <c:ser>
          <c:idx val="62"/>
          <c:order val="62"/>
          <c:tx>
            <c:strRef>
              <c:f>'Neat dates truncated'!$A$65</c:f>
              <c:strCache>
                <c:ptCount val="1"/>
                <c:pt idx="0">
                  <c:v>Cw2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5:$AU$65</c:f>
              <c:numCache>
                <c:formatCode>General</c:formatCode>
                <c:ptCount val="46"/>
                <c:pt idx="0">
                  <c:v>7671</c:v>
                </c:pt>
                <c:pt idx="1">
                  <c:v>6366</c:v>
                </c:pt>
                <c:pt idx="2">
                  <c:v>3486</c:v>
                </c:pt>
                <c:pt idx="3">
                  <c:v>2983</c:v>
                </c:pt>
                <c:pt idx="4">
                  <c:v>3090</c:v>
                </c:pt>
                <c:pt idx="5">
                  <c:v>1347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E-14BC-6F4B-99EC-EA0E3F634294}"/>
            </c:ext>
          </c:extLst>
        </c:ser>
        <c:ser>
          <c:idx val="63"/>
          <c:order val="63"/>
          <c:tx>
            <c:strRef>
              <c:f>'Neat dates truncated'!$A$66</c:f>
              <c:strCache>
                <c:ptCount val="1"/>
                <c:pt idx="0">
                  <c:v>Cw4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6:$AU$66</c:f>
              <c:numCache>
                <c:formatCode>General</c:formatCode>
                <c:ptCount val="46"/>
                <c:pt idx="0">
                  <c:v>2599</c:v>
                </c:pt>
                <c:pt idx="1">
                  <c:v>258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F-14BC-6F4B-99EC-EA0E3F634294}"/>
            </c:ext>
          </c:extLst>
        </c:ser>
        <c:ser>
          <c:idx val="64"/>
          <c:order val="64"/>
          <c:tx>
            <c:strRef>
              <c:f>'Neat dates truncated'!$A$67</c:f>
              <c:strCache>
                <c:ptCount val="1"/>
                <c:pt idx="0">
                  <c:v>Cw5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7:$AU$67</c:f>
              <c:numCache>
                <c:formatCode>General</c:formatCode>
                <c:ptCount val="46"/>
                <c:pt idx="0">
                  <c:v>10312</c:v>
                </c:pt>
                <c:pt idx="1">
                  <c:v>9872</c:v>
                </c:pt>
                <c:pt idx="2">
                  <c:v>6226</c:v>
                </c:pt>
                <c:pt idx="3">
                  <c:v>4909</c:v>
                </c:pt>
                <c:pt idx="4">
                  <c:v>4789</c:v>
                </c:pt>
                <c:pt idx="5">
                  <c:v>2811</c:v>
                </c:pt>
                <c:pt idx="6">
                  <c:v>259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61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0-14BC-6F4B-99EC-EA0E3F634294}"/>
            </c:ext>
          </c:extLst>
        </c:ser>
        <c:ser>
          <c:idx val="65"/>
          <c:order val="65"/>
          <c:tx>
            <c:strRef>
              <c:f>'Neat dates truncated'!$A$68</c:f>
              <c:strCache>
                <c:ptCount val="1"/>
                <c:pt idx="0">
                  <c:v>Cw6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8:$AU$68</c:f>
              <c:numCache>
                <c:formatCode>General</c:formatCode>
                <c:ptCount val="46"/>
                <c:pt idx="0">
                  <c:v>11625</c:v>
                </c:pt>
                <c:pt idx="1">
                  <c:v>10662</c:v>
                </c:pt>
                <c:pt idx="2">
                  <c:v>6951</c:v>
                </c:pt>
                <c:pt idx="3">
                  <c:v>5709</c:v>
                </c:pt>
                <c:pt idx="4">
                  <c:v>5487</c:v>
                </c:pt>
                <c:pt idx="5">
                  <c:v>3844</c:v>
                </c:pt>
                <c:pt idx="6">
                  <c:v>3082</c:v>
                </c:pt>
                <c:pt idx="7">
                  <c:v>219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32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1-14BC-6F4B-99EC-EA0E3F634294}"/>
            </c:ext>
          </c:extLst>
        </c:ser>
        <c:ser>
          <c:idx val="66"/>
          <c:order val="66"/>
          <c:tx>
            <c:strRef>
              <c:f>'Neat dates truncated'!$A$69</c:f>
              <c:strCache>
                <c:ptCount val="1"/>
                <c:pt idx="0">
                  <c:v>DQ5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69:$AU$69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805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2-14BC-6F4B-99EC-EA0E3F634294}"/>
            </c:ext>
          </c:extLst>
        </c:ser>
        <c:ser>
          <c:idx val="67"/>
          <c:order val="67"/>
          <c:tx>
            <c:strRef>
              <c:f>'Neat dates truncated'!$A$70</c:f>
              <c:strCache>
                <c:ptCount val="1"/>
                <c:pt idx="0">
                  <c:v>DQB1*05:02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solidFill>
                  <a:schemeClr val="accent2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0:$AU$70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058</c:v>
                </c:pt>
                <c:pt idx="9">
                  <c:v>0</c:v>
                </c:pt>
                <c:pt idx="10">
                  <c:v>1829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3-14BC-6F4B-99EC-EA0E3F634294}"/>
            </c:ext>
          </c:extLst>
        </c:ser>
        <c:ser>
          <c:idx val="68"/>
          <c:order val="68"/>
          <c:tx>
            <c:strRef>
              <c:f>'Neat dates truncated'!$A$71</c:f>
              <c:strCache>
                <c:ptCount val="1"/>
                <c:pt idx="0">
                  <c:v>DR1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  <a:lumOff val="20000"/>
                </a:schemeClr>
              </a:solidFill>
              <a:ln w="9525">
                <a:solidFill>
                  <a:schemeClr val="accent3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1:$AU$71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46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4-14BC-6F4B-99EC-EA0E3F634294}"/>
            </c:ext>
          </c:extLst>
        </c:ser>
        <c:ser>
          <c:idx val="69"/>
          <c:order val="69"/>
          <c:tx>
            <c:strRef>
              <c:f>'Neat dates truncated'!$A$72</c:f>
              <c:strCache>
                <c:ptCount val="1"/>
                <c:pt idx="0">
                  <c:v>DR103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  <a:lumOff val="20000"/>
                </a:schemeClr>
              </a:solidFill>
              <a:ln w="9525">
                <a:solidFill>
                  <a:schemeClr val="accent4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2:$AU$72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425</c:v>
                </c:pt>
                <c:pt idx="11">
                  <c:v>132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5-14BC-6F4B-99EC-EA0E3F634294}"/>
            </c:ext>
          </c:extLst>
        </c:ser>
        <c:ser>
          <c:idx val="70"/>
          <c:order val="70"/>
          <c:tx>
            <c:strRef>
              <c:f>'Neat dates truncated'!$A$73</c:f>
              <c:strCache>
                <c:ptCount val="1"/>
                <c:pt idx="0">
                  <c:v>DR11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  <a:lumOff val="20000"/>
                </a:schemeClr>
              </a:solidFill>
              <a:ln w="9525">
                <a:solidFill>
                  <a:schemeClr val="accent5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3:$AU$73</c:f>
              <c:numCache>
                <c:formatCode>General</c:formatCode>
                <c:ptCount val="46"/>
                <c:pt idx="0">
                  <c:v>14508</c:v>
                </c:pt>
                <c:pt idx="1">
                  <c:v>15071</c:v>
                </c:pt>
                <c:pt idx="2">
                  <c:v>11648</c:v>
                </c:pt>
                <c:pt idx="3">
                  <c:v>10317</c:v>
                </c:pt>
                <c:pt idx="4">
                  <c:v>8664</c:v>
                </c:pt>
                <c:pt idx="5">
                  <c:v>6269</c:v>
                </c:pt>
                <c:pt idx="6">
                  <c:v>7086</c:v>
                </c:pt>
                <c:pt idx="7">
                  <c:v>4294</c:v>
                </c:pt>
                <c:pt idx="8">
                  <c:v>3731</c:v>
                </c:pt>
                <c:pt idx="9">
                  <c:v>4261</c:v>
                </c:pt>
                <c:pt idx="10">
                  <c:v>4766</c:v>
                </c:pt>
                <c:pt idx="11">
                  <c:v>3566</c:v>
                </c:pt>
                <c:pt idx="12">
                  <c:v>3755</c:v>
                </c:pt>
                <c:pt idx="13">
                  <c:v>3181</c:v>
                </c:pt>
                <c:pt idx="14">
                  <c:v>2975</c:v>
                </c:pt>
                <c:pt idx="15">
                  <c:v>1845</c:v>
                </c:pt>
                <c:pt idx="16">
                  <c:v>2212</c:v>
                </c:pt>
                <c:pt idx="17">
                  <c:v>2519</c:v>
                </c:pt>
                <c:pt idx="18">
                  <c:v>1569</c:v>
                </c:pt>
                <c:pt idx="19">
                  <c:v>2508</c:v>
                </c:pt>
                <c:pt idx="20">
                  <c:v>1555</c:v>
                </c:pt>
                <c:pt idx="21">
                  <c:v>1976</c:v>
                </c:pt>
                <c:pt idx="22">
                  <c:v>2786</c:v>
                </c:pt>
                <c:pt idx="23">
                  <c:v>2104</c:v>
                </c:pt>
                <c:pt idx="24">
                  <c:v>1368</c:v>
                </c:pt>
                <c:pt idx="25">
                  <c:v>1843</c:v>
                </c:pt>
                <c:pt idx="26">
                  <c:v>1828</c:v>
                </c:pt>
                <c:pt idx="27">
                  <c:v>2329</c:v>
                </c:pt>
                <c:pt idx="28">
                  <c:v>1554</c:v>
                </c:pt>
                <c:pt idx="29">
                  <c:v>1464</c:v>
                </c:pt>
                <c:pt idx="30">
                  <c:v>2633</c:v>
                </c:pt>
                <c:pt idx="31">
                  <c:v>2927</c:v>
                </c:pt>
                <c:pt idx="32">
                  <c:v>3124</c:v>
                </c:pt>
                <c:pt idx="33">
                  <c:v>10580</c:v>
                </c:pt>
                <c:pt idx="34">
                  <c:v>17600</c:v>
                </c:pt>
                <c:pt idx="35">
                  <c:v>17700</c:v>
                </c:pt>
                <c:pt idx="36">
                  <c:v>20476</c:v>
                </c:pt>
                <c:pt idx="37">
                  <c:v>21311</c:v>
                </c:pt>
                <c:pt idx="38">
                  <c:v>18058</c:v>
                </c:pt>
                <c:pt idx="39">
                  <c:v>20899</c:v>
                </c:pt>
                <c:pt idx="40">
                  <c:v>21001</c:v>
                </c:pt>
                <c:pt idx="41">
                  <c:v>16288</c:v>
                </c:pt>
                <c:pt idx="42">
                  <c:v>15581</c:v>
                </c:pt>
                <c:pt idx="43">
                  <c:v>16907</c:v>
                </c:pt>
                <c:pt idx="44">
                  <c:v>17266</c:v>
                </c:pt>
                <c:pt idx="45">
                  <c:v>174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6-14BC-6F4B-99EC-EA0E3F634294}"/>
            </c:ext>
          </c:extLst>
        </c:ser>
        <c:ser>
          <c:idx val="71"/>
          <c:order val="71"/>
          <c:tx>
            <c:strRef>
              <c:f>'Neat dates truncated'!$A$74</c:f>
              <c:strCache>
                <c:ptCount val="1"/>
                <c:pt idx="0">
                  <c:v>DR12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4:$AU$74</c:f>
              <c:numCache>
                <c:formatCode>General</c:formatCode>
                <c:ptCount val="46"/>
                <c:pt idx="0">
                  <c:v>8172</c:v>
                </c:pt>
                <c:pt idx="1">
                  <c:v>7980</c:v>
                </c:pt>
                <c:pt idx="2">
                  <c:v>5481</c:v>
                </c:pt>
                <c:pt idx="3">
                  <c:v>4643</c:v>
                </c:pt>
                <c:pt idx="4">
                  <c:v>4132</c:v>
                </c:pt>
                <c:pt idx="5">
                  <c:v>2674</c:v>
                </c:pt>
                <c:pt idx="6">
                  <c:v>3233</c:v>
                </c:pt>
                <c:pt idx="7">
                  <c:v>2058</c:v>
                </c:pt>
                <c:pt idx="8">
                  <c:v>1795</c:v>
                </c:pt>
                <c:pt idx="9">
                  <c:v>2011</c:v>
                </c:pt>
                <c:pt idx="10">
                  <c:v>2381</c:v>
                </c:pt>
                <c:pt idx="11">
                  <c:v>2056</c:v>
                </c:pt>
                <c:pt idx="12">
                  <c:v>2012</c:v>
                </c:pt>
                <c:pt idx="13">
                  <c:v>1642</c:v>
                </c:pt>
                <c:pt idx="14">
                  <c:v>1542</c:v>
                </c:pt>
                <c:pt idx="15">
                  <c:v>0</c:v>
                </c:pt>
                <c:pt idx="16">
                  <c:v>1255</c:v>
                </c:pt>
                <c:pt idx="17">
                  <c:v>1327</c:v>
                </c:pt>
                <c:pt idx="18">
                  <c:v>0</c:v>
                </c:pt>
                <c:pt idx="19">
                  <c:v>1417</c:v>
                </c:pt>
                <c:pt idx="20">
                  <c:v>0</c:v>
                </c:pt>
                <c:pt idx="21">
                  <c:v>0</c:v>
                </c:pt>
                <c:pt idx="22">
                  <c:v>1451</c:v>
                </c:pt>
                <c:pt idx="23">
                  <c:v>1341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1389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7-14BC-6F4B-99EC-EA0E3F634294}"/>
            </c:ext>
          </c:extLst>
        </c:ser>
        <c:ser>
          <c:idx val="72"/>
          <c:order val="72"/>
          <c:tx>
            <c:strRef>
              <c:f>'Neat dates truncated'!$A$75</c:f>
              <c:strCache>
                <c:ptCount val="1"/>
                <c:pt idx="0">
                  <c:v>DR13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</a:schemeClr>
              </a:solidFill>
              <a:ln w="9525">
                <a:solidFill>
                  <a:schemeClr val="accent1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5:$AU$75</c:f>
              <c:numCache>
                <c:formatCode>General</c:formatCode>
                <c:ptCount val="46"/>
                <c:pt idx="0">
                  <c:v>18386</c:v>
                </c:pt>
                <c:pt idx="1">
                  <c:v>18940</c:v>
                </c:pt>
                <c:pt idx="2">
                  <c:v>15223</c:v>
                </c:pt>
                <c:pt idx="3">
                  <c:v>13199</c:v>
                </c:pt>
                <c:pt idx="4">
                  <c:v>11728</c:v>
                </c:pt>
                <c:pt idx="5">
                  <c:v>9321</c:v>
                </c:pt>
                <c:pt idx="6">
                  <c:v>9853</c:v>
                </c:pt>
                <c:pt idx="7">
                  <c:v>6307</c:v>
                </c:pt>
                <c:pt idx="8">
                  <c:v>5498</c:v>
                </c:pt>
                <c:pt idx="9">
                  <c:v>5894</c:v>
                </c:pt>
                <c:pt idx="10">
                  <c:v>6612</c:v>
                </c:pt>
                <c:pt idx="11">
                  <c:v>5312</c:v>
                </c:pt>
                <c:pt idx="12">
                  <c:v>5194</c:v>
                </c:pt>
                <c:pt idx="13">
                  <c:v>4526</c:v>
                </c:pt>
                <c:pt idx="14">
                  <c:v>4161</c:v>
                </c:pt>
                <c:pt idx="15">
                  <c:v>2972</c:v>
                </c:pt>
                <c:pt idx="16">
                  <c:v>3390</c:v>
                </c:pt>
                <c:pt idx="17">
                  <c:v>3304</c:v>
                </c:pt>
                <c:pt idx="18">
                  <c:v>1959</c:v>
                </c:pt>
                <c:pt idx="19">
                  <c:v>3242</c:v>
                </c:pt>
                <c:pt idx="20">
                  <c:v>2068</c:v>
                </c:pt>
                <c:pt idx="21">
                  <c:v>2627</c:v>
                </c:pt>
                <c:pt idx="22">
                  <c:v>3475</c:v>
                </c:pt>
                <c:pt idx="23">
                  <c:v>2542</c:v>
                </c:pt>
                <c:pt idx="24">
                  <c:v>1783</c:v>
                </c:pt>
                <c:pt idx="25">
                  <c:v>2395</c:v>
                </c:pt>
                <c:pt idx="26">
                  <c:v>2463</c:v>
                </c:pt>
                <c:pt idx="27">
                  <c:v>2750</c:v>
                </c:pt>
                <c:pt idx="28">
                  <c:v>1960</c:v>
                </c:pt>
                <c:pt idx="29">
                  <c:v>1957</c:v>
                </c:pt>
                <c:pt idx="30">
                  <c:v>3435</c:v>
                </c:pt>
                <c:pt idx="31">
                  <c:v>3905</c:v>
                </c:pt>
                <c:pt idx="32">
                  <c:v>4083</c:v>
                </c:pt>
                <c:pt idx="33">
                  <c:v>12986</c:v>
                </c:pt>
                <c:pt idx="34">
                  <c:v>20579</c:v>
                </c:pt>
                <c:pt idx="35">
                  <c:v>20603</c:v>
                </c:pt>
                <c:pt idx="36">
                  <c:v>23681</c:v>
                </c:pt>
                <c:pt idx="37">
                  <c:v>22597</c:v>
                </c:pt>
                <c:pt idx="38">
                  <c:v>19538</c:v>
                </c:pt>
                <c:pt idx="39">
                  <c:v>22379</c:v>
                </c:pt>
                <c:pt idx="40">
                  <c:v>22423</c:v>
                </c:pt>
                <c:pt idx="41">
                  <c:v>17163</c:v>
                </c:pt>
                <c:pt idx="42">
                  <c:v>17348</c:v>
                </c:pt>
                <c:pt idx="43">
                  <c:v>18315</c:v>
                </c:pt>
                <c:pt idx="44">
                  <c:v>18852</c:v>
                </c:pt>
                <c:pt idx="45">
                  <c:v>193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8-14BC-6F4B-99EC-EA0E3F634294}"/>
            </c:ext>
          </c:extLst>
        </c:ser>
        <c:ser>
          <c:idx val="73"/>
          <c:order val="73"/>
          <c:tx>
            <c:strRef>
              <c:f>'Neat dates truncated'!$A$76</c:f>
              <c:strCache>
                <c:ptCount val="1"/>
                <c:pt idx="0">
                  <c:v>DR14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6:$AU$76</c:f>
              <c:numCache>
                <c:formatCode>General</c:formatCode>
                <c:ptCount val="46"/>
                <c:pt idx="0">
                  <c:v>15645</c:v>
                </c:pt>
                <c:pt idx="1">
                  <c:v>15791</c:v>
                </c:pt>
                <c:pt idx="2">
                  <c:v>12218</c:v>
                </c:pt>
                <c:pt idx="3">
                  <c:v>10656</c:v>
                </c:pt>
                <c:pt idx="4">
                  <c:v>9482</c:v>
                </c:pt>
                <c:pt idx="5">
                  <c:v>7374</c:v>
                </c:pt>
                <c:pt idx="6">
                  <c:v>7687</c:v>
                </c:pt>
                <c:pt idx="7">
                  <c:v>4713</c:v>
                </c:pt>
                <c:pt idx="8">
                  <c:v>4090</c:v>
                </c:pt>
                <c:pt idx="9">
                  <c:v>4396</c:v>
                </c:pt>
                <c:pt idx="10">
                  <c:v>4951</c:v>
                </c:pt>
                <c:pt idx="11">
                  <c:v>4029</c:v>
                </c:pt>
                <c:pt idx="12">
                  <c:v>3943</c:v>
                </c:pt>
                <c:pt idx="13">
                  <c:v>3309</c:v>
                </c:pt>
                <c:pt idx="14">
                  <c:v>3071</c:v>
                </c:pt>
                <c:pt idx="15">
                  <c:v>2177</c:v>
                </c:pt>
                <c:pt idx="16">
                  <c:v>2481</c:v>
                </c:pt>
                <c:pt idx="17">
                  <c:v>2654</c:v>
                </c:pt>
                <c:pt idx="18">
                  <c:v>1703</c:v>
                </c:pt>
                <c:pt idx="19">
                  <c:v>2660</c:v>
                </c:pt>
                <c:pt idx="20">
                  <c:v>1590</c:v>
                </c:pt>
                <c:pt idx="21">
                  <c:v>2028</c:v>
                </c:pt>
                <c:pt idx="22">
                  <c:v>2937</c:v>
                </c:pt>
                <c:pt idx="23">
                  <c:v>2305</c:v>
                </c:pt>
                <c:pt idx="24">
                  <c:v>1434</c:v>
                </c:pt>
                <c:pt idx="25">
                  <c:v>1886</c:v>
                </c:pt>
                <c:pt idx="26">
                  <c:v>1938</c:v>
                </c:pt>
                <c:pt idx="27">
                  <c:v>2614</c:v>
                </c:pt>
                <c:pt idx="28">
                  <c:v>1572</c:v>
                </c:pt>
                <c:pt idx="29">
                  <c:v>1536</c:v>
                </c:pt>
                <c:pt idx="30">
                  <c:v>2973</c:v>
                </c:pt>
                <c:pt idx="31">
                  <c:v>3252</c:v>
                </c:pt>
                <c:pt idx="32">
                  <c:v>3541</c:v>
                </c:pt>
                <c:pt idx="33">
                  <c:v>10917</c:v>
                </c:pt>
                <c:pt idx="34">
                  <c:v>17978</c:v>
                </c:pt>
                <c:pt idx="35">
                  <c:v>18014</c:v>
                </c:pt>
                <c:pt idx="36">
                  <c:v>20469</c:v>
                </c:pt>
                <c:pt idx="37">
                  <c:v>20910</c:v>
                </c:pt>
                <c:pt idx="38">
                  <c:v>17875</c:v>
                </c:pt>
                <c:pt idx="39">
                  <c:v>21010</c:v>
                </c:pt>
                <c:pt idx="40">
                  <c:v>20956</c:v>
                </c:pt>
                <c:pt idx="41">
                  <c:v>15934</c:v>
                </c:pt>
                <c:pt idx="42">
                  <c:v>15850</c:v>
                </c:pt>
                <c:pt idx="43">
                  <c:v>17046</c:v>
                </c:pt>
                <c:pt idx="44">
                  <c:v>16997</c:v>
                </c:pt>
                <c:pt idx="45">
                  <c:v>178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9-14BC-6F4B-99EC-EA0E3F634294}"/>
            </c:ext>
          </c:extLst>
        </c:ser>
        <c:ser>
          <c:idx val="74"/>
          <c:order val="74"/>
          <c:tx>
            <c:strRef>
              <c:f>'Neat dates truncated'!$A$77</c:f>
              <c:strCache>
                <c:ptCount val="1"/>
                <c:pt idx="0">
                  <c:v>DR17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</a:schemeClr>
              </a:solidFill>
              <a:ln w="9525">
                <a:solidFill>
                  <a:schemeClr val="accent3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7:$AU$77</c:f>
              <c:numCache>
                <c:formatCode>General</c:formatCode>
                <c:ptCount val="46"/>
                <c:pt idx="0">
                  <c:v>17156</c:v>
                </c:pt>
                <c:pt idx="1">
                  <c:v>18468</c:v>
                </c:pt>
                <c:pt idx="2">
                  <c:v>14850</c:v>
                </c:pt>
                <c:pt idx="3">
                  <c:v>12753</c:v>
                </c:pt>
                <c:pt idx="4">
                  <c:v>11959</c:v>
                </c:pt>
                <c:pt idx="5">
                  <c:v>8967</c:v>
                </c:pt>
                <c:pt idx="6">
                  <c:v>9418</c:v>
                </c:pt>
                <c:pt idx="7">
                  <c:v>5447</c:v>
                </c:pt>
                <c:pt idx="8">
                  <c:v>4780</c:v>
                </c:pt>
                <c:pt idx="9">
                  <c:v>4874</c:v>
                </c:pt>
                <c:pt idx="10">
                  <c:v>5354</c:v>
                </c:pt>
                <c:pt idx="11">
                  <c:v>4122</c:v>
                </c:pt>
                <c:pt idx="12">
                  <c:v>4044</c:v>
                </c:pt>
                <c:pt idx="13">
                  <c:v>3460</c:v>
                </c:pt>
                <c:pt idx="14">
                  <c:v>3191</c:v>
                </c:pt>
                <c:pt idx="15">
                  <c:v>2202</c:v>
                </c:pt>
                <c:pt idx="16">
                  <c:v>2551</c:v>
                </c:pt>
                <c:pt idx="17">
                  <c:v>2878</c:v>
                </c:pt>
                <c:pt idx="18">
                  <c:v>1748</c:v>
                </c:pt>
                <c:pt idx="19">
                  <c:v>2812</c:v>
                </c:pt>
                <c:pt idx="20">
                  <c:v>1844</c:v>
                </c:pt>
                <c:pt idx="21">
                  <c:v>2301</c:v>
                </c:pt>
                <c:pt idx="22">
                  <c:v>3085</c:v>
                </c:pt>
                <c:pt idx="23">
                  <c:v>2273</c:v>
                </c:pt>
                <c:pt idx="24">
                  <c:v>1622</c:v>
                </c:pt>
                <c:pt idx="25">
                  <c:v>2129</c:v>
                </c:pt>
                <c:pt idx="26">
                  <c:v>2154</c:v>
                </c:pt>
                <c:pt idx="27">
                  <c:v>2479</c:v>
                </c:pt>
                <c:pt idx="28">
                  <c:v>1834</c:v>
                </c:pt>
                <c:pt idx="29">
                  <c:v>1659</c:v>
                </c:pt>
                <c:pt idx="30">
                  <c:v>3016</c:v>
                </c:pt>
                <c:pt idx="31">
                  <c:v>3042</c:v>
                </c:pt>
                <c:pt idx="32">
                  <c:v>3209</c:v>
                </c:pt>
                <c:pt idx="33">
                  <c:v>9896</c:v>
                </c:pt>
                <c:pt idx="34">
                  <c:v>15850</c:v>
                </c:pt>
                <c:pt idx="35">
                  <c:v>16760</c:v>
                </c:pt>
                <c:pt idx="36">
                  <c:v>18673</c:v>
                </c:pt>
                <c:pt idx="37">
                  <c:v>17134</c:v>
                </c:pt>
                <c:pt idx="38">
                  <c:v>14993</c:v>
                </c:pt>
                <c:pt idx="39">
                  <c:v>17574</c:v>
                </c:pt>
                <c:pt idx="40">
                  <c:v>17787</c:v>
                </c:pt>
                <c:pt idx="41">
                  <c:v>13188</c:v>
                </c:pt>
                <c:pt idx="42">
                  <c:v>13063</c:v>
                </c:pt>
                <c:pt idx="43">
                  <c:v>14119</c:v>
                </c:pt>
                <c:pt idx="44">
                  <c:v>14499</c:v>
                </c:pt>
                <c:pt idx="45">
                  <c:v>149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A-14BC-6F4B-99EC-EA0E3F634294}"/>
            </c:ext>
          </c:extLst>
        </c:ser>
        <c:ser>
          <c:idx val="75"/>
          <c:order val="75"/>
          <c:tx>
            <c:strRef>
              <c:f>'Neat dates truncated'!$A$78</c:f>
              <c:strCache>
                <c:ptCount val="1"/>
                <c:pt idx="0">
                  <c:v>DR18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8:$AU$78</c:f>
              <c:numCache>
                <c:formatCode>General</c:formatCode>
                <c:ptCount val="46"/>
                <c:pt idx="0">
                  <c:v>17957</c:v>
                </c:pt>
                <c:pt idx="1">
                  <c:v>20057</c:v>
                </c:pt>
                <c:pt idx="2">
                  <c:v>15904</c:v>
                </c:pt>
                <c:pt idx="3">
                  <c:v>13594</c:v>
                </c:pt>
                <c:pt idx="4">
                  <c:v>12238</c:v>
                </c:pt>
                <c:pt idx="5">
                  <c:v>9284</c:v>
                </c:pt>
                <c:pt idx="6">
                  <c:v>9903</c:v>
                </c:pt>
                <c:pt idx="7">
                  <c:v>5995</c:v>
                </c:pt>
                <c:pt idx="8">
                  <c:v>5223</c:v>
                </c:pt>
                <c:pt idx="9">
                  <c:v>5558</c:v>
                </c:pt>
                <c:pt idx="10">
                  <c:v>5920</c:v>
                </c:pt>
                <c:pt idx="11">
                  <c:v>4871</c:v>
                </c:pt>
                <c:pt idx="12">
                  <c:v>4693</c:v>
                </c:pt>
                <c:pt idx="13">
                  <c:v>3913</c:v>
                </c:pt>
                <c:pt idx="14">
                  <c:v>3634</c:v>
                </c:pt>
                <c:pt idx="15">
                  <c:v>2440</c:v>
                </c:pt>
                <c:pt idx="16">
                  <c:v>2801</c:v>
                </c:pt>
                <c:pt idx="17">
                  <c:v>3162</c:v>
                </c:pt>
                <c:pt idx="18">
                  <c:v>1860</c:v>
                </c:pt>
                <c:pt idx="19">
                  <c:v>2923</c:v>
                </c:pt>
                <c:pt idx="20">
                  <c:v>1859</c:v>
                </c:pt>
                <c:pt idx="21">
                  <c:v>2470</c:v>
                </c:pt>
                <c:pt idx="22">
                  <c:v>3293</c:v>
                </c:pt>
                <c:pt idx="23">
                  <c:v>2413</c:v>
                </c:pt>
                <c:pt idx="24">
                  <c:v>1823</c:v>
                </c:pt>
                <c:pt idx="25">
                  <c:v>2333</c:v>
                </c:pt>
                <c:pt idx="26">
                  <c:v>2227</c:v>
                </c:pt>
                <c:pt idx="27">
                  <c:v>2650</c:v>
                </c:pt>
                <c:pt idx="28">
                  <c:v>1896</c:v>
                </c:pt>
                <c:pt idx="29">
                  <c:v>1758</c:v>
                </c:pt>
                <c:pt idx="30">
                  <c:v>3152</c:v>
                </c:pt>
                <c:pt idx="31">
                  <c:v>3096</c:v>
                </c:pt>
                <c:pt idx="32">
                  <c:v>3259</c:v>
                </c:pt>
                <c:pt idx="33">
                  <c:v>9197</c:v>
                </c:pt>
                <c:pt idx="34">
                  <c:v>15509</c:v>
                </c:pt>
                <c:pt idx="35">
                  <c:v>15705</c:v>
                </c:pt>
                <c:pt idx="36">
                  <c:v>18128</c:v>
                </c:pt>
                <c:pt idx="37">
                  <c:v>18245</c:v>
                </c:pt>
                <c:pt idx="38">
                  <c:v>14867</c:v>
                </c:pt>
                <c:pt idx="39">
                  <c:v>17550</c:v>
                </c:pt>
                <c:pt idx="40">
                  <c:v>17857</c:v>
                </c:pt>
                <c:pt idx="41">
                  <c:v>13880</c:v>
                </c:pt>
                <c:pt idx="42">
                  <c:v>13238</c:v>
                </c:pt>
                <c:pt idx="43">
                  <c:v>14386</c:v>
                </c:pt>
                <c:pt idx="44">
                  <c:v>14479</c:v>
                </c:pt>
                <c:pt idx="45">
                  <c:v>147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B-14BC-6F4B-99EC-EA0E3F634294}"/>
            </c:ext>
          </c:extLst>
        </c:ser>
        <c:ser>
          <c:idx val="76"/>
          <c:order val="76"/>
          <c:tx>
            <c:strRef>
              <c:f>'Neat dates truncated'!$A$79</c:f>
              <c:strCache>
                <c:ptCount val="1"/>
                <c:pt idx="0">
                  <c:v>DR52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</a:schemeClr>
              </a:solidFill>
              <a:ln w="9525">
                <a:solidFill>
                  <a:schemeClr val="accent5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79:$AU$79</c:f>
              <c:numCache>
                <c:formatCode>General</c:formatCode>
                <c:ptCount val="46"/>
                <c:pt idx="0">
                  <c:v>18334</c:v>
                </c:pt>
                <c:pt idx="1">
                  <c:v>20239</c:v>
                </c:pt>
                <c:pt idx="2">
                  <c:v>17233</c:v>
                </c:pt>
                <c:pt idx="3">
                  <c:v>15044</c:v>
                </c:pt>
                <c:pt idx="4">
                  <c:v>14280</c:v>
                </c:pt>
                <c:pt idx="5">
                  <c:v>11325</c:v>
                </c:pt>
                <c:pt idx="6">
                  <c:v>11106</c:v>
                </c:pt>
                <c:pt idx="7">
                  <c:v>7202</c:v>
                </c:pt>
                <c:pt idx="8">
                  <c:v>6375</c:v>
                </c:pt>
                <c:pt idx="9">
                  <c:v>6413</c:v>
                </c:pt>
                <c:pt idx="10">
                  <c:v>7039</c:v>
                </c:pt>
                <c:pt idx="11">
                  <c:v>5891</c:v>
                </c:pt>
                <c:pt idx="12">
                  <c:v>5394</c:v>
                </c:pt>
                <c:pt idx="13">
                  <c:v>4591</c:v>
                </c:pt>
                <c:pt idx="14">
                  <c:v>4590</c:v>
                </c:pt>
                <c:pt idx="15">
                  <c:v>3118</c:v>
                </c:pt>
                <c:pt idx="16">
                  <c:v>3418</c:v>
                </c:pt>
                <c:pt idx="17">
                  <c:v>2954</c:v>
                </c:pt>
                <c:pt idx="18">
                  <c:v>2570</c:v>
                </c:pt>
                <c:pt idx="19">
                  <c:v>3026</c:v>
                </c:pt>
                <c:pt idx="20">
                  <c:v>2484</c:v>
                </c:pt>
                <c:pt idx="21">
                  <c:v>3298</c:v>
                </c:pt>
                <c:pt idx="22">
                  <c:v>3274</c:v>
                </c:pt>
                <c:pt idx="23">
                  <c:v>2729</c:v>
                </c:pt>
                <c:pt idx="24">
                  <c:v>2449</c:v>
                </c:pt>
                <c:pt idx="25">
                  <c:v>2963</c:v>
                </c:pt>
                <c:pt idx="26">
                  <c:v>2931</c:v>
                </c:pt>
                <c:pt idx="27">
                  <c:v>2513</c:v>
                </c:pt>
                <c:pt idx="28">
                  <c:v>2085</c:v>
                </c:pt>
                <c:pt idx="29">
                  <c:v>1826</c:v>
                </c:pt>
                <c:pt idx="30">
                  <c:v>2545</c:v>
                </c:pt>
                <c:pt idx="31">
                  <c:v>2348</c:v>
                </c:pt>
                <c:pt idx="32">
                  <c:v>2332</c:v>
                </c:pt>
                <c:pt idx="33">
                  <c:v>2335</c:v>
                </c:pt>
                <c:pt idx="34">
                  <c:v>2329</c:v>
                </c:pt>
                <c:pt idx="35">
                  <c:v>2243</c:v>
                </c:pt>
                <c:pt idx="36">
                  <c:v>2652</c:v>
                </c:pt>
                <c:pt idx="37">
                  <c:v>2790</c:v>
                </c:pt>
                <c:pt idx="38">
                  <c:v>2277</c:v>
                </c:pt>
                <c:pt idx="39">
                  <c:v>2841</c:v>
                </c:pt>
                <c:pt idx="40">
                  <c:v>3792</c:v>
                </c:pt>
                <c:pt idx="41">
                  <c:v>1990</c:v>
                </c:pt>
                <c:pt idx="42">
                  <c:v>2261</c:v>
                </c:pt>
                <c:pt idx="43">
                  <c:v>2106</c:v>
                </c:pt>
                <c:pt idx="44">
                  <c:v>1876</c:v>
                </c:pt>
                <c:pt idx="45">
                  <c:v>22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C-14BC-6F4B-99EC-EA0E3F634294}"/>
            </c:ext>
          </c:extLst>
        </c:ser>
        <c:ser>
          <c:idx val="77"/>
          <c:order val="77"/>
          <c:tx>
            <c:strRef>
              <c:f>'Neat dates truncated'!$A$80</c:f>
              <c:strCache>
                <c:ptCount val="1"/>
                <c:pt idx="0">
                  <c:v>DR8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</a:schemeClr>
              </a:solidFill>
              <a:ln w="9525">
                <a:solidFill>
                  <a:schemeClr val="accent6">
                    <a:lumMod val="8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80:$AU$80</c:f>
              <c:numCache>
                <c:formatCode>General</c:formatCode>
                <c:ptCount val="46"/>
                <c:pt idx="0">
                  <c:v>12388</c:v>
                </c:pt>
                <c:pt idx="1">
                  <c:v>12436</c:v>
                </c:pt>
                <c:pt idx="2">
                  <c:v>9508</c:v>
                </c:pt>
                <c:pt idx="3">
                  <c:v>7901</c:v>
                </c:pt>
                <c:pt idx="4">
                  <c:v>6852</c:v>
                </c:pt>
                <c:pt idx="5">
                  <c:v>4592</c:v>
                </c:pt>
                <c:pt idx="6">
                  <c:v>5509</c:v>
                </c:pt>
                <c:pt idx="7">
                  <c:v>3271</c:v>
                </c:pt>
                <c:pt idx="8">
                  <c:v>2986</c:v>
                </c:pt>
                <c:pt idx="9">
                  <c:v>3175</c:v>
                </c:pt>
                <c:pt idx="10">
                  <c:v>3646</c:v>
                </c:pt>
                <c:pt idx="11">
                  <c:v>2928</c:v>
                </c:pt>
                <c:pt idx="12">
                  <c:v>2947</c:v>
                </c:pt>
                <c:pt idx="13">
                  <c:v>2396</c:v>
                </c:pt>
                <c:pt idx="14">
                  <c:v>2230</c:v>
                </c:pt>
                <c:pt idx="15">
                  <c:v>1385</c:v>
                </c:pt>
                <c:pt idx="16">
                  <c:v>1646</c:v>
                </c:pt>
                <c:pt idx="17">
                  <c:v>1827</c:v>
                </c:pt>
                <c:pt idx="18">
                  <c:v>1167</c:v>
                </c:pt>
                <c:pt idx="19">
                  <c:v>1983</c:v>
                </c:pt>
                <c:pt idx="20">
                  <c:v>0</c:v>
                </c:pt>
                <c:pt idx="21">
                  <c:v>1471</c:v>
                </c:pt>
                <c:pt idx="22">
                  <c:v>2074</c:v>
                </c:pt>
                <c:pt idx="23">
                  <c:v>1638</c:v>
                </c:pt>
                <c:pt idx="24">
                  <c:v>0</c:v>
                </c:pt>
                <c:pt idx="25">
                  <c:v>1242</c:v>
                </c:pt>
                <c:pt idx="26">
                  <c:v>1274</c:v>
                </c:pt>
                <c:pt idx="27">
                  <c:v>1835</c:v>
                </c:pt>
                <c:pt idx="28">
                  <c:v>0</c:v>
                </c:pt>
                <c:pt idx="29">
                  <c:v>0</c:v>
                </c:pt>
                <c:pt idx="30">
                  <c:v>2627</c:v>
                </c:pt>
                <c:pt idx="31">
                  <c:v>2363</c:v>
                </c:pt>
                <c:pt idx="32">
                  <c:v>2282</c:v>
                </c:pt>
                <c:pt idx="33">
                  <c:v>2601</c:v>
                </c:pt>
                <c:pt idx="34">
                  <c:v>1863</c:v>
                </c:pt>
                <c:pt idx="35">
                  <c:v>1456</c:v>
                </c:pt>
                <c:pt idx="36">
                  <c:v>1466</c:v>
                </c:pt>
                <c:pt idx="37">
                  <c:v>0</c:v>
                </c:pt>
                <c:pt idx="38">
                  <c:v>0</c:v>
                </c:pt>
                <c:pt idx="39">
                  <c:v>1395</c:v>
                </c:pt>
                <c:pt idx="40">
                  <c:v>177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D-14BC-6F4B-99EC-EA0E3F634294}"/>
            </c:ext>
          </c:extLst>
        </c:ser>
        <c:ser>
          <c:idx val="78"/>
          <c:order val="78"/>
          <c:tx>
            <c:strRef>
              <c:f>'Neat dates truncated'!$A$81</c:f>
              <c:strCache>
                <c:ptCount val="1"/>
                <c:pt idx="0">
                  <c:v>DRB1*04:02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81:$AU$81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E-14BC-6F4B-99EC-EA0E3F634294}"/>
            </c:ext>
          </c:extLst>
        </c:ser>
        <c:ser>
          <c:idx val="79"/>
          <c:order val="79"/>
          <c:tx>
            <c:strRef>
              <c:f>'Neat dates truncated'!$A$82</c:f>
              <c:strCache>
                <c:ptCount val="1"/>
                <c:pt idx="0">
                  <c:v>DRB3*03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Neat dates truncated'!$B$2:$AU$2</c:f>
              <c:numCache>
                <c:formatCode>General</c:formatCode>
                <c:ptCount val="46"/>
                <c:pt idx="0">
                  <c:v>-6</c:v>
                </c:pt>
                <c:pt idx="1">
                  <c:v>5</c:v>
                </c:pt>
                <c:pt idx="2">
                  <c:v>12</c:v>
                </c:pt>
                <c:pt idx="3">
                  <c:v>20</c:v>
                </c:pt>
                <c:pt idx="4">
                  <c:v>28</c:v>
                </c:pt>
                <c:pt idx="5">
                  <c:v>35</c:v>
                </c:pt>
                <c:pt idx="6">
                  <c:v>49</c:v>
                </c:pt>
                <c:pt idx="7">
                  <c:v>62</c:v>
                </c:pt>
                <c:pt idx="8">
                  <c:v>76</c:v>
                </c:pt>
                <c:pt idx="9">
                  <c:v>90</c:v>
                </c:pt>
                <c:pt idx="10">
                  <c:v>102</c:v>
                </c:pt>
                <c:pt idx="11">
                  <c:v>115</c:v>
                </c:pt>
                <c:pt idx="12">
                  <c:v>128</c:v>
                </c:pt>
                <c:pt idx="13">
                  <c:v>141</c:v>
                </c:pt>
                <c:pt idx="14">
                  <c:v>157</c:v>
                </c:pt>
                <c:pt idx="15">
                  <c:v>169</c:v>
                </c:pt>
                <c:pt idx="16">
                  <c:v>181</c:v>
                </c:pt>
                <c:pt idx="17">
                  <c:v>194</c:v>
                </c:pt>
                <c:pt idx="18">
                  <c:v>209</c:v>
                </c:pt>
                <c:pt idx="19">
                  <c:v>222</c:v>
                </c:pt>
                <c:pt idx="20">
                  <c:v>240</c:v>
                </c:pt>
                <c:pt idx="21">
                  <c:v>253</c:v>
                </c:pt>
                <c:pt idx="22">
                  <c:v>274</c:v>
                </c:pt>
                <c:pt idx="23">
                  <c:v>286</c:v>
                </c:pt>
                <c:pt idx="24">
                  <c:v>321</c:v>
                </c:pt>
                <c:pt idx="25">
                  <c:v>351</c:v>
                </c:pt>
                <c:pt idx="26">
                  <c:v>398</c:v>
                </c:pt>
                <c:pt idx="27">
                  <c:v>427</c:v>
                </c:pt>
                <c:pt idx="28">
                  <c:v>468</c:v>
                </c:pt>
                <c:pt idx="29">
                  <c:v>489</c:v>
                </c:pt>
                <c:pt idx="30">
                  <c:v>503</c:v>
                </c:pt>
                <c:pt idx="31">
                  <c:v>526</c:v>
                </c:pt>
                <c:pt idx="32">
                  <c:v>527</c:v>
                </c:pt>
                <c:pt idx="33">
                  <c:v>539</c:v>
                </c:pt>
                <c:pt idx="34">
                  <c:v>574</c:v>
                </c:pt>
                <c:pt idx="35">
                  <c:v>588</c:v>
                </c:pt>
                <c:pt idx="36">
                  <c:v>602</c:v>
                </c:pt>
                <c:pt idx="37">
                  <c:v>617</c:v>
                </c:pt>
                <c:pt idx="38">
                  <c:v>658</c:v>
                </c:pt>
                <c:pt idx="39">
                  <c:v>672</c:v>
                </c:pt>
                <c:pt idx="40">
                  <c:v>686</c:v>
                </c:pt>
                <c:pt idx="41">
                  <c:v>700</c:v>
                </c:pt>
                <c:pt idx="42">
                  <c:v>714</c:v>
                </c:pt>
                <c:pt idx="43">
                  <c:v>728</c:v>
                </c:pt>
                <c:pt idx="44">
                  <c:v>742</c:v>
                </c:pt>
                <c:pt idx="45">
                  <c:v>770</c:v>
                </c:pt>
              </c:numCache>
            </c:numRef>
          </c:cat>
          <c:val>
            <c:numRef>
              <c:f>'Neat dates truncated'!$B$82:$AU$82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F-14BC-6F4B-99EC-EA0E3F6342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6631439"/>
        <c:axId val="616631919"/>
      </c:lineChart>
      <c:catAx>
        <c:axId val="61663143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 Post-Daratumumab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31919"/>
        <c:crosses val="autoZero"/>
        <c:auto val="1"/>
        <c:lblAlgn val="ctr"/>
        <c:lblOffset val="100"/>
        <c:noMultiLvlLbl val="0"/>
      </c:catAx>
      <c:valAx>
        <c:axId val="6166319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HLA Antibody MF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314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/>
              <a:t>Case 2: All Antibodi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Neat!$A$4</c:f>
              <c:strCache>
                <c:ptCount val="1"/>
                <c:pt idx="0">
                  <c:v>A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:$CA$4</c:f>
              <c:numCache>
                <c:formatCode>General</c:formatCode>
                <c:ptCount val="78"/>
                <c:pt idx="0">
                  <c:v>6538</c:v>
                </c:pt>
                <c:pt idx="1">
                  <c:v>15358</c:v>
                </c:pt>
                <c:pt idx="2">
                  <c:v>11528</c:v>
                </c:pt>
                <c:pt idx="3">
                  <c:v>6837</c:v>
                </c:pt>
                <c:pt idx="4">
                  <c:v>15193</c:v>
                </c:pt>
                <c:pt idx="5">
                  <c:v>17111</c:v>
                </c:pt>
                <c:pt idx="6">
                  <c:v>10062</c:v>
                </c:pt>
                <c:pt idx="7">
                  <c:v>13699</c:v>
                </c:pt>
                <c:pt idx="8">
                  <c:v>18160</c:v>
                </c:pt>
                <c:pt idx="9">
                  <c:v>8926</c:v>
                </c:pt>
                <c:pt idx="10">
                  <c:v>15275</c:v>
                </c:pt>
                <c:pt idx="11">
                  <c:v>13200</c:v>
                </c:pt>
                <c:pt idx="12">
                  <c:v>13478</c:v>
                </c:pt>
                <c:pt idx="13">
                  <c:v>16025</c:v>
                </c:pt>
                <c:pt idx="14">
                  <c:v>20786</c:v>
                </c:pt>
                <c:pt idx="15">
                  <c:v>18619</c:v>
                </c:pt>
                <c:pt idx="16">
                  <c:v>19917</c:v>
                </c:pt>
                <c:pt idx="17">
                  <c:v>17454</c:v>
                </c:pt>
                <c:pt idx="18">
                  <c:v>17032</c:v>
                </c:pt>
                <c:pt idx="19">
                  <c:v>21445</c:v>
                </c:pt>
                <c:pt idx="20">
                  <c:v>12716</c:v>
                </c:pt>
                <c:pt idx="21">
                  <c:v>19601</c:v>
                </c:pt>
                <c:pt idx="22">
                  <c:v>19807</c:v>
                </c:pt>
                <c:pt idx="23">
                  <c:v>19381</c:v>
                </c:pt>
                <c:pt idx="24">
                  <c:v>15075</c:v>
                </c:pt>
                <c:pt idx="25">
                  <c:v>21459</c:v>
                </c:pt>
                <c:pt idx="26">
                  <c:v>23061</c:v>
                </c:pt>
                <c:pt idx="27">
                  <c:v>13409</c:v>
                </c:pt>
                <c:pt idx="28">
                  <c:v>20385</c:v>
                </c:pt>
                <c:pt idx="29">
                  <c:v>23007</c:v>
                </c:pt>
                <c:pt idx="30">
                  <c:v>22381</c:v>
                </c:pt>
                <c:pt idx="31">
                  <c:v>17627</c:v>
                </c:pt>
                <c:pt idx="32">
                  <c:v>20717</c:v>
                </c:pt>
                <c:pt idx="33">
                  <c:v>18790</c:v>
                </c:pt>
                <c:pt idx="34">
                  <c:v>22387</c:v>
                </c:pt>
                <c:pt idx="35">
                  <c:v>17241</c:v>
                </c:pt>
                <c:pt idx="36">
                  <c:v>17018</c:v>
                </c:pt>
                <c:pt idx="37">
                  <c:v>7516</c:v>
                </c:pt>
                <c:pt idx="38">
                  <c:v>16197</c:v>
                </c:pt>
                <c:pt idx="39">
                  <c:v>9420</c:v>
                </c:pt>
                <c:pt idx="40">
                  <c:v>11240</c:v>
                </c:pt>
                <c:pt idx="41">
                  <c:v>20094</c:v>
                </c:pt>
                <c:pt idx="42">
                  <c:v>12614</c:v>
                </c:pt>
                <c:pt idx="43">
                  <c:v>13837</c:v>
                </c:pt>
                <c:pt idx="44">
                  <c:v>10681</c:v>
                </c:pt>
                <c:pt idx="45">
                  <c:v>11769</c:v>
                </c:pt>
                <c:pt idx="46">
                  <c:v>24625</c:v>
                </c:pt>
                <c:pt idx="47">
                  <c:v>25181</c:v>
                </c:pt>
                <c:pt idx="48">
                  <c:v>21421</c:v>
                </c:pt>
                <c:pt idx="49">
                  <c:v>20414</c:v>
                </c:pt>
                <c:pt idx="50">
                  <c:v>13111</c:v>
                </c:pt>
                <c:pt idx="51">
                  <c:v>19765</c:v>
                </c:pt>
                <c:pt idx="52">
                  <c:v>14560</c:v>
                </c:pt>
                <c:pt idx="53">
                  <c:v>8775</c:v>
                </c:pt>
                <c:pt idx="54">
                  <c:v>22469</c:v>
                </c:pt>
                <c:pt idx="55">
                  <c:v>18792</c:v>
                </c:pt>
                <c:pt idx="56">
                  <c:v>19487</c:v>
                </c:pt>
                <c:pt idx="57">
                  <c:v>21026</c:v>
                </c:pt>
                <c:pt idx="58">
                  <c:v>12951</c:v>
                </c:pt>
                <c:pt idx="59">
                  <c:v>15975</c:v>
                </c:pt>
                <c:pt idx="60">
                  <c:v>12469</c:v>
                </c:pt>
                <c:pt idx="61">
                  <c:v>17064</c:v>
                </c:pt>
                <c:pt idx="62">
                  <c:v>17002</c:v>
                </c:pt>
                <c:pt idx="63">
                  <c:v>17498</c:v>
                </c:pt>
                <c:pt idx="64">
                  <c:v>14173</c:v>
                </c:pt>
                <c:pt idx="65">
                  <c:v>11077</c:v>
                </c:pt>
                <c:pt idx="66">
                  <c:v>14106</c:v>
                </c:pt>
                <c:pt idx="67">
                  <c:v>16997</c:v>
                </c:pt>
                <c:pt idx="68">
                  <c:v>17940</c:v>
                </c:pt>
                <c:pt idx="69">
                  <c:v>12725</c:v>
                </c:pt>
                <c:pt idx="70">
                  <c:v>12132</c:v>
                </c:pt>
                <c:pt idx="71">
                  <c:v>19285</c:v>
                </c:pt>
                <c:pt idx="72">
                  <c:v>20089</c:v>
                </c:pt>
                <c:pt idx="73">
                  <c:v>17669</c:v>
                </c:pt>
                <c:pt idx="74">
                  <c:v>13117</c:v>
                </c:pt>
                <c:pt idx="75">
                  <c:v>17890</c:v>
                </c:pt>
                <c:pt idx="76">
                  <c:v>21074</c:v>
                </c:pt>
                <c:pt idx="77">
                  <c:v>196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E29-3342-A2AA-0E5784E973CA}"/>
            </c:ext>
          </c:extLst>
        </c:ser>
        <c:ser>
          <c:idx val="1"/>
          <c:order val="1"/>
          <c:tx>
            <c:strRef>
              <c:f>Neat!$A$5</c:f>
              <c:strCache>
                <c:ptCount val="1"/>
                <c:pt idx="0">
                  <c:v>A1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:$CA$5</c:f>
              <c:numCache>
                <c:formatCode>General</c:formatCode>
                <c:ptCount val="78"/>
                <c:pt idx="0">
                  <c:v>12523</c:v>
                </c:pt>
                <c:pt idx="1">
                  <c:v>18221</c:v>
                </c:pt>
                <c:pt idx="2">
                  <c:v>18283</c:v>
                </c:pt>
                <c:pt idx="3">
                  <c:v>18064</c:v>
                </c:pt>
                <c:pt idx="4">
                  <c:v>19160</c:v>
                </c:pt>
                <c:pt idx="5">
                  <c:v>15887</c:v>
                </c:pt>
                <c:pt idx="6">
                  <c:v>20234</c:v>
                </c:pt>
                <c:pt idx="7">
                  <c:v>21188</c:v>
                </c:pt>
                <c:pt idx="8">
                  <c:v>13376</c:v>
                </c:pt>
                <c:pt idx="9">
                  <c:v>19165</c:v>
                </c:pt>
                <c:pt idx="10">
                  <c:v>13940</c:v>
                </c:pt>
                <c:pt idx="11">
                  <c:v>15104</c:v>
                </c:pt>
                <c:pt idx="12">
                  <c:v>14437</c:v>
                </c:pt>
                <c:pt idx="13">
                  <c:v>11514</c:v>
                </c:pt>
                <c:pt idx="14">
                  <c:v>8738</c:v>
                </c:pt>
                <c:pt idx="15">
                  <c:v>2915</c:v>
                </c:pt>
                <c:pt idx="16">
                  <c:v>6023</c:v>
                </c:pt>
                <c:pt idx="17">
                  <c:v>13831</c:v>
                </c:pt>
                <c:pt idx="18">
                  <c:v>12006</c:v>
                </c:pt>
                <c:pt idx="19">
                  <c:v>13085</c:v>
                </c:pt>
                <c:pt idx="20">
                  <c:v>15366</c:v>
                </c:pt>
                <c:pt idx="21">
                  <c:v>13711</c:v>
                </c:pt>
                <c:pt idx="22">
                  <c:v>5980</c:v>
                </c:pt>
                <c:pt idx="23">
                  <c:v>9737</c:v>
                </c:pt>
                <c:pt idx="24">
                  <c:v>13273</c:v>
                </c:pt>
                <c:pt idx="25">
                  <c:v>17052</c:v>
                </c:pt>
                <c:pt idx="26">
                  <c:v>18861</c:v>
                </c:pt>
                <c:pt idx="27">
                  <c:v>19735</c:v>
                </c:pt>
                <c:pt idx="28">
                  <c:v>13643</c:v>
                </c:pt>
                <c:pt idx="29">
                  <c:v>8102</c:v>
                </c:pt>
                <c:pt idx="30">
                  <c:v>9560</c:v>
                </c:pt>
                <c:pt idx="31">
                  <c:v>11112</c:v>
                </c:pt>
                <c:pt idx="32">
                  <c:v>13919</c:v>
                </c:pt>
                <c:pt idx="33">
                  <c:v>15866</c:v>
                </c:pt>
                <c:pt idx="34">
                  <c:v>12008</c:v>
                </c:pt>
                <c:pt idx="35">
                  <c:v>14395</c:v>
                </c:pt>
                <c:pt idx="36">
                  <c:v>13795</c:v>
                </c:pt>
                <c:pt idx="37">
                  <c:v>18821</c:v>
                </c:pt>
                <c:pt idx="38">
                  <c:v>13238</c:v>
                </c:pt>
                <c:pt idx="39">
                  <c:v>14989</c:v>
                </c:pt>
                <c:pt idx="40">
                  <c:v>13435</c:v>
                </c:pt>
                <c:pt idx="41">
                  <c:v>13157</c:v>
                </c:pt>
                <c:pt idx="42">
                  <c:v>12314</c:v>
                </c:pt>
                <c:pt idx="43">
                  <c:v>12471</c:v>
                </c:pt>
                <c:pt idx="44">
                  <c:v>13025</c:v>
                </c:pt>
                <c:pt idx="45">
                  <c:v>12461</c:v>
                </c:pt>
                <c:pt idx="46">
                  <c:v>8066</c:v>
                </c:pt>
                <c:pt idx="47">
                  <c:v>6038</c:v>
                </c:pt>
                <c:pt idx="48">
                  <c:v>7200</c:v>
                </c:pt>
                <c:pt idx="49">
                  <c:v>7746</c:v>
                </c:pt>
                <c:pt idx="50">
                  <c:v>6618</c:v>
                </c:pt>
                <c:pt idx="51">
                  <c:v>7574</c:v>
                </c:pt>
                <c:pt idx="52">
                  <c:v>8332</c:v>
                </c:pt>
                <c:pt idx="53">
                  <c:v>9487</c:v>
                </c:pt>
                <c:pt idx="54">
                  <c:v>4275</c:v>
                </c:pt>
                <c:pt idx="55">
                  <c:v>12775</c:v>
                </c:pt>
                <c:pt idx="56">
                  <c:v>13747</c:v>
                </c:pt>
                <c:pt idx="57">
                  <c:v>12079</c:v>
                </c:pt>
                <c:pt idx="58">
                  <c:v>12986</c:v>
                </c:pt>
                <c:pt idx="59">
                  <c:v>12713</c:v>
                </c:pt>
                <c:pt idx="60">
                  <c:v>13831</c:v>
                </c:pt>
                <c:pt idx="61">
                  <c:v>15158</c:v>
                </c:pt>
                <c:pt idx="62">
                  <c:v>16965</c:v>
                </c:pt>
                <c:pt idx="63">
                  <c:v>17132</c:v>
                </c:pt>
                <c:pt idx="64">
                  <c:v>14813</c:v>
                </c:pt>
                <c:pt idx="65">
                  <c:v>16360</c:v>
                </c:pt>
                <c:pt idx="66">
                  <c:v>14134</c:v>
                </c:pt>
                <c:pt idx="67">
                  <c:v>14297</c:v>
                </c:pt>
                <c:pt idx="68">
                  <c:v>14461</c:v>
                </c:pt>
                <c:pt idx="69">
                  <c:v>13133</c:v>
                </c:pt>
                <c:pt idx="70">
                  <c:v>10620</c:v>
                </c:pt>
                <c:pt idx="71">
                  <c:v>11441</c:v>
                </c:pt>
                <c:pt idx="72">
                  <c:v>11689</c:v>
                </c:pt>
                <c:pt idx="73">
                  <c:v>10669</c:v>
                </c:pt>
                <c:pt idx="74">
                  <c:v>10776</c:v>
                </c:pt>
                <c:pt idx="75">
                  <c:v>11204</c:v>
                </c:pt>
                <c:pt idx="76">
                  <c:v>10834</c:v>
                </c:pt>
                <c:pt idx="77">
                  <c:v>69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E29-3342-A2AA-0E5784E973CA}"/>
            </c:ext>
          </c:extLst>
        </c:ser>
        <c:ser>
          <c:idx val="2"/>
          <c:order val="2"/>
          <c:tx>
            <c:strRef>
              <c:f>Neat!$A$6</c:f>
              <c:strCache>
                <c:ptCount val="1"/>
                <c:pt idx="0">
                  <c:v>A2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:$CA$6</c:f>
              <c:numCache>
                <c:formatCode>General</c:formatCode>
                <c:ptCount val="78"/>
                <c:pt idx="0">
                  <c:v>10781</c:v>
                </c:pt>
                <c:pt idx="1">
                  <c:v>18122</c:v>
                </c:pt>
                <c:pt idx="2">
                  <c:v>16410</c:v>
                </c:pt>
                <c:pt idx="3">
                  <c:v>13511</c:v>
                </c:pt>
                <c:pt idx="4">
                  <c:v>19555</c:v>
                </c:pt>
                <c:pt idx="5">
                  <c:v>20111</c:v>
                </c:pt>
                <c:pt idx="6">
                  <c:v>20269</c:v>
                </c:pt>
                <c:pt idx="7">
                  <c:v>22037</c:v>
                </c:pt>
                <c:pt idx="8">
                  <c:v>20389</c:v>
                </c:pt>
                <c:pt idx="9">
                  <c:v>17261</c:v>
                </c:pt>
                <c:pt idx="10">
                  <c:v>19408</c:v>
                </c:pt>
                <c:pt idx="11">
                  <c:v>17440</c:v>
                </c:pt>
                <c:pt idx="12">
                  <c:v>17040</c:v>
                </c:pt>
                <c:pt idx="13">
                  <c:v>17980</c:v>
                </c:pt>
                <c:pt idx="14">
                  <c:v>17501</c:v>
                </c:pt>
                <c:pt idx="15">
                  <c:v>6065</c:v>
                </c:pt>
                <c:pt idx="16">
                  <c:v>7961</c:v>
                </c:pt>
                <c:pt idx="17">
                  <c:v>12189</c:v>
                </c:pt>
                <c:pt idx="18">
                  <c:v>12524</c:v>
                </c:pt>
                <c:pt idx="19">
                  <c:v>11389</c:v>
                </c:pt>
                <c:pt idx="20">
                  <c:v>15327</c:v>
                </c:pt>
                <c:pt idx="21">
                  <c:v>14870</c:v>
                </c:pt>
                <c:pt idx="22">
                  <c:v>6730</c:v>
                </c:pt>
                <c:pt idx="23">
                  <c:v>11224</c:v>
                </c:pt>
                <c:pt idx="24">
                  <c:v>15084</c:v>
                </c:pt>
                <c:pt idx="25">
                  <c:v>17060</c:v>
                </c:pt>
                <c:pt idx="26">
                  <c:v>18952</c:v>
                </c:pt>
                <c:pt idx="27">
                  <c:v>18928</c:v>
                </c:pt>
                <c:pt idx="28">
                  <c:v>14537</c:v>
                </c:pt>
                <c:pt idx="29">
                  <c:v>9441</c:v>
                </c:pt>
                <c:pt idx="30">
                  <c:v>12089</c:v>
                </c:pt>
                <c:pt idx="31">
                  <c:v>12951</c:v>
                </c:pt>
                <c:pt idx="32">
                  <c:v>16594</c:v>
                </c:pt>
                <c:pt idx="33">
                  <c:v>18861</c:v>
                </c:pt>
                <c:pt idx="34">
                  <c:v>13783</c:v>
                </c:pt>
                <c:pt idx="35">
                  <c:v>18444</c:v>
                </c:pt>
                <c:pt idx="36">
                  <c:v>18623</c:v>
                </c:pt>
                <c:pt idx="37">
                  <c:v>19535</c:v>
                </c:pt>
                <c:pt idx="38">
                  <c:v>17503</c:v>
                </c:pt>
                <c:pt idx="39">
                  <c:v>17692</c:v>
                </c:pt>
                <c:pt idx="40">
                  <c:v>18182</c:v>
                </c:pt>
                <c:pt idx="41">
                  <c:v>20172</c:v>
                </c:pt>
                <c:pt idx="42">
                  <c:v>16924</c:v>
                </c:pt>
                <c:pt idx="43">
                  <c:v>16607</c:v>
                </c:pt>
                <c:pt idx="44">
                  <c:v>16078</c:v>
                </c:pt>
                <c:pt idx="45">
                  <c:v>16456</c:v>
                </c:pt>
                <c:pt idx="46">
                  <c:v>13584</c:v>
                </c:pt>
                <c:pt idx="47">
                  <c:v>11814</c:v>
                </c:pt>
                <c:pt idx="48">
                  <c:v>13772</c:v>
                </c:pt>
                <c:pt idx="49">
                  <c:v>14409</c:v>
                </c:pt>
                <c:pt idx="50">
                  <c:v>12230</c:v>
                </c:pt>
                <c:pt idx="51">
                  <c:v>13903</c:v>
                </c:pt>
                <c:pt idx="52">
                  <c:v>15320</c:v>
                </c:pt>
                <c:pt idx="53">
                  <c:v>15990</c:v>
                </c:pt>
                <c:pt idx="54">
                  <c:v>8232</c:v>
                </c:pt>
                <c:pt idx="55">
                  <c:v>14392</c:v>
                </c:pt>
                <c:pt idx="56">
                  <c:v>17852</c:v>
                </c:pt>
                <c:pt idx="57">
                  <c:v>16086</c:v>
                </c:pt>
                <c:pt idx="58">
                  <c:v>15620</c:v>
                </c:pt>
                <c:pt idx="59">
                  <c:v>15856</c:v>
                </c:pt>
                <c:pt idx="60">
                  <c:v>15845</c:v>
                </c:pt>
                <c:pt idx="61">
                  <c:v>19090</c:v>
                </c:pt>
                <c:pt idx="62">
                  <c:v>21217</c:v>
                </c:pt>
                <c:pt idx="63">
                  <c:v>21111</c:v>
                </c:pt>
                <c:pt idx="64">
                  <c:v>19364</c:v>
                </c:pt>
                <c:pt idx="65">
                  <c:v>20120</c:v>
                </c:pt>
                <c:pt idx="66">
                  <c:v>19101</c:v>
                </c:pt>
                <c:pt idx="67">
                  <c:v>18185</c:v>
                </c:pt>
                <c:pt idx="68">
                  <c:v>19923</c:v>
                </c:pt>
                <c:pt idx="69">
                  <c:v>18594</c:v>
                </c:pt>
                <c:pt idx="70">
                  <c:v>15856</c:v>
                </c:pt>
                <c:pt idx="71">
                  <c:v>18000</c:v>
                </c:pt>
                <c:pt idx="72">
                  <c:v>18488</c:v>
                </c:pt>
                <c:pt idx="73">
                  <c:v>16047</c:v>
                </c:pt>
                <c:pt idx="74">
                  <c:v>18059</c:v>
                </c:pt>
                <c:pt idx="75">
                  <c:v>17351</c:v>
                </c:pt>
                <c:pt idx="76">
                  <c:v>17559</c:v>
                </c:pt>
                <c:pt idx="77">
                  <c:v>14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E29-3342-A2AA-0E5784E973CA}"/>
            </c:ext>
          </c:extLst>
        </c:ser>
        <c:ser>
          <c:idx val="3"/>
          <c:order val="3"/>
          <c:tx>
            <c:strRef>
              <c:f>Neat!$A$7</c:f>
              <c:strCache>
                <c:ptCount val="1"/>
                <c:pt idx="0">
                  <c:v>A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:$CA$7</c:f>
              <c:numCache>
                <c:formatCode>General</c:formatCode>
                <c:ptCount val="78"/>
                <c:pt idx="0">
                  <c:v>13407</c:v>
                </c:pt>
                <c:pt idx="1">
                  <c:v>15483</c:v>
                </c:pt>
                <c:pt idx="2">
                  <c:v>15823</c:v>
                </c:pt>
                <c:pt idx="3">
                  <c:v>13817</c:v>
                </c:pt>
                <c:pt idx="4">
                  <c:v>15010</c:v>
                </c:pt>
                <c:pt idx="5">
                  <c:v>13512</c:v>
                </c:pt>
                <c:pt idx="6">
                  <c:v>16327</c:v>
                </c:pt>
                <c:pt idx="7">
                  <c:v>17314</c:v>
                </c:pt>
                <c:pt idx="8">
                  <c:v>12396</c:v>
                </c:pt>
                <c:pt idx="9">
                  <c:v>14840</c:v>
                </c:pt>
                <c:pt idx="10">
                  <c:v>12247</c:v>
                </c:pt>
                <c:pt idx="11">
                  <c:v>12238</c:v>
                </c:pt>
                <c:pt idx="12">
                  <c:v>11578</c:v>
                </c:pt>
                <c:pt idx="13">
                  <c:v>10370</c:v>
                </c:pt>
                <c:pt idx="14">
                  <c:v>9316</c:v>
                </c:pt>
                <c:pt idx="15">
                  <c:v>2617</c:v>
                </c:pt>
                <c:pt idx="16">
                  <c:v>3732</c:v>
                </c:pt>
                <c:pt idx="17">
                  <c:v>10030</c:v>
                </c:pt>
                <c:pt idx="18">
                  <c:v>9582</c:v>
                </c:pt>
                <c:pt idx="19">
                  <c:v>9589</c:v>
                </c:pt>
                <c:pt idx="20">
                  <c:v>12894</c:v>
                </c:pt>
                <c:pt idx="21">
                  <c:v>11493</c:v>
                </c:pt>
                <c:pt idx="22">
                  <c:v>4914</c:v>
                </c:pt>
                <c:pt idx="23">
                  <c:v>8536</c:v>
                </c:pt>
                <c:pt idx="24">
                  <c:v>12093</c:v>
                </c:pt>
                <c:pt idx="25">
                  <c:v>14413</c:v>
                </c:pt>
                <c:pt idx="26">
                  <c:v>15944</c:v>
                </c:pt>
                <c:pt idx="27">
                  <c:v>16808</c:v>
                </c:pt>
                <c:pt idx="28">
                  <c:v>11501</c:v>
                </c:pt>
                <c:pt idx="29">
                  <c:v>7883</c:v>
                </c:pt>
                <c:pt idx="30">
                  <c:v>9733</c:v>
                </c:pt>
                <c:pt idx="31">
                  <c:v>10422</c:v>
                </c:pt>
                <c:pt idx="32">
                  <c:v>12718</c:v>
                </c:pt>
                <c:pt idx="33">
                  <c:v>14940</c:v>
                </c:pt>
                <c:pt idx="34">
                  <c:v>10118</c:v>
                </c:pt>
                <c:pt idx="35">
                  <c:v>13944</c:v>
                </c:pt>
                <c:pt idx="36">
                  <c:v>13740</c:v>
                </c:pt>
                <c:pt idx="37">
                  <c:v>15422</c:v>
                </c:pt>
                <c:pt idx="38">
                  <c:v>13058</c:v>
                </c:pt>
                <c:pt idx="39">
                  <c:v>13328</c:v>
                </c:pt>
                <c:pt idx="40">
                  <c:v>12968</c:v>
                </c:pt>
                <c:pt idx="41">
                  <c:v>13955</c:v>
                </c:pt>
                <c:pt idx="42">
                  <c:v>12016</c:v>
                </c:pt>
                <c:pt idx="43">
                  <c:v>11953</c:v>
                </c:pt>
                <c:pt idx="44">
                  <c:v>11028</c:v>
                </c:pt>
                <c:pt idx="45">
                  <c:v>11309</c:v>
                </c:pt>
                <c:pt idx="46">
                  <c:v>8681</c:v>
                </c:pt>
                <c:pt idx="47">
                  <c:v>7215</c:v>
                </c:pt>
                <c:pt idx="48">
                  <c:v>8264</c:v>
                </c:pt>
                <c:pt idx="49">
                  <c:v>8923</c:v>
                </c:pt>
                <c:pt idx="50">
                  <c:v>7553</c:v>
                </c:pt>
                <c:pt idx="51">
                  <c:v>8358</c:v>
                </c:pt>
                <c:pt idx="52">
                  <c:v>9781</c:v>
                </c:pt>
                <c:pt idx="53">
                  <c:v>9684</c:v>
                </c:pt>
                <c:pt idx="54">
                  <c:v>4762</c:v>
                </c:pt>
                <c:pt idx="55">
                  <c:v>11441</c:v>
                </c:pt>
                <c:pt idx="56">
                  <c:v>12885</c:v>
                </c:pt>
                <c:pt idx="57">
                  <c:v>11786</c:v>
                </c:pt>
                <c:pt idx="58">
                  <c:v>11446</c:v>
                </c:pt>
                <c:pt idx="59">
                  <c:v>11353</c:v>
                </c:pt>
                <c:pt idx="60">
                  <c:v>11522</c:v>
                </c:pt>
                <c:pt idx="61">
                  <c:v>13436</c:v>
                </c:pt>
                <c:pt idx="62">
                  <c:v>14694</c:v>
                </c:pt>
                <c:pt idx="63">
                  <c:v>14396</c:v>
                </c:pt>
                <c:pt idx="64">
                  <c:v>13442</c:v>
                </c:pt>
                <c:pt idx="65">
                  <c:v>13552</c:v>
                </c:pt>
                <c:pt idx="66">
                  <c:v>12744</c:v>
                </c:pt>
                <c:pt idx="67">
                  <c:v>12335</c:v>
                </c:pt>
                <c:pt idx="68">
                  <c:v>13405</c:v>
                </c:pt>
                <c:pt idx="69">
                  <c:v>11868</c:v>
                </c:pt>
                <c:pt idx="70">
                  <c:v>8637</c:v>
                </c:pt>
                <c:pt idx="71">
                  <c:v>8595</c:v>
                </c:pt>
                <c:pt idx="72">
                  <c:v>8524</c:v>
                </c:pt>
                <c:pt idx="73">
                  <c:v>7893</c:v>
                </c:pt>
                <c:pt idx="74">
                  <c:v>8801</c:v>
                </c:pt>
                <c:pt idx="75">
                  <c:v>8616</c:v>
                </c:pt>
                <c:pt idx="76">
                  <c:v>8216</c:v>
                </c:pt>
                <c:pt idx="77">
                  <c:v>58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E29-3342-A2AA-0E5784E973CA}"/>
            </c:ext>
          </c:extLst>
        </c:ser>
        <c:ser>
          <c:idx val="4"/>
          <c:order val="4"/>
          <c:tx>
            <c:strRef>
              <c:f>Neat!$A$8</c:f>
              <c:strCache>
                <c:ptCount val="1"/>
                <c:pt idx="0">
                  <c:v>A2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:$CA$8</c:f>
              <c:numCache>
                <c:formatCode>General</c:formatCode>
                <c:ptCount val="78"/>
                <c:pt idx="0">
                  <c:v>9184</c:v>
                </c:pt>
                <c:pt idx="1">
                  <c:v>6587</c:v>
                </c:pt>
                <c:pt idx="2">
                  <c:v>6881</c:v>
                </c:pt>
                <c:pt idx="3">
                  <c:v>6431</c:v>
                </c:pt>
                <c:pt idx="4">
                  <c:v>4729</c:v>
                </c:pt>
                <c:pt idx="5">
                  <c:v>3009</c:v>
                </c:pt>
                <c:pt idx="6">
                  <c:v>5736</c:v>
                </c:pt>
                <c:pt idx="7">
                  <c:v>6476</c:v>
                </c:pt>
                <c:pt idx="8">
                  <c:v>2843</c:v>
                </c:pt>
                <c:pt idx="9">
                  <c:v>5632</c:v>
                </c:pt>
                <c:pt idx="10">
                  <c:v>2636</c:v>
                </c:pt>
                <c:pt idx="11">
                  <c:v>2895</c:v>
                </c:pt>
                <c:pt idx="12">
                  <c:v>2693</c:v>
                </c:pt>
                <c:pt idx="13">
                  <c:v>1716</c:v>
                </c:pt>
                <c:pt idx="14">
                  <c:v>1001</c:v>
                </c:pt>
                <c:pt idx="15">
                  <c:v>0</c:v>
                </c:pt>
                <c:pt idx="16">
                  <c:v>0</c:v>
                </c:pt>
                <c:pt idx="17">
                  <c:v>3408</c:v>
                </c:pt>
                <c:pt idx="18">
                  <c:v>2751</c:v>
                </c:pt>
                <c:pt idx="19">
                  <c:v>3078</c:v>
                </c:pt>
                <c:pt idx="20">
                  <c:v>4185</c:v>
                </c:pt>
                <c:pt idx="21">
                  <c:v>3394</c:v>
                </c:pt>
                <c:pt idx="22">
                  <c:v>0</c:v>
                </c:pt>
                <c:pt idx="23">
                  <c:v>2742</c:v>
                </c:pt>
                <c:pt idx="24">
                  <c:v>3812</c:v>
                </c:pt>
                <c:pt idx="25">
                  <c:v>6477</c:v>
                </c:pt>
                <c:pt idx="26">
                  <c:v>6045</c:v>
                </c:pt>
                <c:pt idx="27">
                  <c:v>6983</c:v>
                </c:pt>
                <c:pt idx="28">
                  <c:v>3629</c:v>
                </c:pt>
                <c:pt idx="29">
                  <c:v>1770</c:v>
                </c:pt>
                <c:pt idx="30">
                  <c:v>1874</c:v>
                </c:pt>
                <c:pt idx="31">
                  <c:v>2235</c:v>
                </c:pt>
                <c:pt idx="32">
                  <c:v>3153</c:v>
                </c:pt>
                <c:pt idx="33">
                  <c:v>3762</c:v>
                </c:pt>
                <c:pt idx="34">
                  <c:v>2653</c:v>
                </c:pt>
                <c:pt idx="35">
                  <c:v>2594</c:v>
                </c:pt>
                <c:pt idx="36">
                  <c:v>2627</c:v>
                </c:pt>
                <c:pt idx="37">
                  <c:v>5214</c:v>
                </c:pt>
                <c:pt idx="38">
                  <c:v>2579</c:v>
                </c:pt>
                <c:pt idx="39">
                  <c:v>3162</c:v>
                </c:pt>
                <c:pt idx="40">
                  <c:v>2706</c:v>
                </c:pt>
                <c:pt idx="41">
                  <c:v>2406</c:v>
                </c:pt>
                <c:pt idx="42">
                  <c:v>2181</c:v>
                </c:pt>
                <c:pt idx="43">
                  <c:v>2465</c:v>
                </c:pt>
                <c:pt idx="44">
                  <c:v>2384</c:v>
                </c:pt>
                <c:pt idx="45">
                  <c:v>2188</c:v>
                </c:pt>
                <c:pt idx="46">
                  <c:v>1936</c:v>
                </c:pt>
                <c:pt idx="47">
                  <c:v>1214</c:v>
                </c:pt>
                <c:pt idx="48">
                  <c:v>1193</c:v>
                </c:pt>
                <c:pt idx="49">
                  <c:v>1232</c:v>
                </c:pt>
                <c:pt idx="50">
                  <c:v>0</c:v>
                </c:pt>
                <c:pt idx="51">
                  <c:v>0</c:v>
                </c:pt>
                <c:pt idx="52">
                  <c:v>1237</c:v>
                </c:pt>
                <c:pt idx="53">
                  <c:v>1372</c:v>
                </c:pt>
                <c:pt idx="54">
                  <c:v>0</c:v>
                </c:pt>
                <c:pt idx="55">
                  <c:v>1540</c:v>
                </c:pt>
                <c:pt idx="56">
                  <c:v>1563</c:v>
                </c:pt>
                <c:pt idx="57">
                  <c:v>1331</c:v>
                </c:pt>
                <c:pt idx="58">
                  <c:v>1325</c:v>
                </c:pt>
                <c:pt idx="59">
                  <c:v>1372</c:v>
                </c:pt>
                <c:pt idx="60">
                  <c:v>1525</c:v>
                </c:pt>
                <c:pt idx="61">
                  <c:v>1525</c:v>
                </c:pt>
                <c:pt idx="62">
                  <c:v>1883</c:v>
                </c:pt>
                <c:pt idx="63">
                  <c:v>1891</c:v>
                </c:pt>
                <c:pt idx="64">
                  <c:v>1556</c:v>
                </c:pt>
                <c:pt idx="65">
                  <c:v>1708</c:v>
                </c:pt>
                <c:pt idx="66">
                  <c:v>1450</c:v>
                </c:pt>
                <c:pt idx="67">
                  <c:v>1476</c:v>
                </c:pt>
                <c:pt idx="68">
                  <c:v>1482</c:v>
                </c:pt>
                <c:pt idx="69">
                  <c:v>1276</c:v>
                </c:pt>
                <c:pt idx="70">
                  <c:v>1046</c:v>
                </c:pt>
                <c:pt idx="71">
                  <c:v>0</c:v>
                </c:pt>
                <c:pt idx="72">
                  <c:v>1078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E29-3342-A2AA-0E5784E973CA}"/>
            </c:ext>
          </c:extLst>
        </c:ser>
        <c:ser>
          <c:idx val="5"/>
          <c:order val="5"/>
          <c:tx>
            <c:strRef>
              <c:f>Neat!$A$9</c:f>
              <c:strCache>
                <c:ptCount val="1"/>
                <c:pt idx="0">
                  <c:v>A2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:$CA$9</c:f>
              <c:numCache>
                <c:formatCode>General</c:formatCode>
                <c:ptCount val="78"/>
                <c:pt idx="0">
                  <c:v>10046</c:v>
                </c:pt>
                <c:pt idx="1">
                  <c:v>8140</c:v>
                </c:pt>
                <c:pt idx="2">
                  <c:v>8767</c:v>
                </c:pt>
                <c:pt idx="3">
                  <c:v>8704</c:v>
                </c:pt>
                <c:pt idx="4">
                  <c:v>6398</c:v>
                </c:pt>
                <c:pt idx="5">
                  <c:v>3784</c:v>
                </c:pt>
                <c:pt idx="6">
                  <c:v>7089</c:v>
                </c:pt>
                <c:pt idx="7">
                  <c:v>7639</c:v>
                </c:pt>
                <c:pt idx="8">
                  <c:v>3778</c:v>
                </c:pt>
                <c:pt idx="9">
                  <c:v>8060</c:v>
                </c:pt>
                <c:pt idx="10">
                  <c:v>4161</c:v>
                </c:pt>
                <c:pt idx="11">
                  <c:v>4421</c:v>
                </c:pt>
                <c:pt idx="12">
                  <c:v>3832</c:v>
                </c:pt>
                <c:pt idx="13">
                  <c:v>2775</c:v>
                </c:pt>
                <c:pt idx="14">
                  <c:v>1819</c:v>
                </c:pt>
                <c:pt idx="15">
                  <c:v>0</c:v>
                </c:pt>
                <c:pt idx="16">
                  <c:v>1197</c:v>
                </c:pt>
                <c:pt idx="17">
                  <c:v>3751</c:v>
                </c:pt>
                <c:pt idx="18">
                  <c:v>2984</c:v>
                </c:pt>
                <c:pt idx="19">
                  <c:v>3418</c:v>
                </c:pt>
                <c:pt idx="20">
                  <c:v>5048</c:v>
                </c:pt>
                <c:pt idx="21">
                  <c:v>3970</c:v>
                </c:pt>
                <c:pt idx="22">
                  <c:v>1337</c:v>
                </c:pt>
                <c:pt idx="23">
                  <c:v>2943</c:v>
                </c:pt>
                <c:pt idx="24">
                  <c:v>4190</c:v>
                </c:pt>
                <c:pt idx="25">
                  <c:v>6599</c:v>
                </c:pt>
                <c:pt idx="26">
                  <c:v>5323</c:v>
                </c:pt>
                <c:pt idx="27">
                  <c:v>6299</c:v>
                </c:pt>
                <c:pt idx="28">
                  <c:v>3323</c:v>
                </c:pt>
                <c:pt idx="29">
                  <c:v>2292</c:v>
                </c:pt>
                <c:pt idx="30">
                  <c:v>2312</c:v>
                </c:pt>
                <c:pt idx="31">
                  <c:v>2721</c:v>
                </c:pt>
                <c:pt idx="32">
                  <c:v>2998</c:v>
                </c:pt>
                <c:pt idx="33">
                  <c:v>4626</c:v>
                </c:pt>
                <c:pt idx="34">
                  <c:v>3361</c:v>
                </c:pt>
                <c:pt idx="35">
                  <c:v>3490</c:v>
                </c:pt>
                <c:pt idx="36">
                  <c:v>3590</c:v>
                </c:pt>
                <c:pt idx="37">
                  <c:v>6399</c:v>
                </c:pt>
                <c:pt idx="38">
                  <c:v>3304</c:v>
                </c:pt>
                <c:pt idx="39">
                  <c:v>3991</c:v>
                </c:pt>
                <c:pt idx="40">
                  <c:v>3765</c:v>
                </c:pt>
                <c:pt idx="41">
                  <c:v>3433</c:v>
                </c:pt>
                <c:pt idx="42">
                  <c:v>3043</c:v>
                </c:pt>
                <c:pt idx="43">
                  <c:v>3229</c:v>
                </c:pt>
                <c:pt idx="44">
                  <c:v>3197</c:v>
                </c:pt>
                <c:pt idx="45">
                  <c:v>2934</c:v>
                </c:pt>
                <c:pt idx="46">
                  <c:v>2511</c:v>
                </c:pt>
                <c:pt idx="47">
                  <c:v>1656</c:v>
                </c:pt>
                <c:pt idx="48">
                  <c:v>1742</c:v>
                </c:pt>
                <c:pt idx="49">
                  <c:v>1744</c:v>
                </c:pt>
                <c:pt idx="50">
                  <c:v>1396</c:v>
                </c:pt>
                <c:pt idx="51">
                  <c:v>1433</c:v>
                </c:pt>
                <c:pt idx="52">
                  <c:v>2093</c:v>
                </c:pt>
                <c:pt idx="53">
                  <c:v>2832</c:v>
                </c:pt>
                <c:pt idx="54">
                  <c:v>1404</c:v>
                </c:pt>
                <c:pt idx="55">
                  <c:v>4164</c:v>
                </c:pt>
                <c:pt idx="56">
                  <c:v>4751</c:v>
                </c:pt>
                <c:pt idx="57">
                  <c:v>3692</c:v>
                </c:pt>
                <c:pt idx="58">
                  <c:v>3955</c:v>
                </c:pt>
                <c:pt idx="59">
                  <c:v>4033</c:v>
                </c:pt>
                <c:pt idx="60">
                  <c:v>4216</c:v>
                </c:pt>
                <c:pt idx="61">
                  <c:v>4154</c:v>
                </c:pt>
                <c:pt idx="62">
                  <c:v>5145</c:v>
                </c:pt>
                <c:pt idx="63">
                  <c:v>5382</c:v>
                </c:pt>
                <c:pt idx="64">
                  <c:v>4032</c:v>
                </c:pt>
                <c:pt idx="65">
                  <c:v>4394</c:v>
                </c:pt>
                <c:pt idx="66">
                  <c:v>4248</c:v>
                </c:pt>
                <c:pt idx="67">
                  <c:v>3894</c:v>
                </c:pt>
                <c:pt idx="68">
                  <c:v>3648</c:v>
                </c:pt>
                <c:pt idx="69">
                  <c:v>2971</c:v>
                </c:pt>
                <c:pt idx="70">
                  <c:v>2790</c:v>
                </c:pt>
                <c:pt idx="71">
                  <c:v>2064</c:v>
                </c:pt>
                <c:pt idx="72">
                  <c:v>2275</c:v>
                </c:pt>
                <c:pt idx="73">
                  <c:v>1767</c:v>
                </c:pt>
                <c:pt idx="74">
                  <c:v>2315</c:v>
                </c:pt>
                <c:pt idx="75">
                  <c:v>2210</c:v>
                </c:pt>
                <c:pt idx="76">
                  <c:v>2037</c:v>
                </c:pt>
                <c:pt idx="77">
                  <c:v>14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E29-3342-A2AA-0E5784E973CA}"/>
            </c:ext>
          </c:extLst>
        </c:ser>
        <c:ser>
          <c:idx val="6"/>
          <c:order val="6"/>
          <c:tx>
            <c:strRef>
              <c:f>Neat!$A$10</c:f>
              <c:strCache>
                <c:ptCount val="1"/>
                <c:pt idx="0">
                  <c:v>A29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0:$CA$10</c:f>
              <c:numCache>
                <c:formatCode>General</c:formatCode>
                <c:ptCount val="78"/>
                <c:pt idx="0">
                  <c:v>12260</c:v>
                </c:pt>
                <c:pt idx="1">
                  <c:v>19353</c:v>
                </c:pt>
                <c:pt idx="2">
                  <c:v>18581</c:v>
                </c:pt>
                <c:pt idx="3">
                  <c:v>16943</c:v>
                </c:pt>
                <c:pt idx="4">
                  <c:v>22564</c:v>
                </c:pt>
                <c:pt idx="5">
                  <c:v>22101</c:v>
                </c:pt>
                <c:pt idx="6">
                  <c:v>23393</c:v>
                </c:pt>
                <c:pt idx="7">
                  <c:v>24314</c:v>
                </c:pt>
                <c:pt idx="8">
                  <c:v>20843</c:v>
                </c:pt>
                <c:pt idx="9">
                  <c:v>20235</c:v>
                </c:pt>
                <c:pt idx="10">
                  <c:v>21677</c:v>
                </c:pt>
                <c:pt idx="11">
                  <c:v>20273</c:v>
                </c:pt>
                <c:pt idx="12">
                  <c:v>19697</c:v>
                </c:pt>
                <c:pt idx="13">
                  <c:v>19985</c:v>
                </c:pt>
                <c:pt idx="14">
                  <c:v>18236</c:v>
                </c:pt>
                <c:pt idx="15">
                  <c:v>9049</c:v>
                </c:pt>
                <c:pt idx="16">
                  <c:v>14790</c:v>
                </c:pt>
                <c:pt idx="17">
                  <c:v>20616</c:v>
                </c:pt>
                <c:pt idx="18">
                  <c:v>18009</c:v>
                </c:pt>
                <c:pt idx="19">
                  <c:v>19806</c:v>
                </c:pt>
                <c:pt idx="20">
                  <c:v>20390</c:v>
                </c:pt>
                <c:pt idx="21">
                  <c:v>20536</c:v>
                </c:pt>
                <c:pt idx="22">
                  <c:v>10639</c:v>
                </c:pt>
                <c:pt idx="23">
                  <c:v>14523</c:v>
                </c:pt>
                <c:pt idx="24">
                  <c:v>17922</c:v>
                </c:pt>
                <c:pt idx="25">
                  <c:v>20904</c:v>
                </c:pt>
                <c:pt idx="26">
                  <c:v>24051</c:v>
                </c:pt>
                <c:pt idx="27">
                  <c:v>22586</c:v>
                </c:pt>
                <c:pt idx="28">
                  <c:v>19144</c:v>
                </c:pt>
                <c:pt idx="29">
                  <c:v>12946</c:v>
                </c:pt>
                <c:pt idx="30">
                  <c:v>15306</c:v>
                </c:pt>
                <c:pt idx="31">
                  <c:v>16112</c:v>
                </c:pt>
                <c:pt idx="32">
                  <c:v>18631</c:v>
                </c:pt>
                <c:pt idx="33">
                  <c:v>21797</c:v>
                </c:pt>
                <c:pt idx="34">
                  <c:v>18983</c:v>
                </c:pt>
                <c:pt idx="35">
                  <c:v>21136</c:v>
                </c:pt>
                <c:pt idx="36">
                  <c:v>20997</c:v>
                </c:pt>
                <c:pt idx="37">
                  <c:v>22080</c:v>
                </c:pt>
                <c:pt idx="38">
                  <c:v>20021</c:v>
                </c:pt>
                <c:pt idx="39">
                  <c:v>20504</c:v>
                </c:pt>
                <c:pt idx="40">
                  <c:v>20431</c:v>
                </c:pt>
                <c:pt idx="41">
                  <c:v>20396</c:v>
                </c:pt>
                <c:pt idx="42">
                  <c:v>18880</c:v>
                </c:pt>
                <c:pt idx="43">
                  <c:v>18894</c:v>
                </c:pt>
                <c:pt idx="44">
                  <c:v>18615</c:v>
                </c:pt>
                <c:pt idx="45">
                  <c:v>18867</c:v>
                </c:pt>
                <c:pt idx="46">
                  <c:v>16094</c:v>
                </c:pt>
                <c:pt idx="47">
                  <c:v>13333</c:v>
                </c:pt>
                <c:pt idx="48">
                  <c:v>15514</c:v>
                </c:pt>
                <c:pt idx="49">
                  <c:v>16776</c:v>
                </c:pt>
                <c:pt idx="50">
                  <c:v>14061</c:v>
                </c:pt>
                <c:pt idx="51">
                  <c:v>16462</c:v>
                </c:pt>
                <c:pt idx="52">
                  <c:v>16374</c:v>
                </c:pt>
                <c:pt idx="53">
                  <c:v>17977</c:v>
                </c:pt>
                <c:pt idx="54">
                  <c:v>10480</c:v>
                </c:pt>
                <c:pt idx="55">
                  <c:v>20285</c:v>
                </c:pt>
                <c:pt idx="56">
                  <c:v>22358</c:v>
                </c:pt>
                <c:pt idx="57">
                  <c:v>20842</c:v>
                </c:pt>
                <c:pt idx="58">
                  <c:v>20414</c:v>
                </c:pt>
                <c:pt idx="59">
                  <c:v>21250</c:v>
                </c:pt>
                <c:pt idx="60">
                  <c:v>18568</c:v>
                </c:pt>
                <c:pt idx="61">
                  <c:v>22960</c:v>
                </c:pt>
                <c:pt idx="62">
                  <c:v>23418</c:v>
                </c:pt>
                <c:pt idx="63">
                  <c:v>23202</c:v>
                </c:pt>
                <c:pt idx="64">
                  <c:v>22812</c:v>
                </c:pt>
                <c:pt idx="65">
                  <c:v>22605</c:v>
                </c:pt>
                <c:pt idx="66">
                  <c:v>21691</c:v>
                </c:pt>
                <c:pt idx="67">
                  <c:v>23454</c:v>
                </c:pt>
                <c:pt idx="68">
                  <c:v>24696</c:v>
                </c:pt>
                <c:pt idx="69">
                  <c:v>23206</c:v>
                </c:pt>
                <c:pt idx="70">
                  <c:v>18087</c:v>
                </c:pt>
                <c:pt idx="71">
                  <c:v>23830</c:v>
                </c:pt>
                <c:pt idx="72">
                  <c:v>23724</c:v>
                </c:pt>
                <c:pt idx="73">
                  <c:v>21938</c:v>
                </c:pt>
                <c:pt idx="74">
                  <c:v>21957</c:v>
                </c:pt>
                <c:pt idx="75">
                  <c:v>23213</c:v>
                </c:pt>
                <c:pt idx="76">
                  <c:v>23595</c:v>
                </c:pt>
                <c:pt idx="77">
                  <c:v>159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E29-3342-A2AA-0E5784E973CA}"/>
            </c:ext>
          </c:extLst>
        </c:ser>
        <c:ser>
          <c:idx val="7"/>
          <c:order val="7"/>
          <c:tx>
            <c:strRef>
              <c:f>Neat!$A$11</c:f>
              <c:strCache>
                <c:ptCount val="1"/>
                <c:pt idx="0">
                  <c:v>A3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1:$CA$11</c:f>
              <c:numCache>
                <c:formatCode>General</c:formatCode>
                <c:ptCount val="78"/>
                <c:pt idx="0">
                  <c:v>15248</c:v>
                </c:pt>
                <c:pt idx="1">
                  <c:v>18211</c:v>
                </c:pt>
                <c:pt idx="2">
                  <c:v>19560</c:v>
                </c:pt>
                <c:pt idx="3">
                  <c:v>19025</c:v>
                </c:pt>
                <c:pt idx="4">
                  <c:v>17520</c:v>
                </c:pt>
                <c:pt idx="5">
                  <c:v>13602</c:v>
                </c:pt>
                <c:pt idx="6">
                  <c:v>18328</c:v>
                </c:pt>
                <c:pt idx="7">
                  <c:v>19207</c:v>
                </c:pt>
                <c:pt idx="8">
                  <c:v>11880</c:v>
                </c:pt>
                <c:pt idx="9">
                  <c:v>17982</c:v>
                </c:pt>
                <c:pt idx="10">
                  <c:v>11939</c:v>
                </c:pt>
                <c:pt idx="11">
                  <c:v>13460</c:v>
                </c:pt>
                <c:pt idx="12">
                  <c:v>12854</c:v>
                </c:pt>
                <c:pt idx="13">
                  <c:v>9601</c:v>
                </c:pt>
                <c:pt idx="14">
                  <c:v>7443</c:v>
                </c:pt>
                <c:pt idx="15">
                  <c:v>2313</c:v>
                </c:pt>
                <c:pt idx="16">
                  <c:v>4564</c:v>
                </c:pt>
                <c:pt idx="17">
                  <c:v>11732</c:v>
                </c:pt>
                <c:pt idx="18">
                  <c:v>10091</c:v>
                </c:pt>
                <c:pt idx="19">
                  <c:v>10614</c:v>
                </c:pt>
                <c:pt idx="20">
                  <c:v>13850</c:v>
                </c:pt>
                <c:pt idx="21">
                  <c:v>11828</c:v>
                </c:pt>
                <c:pt idx="22">
                  <c:v>5172</c:v>
                </c:pt>
                <c:pt idx="23">
                  <c:v>8933</c:v>
                </c:pt>
                <c:pt idx="24">
                  <c:v>12095</c:v>
                </c:pt>
                <c:pt idx="25">
                  <c:v>15604</c:v>
                </c:pt>
                <c:pt idx="26">
                  <c:v>17006</c:v>
                </c:pt>
                <c:pt idx="27">
                  <c:v>17945</c:v>
                </c:pt>
                <c:pt idx="28">
                  <c:v>12183</c:v>
                </c:pt>
                <c:pt idx="29">
                  <c:v>6421</c:v>
                </c:pt>
                <c:pt idx="30">
                  <c:v>7969</c:v>
                </c:pt>
                <c:pt idx="31">
                  <c:v>9140</c:v>
                </c:pt>
                <c:pt idx="32">
                  <c:v>11546</c:v>
                </c:pt>
                <c:pt idx="33">
                  <c:v>13575</c:v>
                </c:pt>
                <c:pt idx="34">
                  <c:v>10314</c:v>
                </c:pt>
                <c:pt idx="35">
                  <c:v>11478</c:v>
                </c:pt>
                <c:pt idx="36">
                  <c:v>11776</c:v>
                </c:pt>
                <c:pt idx="37">
                  <c:v>17023</c:v>
                </c:pt>
                <c:pt idx="38">
                  <c:v>10797</c:v>
                </c:pt>
                <c:pt idx="39">
                  <c:v>12693</c:v>
                </c:pt>
                <c:pt idx="40">
                  <c:v>11673</c:v>
                </c:pt>
                <c:pt idx="41">
                  <c:v>10856</c:v>
                </c:pt>
                <c:pt idx="42">
                  <c:v>9990</c:v>
                </c:pt>
                <c:pt idx="43">
                  <c:v>10560</c:v>
                </c:pt>
                <c:pt idx="44">
                  <c:v>10794</c:v>
                </c:pt>
                <c:pt idx="45">
                  <c:v>10182</c:v>
                </c:pt>
                <c:pt idx="46">
                  <c:v>6532</c:v>
                </c:pt>
                <c:pt idx="47">
                  <c:v>4559</c:v>
                </c:pt>
                <c:pt idx="48">
                  <c:v>5578</c:v>
                </c:pt>
                <c:pt idx="49">
                  <c:v>6251</c:v>
                </c:pt>
                <c:pt idx="50">
                  <c:v>5046</c:v>
                </c:pt>
                <c:pt idx="51">
                  <c:v>5694</c:v>
                </c:pt>
                <c:pt idx="52">
                  <c:v>6664</c:v>
                </c:pt>
                <c:pt idx="53">
                  <c:v>7724</c:v>
                </c:pt>
                <c:pt idx="54">
                  <c:v>3249</c:v>
                </c:pt>
                <c:pt idx="55">
                  <c:v>9719</c:v>
                </c:pt>
                <c:pt idx="56">
                  <c:v>10898</c:v>
                </c:pt>
                <c:pt idx="57">
                  <c:v>8879</c:v>
                </c:pt>
                <c:pt idx="58">
                  <c:v>10042</c:v>
                </c:pt>
                <c:pt idx="59">
                  <c:v>10253</c:v>
                </c:pt>
                <c:pt idx="60">
                  <c:v>10721</c:v>
                </c:pt>
                <c:pt idx="61">
                  <c:v>11595</c:v>
                </c:pt>
                <c:pt idx="62">
                  <c:v>12969</c:v>
                </c:pt>
                <c:pt idx="63">
                  <c:v>13721</c:v>
                </c:pt>
                <c:pt idx="64">
                  <c:v>11123</c:v>
                </c:pt>
                <c:pt idx="65">
                  <c:v>12625</c:v>
                </c:pt>
                <c:pt idx="66">
                  <c:v>10944</c:v>
                </c:pt>
                <c:pt idx="67">
                  <c:v>11194</c:v>
                </c:pt>
                <c:pt idx="68">
                  <c:v>10991</c:v>
                </c:pt>
                <c:pt idx="69">
                  <c:v>10343</c:v>
                </c:pt>
                <c:pt idx="70">
                  <c:v>9929</c:v>
                </c:pt>
                <c:pt idx="71">
                  <c:v>10514</c:v>
                </c:pt>
                <c:pt idx="72">
                  <c:v>10518</c:v>
                </c:pt>
                <c:pt idx="73">
                  <c:v>9502</c:v>
                </c:pt>
                <c:pt idx="74">
                  <c:v>10159</c:v>
                </c:pt>
                <c:pt idx="75">
                  <c:v>10542</c:v>
                </c:pt>
                <c:pt idx="76">
                  <c:v>10258</c:v>
                </c:pt>
                <c:pt idx="77">
                  <c:v>62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E29-3342-A2AA-0E5784E973CA}"/>
            </c:ext>
          </c:extLst>
        </c:ser>
        <c:ser>
          <c:idx val="8"/>
          <c:order val="8"/>
          <c:tx>
            <c:strRef>
              <c:f>Neat!$A$12</c:f>
              <c:strCache>
                <c:ptCount val="1"/>
                <c:pt idx="0">
                  <c:v>A30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2:$CA$12</c:f>
              <c:numCache>
                <c:formatCode>General</c:formatCode>
                <c:ptCount val="78"/>
                <c:pt idx="0">
                  <c:v>13861</c:v>
                </c:pt>
                <c:pt idx="1">
                  <c:v>17263</c:v>
                </c:pt>
                <c:pt idx="2">
                  <c:v>18564</c:v>
                </c:pt>
                <c:pt idx="3">
                  <c:v>17903</c:v>
                </c:pt>
                <c:pt idx="4">
                  <c:v>18076</c:v>
                </c:pt>
                <c:pt idx="5">
                  <c:v>14425</c:v>
                </c:pt>
                <c:pt idx="6">
                  <c:v>18855</c:v>
                </c:pt>
                <c:pt idx="7">
                  <c:v>19631</c:v>
                </c:pt>
                <c:pt idx="8">
                  <c:v>12861</c:v>
                </c:pt>
                <c:pt idx="9">
                  <c:v>18158</c:v>
                </c:pt>
                <c:pt idx="10">
                  <c:v>14145</c:v>
                </c:pt>
                <c:pt idx="11">
                  <c:v>14156</c:v>
                </c:pt>
                <c:pt idx="12">
                  <c:v>13472</c:v>
                </c:pt>
                <c:pt idx="13">
                  <c:v>11807</c:v>
                </c:pt>
                <c:pt idx="14">
                  <c:v>9573</c:v>
                </c:pt>
                <c:pt idx="15">
                  <c:v>3933</c:v>
                </c:pt>
                <c:pt idx="16">
                  <c:v>6766</c:v>
                </c:pt>
                <c:pt idx="17">
                  <c:v>11669</c:v>
                </c:pt>
                <c:pt idx="18">
                  <c:v>10411</c:v>
                </c:pt>
                <c:pt idx="19">
                  <c:v>11182</c:v>
                </c:pt>
                <c:pt idx="20">
                  <c:v>13747</c:v>
                </c:pt>
                <c:pt idx="21">
                  <c:v>12079</c:v>
                </c:pt>
                <c:pt idx="22">
                  <c:v>5638</c:v>
                </c:pt>
                <c:pt idx="23">
                  <c:v>8742</c:v>
                </c:pt>
                <c:pt idx="24">
                  <c:v>11464</c:v>
                </c:pt>
                <c:pt idx="25">
                  <c:v>14714</c:v>
                </c:pt>
                <c:pt idx="26">
                  <c:v>15621</c:v>
                </c:pt>
                <c:pt idx="27">
                  <c:v>15984</c:v>
                </c:pt>
                <c:pt idx="28">
                  <c:v>11099</c:v>
                </c:pt>
                <c:pt idx="29">
                  <c:v>7394</c:v>
                </c:pt>
                <c:pt idx="30">
                  <c:v>8833</c:v>
                </c:pt>
                <c:pt idx="31">
                  <c:v>9892</c:v>
                </c:pt>
                <c:pt idx="32">
                  <c:v>11876</c:v>
                </c:pt>
                <c:pt idx="33">
                  <c:v>14462</c:v>
                </c:pt>
                <c:pt idx="34">
                  <c:v>11059</c:v>
                </c:pt>
                <c:pt idx="35">
                  <c:v>13160</c:v>
                </c:pt>
                <c:pt idx="36">
                  <c:v>13082</c:v>
                </c:pt>
                <c:pt idx="37">
                  <c:v>17454</c:v>
                </c:pt>
                <c:pt idx="38">
                  <c:v>12665</c:v>
                </c:pt>
                <c:pt idx="39">
                  <c:v>13609</c:v>
                </c:pt>
                <c:pt idx="40">
                  <c:v>13083</c:v>
                </c:pt>
                <c:pt idx="41">
                  <c:v>12911</c:v>
                </c:pt>
                <c:pt idx="42">
                  <c:v>12077</c:v>
                </c:pt>
                <c:pt idx="43">
                  <c:v>12105</c:v>
                </c:pt>
                <c:pt idx="44">
                  <c:v>12476</c:v>
                </c:pt>
                <c:pt idx="45">
                  <c:v>11784</c:v>
                </c:pt>
                <c:pt idx="46">
                  <c:v>9045</c:v>
                </c:pt>
                <c:pt idx="47">
                  <c:v>7008</c:v>
                </c:pt>
                <c:pt idx="48">
                  <c:v>8134</c:v>
                </c:pt>
                <c:pt idx="49">
                  <c:v>8642</c:v>
                </c:pt>
                <c:pt idx="50">
                  <c:v>7315</c:v>
                </c:pt>
                <c:pt idx="51">
                  <c:v>8265</c:v>
                </c:pt>
                <c:pt idx="52">
                  <c:v>9625</c:v>
                </c:pt>
                <c:pt idx="53">
                  <c:v>11122</c:v>
                </c:pt>
                <c:pt idx="54">
                  <c:v>5310</c:v>
                </c:pt>
                <c:pt idx="55">
                  <c:v>12944</c:v>
                </c:pt>
                <c:pt idx="56">
                  <c:v>15010</c:v>
                </c:pt>
                <c:pt idx="57">
                  <c:v>13235</c:v>
                </c:pt>
                <c:pt idx="58">
                  <c:v>13463</c:v>
                </c:pt>
                <c:pt idx="59">
                  <c:v>13950</c:v>
                </c:pt>
                <c:pt idx="60">
                  <c:v>14087</c:v>
                </c:pt>
                <c:pt idx="61">
                  <c:v>15739</c:v>
                </c:pt>
                <c:pt idx="62">
                  <c:v>16607</c:v>
                </c:pt>
                <c:pt idx="63">
                  <c:v>16980</c:v>
                </c:pt>
                <c:pt idx="64">
                  <c:v>15708</c:v>
                </c:pt>
                <c:pt idx="65">
                  <c:v>16533</c:v>
                </c:pt>
                <c:pt idx="66">
                  <c:v>15112</c:v>
                </c:pt>
                <c:pt idx="67">
                  <c:v>14967</c:v>
                </c:pt>
                <c:pt idx="68">
                  <c:v>15735</c:v>
                </c:pt>
                <c:pt idx="69">
                  <c:v>14018</c:v>
                </c:pt>
                <c:pt idx="70">
                  <c:v>11179</c:v>
                </c:pt>
                <c:pt idx="71">
                  <c:v>11875</c:v>
                </c:pt>
                <c:pt idx="72">
                  <c:v>11807</c:v>
                </c:pt>
                <c:pt idx="73">
                  <c:v>10546</c:v>
                </c:pt>
                <c:pt idx="74">
                  <c:v>11687</c:v>
                </c:pt>
                <c:pt idx="75">
                  <c:v>12040</c:v>
                </c:pt>
                <c:pt idx="76">
                  <c:v>11454</c:v>
                </c:pt>
                <c:pt idx="77">
                  <c:v>83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E29-3342-A2AA-0E5784E973CA}"/>
            </c:ext>
          </c:extLst>
        </c:ser>
        <c:ser>
          <c:idx val="9"/>
          <c:order val="9"/>
          <c:tx>
            <c:strRef>
              <c:f>Neat!$A$13</c:f>
              <c:strCache>
                <c:ptCount val="1"/>
                <c:pt idx="0">
                  <c:v>A31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3:$CA$13</c:f>
              <c:numCache>
                <c:formatCode>General</c:formatCode>
                <c:ptCount val="78"/>
                <c:pt idx="0">
                  <c:v>13320</c:v>
                </c:pt>
                <c:pt idx="1">
                  <c:v>17050</c:v>
                </c:pt>
                <c:pt idx="2">
                  <c:v>17806</c:v>
                </c:pt>
                <c:pt idx="3">
                  <c:v>17835</c:v>
                </c:pt>
                <c:pt idx="4">
                  <c:v>16308</c:v>
                </c:pt>
                <c:pt idx="5">
                  <c:v>13089</c:v>
                </c:pt>
                <c:pt idx="6">
                  <c:v>17585</c:v>
                </c:pt>
                <c:pt idx="7">
                  <c:v>18429</c:v>
                </c:pt>
                <c:pt idx="8">
                  <c:v>11964</c:v>
                </c:pt>
                <c:pt idx="9">
                  <c:v>17196</c:v>
                </c:pt>
                <c:pt idx="10">
                  <c:v>12424</c:v>
                </c:pt>
                <c:pt idx="11">
                  <c:v>13533</c:v>
                </c:pt>
                <c:pt idx="12">
                  <c:v>11729</c:v>
                </c:pt>
                <c:pt idx="13">
                  <c:v>9426</c:v>
                </c:pt>
                <c:pt idx="14">
                  <c:v>7413</c:v>
                </c:pt>
                <c:pt idx="15">
                  <c:v>2473</c:v>
                </c:pt>
                <c:pt idx="16">
                  <c:v>4854</c:v>
                </c:pt>
                <c:pt idx="17">
                  <c:v>8801</c:v>
                </c:pt>
                <c:pt idx="18">
                  <c:v>7730</c:v>
                </c:pt>
                <c:pt idx="19">
                  <c:v>8870</c:v>
                </c:pt>
                <c:pt idx="20">
                  <c:v>11011</c:v>
                </c:pt>
                <c:pt idx="21">
                  <c:v>9700</c:v>
                </c:pt>
                <c:pt idx="22">
                  <c:v>4197</c:v>
                </c:pt>
                <c:pt idx="23">
                  <c:v>7320</c:v>
                </c:pt>
                <c:pt idx="24">
                  <c:v>9799</c:v>
                </c:pt>
                <c:pt idx="25">
                  <c:v>12869</c:v>
                </c:pt>
                <c:pt idx="26">
                  <c:v>13974</c:v>
                </c:pt>
                <c:pt idx="27">
                  <c:v>14510</c:v>
                </c:pt>
                <c:pt idx="28">
                  <c:v>9689</c:v>
                </c:pt>
                <c:pt idx="29">
                  <c:v>5861</c:v>
                </c:pt>
                <c:pt idx="30">
                  <c:v>7380</c:v>
                </c:pt>
                <c:pt idx="31">
                  <c:v>8503</c:v>
                </c:pt>
                <c:pt idx="32">
                  <c:v>10747</c:v>
                </c:pt>
                <c:pt idx="33">
                  <c:v>12740</c:v>
                </c:pt>
                <c:pt idx="34">
                  <c:v>10176</c:v>
                </c:pt>
                <c:pt idx="35">
                  <c:v>11427</c:v>
                </c:pt>
                <c:pt idx="36">
                  <c:v>11033</c:v>
                </c:pt>
                <c:pt idx="37">
                  <c:v>16386</c:v>
                </c:pt>
                <c:pt idx="38">
                  <c:v>10858</c:v>
                </c:pt>
                <c:pt idx="39">
                  <c:v>12298</c:v>
                </c:pt>
                <c:pt idx="40">
                  <c:v>11718</c:v>
                </c:pt>
                <c:pt idx="41">
                  <c:v>10944</c:v>
                </c:pt>
                <c:pt idx="42">
                  <c:v>10284</c:v>
                </c:pt>
                <c:pt idx="43">
                  <c:v>10522</c:v>
                </c:pt>
                <c:pt idx="44">
                  <c:v>10579</c:v>
                </c:pt>
                <c:pt idx="45">
                  <c:v>10166</c:v>
                </c:pt>
                <c:pt idx="46">
                  <c:v>7481</c:v>
                </c:pt>
                <c:pt idx="47">
                  <c:v>5629</c:v>
                </c:pt>
                <c:pt idx="48">
                  <c:v>6545</c:v>
                </c:pt>
                <c:pt idx="49">
                  <c:v>6785</c:v>
                </c:pt>
                <c:pt idx="50">
                  <c:v>5772</c:v>
                </c:pt>
                <c:pt idx="51">
                  <c:v>6583</c:v>
                </c:pt>
                <c:pt idx="52">
                  <c:v>7595</c:v>
                </c:pt>
                <c:pt idx="53">
                  <c:v>8783</c:v>
                </c:pt>
                <c:pt idx="54">
                  <c:v>4178</c:v>
                </c:pt>
                <c:pt idx="55">
                  <c:v>9779</c:v>
                </c:pt>
                <c:pt idx="56">
                  <c:v>11169</c:v>
                </c:pt>
                <c:pt idx="57">
                  <c:v>9692</c:v>
                </c:pt>
                <c:pt idx="58">
                  <c:v>10431</c:v>
                </c:pt>
                <c:pt idx="59">
                  <c:v>10683</c:v>
                </c:pt>
                <c:pt idx="60">
                  <c:v>11488</c:v>
                </c:pt>
                <c:pt idx="61">
                  <c:v>12638</c:v>
                </c:pt>
                <c:pt idx="62">
                  <c:v>13984</c:v>
                </c:pt>
                <c:pt idx="63">
                  <c:v>14403</c:v>
                </c:pt>
                <c:pt idx="64">
                  <c:v>12286</c:v>
                </c:pt>
                <c:pt idx="65">
                  <c:v>13912</c:v>
                </c:pt>
                <c:pt idx="66">
                  <c:v>12031</c:v>
                </c:pt>
                <c:pt idx="67">
                  <c:v>12173</c:v>
                </c:pt>
                <c:pt idx="68">
                  <c:v>12971</c:v>
                </c:pt>
                <c:pt idx="69">
                  <c:v>11584</c:v>
                </c:pt>
                <c:pt idx="70">
                  <c:v>9362</c:v>
                </c:pt>
                <c:pt idx="71">
                  <c:v>9129</c:v>
                </c:pt>
                <c:pt idx="72">
                  <c:v>9462</c:v>
                </c:pt>
                <c:pt idx="73">
                  <c:v>8788</c:v>
                </c:pt>
                <c:pt idx="74">
                  <c:v>9218</c:v>
                </c:pt>
                <c:pt idx="75">
                  <c:v>9832</c:v>
                </c:pt>
                <c:pt idx="76">
                  <c:v>9116</c:v>
                </c:pt>
                <c:pt idx="77">
                  <c:v>60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E29-3342-A2AA-0E5784E973CA}"/>
            </c:ext>
          </c:extLst>
        </c:ser>
        <c:ser>
          <c:idx val="10"/>
          <c:order val="10"/>
          <c:tx>
            <c:strRef>
              <c:f>Neat!$A$14</c:f>
              <c:strCache>
                <c:ptCount val="1"/>
                <c:pt idx="0">
                  <c:v>A32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4:$CA$14</c:f>
              <c:numCache>
                <c:formatCode>General</c:formatCode>
                <c:ptCount val="78"/>
                <c:pt idx="0">
                  <c:v>10296</c:v>
                </c:pt>
                <c:pt idx="1">
                  <c:v>7797</c:v>
                </c:pt>
                <c:pt idx="2">
                  <c:v>8453</c:v>
                </c:pt>
                <c:pt idx="3">
                  <c:v>7674</c:v>
                </c:pt>
                <c:pt idx="4">
                  <c:v>5523</c:v>
                </c:pt>
                <c:pt idx="5">
                  <c:v>3503</c:v>
                </c:pt>
                <c:pt idx="6">
                  <c:v>6250</c:v>
                </c:pt>
                <c:pt idx="7">
                  <c:v>7073</c:v>
                </c:pt>
                <c:pt idx="8">
                  <c:v>2956</c:v>
                </c:pt>
                <c:pt idx="9">
                  <c:v>6351</c:v>
                </c:pt>
                <c:pt idx="10">
                  <c:v>2859</c:v>
                </c:pt>
                <c:pt idx="11">
                  <c:v>3305</c:v>
                </c:pt>
                <c:pt idx="12">
                  <c:v>3060</c:v>
                </c:pt>
                <c:pt idx="13">
                  <c:v>1875</c:v>
                </c:pt>
                <c:pt idx="14">
                  <c:v>1149</c:v>
                </c:pt>
                <c:pt idx="15">
                  <c:v>0</c:v>
                </c:pt>
                <c:pt idx="16">
                  <c:v>0</c:v>
                </c:pt>
                <c:pt idx="17">
                  <c:v>3241</c:v>
                </c:pt>
                <c:pt idx="18">
                  <c:v>2845</c:v>
                </c:pt>
                <c:pt idx="19">
                  <c:v>2730</c:v>
                </c:pt>
                <c:pt idx="20">
                  <c:v>3947</c:v>
                </c:pt>
                <c:pt idx="21">
                  <c:v>3463</c:v>
                </c:pt>
                <c:pt idx="22">
                  <c:v>1193</c:v>
                </c:pt>
                <c:pt idx="23">
                  <c:v>2777</c:v>
                </c:pt>
                <c:pt idx="24">
                  <c:v>3993</c:v>
                </c:pt>
                <c:pt idx="25">
                  <c:v>6450</c:v>
                </c:pt>
                <c:pt idx="26">
                  <c:v>6318</c:v>
                </c:pt>
                <c:pt idx="27">
                  <c:v>7480</c:v>
                </c:pt>
                <c:pt idx="28">
                  <c:v>4057</c:v>
                </c:pt>
                <c:pt idx="29">
                  <c:v>2177</c:v>
                </c:pt>
                <c:pt idx="30">
                  <c:v>2367</c:v>
                </c:pt>
                <c:pt idx="31">
                  <c:v>2827</c:v>
                </c:pt>
                <c:pt idx="32">
                  <c:v>3845</c:v>
                </c:pt>
                <c:pt idx="33">
                  <c:v>4752</c:v>
                </c:pt>
                <c:pt idx="34">
                  <c:v>3623</c:v>
                </c:pt>
                <c:pt idx="35">
                  <c:v>3518</c:v>
                </c:pt>
                <c:pt idx="36">
                  <c:v>3569</c:v>
                </c:pt>
                <c:pt idx="37">
                  <c:v>6474</c:v>
                </c:pt>
                <c:pt idx="38">
                  <c:v>3319</c:v>
                </c:pt>
                <c:pt idx="39">
                  <c:v>4005</c:v>
                </c:pt>
                <c:pt idx="40">
                  <c:v>3470</c:v>
                </c:pt>
                <c:pt idx="41">
                  <c:v>3203</c:v>
                </c:pt>
                <c:pt idx="42">
                  <c:v>2806</c:v>
                </c:pt>
                <c:pt idx="43">
                  <c:v>3110</c:v>
                </c:pt>
                <c:pt idx="44">
                  <c:v>2984</c:v>
                </c:pt>
                <c:pt idx="45">
                  <c:v>2874</c:v>
                </c:pt>
                <c:pt idx="46">
                  <c:v>1560</c:v>
                </c:pt>
                <c:pt idx="47">
                  <c:v>0</c:v>
                </c:pt>
                <c:pt idx="48">
                  <c:v>1207</c:v>
                </c:pt>
                <c:pt idx="49">
                  <c:v>1270</c:v>
                </c:pt>
                <c:pt idx="50">
                  <c:v>0</c:v>
                </c:pt>
                <c:pt idx="51">
                  <c:v>1184</c:v>
                </c:pt>
                <c:pt idx="52">
                  <c:v>1545</c:v>
                </c:pt>
                <c:pt idx="53">
                  <c:v>1694</c:v>
                </c:pt>
                <c:pt idx="54">
                  <c:v>0</c:v>
                </c:pt>
                <c:pt idx="55">
                  <c:v>1677</c:v>
                </c:pt>
                <c:pt idx="56">
                  <c:v>1764</c:v>
                </c:pt>
                <c:pt idx="57">
                  <c:v>1533</c:v>
                </c:pt>
                <c:pt idx="58">
                  <c:v>1608</c:v>
                </c:pt>
                <c:pt idx="59">
                  <c:v>1657</c:v>
                </c:pt>
                <c:pt idx="60">
                  <c:v>1890</c:v>
                </c:pt>
                <c:pt idx="61">
                  <c:v>1933</c:v>
                </c:pt>
                <c:pt idx="62">
                  <c:v>2312</c:v>
                </c:pt>
                <c:pt idx="63">
                  <c:v>2413</c:v>
                </c:pt>
                <c:pt idx="64">
                  <c:v>1933</c:v>
                </c:pt>
                <c:pt idx="65">
                  <c:v>2079</c:v>
                </c:pt>
                <c:pt idx="66">
                  <c:v>1773</c:v>
                </c:pt>
                <c:pt idx="67">
                  <c:v>1948</c:v>
                </c:pt>
                <c:pt idx="68">
                  <c:v>1988</c:v>
                </c:pt>
                <c:pt idx="69">
                  <c:v>1710</c:v>
                </c:pt>
                <c:pt idx="70">
                  <c:v>1538</c:v>
                </c:pt>
                <c:pt idx="71">
                  <c:v>1558</c:v>
                </c:pt>
                <c:pt idx="72">
                  <c:v>1632</c:v>
                </c:pt>
                <c:pt idx="73">
                  <c:v>1415</c:v>
                </c:pt>
                <c:pt idx="74">
                  <c:v>1511</c:v>
                </c:pt>
                <c:pt idx="75">
                  <c:v>1627</c:v>
                </c:pt>
                <c:pt idx="76">
                  <c:v>1563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E29-3342-A2AA-0E5784E973CA}"/>
            </c:ext>
          </c:extLst>
        </c:ser>
        <c:ser>
          <c:idx val="11"/>
          <c:order val="11"/>
          <c:tx>
            <c:strRef>
              <c:f>Neat!$A$15</c:f>
              <c:strCache>
                <c:ptCount val="1"/>
                <c:pt idx="0">
                  <c:v>A33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5:$CA$15</c:f>
              <c:numCache>
                <c:formatCode>General</c:formatCode>
                <c:ptCount val="78"/>
                <c:pt idx="0">
                  <c:v>13054</c:v>
                </c:pt>
                <c:pt idx="1">
                  <c:v>15136</c:v>
                </c:pt>
                <c:pt idx="2">
                  <c:v>16302</c:v>
                </c:pt>
                <c:pt idx="3">
                  <c:v>16400</c:v>
                </c:pt>
                <c:pt idx="4">
                  <c:v>15235</c:v>
                </c:pt>
                <c:pt idx="5">
                  <c:v>11736</c:v>
                </c:pt>
                <c:pt idx="6">
                  <c:v>16040</c:v>
                </c:pt>
                <c:pt idx="7">
                  <c:v>16759</c:v>
                </c:pt>
                <c:pt idx="8">
                  <c:v>11306</c:v>
                </c:pt>
                <c:pt idx="9">
                  <c:v>16897</c:v>
                </c:pt>
                <c:pt idx="10">
                  <c:v>11435</c:v>
                </c:pt>
                <c:pt idx="11">
                  <c:v>12257</c:v>
                </c:pt>
                <c:pt idx="12">
                  <c:v>10895</c:v>
                </c:pt>
                <c:pt idx="13">
                  <c:v>8476</c:v>
                </c:pt>
                <c:pt idx="14">
                  <c:v>6516</c:v>
                </c:pt>
                <c:pt idx="15">
                  <c:v>2403</c:v>
                </c:pt>
                <c:pt idx="16">
                  <c:v>4367</c:v>
                </c:pt>
                <c:pt idx="17">
                  <c:v>7959</c:v>
                </c:pt>
                <c:pt idx="18">
                  <c:v>7083</c:v>
                </c:pt>
                <c:pt idx="19">
                  <c:v>8287</c:v>
                </c:pt>
                <c:pt idx="20">
                  <c:v>10520</c:v>
                </c:pt>
                <c:pt idx="21">
                  <c:v>9513</c:v>
                </c:pt>
                <c:pt idx="22">
                  <c:v>3871</c:v>
                </c:pt>
                <c:pt idx="23">
                  <c:v>7361</c:v>
                </c:pt>
                <c:pt idx="24">
                  <c:v>10046</c:v>
                </c:pt>
                <c:pt idx="25">
                  <c:v>13090</c:v>
                </c:pt>
                <c:pt idx="26">
                  <c:v>13191</c:v>
                </c:pt>
                <c:pt idx="27">
                  <c:v>13901</c:v>
                </c:pt>
                <c:pt idx="28">
                  <c:v>10006</c:v>
                </c:pt>
                <c:pt idx="29">
                  <c:v>5416</c:v>
                </c:pt>
                <c:pt idx="30">
                  <c:v>6522</c:v>
                </c:pt>
                <c:pt idx="31">
                  <c:v>7726</c:v>
                </c:pt>
                <c:pt idx="32">
                  <c:v>9456</c:v>
                </c:pt>
                <c:pt idx="33">
                  <c:v>11632</c:v>
                </c:pt>
                <c:pt idx="34">
                  <c:v>9101</c:v>
                </c:pt>
                <c:pt idx="35">
                  <c:v>10028</c:v>
                </c:pt>
                <c:pt idx="36">
                  <c:v>9774</c:v>
                </c:pt>
                <c:pt idx="37">
                  <c:v>14934</c:v>
                </c:pt>
                <c:pt idx="38">
                  <c:v>9459</c:v>
                </c:pt>
                <c:pt idx="39">
                  <c:v>10899</c:v>
                </c:pt>
                <c:pt idx="40">
                  <c:v>10259</c:v>
                </c:pt>
                <c:pt idx="41">
                  <c:v>9704</c:v>
                </c:pt>
                <c:pt idx="42">
                  <c:v>9319</c:v>
                </c:pt>
                <c:pt idx="43">
                  <c:v>9293</c:v>
                </c:pt>
                <c:pt idx="44">
                  <c:v>9459</c:v>
                </c:pt>
                <c:pt idx="45">
                  <c:v>8976</c:v>
                </c:pt>
                <c:pt idx="46">
                  <c:v>6320</c:v>
                </c:pt>
                <c:pt idx="47">
                  <c:v>4707</c:v>
                </c:pt>
                <c:pt idx="48">
                  <c:v>5640</c:v>
                </c:pt>
                <c:pt idx="49">
                  <c:v>6139</c:v>
                </c:pt>
                <c:pt idx="50">
                  <c:v>5024</c:v>
                </c:pt>
                <c:pt idx="51">
                  <c:v>5841</c:v>
                </c:pt>
                <c:pt idx="52">
                  <c:v>6856</c:v>
                </c:pt>
                <c:pt idx="53">
                  <c:v>7758</c:v>
                </c:pt>
                <c:pt idx="54">
                  <c:v>3598</c:v>
                </c:pt>
                <c:pt idx="55">
                  <c:v>8850</c:v>
                </c:pt>
                <c:pt idx="56">
                  <c:v>10023</c:v>
                </c:pt>
                <c:pt idx="57">
                  <c:v>8394</c:v>
                </c:pt>
                <c:pt idx="58">
                  <c:v>9528</c:v>
                </c:pt>
                <c:pt idx="59">
                  <c:v>9475</c:v>
                </c:pt>
                <c:pt idx="60">
                  <c:v>10029</c:v>
                </c:pt>
                <c:pt idx="61">
                  <c:v>11224</c:v>
                </c:pt>
                <c:pt idx="62">
                  <c:v>12192</c:v>
                </c:pt>
                <c:pt idx="63">
                  <c:v>12957</c:v>
                </c:pt>
                <c:pt idx="64">
                  <c:v>10962</c:v>
                </c:pt>
                <c:pt idx="65">
                  <c:v>11871</c:v>
                </c:pt>
                <c:pt idx="66">
                  <c:v>10829</c:v>
                </c:pt>
                <c:pt idx="67">
                  <c:v>10751</c:v>
                </c:pt>
                <c:pt idx="68">
                  <c:v>11181</c:v>
                </c:pt>
                <c:pt idx="69">
                  <c:v>10225</c:v>
                </c:pt>
                <c:pt idx="70">
                  <c:v>8774</c:v>
                </c:pt>
                <c:pt idx="71">
                  <c:v>8816</c:v>
                </c:pt>
                <c:pt idx="72">
                  <c:v>8951</c:v>
                </c:pt>
                <c:pt idx="73">
                  <c:v>8207</c:v>
                </c:pt>
                <c:pt idx="74">
                  <c:v>8637</c:v>
                </c:pt>
                <c:pt idx="75">
                  <c:v>8764</c:v>
                </c:pt>
                <c:pt idx="76">
                  <c:v>8362</c:v>
                </c:pt>
                <c:pt idx="77">
                  <c:v>56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E29-3342-A2AA-0E5784E973CA}"/>
            </c:ext>
          </c:extLst>
        </c:ser>
        <c:ser>
          <c:idx val="12"/>
          <c:order val="12"/>
          <c:tx>
            <c:strRef>
              <c:f>Neat!$A$16</c:f>
              <c:strCache>
                <c:ptCount val="1"/>
                <c:pt idx="0">
                  <c:v>A34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6:$CA$16</c:f>
              <c:numCache>
                <c:formatCode>General</c:formatCode>
                <c:ptCount val="78"/>
                <c:pt idx="0">
                  <c:v>8767</c:v>
                </c:pt>
                <c:pt idx="1">
                  <c:v>6127</c:v>
                </c:pt>
                <c:pt idx="2">
                  <c:v>6679</c:v>
                </c:pt>
                <c:pt idx="3">
                  <c:v>6150</c:v>
                </c:pt>
                <c:pt idx="4">
                  <c:v>4388</c:v>
                </c:pt>
                <c:pt idx="5">
                  <c:v>2662</c:v>
                </c:pt>
                <c:pt idx="6">
                  <c:v>5351</c:v>
                </c:pt>
                <c:pt idx="7">
                  <c:v>5838</c:v>
                </c:pt>
                <c:pt idx="8">
                  <c:v>2400</c:v>
                </c:pt>
                <c:pt idx="9">
                  <c:v>5408</c:v>
                </c:pt>
                <c:pt idx="10">
                  <c:v>2476</c:v>
                </c:pt>
                <c:pt idx="11">
                  <c:v>2714</c:v>
                </c:pt>
                <c:pt idx="12">
                  <c:v>2346</c:v>
                </c:pt>
                <c:pt idx="13">
                  <c:v>1602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2657</c:v>
                </c:pt>
                <c:pt idx="18">
                  <c:v>2280</c:v>
                </c:pt>
                <c:pt idx="19">
                  <c:v>2639</c:v>
                </c:pt>
                <c:pt idx="20">
                  <c:v>3546</c:v>
                </c:pt>
                <c:pt idx="21">
                  <c:v>2845</c:v>
                </c:pt>
                <c:pt idx="22">
                  <c:v>0</c:v>
                </c:pt>
                <c:pt idx="23">
                  <c:v>2464</c:v>
                </c:pt>
                <c:pt idx="24">
                  <c:v>3604</c:v>
                </c:pt>
                <c:pt idx="25">
                  <c:v>5984</c:v>
                </c:pt>
                <c:pt idx="26">
                  <c:v>5117</c:v>
                </c:pt>
                <c:pt idx="27">
                  <c:v>5870</c:v>
                </c:pt>
                <c:pt idx="28">
                  <c:v>2968</c:v>
                </c:pt>
                <c:pt idx="29">
                  <c:v>1913</c:v>
                </c:pt>
                <c:pt idx="30">
                  <c:v>1858</c:v>
                </c:pt>
                <c:pt idx="31">
                  <c:v>2343</c:v>
                </c:pt>
                <c:pt idx="32">
                  <c:v>3059</c:v>
                </c:pt>
                <c:pt idx="33">
                  <c:v>3904</c:v>
                </c:pt>
                <c:pt idx="34">
                  <c:v>2679</c:v>
                </c:pt>
                <c:pt idx="35">
                  <c:v>2840</c:v>
                </c:pt>
                <c:pt idx="36">
                  <c:v>2806</c:v>
                </c:pt>
                <c:pt idx="37">
                  <c:v>5441</c:v>
                </c:pt>
                <c:pt idx="38">
                  <c:v>2739</c:v>
                </c:pt>
                <c:pt idx="39">
                  <c:v>3309</c:v>
                </c:pt>
                <c:pt idx="40">
                  <c:v>2991</c:v>
                </c:pt>
                <c:pt idx="41">
                  <c:v>2673</c:v>
                </c:pt>
                <c:pt idx="42">
                  <c:v>2524</c:v>
                </c:pt>
                <c:pt idx="43">
                  <c:v>2661</c:v>
                </c:pt>
                <c:pt idx="44">
                  <c:v>2429</c:v>
                </c:pt>
                <c:pt idx="45">
                  <c:v>2357</c:v>
                </c:pt>
                <c:pt idx="46">
                  <c:v>2094</c:v>
                </c:pt>
                <c:pt idx="47">
                  <c:v>1316</c:v>
                </c:pt>
                <c:pt idx="48">
                  <c:v>1355</c:v>
                </c:pt>
                <c:pt idx="49">
                  <c:v>1320</c:v>
                </c:pt>
                <c:pt idx="50">
                  <c:v>0</c:v>
                </c:pt>
                <c:pt idx="51">
                  <c:v>1016</c:v>
                </c:pt>
                <c:pt idx="52">
                  <c:v>1406</c:v>
                </c:pt>
                <c:pt idx="53">
                  <c:v>1663</c:v>
                </c:pt>
                <c:pt idx="54">
                  <c:v>0</c:v>
                </c:pt>
                <c:pt idx="55">
                  <c:v>1810</c:v>
                </c:pt>
                <c:pt idx="56">
                  <c:v>2006</c:v>
                </c:pt>
                <c:pt idx="57">
                  <c:v>1666</c:v>
                </c:pt>
                <c:pt idx="58">
                  <c:v>1677</c:v>
                </c:pt>
                <c:pt idx="59">
                  <c:v>1786</c:v>
                </c:pt>
                <c:pt idx="60">
                  <c:v>1962</c:v>
                </c:pt>
                <c:pt idx="61">
                  <c:v>1878</c:v>
                </c:pt>
                <c:pt idx="62">
                  <c:v>2476</c:v>
                </c:pt>
                <c:pt idx="63">
                  <c:v>2518</c:v>
                </c:pt>
                <c:pt idx="64">
                  <c:v>1960</c:v>
                </c:pt>
                <c:pt idx="65">
                  <c:v>2108</c:v>
                </c:pt>
                <c:pt idx="66">
                  <c:v>1916</c:v>
                </c:pt>
                <c:pt idx="67">
                  <c:v>1819</c:v>
                </c:pt>
                <c:pt idx="68">
                  <c:v>1802</c:v>
                </c:pt>
                <c:pt idx="69">
                  <c:v>1494</c:v>
                </c:pt>
                <c:pt idx="70">
                  <c:v>1617</c:v>
                </c:pt>
                <c:pt idx="71">
                  <c:v>1331</c:v>
                </c:pt>
                <c:pt idx="72">
                  <c:v>1460</c:v>
                </c:pt>
                <c:pt idx="73">
                  <c:v>1166</c:v>
                </c:pt>
                <c:pt idx="74">
                  <c:v>1380</c:v>
                </c:pt>
                <c:pt idx="75">
                  <c:v>1396</c:v>
                </c:pt>
                <c:pt idx="76">
                  <c:v>1279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1E29-3342-A2AA-0E5784E973CA}"/>
            </c:ext>
          </c:extLst>
        </c:ser>
        <c:ser>
          <c:idx val="13"/>
          <c:order val="13"/>
          <c:tx>
            <c:strRef>
              <c:f>Neat!$A$17</c:f>
              <c:strCache>
                <c:ptCount val="1"/>
                <c:pt idx="0">
                  <c:v>A36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solidFill>
                  <a:schemeClr val="accent2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7:$CA$17</c:f>
              <c:numCache>
                <c:formatCode>General</c:formatCode>
                <c:ptCount val="78"/>
                <c:pt idx="0">
                  <c:v>11351</c:v>
                </c:pt>
                <c:pt idx="1">
                  <c:v>18956</c:v>
                </c:pt>
                <c:pt idx="2">
                  <c:v>17504</c:v>
                </c:pt>
                <c:pt idx="3">
                  <c:v>14097</c:v>
                </c:pt>
                <c:pt idx="4">
                  <c:v>21788</c:v>
                </c:pt>
                <c:pt idx="5">
                  <c:v>22609</c:v>
                </c:pt>
                <c:pt idx="6">
                  <c:v>20396</c:v>
                </c:pt>
                <c:pt idx="7">
                  <c:v>22941</c:v>
                </c:pt>
                <c:pt idx="8">
                  <c:v>21984</c:v>
                </c:pt>
                <c:pt idx="9">
                  <c:v>18150</c:v>
                </c:pt>
                <c:pt idx="10">
                  <c:v>21210</c:v>
                </c:pt>
                <c:pt idx="11">
                  <c:v>19440</c:v>
                </c:pt>
                <c:pt idx="12">
                  <c:v>19418</c:v>
                </c:pt>
                <c:pt idx="13">
                  <c:v>21784</c:v>
                </c:pt>
                <c:pt idx="14">
                  <c:v>23647</c:v>
                </c:pt>
                <c:pt idx="15">
                  <c:v>13500</c:v>
                </c:pt>
                <c:pt idx="16">
                  <c:v>19919</c:v>
                </c:pt>
                <c:pt idx="17">
                  <c:v>22639</c:v>
                </c:pt>
                <c:pt idx="18">
                  <c:v>20964</c:v>
                </c:pt>
                <c:pt idx="19">
                  <c:v>23726</c:v>
                </c:pt>
                <c:pt idx="20">
                  <c:v>20352</c:v>
                </c:pt>
                <c:pt idx="21">
                  <c:v>23512</c:v>
                </c:pt>
                <c:pt idx="22">
                  <c:v>14044</c:v>
                </c:pt>
                <c:pt idx="23">
                  <c:v>17894</c:v>
                </c:pt>
                <c:pt idx="24">
                  <c:v>21109</c:v>
                </c:pt>
                <c:pt idx="25">
                  <c:v>24659</c:v>
                </c:pt>
                <c:pt idx="26">
                  <c:v>27440</c:v>
                </c:pt>
                <c:pt idx="27">
                  <c:v>22915</c:v>
                </c:pt>
                <c:pt idx="28">
                  <c:v>22778</c:v>
                </c:pt>
                <c:pt idx="29">
                  <c:v>16500</c:v>
                </c:pt>
                <c:pt idx="30">
                  <c:v>19016</c:v>
                </c:pt>
                <c:pt idx="31">
                  <c:v>20299</c:v>
                </c:pt>
                <c:pt idx="32">
                  <c:v>23693</c:v>
                </c:pt>
                <c:pt idx="33">
                  <c:v>25057</c:v>
                </c:pt>
                <c:pt idx="34">
                  <c:v>21430</c:v>
                </c:pt>
                <c:pt idx="35">
                  <c:v>24712</c:v>
                </c:pt>
                <c:pt idx="36">
                  <c:v>25603</c:v>
                </c:pt>
                <c:pt idx="37">
                  <c:v>22694</c:v>
                </c:pt>
                <c:pt idx="38">
                  <c:v>23344</c:v>
                </c:pt>
                <c:pt idx="39">
                  <c:v>22550</c:v>
                </c:pt>
                <c:pt idx="40">
                  <c:v>23136</c:v>
                </c:pt>
                <c:pt idx="41">
                  <c:v>24629</c:v>
                </c:pt>
                <c:pt idx="42">
                  <c:v>20656</c:v>
                </c:pt>
                <c:pt idx="43">
                  <c:v>22089</c:v>
                </c:pt>
                <c:pt idx="44">
                  <c:v>20115</c:v>
                </c:pt>
                <c:pt idx="45">
                  <c:v>21303</c:v>
                </c:pt>
                <c:pt idx="46">
                  <c:v>20503</c:v>
                </c:pt>
                <c:pt idx="47">
                  <c:v>17863</c:v>
                </c:pt>
                <c:pt idx="48">
                  <c:v>20462</c:v>
                </c:pt>
                <c:pt idx="49">
                  <c:v>21498</c:v>
                </c:pt>
                <c:pt idx="50">
                  <c:v>17622</c:v>
                </c:pt>
                <c:pt idx="51">
                  <c:v>21133</c:v>
                </c:pt>
                <c:pt idx="52">
                  <c:v>20670</c:v>
                </c:pt>
                <c:pt idx="53">
                  <c:v>19813</c:v>
                </c:pt>
                <c:pt idx="54">
                  <c:v>14214</c:v>
                </c:pt>
                <c:pt idx="55">
                  <c:v>23180</c:v>
                </c:pt>
                <c:pt idx="56">
                  <c:v>25020</c:v>
                </c:pt>
                <c:pt idx="57">
                  <c:v>24400</c:v>
                </c:pt>
                <c:pt idx="58">
                  <c:v>21603</c:v>
                </c:pt>
                <c:pt idx="59">
                  <c:v>22341</c:v>
                </c:pt>
                <c:pt idx="60">
                  <c:v>19296</c:v>
                </c:pt>
                <c:pt idx="61">
                  <c:v>24217</c:v>
                </c:pt>
                <c:pt idx="62">
                  <c:v>23800</c:v>
                </c:pt>
                <c:pt idx="63">
                  <c:v>23463</c:v>
                </c:pt>
                <c:pt idx="64">
                  <c:v>23779</c:v>
                </c:pt>
                <c:pt idx="65">
                  <c:v>22659</c:v>
                </c:pt>
                <c:pt idx="66">
                  <c:v>22884</c:v>
                </c:pt>
                <c:pt idx="67">
                  <c:v>24880</c:v>
                </c:pt>
                <c:pt idx="68">
                  <c:v>25887</c:v>
                </c:pt>
                <c:pt idx="69">
                  <c:v>24859</c:v>
                </c:pt>
                <c:pt idx="70">
                  <c:v>19636</c:v>
                </c:pt>
                <c:pt idx="71">
                  <c:v>26797</c:v>
                </c:pt>
                <c:pt idx="72">
                  <c:v>25890</c:v>
                </c:pt>
                <c:pt idx="73">
                  <c:v>24094</c:v>
                </c:pt>
                <c:pt idx="74">
                  <c:v>23931</c:v>
                </c:pt>
                <c:pt idx="75">
                  <c:v>26274</c:v>
                </c:pt>
                <c:pt idx="76">
                  <c:v>26436</c:v>
                </c:pt>
                <c:pt idx="77">
                  <c:v>203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1E29-3342-A2AA-0E5784E973CA}"/>
            </c:ext>
          </c:extLst>
        </c:ser>
        <c:ser>
          <c:idx val="14"/>
          <c:order val="14"/>
          <c:tx>
            <c:strRef>
              <c:f>Neat!$A$18</c:f>
              <c:strCache>
                <c:ptCount val="1"/>
                <c:pt idx="0">
                  <c:v>A43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  <a:lumOff val="20000"/>
                </a:schemeClr>
              </a:solidFill>
              <a:ln w="9525">
                <a:solidFill>
                  <a:schemeClr val="accent3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8:$CA$18</c:f>
              <c:numCache>
                <c:formatCode>General</c:formatCode>
                <c:ptCount val="78"/>
                <c:pt idx="0">
                  <c:v>8706</c:v>
                </c:pt>
                <c:pt idx="1">
                  <c:v>8006</c:v>
                </c:pt>
                <c:pt idx="2">
                  <c:v>9186</c:v>
                </c:pt>
                <c:pt idx="3">
                  <c:v>8829</c:v>
                </c:pt>
                <c:pt idx="4">
                  <c:v>7420</c:v>
                </c:pt>
                <c:pt idx="5">
                  <c:v>4096</c:v>
                </c:pt>
                <c:pt idx="6">
                  <c:v>7187</c:v>
                </c:pt>
                <c:pt idx="7">
                  <c:v>7651</c:v>
                </c:pt>
                <c:pt idx="8">
                  <c:v>4580</c:v>
                </c:pt>
                <c:pt idx="9">
                  <c:v>8320</c:v>
                </c:pt>
                <c:pt idx="10">
                  <c:v>5190</c:v>
                </c:pt>
                <c:pt idx="11">
                  <c:v>4577</c:v>
                </c:pt>
                <c:pt idx="12">
                  <c:v>4043</c:v>
                </c:pt>
                <c:pt idx="13">
                  <c:v>3008</c:v>
                </c:pt>
                <c:pt idx="14">
                  <c:v>1866</c:v>
                </c:pt>
                <c:pt idx="15">
                  <c:v>0</c:v>
                </c:pt>
                <c:pt idx="16">
                  <c:v>1225</c:v>
                </c:pt>
                <c:pt idx="17">
                  <c:v>3244</c:v>
                </c:pt>
                <c:pt idx="18">
                  <c:v>2776</c:v>
                </c:pt>
                <c:pt idx="19">
                  <c:v>3067</c:v>
                </c:pt>
                <c:pt idx="20">
                  <c:v>4397</c:v>
                </c:pt>
                <c:pt idx="21">
                  <c:v>3307</c:v>
                </c:pt>
                <c:pt idx="22">
                  <c:v>0</c:v>
                </c:pt>
                <c:pt idx="23">
                  <c:v>2441</c:v>
                </c:pt>
                <c:pt idx="24">
                  <c:v>3588</c:v>
                </c:pt>
                <c:pt idx="25">
                  <c:v>5325</c:v>
                </c:pt>
                <c:pt idx="26">
                  <c:v>4633</c:v>
                </c:pt>
                <c:pt idx="27">
                  <c:v>4983</c:v>
                </c:pt>
                <c:pt idx="28">
                  <c:v>2650</c:v>
                </c:pt>
                <c:pt idx="29">
                  <c:v>2029</c:v>
                </c:pt>
                <c:pt idx="30">
                  <c:v>2109</c:v>
                </c:pt>
                <c:pt idx="31">
                  <c:v>2463</c:v>
                </c:pt>
                <c:pt idx="32">
                  <c:v>2831</c:v>
                </c:pt>
                <c:pt idx="33">
                  <c:v>3949</c:v>
                </c:pt>
                <c:pt idx="34">
                  <c:v>2865</c:v>
                </c:pt>
                <c:pt idx="35">
                  <c:v>3158</c:v>
                </c:pt>
                <c:pt idx="36">
                  <c:v>3178</c:v>
                </c:pt>
                <c:pt idx="37">
                  <c:v>5595</c:v>
                </c:pt>
                <c:pt idx="38">
                  <c:v>3102</c:v>
                </c:pt>
                <c:pt idx="39">
                  <c:v>3695</c:v>
                </c:pt>
                <c:pt idx="40">
                  <c:v>3396</c:v>
                </c:pt>
                <c:pt idx="41">
                  <c:v>3212</c:v>
                </c:pt>
                <c:pt idx="42">
                  <c:v>2964</c:v>
                </c:pt>
                <c:pt idx="43">
                  <c:v>3155</c:v>
                </c:pt>
                <c:pt idx="44">
                  <c:v>3035</c:v>
                </c:pt>
                <c:pt idx="45">
                  <c:v>2850</c:v>
                </c:pt>
                <c:pt idx="46">
                  <c:v>2484</c:v>
                </c:pt>
                <c:pt idx="47">
                  <c:v>1679</c:v>
                </c:pt>
                <c:pt idx="48">
                  <c:v>1668</c:v>
                </c:pt>
                <c:pt idx="49">
                  <c:v>1679</c:v>
                </c:pt>
                <c:pt idx="50">
                  <c:v>1373</c:v>
                </c:pt>
                <c:pt idx="51">
                  <c:v>1372</c:v>
                </c:pt>
                <c:pt idx="52">
                  <c:v>2222</c:v>
                </c:pt>
                <c:pt idx="53">
                  <c:v>2941</c:v>
                </c:pt>
                <c:pt idx="54">
                  <c:v>1407</c:v>
                </c:pt>
                <c:pt idx="55">
                  <c:v>3418</c:v>
                </c:pt>
                <c:pt idx="56">
                  <c:v>3986</c:v>
                </c:pt>
                <c:pt idx="57">
                  <c:v>3135</c:v>
                </c:pt>
                <c:pt idx="58">
                  <c:v>3249</c:v>
                </c:pt>
                <c:pt idx="59">
                  <c:v>3303</c:v>
                </c:pt>
                <c:pt idx="60">
                  <c:v>3684</c:v>
                </c:pt>
                <c:pt idx="61">
                  <c:v>3634</c:v>
                </c:pt>
                <c:pt idx="62">
                  <c:v>4658</c:v>
                </c:pt>
                <c:pt idx="63">
                  <c:v>4803</c:v>
                </c:pt>
                <c:pt idx="64">
                  <c:v>3665</c:v>
                </c:pt>
                <c:pt idx="65">
                  <c:v>3896</c:v>
                </c:pt>
                <c:pt idx="66">
                  <c:v>3538</c:v>
                </c:pt>
                <c:pt idx="67">
                  <c:v>3225</c:v>
                </c:pt>
                <c:pt idx="68">
                  <c:v>3165</c:v>
                </c:pt>
                <c:pt idx="69">
                  <c:v>2608</c:v>
                </c:pt>
                <c:pt idx="70">
                  <c:v>3002</c:v>
                </c:pt>
                <c:pt idx="71">
                  <c:v>2153</c:v>
                </c:pt>
                <c:pt idx="72">
                  <c:v>2373</c:v>
                </c:pt>
                <c:pt idx="73">
                  <c:v>1880</c:v>
                </c:pt>
                <c:pt idx="74">
                  <c:v>2570</c:v>
                </c:pt>
                <c:pt idx="75">
                  <c:v>2250</c:v>
                </c:pt>
                <c:pt idx="76">
                  <c:v>2156</c:v>
                </c:pt>
                <c:pt idx="77">
                  <c:v>14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1E29-3342-A2AA-0E5784E973CA}"/>
            </c:ext>
          </c:extLst>
        </c:ser>
        <c:ser>
          <c:idx val="15"/>
          <c:order val="15"/>
          <c:tx>
            <c:strRef>
              <c:f>Neat!$A$19</c:f>
              <c:strCache>
                <c:ptCount val="1"/>
                <c:pt idx="0">
                  <c:v>A66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  <a:lumOff val="20000"/>
                </a:schemeClr>
              </a:solidFill>
              <a:ln w="9525">
                <a:solidFill>
                  <a:schemeClr val="accent4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9:$CA$19</c:f>
              <c:numCache>
                <c:formatCode>General</c:formatCode>
                <c:ptCount val="78"/>
                <c:pt idx="0">
                  <c:v>7328</c:v>
                </c:pt>
                <c:pt idx="1">
                  <c:v>4803</c:v>
                </c:pt>
                <c:pt idx="2">
                  <c:v>5421</c:v>
                </c:pt>
                <c:pt idx="3">
                  <c:v>5471</c:v>
                </c:pt>
                <c:pt idx="4">
                  <c:v>3935</c:v>
                </c:pt>
                <c:pt idx="5">
                  <c:v>2137</c:v>
                </c:pt>
                <c:pt idx="6">
                  <c:v>4336</c:v>
                </c:pt>
                <c:pt idx="7">
                  <c:v>4890</c:v>
                </c:pt>
                <c:pt idx="8">
                  <c:v>2421</c:v>
                </c:pt>
                <c:pt idx="9">
                  <c:v>4844</c:v>
                </c:pt>
                <c:pt idx="10">
                  <c:v>2272</c:v>
                </c:pt>
                <c:pt idx="11">
                  <c:v>2327</c:v>
                </c:pt>
                <c:pt idx="12">
                  <c:v>1951</c:v>
                </c:pt>
                <c:pt idx="13">
                  <c:v>160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2070</c:v>
                </c:pt>
                <c:pt idx="18">
                  <c:v>1761</c:v>
                </c:pt>
                <c:pt idx="19">
                  <c:v>2074</c:v>
                </c:pt>
                <c:pt idx="20">
                  <c:v>3070</c:v>
                </c:pt>
                <c:pt idx="21">
                  <c:v>2523</c:v>
                </c:pt>
                <c:pt idx="22">
                  <c:v>0</c:v>
                </c:pt>
                <c:pt idx="23">
                  <c:v>2149</c:v>
                </c:pt>
                <c:pt idx="24">
                  <c:v>3105</c:v>
                </c:pt>
                <c:pt idx="25">
                  <c:v>5234</c:v>
                </c:pt>
                <c:pt idx="26">
                  <c:v>4283</c:v>
                </c:pt>
                <c:pt idx="27">
                  <c:v>4895</c:v>
                </c:pt>
                <c:pt idx="28">
                  <c:v>2635</c:v>
                </c:pt>
                <c:pt idx="29">
                  <c:v>1959</c:v>
                </c:pt>
                <c:pt idx="30">
                  <c:v>1753</c:v>
                </c:pt>
                <c:pt idx="31">
                  <c:v>2084</c:v>
                </c:pt>
                <c:pt idx="32">
                  <c:v>2436</c:v>
                </c:pt>
                <c:pt idx="33">
                  <c:v>3423</c:v>
                </c:pt>
                <c:pt idx="34">
                  <c:v>2496</c:v>
                </c:pt>
                <c:pt idx="35">
                  <c:v>2496</c:v>
                </c:pt>
                <c:pt idx="36">
                  <c:v>2522</c:v>
                </c:pt>
                <c:pt idx="37">
                  <c:v>4891</c:v>
                </c:pt>
                <c:pt idx="38">
                  <c:v>2248</c:v>
                </c:pt>
                <c:pt idx="39">
                  <c:v>2849</c:v>
                </c:pt>
                <c:pt idx="40">
                  <c:v>2607</c:v>
                </c:pt>
                <c:pt idx="41">
                  <c:v>2308</c:v>
                </c:pt>
                <c:pt idx="42">
                  <c:v>2099</c:v>
                </c:pt>
                <c:pt idx="43">
                  <c:v>2232</c:v>
                </c:pt>
                <c:pt idx="44">
                  <c:v>2174</c:v>
                </c:pt>
                <c:pt idx="45">
                  <c:v>2017</c:v>
                </c:pt>
                <c:pt idx="46">
                  <c:v>2040</c:v>
                </c:pt>
                <c:pt idx="47">
                  <c:v>1287</c:v>
                </c:pt>
                <c:pt idx="48">
                  <c:v>1418</c:v>
                </c:pt>
                <c:pt idx="49">
                  <c:v>1373</c:v>
                </c:pt>
                <c:pt idx="50">
                  <c:v>0</c:v>
                </c:pt>
                <c:pt idx="51">
                  <c:v>0</c:v>
                </c:pt>
                <c:pt idx="52">
                  <c:v>1353</c:v>
                </c:pt>
                <c:pt idx="53">
                  <c:v>1537</c:v>
                </c:pt>
                <c:pt idx="54">
                  <c:v>1196</c:v>
                </c:pt>
                <c:pt idx="55">
                  <c:v>1509</c:v>
                </c:pt>
                <c:pt idx="56">
                  <c:v>1575</c:v>
                </c:pt>
                <c:pt idx="57">
                  <c:v>1417</c:v>
                </c:pt>
                <c:pt idx="58">
                  <c:v>1291</c:v>
                </c:pt>
                <c:pt idx="59">
                  <c:v>1390</c:v>
                </c:pt>
                <c:pt idx="60">
                  <c:v>1433</c:v>
                </c:pt>
                <c:pt idx="61">
                  <c:v>1415</c:v>
                </c:pt>
                <c:pt idx="62">
                  <c:v>1918</c:v>
                </c:pt>
                <c:pt idx="63">
                  <c:v>1943</c:v>
                </c:pt>
                <c:pt idx="64">
                  <c:v>1536</c:v>
                </c:pt>
                <c:pt idx="65">
                  <c:v>1582</c:v>
                </c:pt>
                <c:pt idx="66">
                  <c:v>1526</c:v>
                </c:pt>
                <c:pt idx="67">
                  <c:v>1447</c:v>
                </c:pt>
                <c:pt idx="68">
                  <c:v>1418</c:v>
                </c:pt>
                <c:pt idx="69">
                  <c:v>1419</c:v>
                </c:pt>
                <c:pt idx="70">
                  <c:v>1213</c:v>
                </c:pt>
                <c:pt idx="71">
                  <c:v>0</c:v>
                </c:pt>
                <c:pt idx="72">
                  <c:v>1218</c:v>
                </c:pt>
                <c:pt idx="73">
                  <c:v>0</c:v>
                </c:pt>
                <c:pt idx="74">
                  <c:v>1236</c:v>
                </c:pt>
                <c:pt idx="75">
                  <c:v>1217</c:v>
                </c:pt>
                <c:pt idx="76">
                  <c:v>1133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1E29-3342-A2AA-0E5784E973CA}"/>
            </c:ext>
          </c:extLst>
        </c:ser>
        <c:ser>
          <c:idx val="16"/>
          <c:order val="16"/>
          <c:tx>
            <c:strRef>
              <c:f>Neat!$A$20</c:f>
              <c:strCache>
                <c:ptCount val="1"/>
                <c:pt idx="0">
                  <c:v>A74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  <a:lumOff val="20000"/>
                </a:schemeClr>
              </a:solidFill>
              <a:ln w="9525">
                <a:solidFill>
                  <a:schemeClr val="accent5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0:$CA$20</c:f>
              <c:numCache>
                <c:formatCode>General</c:formatCode>
                <c:ptCount val="78"/>
                <c:pt idx="0">
                  <c:v>13481</c:v>
                </c:pt>
                <c:pt idx="1">
                  <c:v>18013</c:v>
                </c:pt>
                <c:pt idx="2">
                  <c:v>18661</c:v>
                </c:pt>
                <c:pt idx="3">
                  <c:v>18489</c:v>
                </c:pt>
                <c:pt idx="4">
                  <c:v>18330</c:v>
                </c:pt>
                <c:pt idx="5">
                  <c:v>14941</c:v>
                </c:pt>
                <c:pt idx="6">
                  <c:v>18629</c:v>
                </c:pt>
                <c:pt idx="7">
                  <c:v>20076</c:v>
                </c:pt>
                <c:pt idx="8">
                  <c:v>13038</c:v>
                </c:pt>
                <c:pt idx="9">
                  <c:v>18558</c:v>
                </c:pt>
                <c:pt idx="10">
                  <c:v>13920</c:v>
                </c:pt>
                <c:pt idx="11">
                  <c:v>15274</c:v>
                </c:pt>
                <c:pt idx="12">
                  <c:v>12808</c:v>
                </c:pt>
                <c:pt idx="13">
                  <c:v>10191</c:v>
                </c:pt>
                <c:pt idx="14">
                  <c:v>8039</c:v>
                </c:pt>
                <c:pt idx="15">
                  <c:v>2685</c:v>
                </c:pt>
                <c:pt idx="16">
                  <c:v>5380</c:v>
                </c:pt>
                <c:pt idx="17">
                  <c:v>9803</c:v>
                </c:pt>
                <c:pt idx="18">
                  <c:v>8208</c:v>
                </c:pt>
                <c:pt idx="19">
                  <c:v>9193</c:v>
                </c:pt>
                <c:pt idx="20">
                  <c:v>11897</c:v>
                </c:pt>
                <c:pt idx="21">
                  <c:v>10727</c:v>
                </c:pt>
                <c:pt idx="22">
                  <c:v>4679</c:v>
                </c:pt>
                <c:pt idx="23">
                  <c:v>7833</c:v>
                </c:pt>
                <c:pt idx="24">
                  <c:v>10811</c:v>
                </c:pt>
                <c:pt idx="25">
                  <c:v>14647</c:v>
                </c:pt>
                <c:pt idx="26">
                  <c:v>14995</c:v>
                </c:pt>
                <c:pt idx="27">
                  <c:v>15766</c:v>
                </c:pt>
                <c:pt idx="28">
                  <c:v>10882</c:v>
                </c:pt>
                <c:pt idx="29">
                  <c:v>6212</c:v>
                </c:pt>
                <c:pt idx="30">
                  <c:v>7772</c:v>
                </c:pt>
                <c:pt idx="31">
                  <c:v>9442</c:v>
                </c:pt>
                <c:pt idx="32">
                  <c:v>10966</c:v>
                </c:pt>
                <c:pt idx="33">
                  <c:v>13823</c:v>
                </c:pt>
                <c:pt idx="34">
                  <c:v>10753</c:v>
                </c:pt>
                <c:pt idx="35">
                  <c:v>12555</c:v>
                </c:pt>
                <c:pt idx="36">
                  <c:v>12095</c:v>
                </c:pt>
                <c:pt idx="37">
                  <c:v>17193</c:v>
                </c:pt>
                <c:pt idx="38">
                  <c:v>11378</c:v>
                </c:pt>
                <c:pt idx="39">
                  <c:v>13113</c:v>
                </c:pt>
                <c:pt idx="40">
                  <c:v>12323</c:v>
                </c:pt>
                <c:pt idx="41">
                  <c:v>12088</c:v>
                </c:pt>
                <c:pt idx="42">
                  <c:v>11352</c:v>
                </c:pt>
                <c:pt idx="43">
                  <c:v>11094</c:v>
                </c:pt>
                <c:pt idx="44">
                  <c:v>11570</c:v>
                </c:pt>
                <c:pt idx="45">
                  <c:v>10572</c:v>
                </c:pt>
                <c:pt idx="46">
                  <c:v>7633</c:v>
                </c:pt>
                <c:pt idx="47">
                  <c:v>5798</c:v>
                </c:pt>
                <c:pt idx="48">
                  <c:v>6857</c:v>
                </c:pt>
                <c:pt idx="49">
                  <c:v>7223</c:v>
                </c:pt>
                <c:pt idx="50">
                  <c:v>5990</c:v>
                </c:pt>
                <c:pt idx="51">
                  <c:v>7277</c:v>
                </c:pt>
                <c:pt idx="52">
                  <c:v>8003</c:v>
                </c:pt>
                <c:pt idx="53">
                  <c:v>9641</c:v>
                </c:pt>
                <c:pt idx="54">
                  <c:v>3999</c:v>
                </c:pt>
                <c:pt idx="55">
                  <c:v>10510</c:v>
                </c:pt>
                <c:pt idx="56">
                  <c:v>11869</c:v>
                </c:pt>
                <c:pt idx="57">
                  <c:v>9700</c:v>
                </c:pt>
                <c:pt idx="58">
                  <c:v>11644</c:v>
                </c:pt>
                <c:pt idx="59">
                  <c:v>11326</c:v>
                </c:pt>
                <c:pt idx="60">
                  <c:v>11673</c:v>
                </c:pt>
                <c:pt idx="61">
                  <c:v>13651</c:v>
                </c:pt>
                <c:pt idx="62">
                  <c:v>15147</c:v>
                </c:pt>
                <c:pt idx="63">
                  <c:v>15390</c:v>
                </c:pt>
                <c:pt idx="64">
                  <c:v>13031</c:v>
                </c:pt>
                <c:pt idx="65">
                  <c:v>14651</c:v>
                </c:pt>
                <c:pt idx="66">
                  <c:v>12612</c:v>
                </c:pt>
                <c:pt idx="67">
                  <c:v>12937</c:v>
                </c:pt>
                <c:pt idx="68">
                  <c:v>13306</c:v>
                </c:pt>
                <c:pt idx="69">
                  <c:v>12330</c:v>
                </c:pt>
                <c:pt idx="70">
                  <c:v>10176</c:v>
                </c:pt>
                <c:pt idx="71">
                  <c:v>10614</c:v>
                </c:pt>
                <c:pt idx="72">
                  <c:v>10744</c:v>
                </c:pt>
                <c:pt idx="73">
                  <c:v>10079</c:v>
                </c:pt>
                <c:pt idx="74">
                  <c:v>10466</c:v>
                </c:pt>
                <c:pt idx="75">
                  <c:v>10764</c:v>
                </c:pt>
                <c:pt idx="76">
                  <c:v>10305</c:v>
                </c:pt>
                <c:pt idx="77">
                  <c:v>64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1E29-3342-A2AA-0E5784E973CA}"/>
            </c:ext>
          </c:extLst>
        </c:ser>
        <c:ser>
          <c:idx val="17"/>
          <c:order val="17"/>
          <c:tx>
            <c:strRef>
              <c:f>Neat!$A$21</c:f>
              <c:strCache>
                <c:ptCount val="1"/>
                <c:pt idx="0">
                  <c:v>A80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1:$CA$21</c:f>
              <c:numCache>
                <c:formatCode>General</c:formatCode>
                <c:ptCount val="78"/>
                <c:pt idx="0">
                  <c:v>8816</c:v>
                </c:pt>
                <c:pt idx="1">
                  <c:v>17528</c:v>
                </c:pt>
                <c:pt idx="2">
                  <c:v>15082</c:v>
                </c:pt>
                <c:pt idx="3">
                  <c:v>11812</c:v>
                </c:pt>
                <c:pt idx="4">
                  <c:v>20317</c:v>
                </c:pt>
                <c:pt idx="5">
                  <c:v>21609</c:v>
                </c:pt>
                <c:pt idx="6">
                  <c:v>18421</c:v>
                </c:pt>
                <c:pt idx="7">
                  <c:v>20180</c:v>
                </c:pt>
                <c:pt idx="8">
                  <c:v>21909</c:v>
                </c:pt>
                <c:pt idx="9">
                  <c:v>15303</c:v>
                </c:pt>
                <c:pt idx="10">
                  <c:v>20331</c:v>
                </c:pt>
                <c:pt idx="11">
                  <c:v>17554</c:v>
                </c:pt>
                <c:pt idx="12">
                  <c:v>17275</c:v>
                </c:pt>
                <c:pt idx="13">
                  <c:v>20213</c:v>
                </c:pt>
                <c:pt idx="14">
                  <c:v>22949</c:v>
                </c:pt>
                <c:pt idx="15">
                  <c:v>11804</c:v>
                </c:pt>
                <c:pt idx="16">
                  <c:v>18352</c:v>
                </c:pt>
                <c:pt idx="17">
                  <c:v>21446</c:v>
                </c:pt>
                <c:pt idx="18">
                  <c:v>19611</c:v>
                </c:pt>
                <c:pt idx="19">
                  <c:v>22929</c:v>
                </c:pt>
                <c:pt idx="20">
                  <c:v>19279</c:v>
                </c:pt>
                <c:pt idx="21">
                  <c:v>22431</c:v>
                </c:pt>
                <c:pt idx="22">
                  <c:v>13713</c:v>
                </c:pt>
                <c:pt idx="23">
                  <c:v>17667</c:v>
                </c:pt>
                <c:pt idx="24">
                  <c:v>19895</c:v>
                </c:pt>
                <c:pt idx="25">
                  <c:v>23722</c:v>
                </c:pt>
                <c:pt idx="26">
                  <c:v>26702</c:v>
                </c:pt>
                <c:pt idx="27">
                  <c:v>20972</c:v>
                </c:pt>
                <c:pt idx="28">
                  <c:v>23353</c:v>
                </c:pt>
                <c:pt idx="29">
                  <c:v>17936</c:v>
                </c:pt>
                <c:pt idx="30">
                  <c:v>20012</c:v>
                </c:pt>
                <c:pt idx="31">
                  <c:v>20105</c:v>
                </c:pt>
                <c:pt idx="32">
                  <c:v>23355</c:v>
                </c:pt>
                <c:pt idx="33">
                  <c:v>24801</c:v>
                </c:pt>
                <c:pt idx="34">
                  <c:v>22063</c:v>
                </c:pt>
                <c:pt idx="35">
                  <c:v>23510</c:v>
                </c:pt>
                <c:pt idx="36">
                  <c:v>23671</c:v>
                </c:pt>
                <c:pt idx="37">
                  <c:v>17368</c:v>
                </c:pt>
                <c:pt idx="38">
                  <c:v>22491</c:v>
                </c:pt>
                <c:pt idx="39">
                  <c:v>19619</c:v>
                </c:pt>
                <c:pt idx="40">
                  <c:v>20403</c:v>
                </c:pt>
                <c:pt idx="41">
                  <c:v>23969</c:v>
                </c:pt>
                <c:pt idx="42">
                  <c:v>18417</c:v>
                </c:pt>
                <c:pt idx="43">
                  <c:v>20166</c:v>
                </c:pt>
                <c:pt idx="44">
                  <c:v>17115</c:v>
                </c:pt>
                <c:pt idx="45">
                  <c:v>18808</c:v>
                </c:pt>
                <c:pt idx="46">
                  <c:v>20394</c:v>
                </c:pt>
                <c:pt idx="47">
                  <c:v>18321</c:v>
                </c:pt>
                <c:pt idx="48">
                  <c:v>20408</c:v>
                </c:pt>
                <c:pt idx="49">
                  <c:v>21709</c:v>
                </c:pt>
                <c:pt idx="50">
                  <c:v>17064</c:v>
                </c:pt>
                <c:pt idx="51">
                  <c:v>21435</c:v>
                </c:pt>
                <c:pt idx="52">
                  <c:v>19557</c:v>
                </c:pt>
                <c:pt idx="53">
                  <c:v>17639</c:v>
                </c:pt>
                <c:pt idx="54">
                  <c:v>13964</c:v>
                </c:pt>
                <c:pt idx="55">
                  <c:v>22336</c:v>
                </c:pt>
                <c:pt idx="56">
                  <c:v>23875</c:v>
                </c:pt>
                <c:pt idx="57">
                  <c:v>23723</c:v>
                </c:pt>
                <c:pt idx="58">
                  <c:v>18451</c:v>
                </c:pt>
                <c:pt idx="59">
                  <c:v>20810</c:v>
                </c:pt>
                <c:pt idx="60">
                  <c:v>16847</c:v>
                </c:pt>
                <c:pt idx="61">
                  <c:v>21993</c:v>
                </c:pt>
                <c:pt idx="62">
                  <c:v>21598</c:v>
                </c:pt>
                <c:pt idx="63">
                  <c:v>21646</c:v>
                </c:pt>
                <c:pt idx="64">
                  <c:v>21468</c:v>
                </c:pt>
                <c:pt idx="65">
                  <c:v>18536</c:v>
                </c:pt>
                <c:pt idx="66">
                  <c:v>20246</c:v>
                </c:pt>
                <c:pt idx="67">
                  <c:v>21694</c:v>
                </c:pt>
                <c:pt idx="68">
                  <c:v>23180</c:v>
                </c:pt>
                <c:pt idx="69">
                  <c:v>21324</c:v>
                </c:pt>
                <c:pt idx="70">
                  <c:v>17210</c:v>
                </c:pt>
                <c:pt idx="71">
                  <c:v>26221</c:v>
                </c:pt>
                <c:pt idx="72">
                  <c:v>24645</c:v>
                </c:pt>
                <c:pt idx="73">
                  <c:v>23019</c:v>
                </c:pt>
                <c:pt idx="74">
                  <c:v>21627</c:v>
                </c:pt>
                <c:pt idx="75">
                  <c:v>24457</c:v>
                </c:pt>
                <c:pt idx="76">
                  <c:v>25634</c:v>
                </c:pt>
                <c:pt idx="77">
                  <c:v>2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1E29-3342-A2AA-0E5784E973CA}"/>
            </c:ext>
          </c:extLst>
        </c:ser>
        <c:ser>
          <c:idx val="18"/>
          <c:order val="18"/>
          <c:tx>
            <c:strRef>
              <c:f>Neat!$A$22</c:f>
              <c:strCache>
                <c:ptCount val="1"/>
                <c:pt idx="0">
                  <c:v>B13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</a:schemeClr>
              </a:solidFill>
              <a:ln w="9525">
                <a:solidFill>
                  <a:schemeClr val="accent1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2:$CA$22</c:f>
              <c:numCache>
                <c:formatCode>General</c:formatCode>
                <c:ptCount val="78"/>
                <c:pt idx="0">
                  <c:v>11584</c:v>
                </c:pt>
                <c:pt idx="1">
                  <c:v>11752</c:v>
                </c:pt>
                <c:pt idx="2">
                  <c:v>12696</c:v>
                </c:pt>
                <c:pt idx="3">
                  <c:v>13377</c:v>
                </c:pt>
                <c:pt idx="4">
                  <c:v>11354</c:v>
                </c:pt>
                <c:pt idx="5">
                  <c:v>8304</c:v>
                </c:pt>
                <c:pt idx="6">
                  <c:v>11980</c:v>
                </c:pt>
                <c:pt idx="7">
                  <c:v>12737</c:v>
                </c:pt>
                <c:pt idx="8">
                  <c:v>7429</c:v>
                </c:pt>
                <c:pt idx="9">
                  <c:v>12097</c:v>
                </c:pt>
                <c:pt idx="10">
                  <c:v>6750</c:v>
                </c:pt>
                <c:pt idx="11">
                  <c:v>7925</c:v>
                </c:pt>
                <c:pt idx="12">
                  <c:v>6997</c:v>
                </c:pt>
                <c:pt idx="13">
                  <c:v>4987</c:v>
                </c:pt>
                <c:pt idx="14">
                  <c:v>3396</c:v>
                </c:pt>
                <c:pt idx="15">
                  <c:v>1065</c:v>
                </c:pt>
                <c:pt idx="16">
                  <c:v>1987</c:v>
                </c:pt>
                <c:pt idx="17">
                  <c:v>3722</c:v>
                </c:pt>
                <c:pt idx="18">
                  <c:v>4762</c:v>
                </c:pt>
                <c:pt idx="19">
                  <c:v>3325</c:v>
                </c:pt>
                <c:pt idx="20">
                  <c:v>4910</c:v>
                </c:pt>
                <c:pt idx="21">
                  <c:v>4099</c:v>
                </c:pt>
                <c:pt idx="22">
                  <c:v>2651</c:v>
                </c:pt>
                <c:pt idx="23">
                  <c:v>4400</c:v>
                </c:pt>
                <c:pt idx="24">
                  <c:v>6494</c:v>
                </c:pt>
                <c:pt idx="25">
                  <c:v>8476</c:v>
                </c:pt>
                <c:pt idx="26">
                  <c:v>7770</c:v>
                </c:pt>
                <c:pt idx="27">
                  <c:v>8228</c:v>
                </c:pt>
                <c:pt idx="28">
                  <c:v>6372</c:v>
                </c:pt>
                <c:pt idx="29">
                  <c:v>4969</c:v>
                </c:pt>
                <c:pt idx="30">
                  <c:v>5596</c:v>
                </c:pt>
                <c:pt idx="31">
                  <c:v>5736</c:v>
                </c:pt>
                <c:pt idx="32">
                  <c:v>6255</c:v>
                </c:pt>
                <c:pt idx="33">
                  <c:v>8324</c:v>
                </c:pt>
                <c:pt idx="34">
                  <c:v>6598</c:v>
                </c:pt>
                <c:pt idx="35">
                  <c:v>7207</c:v>
                </c:pt>
                <c:pt idx="36">
                  <c:v>7450</c:v>
                </c:pt>
                <c:pt idx="37">
                  <c:v>10726</c:v>
                </c:pt>
                <c:pt idx="38">
                  <c:v>6825</c:v>
                </c:pt>
                <c:pt idx="39">
                  <c:v>7566</c:v>
                </c:pt>
                <c:pt idx="40">
                  <c:v>6929</c:v>
                </c:pt>
                <c:pt idx="41">
                  <c:v>6964</c:v>
                </c:pt>
                <c:pt idx="42">
                  <c:v>6091</c:v>
                </c:pt>
                <c:pt idx="43">
                  <c:v>6410</c:v>
                </c:pt>
                <c:pt idx="44">
                  <c:v>6375</c:v>
                </c:pt>
                <c:pt idx="45">
                  <c:v>6163</c:v>
                </c:pt>
                <c:pt idx="46">
                  <c:v>4216</c:v>
                </c:pt>
                <c:pt idx="47">
                  <c:v>3089</c:v>
                </c:pt>
                <c:pt idx="48">
                  <c:v>3640</c:v>
                </c:pt>
                <c:pt idx="49">
                  <c:v>4033</c:v>
                </c:pt>
                <c:pt idx="50">
                  <c:v>3312</c:v>
                </c:pt>
                <c:pt idx="51">
                  <c:v>3747</c:v>
                </c:pt>
                <c:pt idx="52">
                  <c:v>4587</c:v>
                </c:pt>
                <c:pt idx="53">
                  <c:v>5902</c:v>
                </c:pt>
                <c:pt idx="54">
                  <c:v>2749</c:v>
                </c:pt>
                <c:pt idx="55">
                  <c:v>2995</c:v>
                </c:pt>
                <c:pt idx="56">
                  <c:v>3219</c:v>
                </c:pt>
                <c:pt idx="57">
                  <c:v>4393</c:v>
                </c:pt>
                <c:pt idx="58">
                  <c:v>3016</c:v>
                </c:pt>
                <c:pt idx="59">
                  <c:v>3250</c:v>
                </c:pt>
                <c:pt idx="60">
                  <c:v>3677</c:v>
                </c:pt>
                <c:pt idx="61">
                  <c:v>4218</c:v>
                </c:pt>
                <c:pt idx="62">
                  <c:v>5014</c:v>
                </c:pt>
                <c:pt idx="63">
                  <c:v>5462</c:v>
                </c:pt>
                <c:pt idx="64">
                  <c:v>4722</c:v>
                </c:pt>
                <c:pt idx="65">
                  <c:v>4862</c:v>
                </c:pt>
                <c:pt idx="66">
                  <c:v>4813</c:v>
                </c:pt>
                <c:pt idx="67">
                  <c:v>5013</c:v>
                </c:pt>
                <c:pt idx="68">
                  <c:v>5545</c:v>
                </c:pt>
                <c:pt idx="69">
                  <c:v>5699</c:v>
                </c:pt>
                <c:pt idx="70">
                  <c:v>4906</c:v>
                </c:pt>
                <c:pt idx="71">
                  <c:v>4648</c:v>
                </c:pt>
                <c:pt idx="72">
                  <c:v>5097</c:v>
                </c:pt>
                <c:pt idx="73">
                  <c:v>4055</c:v>
                </c:pt>
                <c:pt idx="74">
                  <c:v>4927</c:v>
                </c:pt>
                <c:pt idx="75">
                  <c:v>4940</c:v>
                </c:pt>
                <c:pt idx="76">
                  <c:v>4757</c:v>
                </c:pt>
                <c:pt idx="77">
                  <c:v>31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1E29-3342-A2AA-0E5784E973CA}"/>
            </c:ext>
          </c:extLst>
        </c:ser>
        <c:ser>
          <c:idx val="19"/>
          <c:order val="19"/>
          <c:tx>
            <c:strRef>
              <c:f>Neat!$A$23</c:f>
              <c:strCache>
                <c:ptCount val="1"/>
                <c:pt idx="0">
                  <c:v>B18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3:$CA$23</c:f>
              <c:numCache>
                <c:formatCode>General</c:formatCode>
                <c:ptCount val="78"/>
                <c:pt idx="0">
                  <c:v>15116</c:v>
                </c:pt>
                <c:pt idx="1">
                  <c:v>12264</c:v>
                </c:pt>
                <c:pt idx="2">
                  <c:v>13050</c:v>
                </c:pt>
                <c:pt idx="3">
                  <c:v>12351</c:v>
                </c:pt>
                <c:pt idx="4">
                  <c:v>9289</c:v>
                </c:pt>
                <c:pt idx="5">
                  <c:v>6270</c:v>
                </c:pt>
                <c:pt idx="6">
                  <c:v>10011</c:v>
                </c:pt>
                <c:pt idx="7">
                  <c:v>10884</c:v>
                </c:pt>
                <c:pt idx="8">
                  <c:v>5587</c:v>
                </c:pt>
                <c:pt idx="9">
                  <c:v>10045</c:v>
                </c:pt>
                <c:pt idx="10">
                  <c:v>5154</c:v>
                </c:pt>
                <c:pt idx="11">
                  <c:v>5728</c:v>
                </c:pt>
                <c:pt idx="12">
                  <c:v>5600</c:v>
                </c:pt>
                <c:pt idx="13">
                  <c:v>3673</c:v>
                </c:pt>
                <c:pt idx="14">
                  <c:v>2436</c:v>
                </c:pt>
                <c:pt idx="15">
                  <c:v>0</c:v>
                </c:pt>
                <c:pt idx="16">
                  <c:v>1538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1412</c:v>
                </c:pt>
                <c:pt idx="22">
                  <c:v>1350</c:v>
                </c:pt>
                <c:pt idx="23">
                  <c:v>3526</c:v>
                </c:pt>
                <c:pt idx="24">
                  <c:v>6192</c:v>
                </c:pt>
                <c:pt idx="25">
                  <c:v>8488</c:v>
                </c:pt>
                <c:pt idx="26">
                  <c:v>7263</c:v>
                </c:pt>
                <c:pt idx="27">
                  <c:v>7986</c:v>
                </c:pt>
                <c:pt idx="28">
                  <c:v>5958</c:v>
                </c:pt>
                <c:pt idx="29">
                  <c:v>4800</c:v>
                </c:pt>
                <c:pt idx="30">
                  <c:v>4127</c:v>
                </c:pt>
                <c:pt idx="31">
                  <c:v>3956</c:v>
                </c:pt>
                <c:pt idx="32">
                  <c:v>4286</c:v>
                </c:pt>
                <c:pt idx="33">
                  <c:v>6214</c:v>
                </c:pt>
                <c:pt idx="34">
                  <c:v>5114</c:v>
                </c:pt>
                <c:pt idx="35">
                  <c:v>4923</c:v>
                </c:pt>
                <c:pt idx="36">
                  <c:v>4826</c:v>
                </c:pt>
                <c:pt idx="37">
                  <c:v>6928</c:v>
                </c:pt>
                <c:pt idx="38">
                  <c:v>4374</c:v>
                </c:pt>
                <c:pt idx="39">
                  <c:v>4635</c:v>
                </c:pt>
                <c:pt idx="40">
                  <c:v>4400</c:v>
                </c:pt>
                <c:pt idx="41">
                  <c:v>5157</c:v>
                </c:pt>
                <c:pt idx="42">
                  <c:v>3712</c:v>
                </c:pt>
                <c:pt idx="43">
                  <c:v>3798</c:v>
                </c:pt>
                <c:pt idx="44">
                  <c:v>3141</c:v>
                </c:pt>
                <c:pt idx="45">
                  <c:v>3150</c:v>
                </c:pt>
                <c:pt idx="46">
                  <c:v>2130</c:v>
                </c:pt>
                <c:pt idx="47">
                  <c:v>1676</c:v>
                </c:pt>
                <c:pt idx="48">
                  <c:v>1745</c:v>
                </c:pt>
                <c:pt idx="49">
                  <c:v>1761</c:v>
                </c:pt>
                <c:pt idx="50">
                  <c:v>1419</c:v>
                </c:pt>
                <c:pt idx="51">
                  <c:v>1491</c:v>
                </c:pt>
                <c:pt idx="52">
                  <c:v>2567</c:v>
                </c:pt>
                <c:pt idx="53">
                  <c:v>3611</c:v>
                </c:pt>
                <c:pt idx="54">
                  <c:v>1467</c:v>
                </c:pt>
                <c:pt idx="55">
                  <c:v>1388</c:v>
                </c:pt>
                <c:pt idx="56">
                  <c:v>1721</c:v>
                </c:pt>
                <c:pt idx="57">
                  <c:v>1408</c:v>
                </c:pt>
                <c:pt idx="58">
                  <c:v>1276</c:v>
                </c:pt>
                <c:pt idx="59">
                  <c:v>1606</c:v>
                </c:pt>
                <c:pt idx="60">
                  <c:v>1472</c:v>
                </c:pt>
                <c:pt idx="61">
                  <c:v>1554</c:v>
                </c:pt>
                <c:pt idx="62">
                  <c:v>2348</c:v>
                </c:pt>
                <c:pt idx="63">
                  <c:v>2381</c:v>
                </c:pt>
                <c:pt idx="64">
                  <c:v>1697</c:v>
                </c:pt>
                <c:pt idx="65">
                  <c:v>1890</c:v>
                </c:pt>
                <c:pt idx="66">
                  <c:v>2146</c:v>
                </c:pt>
                <c:pt idx="67">
                  <c:v>1842</c:v>
                </c:pt>
                <c:pt idx="68">
                  <c:v>2030</c:v>
                </c:pt>
                <c:pt idx="69">
                  <c:v>2080</c:v>
                </c:pt>
                <c:pt idx="70">
                  <c:v>1590</c:v>
                </c:pt>
                <c:pt idx="71">
                  <c:v>0</c:v>
                </c:pt>
                <c:pt idx="72">
                  <c:v>1101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1E29-3342-A2AA-0E5784E973CA}"/>
            </c:ext>
          </c:extLst>
        </c:ser>
        <c:ser>
          <c:idx val="20"/>
          <c:order val="20"/>
          <c:tx>
            <c:strRef>
              <c:f>Neat!$A$24</c:f>
              <c:strCache>
                <c:ptCount val="1"/>
                <c:pt idx="0">
                  <c:v>B27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</a:schemeClr>
              </a:solidFill>
              <a:ln w="9525">
                <a:solidFill>
                  <a:schemeClr val="accent3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4:$CA$24</c:f>
              <c:numCache>
                <c:formatCode>General</c:formatCode>
                <c:ptCount val="78"/>
                <c:pt idx="0">
                  <c:v>13722</c:v>
                </c:pt>
                <c:pt idx="1">
                  <c:v>20952</c:v>
                </c:pt>
                <c:pt idx="2">
                  <c:v>20956</c:v>
                </c:pt>
                <c:pt idx="3">
                  <c:v>21384</c:v>
                </c:pt>
                <c:pt idx="4">
                  <c:v>22723</c:v>
                </c:pt>
                <c:pt idx="5">
                  <c:v>19295</c:v>
                </c:pt>
                <c:pt idx="6">
                  <c:v>23284</c:v>
                </c:pt>
                <c:pt idx="7">
                  <c:v>23513</c:v>
                </c:pt>
                <c:pt idx="8">
                  <c:v>16512</c:v>
                </c:pt>
                <c:pt idx="9">
                  <c:v>21411</c:v>
                </c:pt>
                <c:pt idx="10">
                  <c:v>16176</c:v>
                </c:pt>
                <c:pt idx="11">
                  <c:v>18214</c:v>
                </c:pt>
                <c:pt idx="12">
                  <c:v>17220</c:v>
                </c:pt>
                <c:pt idx="13">
                  <c:v>14180</c:v>
                </c:pt>
                <c:pt idx="14">
                  <c:v>10626</c:v>
                </c:pt>
                <c:pt idx="15">
                  <c:v>4429</c:v>
                </c:pt>
                <c:pt idx="16">
                  <c:v>7191</c:v>
                </c:pt>
                <c:pt idx="17">
                  <c:v>11145</c:v>
                </c:pt>
                <c:pt idx="18">
                  <c:v>9276</c:v>
                </c:pt>
                <c:pt idx="19">
                  <c:v>9882</c:v>
                </c:pt>
                <c:pt idx="20">
                  <c:v>12253</c:v>
                </c:pt>
                <c:pt idx="21">
                  <c:v>10759</c:v>
                </c:pt>
                <c:pt idx="22">
                  <c:v>6073</c:v>
                </c:pt>
                <c:pt idx="23">
                  <c:v>11735</c:v>
                </c:pt>
                <c:pt idx="24">
                  <c:v>15950</c:v>
                </c:pt>
                <c:pt idx="25">
                  <c:v>19168</c:v>
                </c:pt>
                <c:pt idx="26">
                  <c:v>21603</c:v>
                </c:pt>
                <c:pt idx="27">
                  <c:v>22045</c:v>
                </c:pt>
                <c:pt idx="28">
                  <c:v>17396</c:v>
                </c:pt>
                <c:pt idx="29">
                  <c:v>12040</c:v>
                </c:pt>
                <c:pt idx="30">
                  <c:v>13737</c:v>
                </c:pt>
                <c:pt idx="31">
                  <c:v>14146</c:v>
                </c:pt>
                <c:pt idx="32">
                  <c:v>17813</c:v>
                </c:pt>
                <c:pt idx="33">
                  <c:v>18799</c:v>
                </c:pt>
                <c:pt idx="34">
                  <c:v>17178</c:v>
                </c:pt>
                <c:pt idx="35">
                  <c:v>17097</c:v>
                </c:pt>
                <c:pt idx="36">
                  <c:v>17253</c:v>
                </c:pt>
                <c:pt idx="37">
                  <c:v>22259</c:v>
                </c:pt>
                <c:pt idx="38">
                  <c:v>16656</c:v>
                </c:pt>
                <c:pt idx="39">
                  <c:v>18101</c:v>
                </c:pt>
                <c:pt idx="40">
                  <c:v>16568</c:v>
                </c:pt>
                <c:pt idx="41">
                  <c:v>16361</c:v>
                </c:pt>
                <c:pt idx="42">
                  <c:v>14743</c:v>
                </c:pt>
                <c:pt idx="43">
                  <c:v>16402</c:v>
                </c:pt>
                <c:pt idx="44">
                  <c:v>16381</c:v>
                </c:pt>
                <c:pt idx="45">
                  <c:v>16416</c:v>
                </c:pt>
                <c:pt idx="46">
                  <c:v>10812</c:v>
                </c:pt>
                <c:pt idx="47">
                  <c:v>8442</c:v>
                </c:pt>
                <c:pt idx="48">
                  <c:v>9895</c:v>
                </c:pt>
                <c:pt idx="49">
                  <c:v>10702</c:v>
                </c:pt>
                <c:pt idx="50">
                  <c:v>9333</c:v>
                </c:pt>
                <c:pt idx="51">
                  <c:v>10414</c:v>
                </c:pt>
                <c:pt idx="52">
                  <c:v>11080</c:v>
                </c:pt>
                <c:pt idx="53">
                  <c:v>14656</c:v>
                </c:pt>
                <c:pt idx="54">
                  <c:v>7488</c:v>
                </c:pt>
                <c:pt idx="55">
                  <c:v>8033</c:v>
                </c:pt>
                <c:pt idx="56">
                  <c:v>8369</c:v>
                </c:pt>
                <c:pt idx="57">
                  <c:v>7280</c:v>
                </c:pt>
                <c:pt idx="58">
                  <c:v>7697</c:v>
                </c:pt>
                <c:pt idx="59">
                  <c:v>8267</c:v>
                </c:pt>
                <c:pt idx="60">
                  <c:v>9141</c:v>
                </c:pt>
                <c:pt idx="61">
                  <c:v>10564</c:v>
                </c:pt>
                <c:pt idx="62">
                  <c:v>12102</c:v>
                </c:pt>
                <c:pt idx="63">
                  <c:v>12404</c:v>
                </c:pt>
                <c:pt idx="64">
                  <c:v>11177</c:v>
                </c:pt>
                <c:pt idx="65">
                  <c:v>11900</c:v>
                </c:pt>
                <c:pt idx="66">
                  <c:v>10710</c:v>
                </c:pt>
                <c:pt idx="67">
                  <c:v>12309</c:v>
                </c:pt>
                <c:pt idx="68">
                  <c:v>13158</c:v>
                </c:pt>
                <c:pt idx="69">
                  <c:v>13184</c:v>
                </c:pt>
                <c:pt idx="70">
                  <c:v>12112</c:v>
                </c:pt>
                <c:pt idx="71">
                  <c:v>13171</c:v>
                </c:pt>
                <c:pt idx="72">
                  <c:v>13857</c:v>
                </c:pt>
                <c:pt idx="73">
                  <c:v>12457</c:v>
                </c:pt>
                <c:pt idx="74">
                  <c:v>13108</c:v>
                </c:pt>
                <c:pt idx="75">
                  <c:v>13056</c:v>
                </c:pt>
                <c:pt idx="76">
                  <c:v>12671</c:v>
                </c:pt>
                <c:pt idx="77">
                  <c:v>8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1E29-3342-A2AA-0E5784E973CA}"/>
            </c:ext>
          </c:extLst>
        </c:ser>
        <c:ser>
          <c:idx val="21"/>
          <c:order val="21"/>
          <c:tx>
            <c:strRef>
              <c:f>Neat!$A$25</c:f>
              <c:strCache>
                <c:ptCount val="1"/>
                <c:pt idx="0">
                  <c:v>B35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5:$CA$25</c:f>
              <c:numCache>
                <c:formatCode>General</c:formatCode>
                <c:ptCount val="78"/>
                <c:pt idx="0">
                  <c:v>13524</c:v>
                </c:pt>
                <c:pt idx="1">
                  <c:v>10410</c:v>
                </c:pt>
                <c:pt idx="2">
                  <c:v>10896</c:v>
                </c:pt>
                <c:pt idx="3">
                  <c:v>10470</c:v>
                </c:pt>
                <c:pt idx="4">
                  <c:v>7532</c:v>
                </c:pt>
                <c:pt idx="5">
                  <c:v>5382</c:v>
                </c:pt>
                <c:pt idx="6">
                  <c:v>8970</c:v>
                </c:pt>
                <c:pt idx="7">
                  <c:v>9847</c:v>
                </c:pt>
                <c:pt idx="8">
                  <c:v>4633</c:v>
                </c:pt>
                <c:pt idx="9">
                  <c:v>8822</c:v>
                </c:pt>
                <c:pt idx="10">
                  <c:v>4297</c:v>
                </c:pt>
                <c:pt idx="11">
                  <c:v>4990</c:v>
                </c:pt>
                <c:pt idx="12">
                  <c:v>4536</c:v>
                </c:pt>
                <c:pt idx="13">
                  <c:v>3193</c:v>
                </c:pt>
                <c:pt idx="14">
                  <c:v>204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541</c:v>
                </c:pt>
                <c:pt idx="26">
                  <c:v>1788</c:v>
                </c:pt>
                <c:pt idx="27">
                  <c:v>1747</c:v>
                </c:pt>
                <c:pt idx="28">
                  <c:v>0</c:v>
                </c:pt>
                <c:pt idx="29">
                  <c:v>163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227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1195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1E29-3342-A2AA-0E5784E973CA}"/>
            </c:ext>
          </c:extLst>
        </c:ser>
        <c:ser>
          <c:idx val="22"/>
          <c:order val="22"/>
          <c:tx>
            <c:strRef>
              <c:f>Neat!$A$26</c:f>
              <c:strCache>
                <c:ptCount val="1"/>
                <c:pt idx="0">
                  <c:v>B37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</a:schemeClr>
              </a:solidFill>
              <a:ln w="9525">
                <a:solidFill>
                  <a:schemeClr val="accent5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6:$CA$26</c:f>
              <c:numCache>
                <c:formatCode>General</c:formatCode>
                <c:ptCount val="78"/>
                <c:pt idx="0">
                  <c:v>7021</c:v>
                </c:pt>
                <c:pt idx="1">
                  <c:v>5461</c:v>
                </c:pt>
                <c:pt idx="2">
                  <c:v>5700</c:v>
                </c:pt>
                <c:pt idx="3">
                  <c:v>6685</c:v>
                </c:pt>
                <c:pt idx="4">
                  <c:v>5312</c:v>
                </c:pt>
                <c:pt idx="5">
                  <c:v>3137</c:v>
                </c:pt>
                <c:pt idx="6">
                  <c:v>5553</c:v>
                </c:pt>
                <c:pt idx="7">
                  <c:v>5843</c:v>
                </c:pt>
                <c:pt idx="8">
                  <c:v>3177</c:v>
                </c:pt>
                <c:pt idx="9">
                  <c:v>6575</c:v>
                </c:pt>
                <c:pt idx="10">
                  <c:v>3048</c:v>
                </c:pt>
                <c:pt idx="11">
                  <c:v>3453</c:v>
                </c:pt>
                <c:pt idx="12">
                  <c:v>2696</c:v>
                </c:pt>
                <c:pt idx="13">
                  <c:v>1954</c:v>
                </c:pt>
                <c:pt idx="14">
                  <c:v>1157</c:v>
                </c:pt>
                <c:pt idx="15">
                  <c:v>0</c:v>
                </c:pt>
                <c:pt idx="16">
                  <c:v>0</c:v>
                </c:pt>
                <c:pt idx="17">
                  <c:v>1383</c:v>
                </c:pt>
                <c:pt idx="18">
                  <c:v>1269</c:v>
                </c:pt>
                <c:pt idx="19">
                  <c:v>1737</c:v>
                </c:pt>
                <c:pt idx="20">
                  <c:v>2607</c:v>
                </c:pt>
                <c:pt idx="21">
                  <c:v>2234</c:v>
                </c:pt>
                <c:pt idx="22">
                  <c:v>0</c:v>
                </c:pt>
                <c:pt idx="23">
                  <c:v>2473</c:v>
                </c:pt>
                <c:pt idx="24">
                  <c:v>3967</c:v>
                </c:pt>
                <c:pt idx="25">
                  <c:v>5262</c:v>
                </c:pt>
                <c:pt idx="26">
                  <c:v>4413</c:v>
                </c:pt>
                <c:pt idx="27">
                  <c:v>4934</c:v>
                </c:pt>
                <c:pt idx="28">
                  <c:v>4006</c:v>
                </c:pt>
                <c:pt idx="29">
                  <c:v>3507</c:v>
                </c:pt>
                <c:pt idx="30">
                  <c:v>3384</c:v>
                </c:pt>
                <c:pt idx="31">
                  <c:v>3798</c:v>
                </c:pt>
                <c:pt idx="32">
                  <c:v>3387</c:v>
                </c:pt>
                <c:pt idx="33">
                  <c:v>5537</c:v>
                </c:pt>
                <c:pt idx="34">
                  <c:v>4079</c:v>
                </c:pt>
                <c:pt idx="35">
                  <c:v>4681</c:v>
                </c:pt>
                <c:pt idx="36">
                  <c:v>4875</c:v>
                </c:pt>
                <c:pt idx="37">
                  <c:v>7683</c:v>
                </c:pt>
                <c:pt idx="38">
                  <c:v>3983</c:v>
                </c:pt>
                <c:pt idx="39">
                  <c:v>4708</c:v>
                </c:pt>
                <c:pt idx="40">
                  <c:v>4457</c:v>
                </c:pt>
                <c:pt idx="41">
                  <c:v>4250</c:v>
                </c:pt>
                <c:pt idx="42">
                  <c:v>3743</c:v>
                </c:pt>
                <c:pt idx="43">
                  <c:v>3920</c:v>
                </c:pt>
                <c:pt idx="44">
                  <c:v>3887</c:v>
                </c:pt>
                <c:pt idx="45">
                  <c:v>3507</c:v>
                </c:pt>
                <c:pt idx="46">
                  <c:v>2477</c:v>
                </c:pt>
                <c:pt idx="47">
                  <c:v>1605</c:v>
                </c:pt>
                <c:pt idx="48">
                  <c:v>2010</c:v>
                </c:pt>
                <c:pt idx="49">
                  <c:v>2133</c:v>
                </c:pt>
                <c:pt idx="50">
                  <c:v>1799</c:v>
                </c:pt>
                <c:pt idx="51">
                  <c:v>2044</c:v>
                </c:pt>
                <c:pt idx="52">
                  <c:v>2748</c:v>
                </c:pt>
                <c:pt idx="53">
                  <c:v>3565</c:v>
                </c:pt>
                <c:pt idx="54">
                  <c:v>1718</c:v>
                </c:pt>
                <c:pt idx="55">
                  <c:v>1740</c:v>
                </c:pt>
                <c:pt idx="56">
                  <c:v>1838</c:v>
                </c:pt>
                <c:pt idx="57">
                  <c:v>1243</c:v>
                </c:pt>
                <c:pt idx="58">
                  <c:v>1782</c:v>
                </c:pt>
                <c:pt idx="59">
                  <c:v>1913</c:v>
                </c:pt>
                <c:pt idx="60">
                  <c:v>2080</c:v>
                </c:pt>
                <c:pt idx="61">
                  <c:v>2393</c:v>
                </c:pt>
                <c:pt idx="62">
                  <c:v>3257</c:v>
                </c:pt>
                <c:pt idx="63">
                  <c:v>3365</c:v>
                </c:pt>
                <c:pt idx="64">
                  <c:v>2963</c:v>
                </c:pt>
                <c:pt idx="65">
                  <c:v>3170</c:v>
                </c:pt>
                <c:pt idx="66">
                  <c:v>3132</c:v>
                </c:pt>
                <c:pt idx="67">
                  <c:v>3130</c:v>
                </c:pt>
                <c:pt idx="68">
                  <c:v>3472</c:v>
                </c:pt>
                <c:pt idx="69">
                  <c:v>3470</c:v>
                </c:pt>
                <c:pt idx="70">
                  <c:v>3357</c:v>
                </c:pt>
                <c:pt idx="71">
                  <c:v>2867</c:v>
                </c:pt>
                <c:pt idx="72">
                  <c:v>3330</c:v>
                </c:pt>
                <c:pt idx="73">
                  <c:v>2496</c:v>
                </c:pt>
                <c:pt idx="74">
                  <c:v>3308</c:v>
                </c:pt>
                <c:pt idx="75">
                  <c:v>3213</c:v>
                </c:pt>
                <c:pt idx="76">
                  <c:v>3155</c:v>
                </c:pt>
                <c:pt idx="77">
                  <c:v>20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1E29-3342-A2AA-0E5784E973CA}"/>
            </c:ext>
          </c:extLst>
        </c:ser>
        <c:ser>
          <c:idx val="23"/>
          <c:order val="23"/>
          <c:tx>
            <c:strRef>
              <c:f>Neat!$A$27</c:f>
              <c:strCache>
                <c:ptCount val="1"/>
                <c:pt idx="0">
                  <c:v>B38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</a:schemeClr>
              </a:solidFill>
              <a:ln w="9525">
                <a:solidFill>
                  <a:schemeClr val="accent6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7:$CA$27</c:f>
              <c:numCache>
                <c:formatCode>General</c:formatCode>
                <c:ptCount val="78"/>
                <c:pt idx="0">
                  <c:v>5388</c:v>
                </c:pt>
                <c:pt idx="1">
                  <c:v>3118</c:v>
                </c:pt>
                <c:pt idx="2">
                  <c:v>3732</c:v>
                </c:pt>
                <c:pt idx="3">
                  <c:v>3672</c:v>
                </c:pt>
                <c:pt idx="4">
                  <c:v>2600</c:v>
                </c:pt>
                <c:pt idx="5">
                  <c:v>1363</c:v>
                </c:pt>
                <c:pt idx="6">
                  <c:v>2824</c:v>
                </c:pt>
                <c:pt idx="7">
                  <c:v>2983</c:v>
                </c:pt>
                <c:pt idx="8">
                  <c:v>1438</c:v>
                </c:pt>
                <c:pt idx="9">
                  <c:v>3150</c:v>
                </c:pt>
                <c:pt idx="10">
                  <c:v>1273</c:v>
                </c:pt>
                <c:pt idx="11">
                  <c:v>132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2560</c:v>
                </c:pt>
                <c:pt idx="24">
                  <c:v>4606</c:v>
                </c:pt>
                <c:pt idx="25">
                  <c:v>6579</c:v>
                </c:pt>
                <c:pt idx="26">
                  <c:v>4115</c:v>
                </c:pt>
                <c:pt idx="27">
                  <c:v>4343</c:v>
                </c:pt>
                <c:pt idx="28">
                  <c:v>3604</c:v>
                </c:pt>
                <c:pt idx="29">
                  <c:v>2482</c:v>
                </c:pt>
                <c:pt idx="30">
                  <c:v>2485</c:v>
                </c:pt>
                <c:pt idx="31">
                  <c:v>2566</c:v>
                </c:pt>
                <c:pt idx="32">
                  <c:v>2750</c:v>
                </c:pt>
                <c:pt idx="33">
                  <c:v>4404</c:v>
                </c:pt>
                <c:pt idx="34">
                  <c:v>3212</c:v>
                </c:pt>
                <c:pt idx="35">
                  <c:v>3170</c:v>
                </c:pt>
                <c:pt idx="36">
                  <c:v>3568</c:v>
                </c:pt>
                <c:pt idx="37">
                  <c:v>5237</c:v>
                </c:pt>
                <c:pt idx="38">
                  <c:v>3410</c:v>
                </c:pt>
                <c:pt idx="39">
                  <c:v>3583</c:v>
                </c:pt>
                <c:pt idx="40">
                  <c:v>3476</c:v>
                </c:pt>
                <c:pt idx="41">
                  <c:v>4128</c:v>
                </c:pt>
                <c:pt idx="42">
                  <c:v>2886</c:v>
                </c:pt>
                <c:pt idx="43">
                  <c:v>3134</c:v>
                </c:pt>
                <c:pt idx="44">
                  <c:v>2563</c:v>
                </c:pt>
                <c:pt idx="45">
                  <c:v>2527</c:v>
                </c:pt>
                <c:pt idx="46">
                  <c:v>1580</c:v>
                </c:pt>
                <c:pt idx="47">
                  <c:v>1369</c:v>
                </c:pt>
                <c:pt idx="48">
                  <c:v>1267</c:v>
                </c:pt>
                <c:pt idx="49">
                  <c:v>1249</c:v>
                </c:pt>
                <c:pt idx="50">
                  <c:v>1017</c:v>
                </c:pt>
                <c:pt idx="51">
                  <c:v>0</c:v>
                </c:pt>
                <c:pt idx="52">
                  <c:v>2026</c:v>
                </c:pt>
                <c:pt idx="53">
                  <c:v>2947</c:v>
                </c:pt>
                <c:pt idx="54">
                  <c:v>0</c:v>
                </c:pt>
                <c:pt idx="55">
                  <c:v>0</c:v>
                </c:pt>
                <c:pt idx="56">
                  <c:v>1425</c:v>
                </c:pt>
                <c:pt idx="57">
                  <c:v>1232</c:v>
                </c:pt>
                <c:pt idx="58">
                  <c:v>0</c:v>
                </c:pt>
                <c:pt idx="59">
                  <c:v>1319</c:v>
                </c:pt>
                <c:pt idx="60">
                  <c:v>1170</c:v>
                </c:pt>
                <c:pt idx="61">
                  <c:v>1139</c:v>
                </c:pt>
                <c:pt idx="62">
                  <c:v>1909</c:v>
                </c:pt>
                <c:pt idx="63">
                  <c:v>1974</c:v>
                </c:pt>
                <c:pt idx="64">
                  <c:v>1302</c:v>
                </c:pt>
                <c:pt idx="65">
                  <c:v>1460</c:v>
                </c:pt>
                <c:pt idx="66">
                  <c:v>1582</c:v>
                </c:pt>
                <c:pt idx="67">
                  <c:v>1227</c:v>
                </c:pt>
                <c:pt idx="68">
                  <c:v>1269</c:v>
                </c:pt>
                <c:pt idx="69">
                  <c:v>1419</c:v>
                </c:pt>
                <c:pt idx="70">
                  <c:v>1319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1E29-3342-A2AA-0E5784E973CA}"/>
            </c:ext>
          </c:extLst>
        </c:ser>
        <c:ser>
          <c:idx val="24"/>
          <c:order val="24"/>
          <c:tx>
            <c:strRef>
              <c:f>Neat!$A$28</c:f>
              <c:strCache>
                <c:ptCount val="1"/>
                <c:pt idx="0">
                  <c:v>B39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8:$CA$28</c:f>
              <c:numCache>
                <c:formatCode>General</c:formatCode>
                <c:ptCount val="78"/>
                <c:pt idx="0">
                  <c:v>15365</c:v>
                </c:pt>
                <c:pt idx="1">
                  <c:v>13568</c:v>
                </c:pt>
                <c:pt idx="2">
                  <c:v>14361</c:v>
                </c:pt>
                <c:pt idx="3">
                  <c:v>13160</c:v>
                </c:pt>
                <c:pt idx="4">
                  <c:v>10128</c:v>
                </c:pt>
                <c:pt idx="5">
                  <c:v>7007</c:v>
                </c:pt>
                <c:pt idx="6">
                  <c:v>11180</c:v>
                </c:pt>
                <c:pt idx="7">
                  <c:v>12076</c:v>
                </c:pt>
                <c:pt idx="8">
                  <c:v>5653</c:v>
                </c:pt>
                <c:pt idx="9">
                  <c:v>10881</c:v>
                </c:pt>
                <c:pt idx="10">
                  <c:v>5575</c:v>
                </c:pt>
                <c:pt idx="11">
                  <c:v>6244</c:v>
                </c:pt>
                <c:pt idx="12">
                  <c:v>5785</c:v>
                </c:pt>
                <c:pt idx="13">
                  <c:v>4123</c:v>
                </c:pt>
                <c:pt idx="14">
                  <c:v>2683</c:v>
                </c:pt>
                <c:pt idx="15">
                  <c:v>0</c:v>
                </c:pt>
                <c:pt idx="16">
                  <c:v>1724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1651</c:v>
                </c:pt>
                <c:pt idx="22">
                  <c:v>1777</c:v>
                </c:pt>
                <c:pt idx="23">
                  <c:v>3128</c:v>
                </c:pt>
                <c:pt idx="24">
                  <c:v>4952</c:v>
                </c:pt>
                <c:pt idx="25">
                  <c:v>7375</c:v>
                </c:pt>
                <c:pt idx="26">
                  <c:v>5601</c:v>
                </c:pt>
                <c:pt idx="27">
                  <c:v>6083</c:v>
                </c:pt>
                <c:pt idx="28">
                  <c:v>4161</c:v>
                </c:pt>
                <c:pt idx="29">
                  <c:v>3411</c:v>
                </c:pt>
                <c:pt idx="30">
                  <c:v>2261</c:v>
                </c:pt>
                <c:pt idx="31">
                  <c:v>2503</c:v>
                </c:pt>
                <c:pt idx="32">
                  <c:v>3079</c:v>
                </c:pt>
                <c:pt idx="33">
                  <c:v>4228</c:v>
                </c:pt>
                <c:pt idx="34">
                  <c:v>3149</c:v>
                </c:pt>
                <c:pt idx="35">
                  <c:v>2909</c:v>
                </c:pt>
                <c:pt idx="36">
                  <c:v>3003</c:v>
                </c:pt>
                <c:pt idx="37">
                  <c:v>4818</c:v>
                </c:pt>
                <c:pt idx="38">
                  <c:v>2849</c:v>
                </c:pt>
                <c:pt idx="39">
                  <c:v>3012</c:v>
                </c:pt>
                <c:pt idx="40">
                  <c:v>2971</c:v>
                </c:pt>
                <c:pt idx="41">
                  <c:v>3375</c:v>
                </c:pt>
                <c:pt idx="42">
                  <c:v>2350</c:v>
                </c:pt>
                <c:pt idx="43">
                  <c:v>2500</c:v>
                </c:pt>
                <c:pt idx="44">
                  <c:v>1998</c:v>
                </c:pt>
                <c:pt idx="45">
                  <c:v>2020</c:v>
                </c:pt>
                <c:pt idx="46">
                  <c:v>1366</c:v>
                </c:pt>
                <c:pt idx="47">
                  <c:v>1115</c:v>
                </c:pt>
                <c:pt idx="48">
                  <c:v>1105</c:v>
                </c:pt>
                <c:pt idx="49">
                  <c:v>1122</c:v>
                </c:pt>
                <c:pt idx="50">
                  <c:v>0</c:v>
                </c:pt>
                <c:pt idx="51">
                  <c:v>0</c:v>
                </c:pt>
                <c:pt idx="52">
                  <c:v>1800</c:v>
                </c:pt>
                <c:pt idx="53">
                  <c:v>2728</c:v>
                </c:pt>
                <c:pt idx="54">
                  <c:v>0</c:v>
                </c:pt>
                <c:pt idx="55">
                  <c:v>0</c:v>
                </c:pt>
                <c:pt idx="56">
                  <c:v>1192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1646</c:v>
                </c:pt>
                <c:pt idx="63">
                  <c:v>1603</c:v>
                </c:pt>
                <c:pt idx="64">
                  <c:v>1084</c:v>
                </c:pt>
                <c:pt idx="65">
                  <c:v>1224</c:v>
                </c:pt>
                <c:pt idx="66">
                  <c:v>1405</c:v>
                </c:pt>
                <c:pt idx="67">
                  <c:v>1103</c:v>
                </c:pt>
                <c:pt idx="68">
                  <c:v>1232</c:v>
                </c:pt>
                <c:pt idx="69">
                  <c:v>1186</c:v>
                </c:pt>
                <c:pt idx="70">
                  <c:v>1288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E29-3342-A2AA-0E5784E973CA}"/>
            </c:ext>
          </c:extLst>
        </c:ser>
        <c:ser>
          <c:idx val="25"/>
          <c:order val="25"/>
          <c:tx>
            <c:strRef>
              <c:f>Neat!$A$29</c:f>
              <c:strCache>
                <c:ptCount val="1"/>
                <c:pt idx="0">
                  <c:v>B41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29:$CA$29</c:f>
              <c:numCache>
                <c:formatCode>General</c:formatCode>
                <c:ptCount val="78"/>
                <c:pt idx="0">
                  <c:v>11729</c:v>
                </c:pt>
                <c:pt idx="1">
                  <c:v>9498</c:v>
                </c:pt>
                <c:pt idx="2">
                  <c:v>9695</c:v>
                </c:pt>
                <c:pt idx="3">
                  <c:v>9544</c:v>
                </c:pt>
                <c:pt idx="4">
                  <c:v>6882</c:v>
                </c:pt>
                <c:pt idx="5">
                  <c:v>4662</c:v>
                </c:pt>
                <c:pt idx="6">
                  <c:v>7988</c:v>
                </c:pt>
                <c:pt idx="7">
                  <c:v>8910</c:v>
                </c:pt>
                <c:pt idx="8">
                  <c:v>4086</c:v>
                </c:pt>
                <c:pt idx="9">
                  <c:v>8027</c:v>
                </c:pt>
                <c:pt idx="10">
                  <c:v>3867</c:v>
                </c:pt>
                <c:pt idx="11">
                  <c:v>4346</c:v>
                </c:pt>
                <c:pt idx="12">
                  <c:v>4460</c:v>
                </c:pt>
                <c:pt idx="13">
                  <c:v>2865</c:v>
                </c:pt>
                <c:pt idx="14">
                  <c:v>1887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1837</c:v>
                </c:pt>
                <c:pt idx="25">
                  <c:v>3341</c:v>
                </c:pt>
                <c:pt idx="26">
                  <c:v>2265</c:v>
                </c:pt>
                <c:pt idx="27">
                  <c:v>2424</c:v>
                </c:pt>
                <c:pt idx="28">
                  <c:v>1536</c:v>
                </c:pt>
                <c:pt idx="29">
                  <c:v>1805</c:v>
                </c:pt>
                <c:pt idx="30">
                  <c:v>0</c:v>
                </c:pt>
                <c:pt idx="31">
                  <c:v>0</c:v>
                </c:pt>
                <c:pt idx="32">
                  <c:v>1220</c:v>
                </c:pt>
                <c:pt idx="33">
                  <c:v>1510</c:v>
                </c:pt>
                <c:pt idx="34">
                  <c:v>1198</c:v>
                </c:pt>
                <c:pt idx="35">
                  <c:v>0</c:v>
                </c:pt>
                <c:pt idx="36">
                  <c:v>0</c:v>
                </c:pt>
                <c:pt idx="37">
                  <c:v>1816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1E29-3342-A2AA-0E5784E973CA}"/>
            </c:ext>
          </c:extLst>
        </c:ser>
        <c:ser>
          <c:idx val="26"/>
          <c:order val="26"/>
          <c:tx>
            <c:strRef>
              <c:f>Neat!$A$30</c:f>
              <c:strCache>
                <c:ptCount val="1"/>
                <c:pt idx="0">
                  <c:v>B42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accent3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0:$CA$30</c:f>
              <c:numCache>
                <c:formatCode>General</c:formatCode>
                <c:ptCount val="78"/>
                <c:pt idx="0">
                  <c:v>14377</c:v>
                </c:pt>
                <c:pt idx="1">
                  <c:v>16723</c:v>
                </c:pt>
                <c:pt idx="2">
                  <c:v>17630</c:v>
                </c:pt>
                <c:pt idx="3">
                  <c:v>15809</c:v>
                </c:pt>
                <c:pt idx="4">
                  <c:v>13377</c:v>
                </c:pt>
                <c:pt idx="5">
                  <c:v>9682</c:v>
                </c:pt>
                <c:pt idx="6">
                  <c:v>14056</c:v>
                </c:pt>
                <c:pt idx="7">
                  <c:v>14732</c:v>
                </c:pt>
                <c:pt idx="8">
                  <c:v>7908</c:v>
                </c:pt>
                <c:pt idx="9">
                  <c:v>13198</c:v>
                </c:pt>
                <c:pt idx="10">
                  <c:v>7802</c:v>
                </c:pt>
                <c:pt idx="11">
                  <c:v>8627</c:v>
                </c:pt>
                <c:pt idx="12">
                  <c:v>8095</c:v>
                </c:pt>
                <c:pt idx="13">
                  <c:v>5731</c:v>
                </c:pt>
                <c:pt idx="14">
                  <c:v>3964</c:v>
                </c:pt>
                <c:pt idx="15">
                  <c:v>1339</c:v>
                </c:pt>
                <c:pt idx="16">
                  <c:v>2412</c:v>
                </c:pt>
                <c:pt idx="17">
                  <c:v>2109</c:v>
                </c:pt>
                <c:pt idx="18">
                  <c:v>1758</c:v>
                </c:pt>
                <c:pt idx="19">
                  <c:v>2372</c:v>
                </c:pt>
                <c:pt idx="20">
                  <c:v>3099</c:v>
                </c:pt>
                <c:pt idx="21">
                  <c:v>2975</c:v>
                </c:pt>
                <c:pt idx="22">
                  <c:v>2112</c:v>
                </c:pt>
                <c:pt idx="23">
                  <c:v>4193</c:v>
                </c:pt>
                <c:pt idx="24">
                  <c:v>5765</c:v>
                </c:pt>
                <c:pt idx="25">
                  <c:v>8855</c:v>
                </c:pt>
                <c:pt idx="26">
                  <c:v>7787</c:v>
                </c:pt>
                <c:pt idx="27">
                  <c:v>8654</c:v>
                </c:pt>
                <c:pt idx="28">
                  <c:v>5424</c:v>
                </c:pt>
                <c:pt idx="29">
                  <c:v>5220</c:v>
                </c:pt>
                <c:pt idx="30">
                  <c:v>4238</c:v>
                </c:pt>
                <c:pt idx="31">
                  <c:v>4235</c:v>
                </c:pt>
                <c:pt idx="32">
                  <c:v>5529</c:v>
                </c:pt>
                <c:pt idx="33">
                  <c:v>6515</c:v>
                </c:pt>
                <c:pt idx="34">
                  <c:v>5919</c:v>
                </c:pt>
                <c:pt idx="35">
                  <c:v>5322</c:v>
                </c:pt>
                <c:pt idx="36">
                  <c:v>5163</c:v>
                </c:pt>
                <c:pt idx="37">
                  <c:v>8451</c:v>
                </c:pt>
                <c:pt idx="38">
                  <c:v>4755</c:v>
                </c:pt>
                <c:pt idx="39">
                  <c:v>5442</c:v>
                </c:pt>
                <c:pt idx="40">
                  <c:v>4775</c:v>
                </c:pt>
                <c:pt idx="41">
                  <c:v>4942</c:v>
                </c:pt>
                <c:pt idx="42">
                  <c:v>3989</c:v>
                </c:pt>
                <c:pt idx="43">
                  <c:v>4349</c:v>
                </c:pt>
                <c:pt idx="44">
                  <c:v>4034</c:v>
                </c:pt>
                <c:pt idx="45">
                  <c:v>3852</c:v>
                </c:pt>
                <c:pt idx="46">
                  <c:v>2874</c:v>
                </c:pt>
                <c:pt idx="47">
                  <c:v>2082</c:v>
                </c:pt>
                <c:pt idx="48">
                  <c:v>2268</c:v>
                </c:pt>
                <c:pt idx="49">
                  <c:v>2347</c:v>
                </c:pt>
                <c:pt idx="50">
                  <c:v>1936</c:v>
                </c:pt>
                <c:pt idx="51">
                  <c:v>2119</c:v>
                </c:pt>
                <c:pt idx="52">
                  <c:v>3020</c:v>
                </c:pt>
                <c:pt idx="53">
                  <c:v>3968</c:v>
                </c:pt>
                <c:pt idx="54">
                  <c:v>2263</c:v>
                </c:pt>
                <c:pt idx="55">
                  <c:v>1907</c:v>
                </c:pt>
                <c:pt idx="56">
                  <c:v>1981</c:v>
                </c:pt>
                <c:pt idx="57">
                  <c:v>1781</c:v>
                </c:pt>
                <c:pt idx="58">
                  <c:v>1618</c:v>
                </c:pt>
                <c:pt idx="59">
                  <c:v>1765</c:v>
                </c:pt>
                <c:pt idx="60">
                  <c:v>1830</c:v>
                </c:pt>
                <c:pt idx="61">
                  <c:v>2044</c:v>
                </c:pt>
                <c:pt idx="62">
                  <c:v>2730</c:v>
                </c:pt>
                <c:pt idx="63">
                  <c:v>2913</c:v>
                </c:pt>
                <c:pt idx="64">
                  <c:v>2189</c:v>
                </c:pt>
                <c:pt idx="65">
                  <c:v>2364</c:v>
                </c:pt>
                <c:pt idx="66">
                  <c:v>2501</c:v>
                </c:pt>
                <c:pt idx="67">
                  <c:v>2403</c:v>
                </c:pt>
                <c:pt idx="68">
                  <c:v>2753</c:v>
                </c:pt>
                <c:pt idx="69">
                  <c:v>2754</c:v>
                </c:pt>
                <c:pt idx="70">
                  <c:v>2287</c:v>
                </c:pt>
                <c:pt idx="71">
                  <c:v>1961</c:v>
                </c:pt>
                <c:pt idx="72">
                  <c:v>2158</c:v>
                </c:pt>
                <c:pt idx="73">
                  <c:v>1601</c:v>
                </c:pt>
                <c:pt idx="74">
                  <c:v>1875</c:v>
                </c:pt>
                <c:pt idx="75">
                  <c:v>1853</c:v>
                </c:pt>
                <c:pt idx="76">
                  <c:v>1822</c:v>
                </c:pt>
                <c:pt idx="77">
                  <c:v>15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1E29-3342-A2AA-0E5784E973CA}"/>
            </c:ext>
          </c:extLst>
        </c:ser>
        <c:ser>
          <c:idx val="27"/>
          <c:order val="27"/>
          <c:tx>
            <c:strRef>
              <c:f>Neat!$A$31</c:f>
              <c:strCache>
                <c:ptCount val="1"/>
                <c:pt idx="0">
                  <c:v>B44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1:$CA$31</c:f>
              <c:numCache>
                <c:formatCode>General</c:formatCode>
                <c:ptCount val="78"/>
                <c:pt idx="0">
                  <c:v>10156</c:v>
                </c:pt>
                <c:pt idx="1">
                  <c:v>11899</c:v>
                </c:pt>
                <c:pt idx="2">
                  <c:v>12451</c:v>
                </c:pt>
                <c:pt idx="3">
                  <c:v>12993</c:v>
                </c:pt>
                <c:pt idx="4">
                  <c:v>12203</c:v>
                </c:pt>
                <c:pt idx="5">
                  <c:v>9721</c:v>
                </c:pt>
                <c:pt idx="6">
                  <c:v>13355</c:v>
                </c:pt>
                <c:pt idx="7">
                  <c:v>14087</c:v>
                </c:pt>
                <c:pt idx="8">
                  <c:v>8520</c:v>
                </c:pt>
                <c:pt idx="9">
                  <c:v>13709</c:v>
                </c:pt>
                <c:pt idx="10">
                  <c:v>8557</c:v>
                </c:pt>
                <c:pt idx="11">
                  <c:v>9267</c:v>
                </c:pt>
                <c:pt idx="12">
                  <c:v>8652</c:v>
                </c:pt>
                <c:pt idx="13">
                  <c:v>7076</c:v>
                </c:pt>
                <c:pt idx="14">
                  <c:v>5284</c:v>
                </c:pt>
                <c:pt idx="15">
                  <c:v>2080</c:v>
                </c:pt>
                <c:pt idx="16">
                  <c:v>3041</c:v>
                </c:pt>
                <c:pt idx="17">
                  <c:v>4981</c:v>
                </c:pt>
                <c:pt idx="18">
                  <c:v>4251</c:v>
                </c:pt>
                <c:pt idx="19">
                  <c:v>4652</c:v>
                </c:pt>
                <c:pt idx="20">
                  <c:v>6290</c:v>
                </c:pt>
                <c:pt idx="21">
                  <c:v>5309</c:v>
                </c:pt>
                <c:pt idx="22">
                  <c:v>2517</c:v>
                </c:pt>
                <c:pt idx="23">
                  <c:v>4765</c:v>
                </c:pt>
                <c:pt idx="24">
                  <c:v>6689</c:v>
                </c:pt>
                <c:pt idx="25">
                  <c:v>9301</c:v>
                </c:pt>
                <c:pt idx="26">
                  <c:v>8767</c:v>
                </c:pt>
                <c:pt idx="27">
                  <c:v>9031</c:v>
                </c:pt>
                <c:pt idx="28">
                  <c:v>6500</c:v>
                </c:pt>
                <c:pt idx="29">
                  <c:v>3946</c:v>
                </c:pt>
                <c:pt idx="30">
                  <c:v>4522</c:v>
                </c:pt>
                <c:pt idx="31">
                  <c:v>4807</c:v>
                </c:pt>
                <c:pt idx="32">
                  <c:v>6251</c:v>
                </c:pt>
                <c:pt idx="33">
                  <c:v>7247</c:v>
                </c:pt>
                <c:pt idx="34">
                  <c:v>5808</c:v>
                </c:pt>
                <c:pt idx="35">
                  <c:v>5973</c:v>
                </c:pt>
                <c:pt idx="36">
                  <c:v>6138</c:v>
                </c:pt>
                <c:pt idx="37">
                  <c:v>9558</c:v>
                </c:pt>
                <c:pt idx="38">
                  <c:v>5636</c:v>
                </c:pt>
                <c:pt idx="39">
                  <c:v>6446</c:v>
                </c:pt>
                <c:pt idx="40">
                  <c:v>6217</c:v>
                </c:pt>
                <c:pt idx="41">
                  <c:v>5993</c:v>
                </c:pt>
                <c:pt idx="42">
                  <c:v>5283</c:v>
                </c:pt>
                <c:pt idx="43">
                  <c:v>5892</c:v>
                </c:pt>
                <c:pt idx="44">
                  <c:v>5719</c:v>
                </c:pt>
                <c:pt idx="45">
                  <c:v>5637</c:v>
                </c:pt>
                <c:pt idx="46">
                  <c:v>4010</c:v>
                </c:pt>
                <c:pt idx="47">
                  <c:v>3013</c:v>
                </c:pt>
                <c:pt idx="48">
                  <c:v>3515</c:v>
                </c:pt>
                <c:pt idx="49">
                  <c:v>3707</c:v>
                </c:pt>
                <c:pt idx="50">
                  <c:v>3149</c:v>
                </c:pt>
                <c:pt idx="51">
                  <c:v>3553</c:v>
                </c:pt>
                <c:pt idx="52">
                  <c:v>4593</c:v>
                </c:pt>
                <c:pt idx="53">
                  <c:v>5654</c:v>
                </c:pt>
                <c:pt idx="54">
                  <c:v>3313</c:v>
                </c:pt>
                <c:pt idx="55">
                  <c:v>3436</c:v>
                </c:pt>
                <c:pt idx="56">
                  <c:v>3993</c:v>
                </c:pt>
                <c:pt idx="57">
                  <c:v>3546</c:v>
                </c:pt>
                <c:pt idx="58">
                  <c:v>3359</c:v>
                </c:pt>
                <c:pt idx="59">
                  <c:v>3671</c:v>
                </c:pt>
                <c:pt idx="60">
                  <c:v>3922</c:v>
                </c:pt>
                <c:pt idx="61">
                  <c:v>4456</c:v>
                </c:pt>
                <c:pt idx="62">
                  <c:v>5588</c:v>
                </c:pt>
                <c:pt idx="63">
                  <c:v>5768</c:v>
                </c:pt>
                <c:pt idx="64">
                  <c:v>5187</c:v>
                </c:pt>
                <c:pt idx="65">
                  <c:v>5363</c:v>
                </c:pt>
                <c:pt idx="66">
                  <c:v>5219</c:v>
                </c:pt>
                <c:pt idx="67">
                  <c:v>5285</c:v>
                </c:pt>
                <c:pt idx="68">
                  <c:v>5381</c:v>
                </c:pt>
                <c:pt idx="69">
                  <c:v>5564</c:v>
                </c:pt>
                <c:pt idx="70">
                  <c:v>6732</c:v>
                </c:pt>
                <c:pt idx="71">
                  <c:v>6458</c:v>
                </c:pt>
                <c:pt idx="72">
                  <c:v>6828</c:v>
                </c:pt>
                <c:pt idx="73">
                  <c:v>5924</c:v>
                </c:pt>
                <c:pt idx="74">
                  <c:v>7199</c:v>
                </c:pt>
                <c:pt idx="75">
                  <c:v>6744</c:v>
                </c:pt>
                <c:pt idx="76">
                  <c:v>6733</c:v>
                </c:pt>
                <c:pt idx="77">
                  <c:v>52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1E29-3342-A2AA-0E5784E973CA}"/>
            </c:ext>
          </c:extLst>
        </c:ser>
        <c:ser>
          <c:idx val="28"/>
          <c:order val="28"/>
          <c:tx>
            <c:strRef>
              <c:f>Neat!$A$32</c:f>
              <c:strCache>
                <c:ptCount val="1"/>
                <c:pt idx="0">
                  <c:v>B45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2:$CA$32</c:f>
              <c:numCache>
                <c:formatCode>General</c:formatCode>
                <c:ptCount val="78"/>
                <c:pt idx="0">
                  <c:v>10248</c:v>
                </c:pt>
                <c:pt idx="1">
                  <c:v>14237</c:v>
                </c:pt>
                <c:pt idx="2">
                  <c:v>13875</c:v>
                </c:pt>
                <c:pt idx="3">
                  <c:v>13140</c:v>
                </c:pt>
                <c:pt idx="4">
                  <c:v>14317</c:v>
                </c:pt>
                <c:pt idx="5">
                  <c:v>11937</c:v>
                </c:pt>
                <c:pt idx="6">
                  <c:v>15784</c:v>
                </c:pt>
                <c:pt idx="7">
                  <c:v>16410</c:v>
                </c:pt>
                <c:pt idx="8">
                  <c:v>10706</c:v>
                </c:pt>
                <c:pt idx="9">
                  <c:v>14922</c:v>
                </c:pt>
                <c:pt idx="10">
                  <c:v>11362</c:v>
                </c:pt>
                <c:pt idx="11">
                  <c:v>11386</c:v>
                </c:pt>
                <c:pt idx="12">
                  <c:v>9827</c:v>
                </c:pt>
                <c:pt idx="13">
                  <c:v>8224</c:v>
                </c:pt>
                <c:pt idx="14">
                  <c:v>6544</c:v>
                </c:pt>
                <c:pt idx="15">
                  <c:v>2538</c:v>
                </c:pt>
                <c:pt idx="16">
                  <c:v>3492</c:v>
                </c:pt>
                <c:pt idx="17">
                  <c:v>3467</c:v>
                </c:pt>
                <c:pt idx="18">
                  <c:v>3489</c:v>
                </c:pt>
                <c:pt idx="19">
                  <c:v>3772</c:v>
                </c:pt>
                <c:pt idx="20">
                  <c:v>4401</c:v>
                </c:pt>
                <c:pt idx="21">
                  <c:v>3926</c:v>
                </c:pt>
                <c:pt idx="22">
                  <c:v>2074</c:v>
                </c:pt>
                <c:pt idx="23">
                  <c:v>3369</c:v>
                </c:pt>
                <c:pt idx="24">
                  <c:v>4586</c:v>
                </c:pt>
                <c:pt idx="25">
                  <c:v>5962</c:v>
                </c:pt>
                <c:pt idx="26">
                  <c:v>5398</c:v>
                </c:pt>
                <c:pt idx="27">
                  <c:v>5852</c:v>
                </c:pt>
                <c:pt idx="28">
                  <c:v>3489</c:v>
                </c:pt>
                <c:pt idx="29">
                  <c:v>3229</c:v>
                </c:pt>
                <c:pt idx="30">
                  <c:v>3046</c:v>
                </c:pt>
                <c:pt idx="31">
                  <c:v>3265</c:v>
                </c:pt>
                <c:pt idx="32">
                  <c:v>4357</c:v>
                </c:pt>
                <c:pt idx="33">
                  <c:v>5630</c:v>
                </c:pt>
                <c:pt idx="34">
                  <c:v>4643</c:v>
                </c:pt>
                <c:pt idx="35">
                  <c:v>4624</c:v>
                </c:pt>
                <c:pt idx="36">
                  <c:v>4774</c:v>
                </c:pt>
                <c:pt idx="37">
                  <c:v>6915</c:v>
                </c:pt>
                <c:pt idx="38">
                  <c:v>4868</c:v>
                </c:pt>
                <c:pt idx="39">
                  <c:v>5235</c:v>
                </c:pt>
                <c:pt idx="40">
                  <c:v>5539</c:v>
                </c:pt>
                <c:pt idx="41">
                  <c:v>6152</c:v>
                </c:pt>
                <c:pt idx="42">
                  <c:v>4928</c:v>
                </c:pt>
                <c:pt idx="43">
                  <c:v>5465</c:v>
                </c:pt>
                <c:pt idx="44">
                  <c:v>5237</c:v>
                </c:pt>
                <c:pt idx="45">
                  <c:v>5496</c:v>
                </c:pt>
                <c:pt idx="46">
                  <c:v>3849</c:v>
                </c:pt>
                <c:pt idx="47">
                  <c:v>2918</c:v>
                </c:pt>
                <c:pt idx="48">
                  <c:v>3476</c:v>
                </c:pt>
                <c:pt idx="49">
                  <c:v>3602</c:v>
                </c:pt>
                <c:pt idx="50">
                  <c:v>3189</c:v>
                </c:pt>
                <c:pt idx="51">
                  <c:v>3699</c:v>
                </c:pt>
                <c:pt idx="52">
                  <c:v>4938</c:v>
                </c:pt>
                <c:pt idx="53">
                  <c:v>5773</c:v>
                </c:pt>
                <c:pt idx="54">
                  <c:v>3413</c:v>
                </c:pt>
                <c:pt idx="55">
                  <c:v>3735</c:v>
                </c:pt>
                <c:pt idx="56">
                  <c:v>4821</c:v>
                </c:pt>
                <c:pt idx="57">
                  <c:v>4419</c:v>
                </c:pt>
                <c:pt idx="58">
                  <c:v>3748</c:v>
                </c:pt>
                <c:pt idx="59">
                  <c:v>4309</c:v>
                </c:pt>
                <c:pt idx="60">
                  <c:v>4204</c:v>
                </c:pt>
                <c:pt idx="61">
                  <c:v>4626</c:v>
                </c:pt>
                <c:pt idx="62">
                  <c:v>6463</c:v>
                </c:pt>
                <c:pt idx="63">
                  <c:v>6739</c:v>
                </c:pt>
                <c:pt idx="64">
                  <c:v>5909</c:v>
                </c:pt>
                <c:pt idx="65">
                  <c:v>5692</c:v>
                </c:pt>
                <c:pt idx="66">
                  <c:v>5522</c:v>
                </c:pt>
                <c:pt idx="67">
                  <c:v>5378</c:v>
                </c:pt>
                <c:pt idx="68">
                  <c:v>5099</c:v>
                </c:pt>
                <c:pt idx="69">
                  <c:v>5698</c:v>
                </c:pt>
                <c:pt idx="70">
                  <c:v>4507</c:v>
                </c:pt>
                <c:pt idx="71">
                  <c:v>3567</c:v>
                </c:pt>
                <c:pt idx="72">
                  <c:v>4205</c:v>
                </c:pt>
                <c:pt idx="73">
                  <c:v>3467</c:v>
                </c:pt>
                <c:pt idx="74">
                  <c:v>4211</c:v>
                </c:pt>
                <c:pt idx="75">
                  <c:v>3712</c:v>
                </c:pt>
                <c:pt idx="76">
                  <c:v>3820</c:v>
                </c:pt>
                <c:pt idx="77">
                  <c:v>35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1E29-3342-A2AA-0E5784E973CA}"/>
            </c:ext>
          </c:extLst>
        </c:ser>
        <c:ser>
          <c:idx val="29"/>
          <c:order val="29"/>
          <c:tx>
            <c:strRef>
              <c:f>Neat!$A$33</c:f>
              <c:strCache>
                <c:ptCount val="1"/>
                <c:pt idx="0">
                  <c:v>B46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accent6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3:$CA$33</c:f>
              <c:numCache>
                <c:formatCode>General</c:formatCode>
                <c:ptCount val="78"/>
                <c:pt idx="0">
                  <c:v>12470</c:v>
                </c:pt>
                <c:pt idx="1">
                  <c:v>10370</c:v>
                </c:pt>
                <c:pt idx="2">
                  <c:v>11210</c:v>
                </c:pt>
                <c:pt idx="3">
                  <c:v>9974</c:v>
                </c:pt>
                <c:pt idx="4">
                  <c:v>7785</c:v>
                </c:pt>
                <c:pt idx="5">
                  <c:v>4436</c:v>
                </c:pt>
                <c:pt idx="6">
                  <c:v>7596</c:v>
                </c:pt>
                <c:pt idx="7">
                  <c:v>8170</c:v>
                </c:pt>
                <c:pt idx="8">
                  <c:v>3623</c:v>
                </c:pt>
                <c:pt idx="9">
                  <c:v>7195</c:v>
                </c:pt>
                <c:pt idx="10">
                  <c:v>3513</c:v>
                </c:pt>
                <c:pt idx="11">
                  <c:v>3980</c:v>
                </c:pt>
                <c:pt idx="12">
                  <c:v>2849</c:v>
                </c:pt>
                <c:pt idx="13">
                  <c:v>187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491</c:v>
                </c:pt>
                <c:pt idx="21">
                  <c:v>0</c:v>
                </c:pt>
                <c:pt idx="22">
                  <c:v>0</c:v>
                </c:pt>
                <c:pt idx="23">
                  <c:v>2010</c:v>
                </c:pt>
                <c:pt idx="24">
                  <c:v>3124</c:v>
                </c:pt>
                <c:pt idx="25">
                  <c:v>4941</c:v>
                </c:pt>
                <c:pt idx="26">
                  <c:v>4826</c:v>
                </c:pt>
                <c:pt idx="27">
                  <c:v>5882</c:v>
                </c:pt>
                <c:pt idx="28">
                  <c:v>3622</c:v>
                </c:pt>
                <c:pt idx="29">
                  <c:v>2880</c:v>
                </c:pt>
                <c:pt idx="30">
                  <c:v>2091</c:v>
                </c:pt>
                <c:pt idx="31">
                  <c:v>2120</c:v>
                </c:pt>
                <c:pt idx="32">
                  <c:v>2613</c:v>
                </c:pt>
                <c:pt idx="33">
                  <c:v>3237</c:v>
                </c:pt>
                <c:pt idx="34">
                  <c:v>2174</c:v>
                </c:pt>
                <c:pt idx="35">
                  <c:v>2387</c:v>
                </c:pt>
                <c:pt idx="36">
                  <c:v>2219</c:v>
                </c:pt>
                <c:pt idx="37">
                  <c:v>3789</c:v>
                </c:pt>
                <c:pt idx="38">
                  <c:v>1923</c:v>
                </c:pt>
                <c:pt idx="39">
                  <c:v>2399</c:v>
                </c:pt>
                <c:pt idx="40">
                  <c:v>1978</c:v>
                </c:pt>
                <c:pt idx="41">
                  <c:v>1893</c:v>
                </c:pt>
                <c:pt idx="42">
                  <c:v>1697</c:v>
                </c:pt>
                <c:pt idx="43">
                  <c:v>1757</c:v>
                </c:pt>
                <c:pt idx="44">
                  <c:v>1626</c:v>
                </c:pt>
                <c:pt idx="45">
                  <c:v>1597</c:v>
                </c:pt>
                <c:pt idx="46">
                  <c:v>1382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490</c:v>
                </c:pt>
                <c:pt idx="54">
                  <c:v>1321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1E29-3342-A2AA-0E5784E973CA}"/>
            </c:ext>
          </c:extLst>
        </c:ser>
        <c:ser>
          <c:idx val="30"/>
          <c:order val="30"/>
          <c:tx>
            <c:strRef>
              <c:f>Neat!$A$34</c:f>
              <c:strCache>
                <c:ptCount val="1"/>
                <c:pt idx="0">
                  <c:v>B47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4:$CA$34</c:f>
              <c:numCache>
                <c:formatCode>General</c:formatCode>
                <c:ptCount val="78"/>
                <c:pt idx="0">
                  <c:v>11251</c:v>
                </c:pt>
                <c:pt idx="1">
                  <c:v>12221</c:v>
                </c:pt>
                <c:pt idx="2">
                  <c:v>12955</c:v>
                </c:pt>
                <c:pt idx="3">
                  <c:v>14106</c:v>
                </c:pt>
                <c:pt idx="4">
                  <c:v>12225</c:v>
                </c:pt>
                <c:pt idx="5">
                  <c:v>8771</c:v>
                </c:pt>
                <c:pt idx="6">
                  <c:v>12984</c:v>
                </c:pt>
                <c:pt idx="7">
                  <c:v>13378</c:v>
                </c:pt>
                <c:pt idx="8">
                  <c:v>7912</c:v>
                </c:pt>
                <c:pt idx="9">
                  <c:v>12766</c:v>
                </c:pt>
                <c:pt idx="10">
                  <c:v>6532</c:v>
                </c:pt>
                <c:pt idx="11">
                  <c:v>7898</c:v>
                </c:pt>
                <c:pt idx="12">
                  <c:v>8926</c:v>
                </c:pt>
                <c:pt idx="13">
                  <c:v>6499</c:v>
                </c:pt>
                <c:pt idx="14">
                  <c:v>4342</c:v>
                </c:pt>
                <c:pt idx="15">
                  <c:v>1581</c:v>
                </c:pt>
                <c:pt idx="16">
                  <c:v>2696</c:v>
                </c:pt>
                <c:pt idx="17">
                  <c:v>5365</c:v>
                </c:pt>
                <c:pt idx="18">
                  <c:v>4277</c:v>
                </c:pt>
                <c:pt idx="19">
                  <c:v>4872</c:v>
                </c:pt>
                <c:pt idx="20">
                  <c:v>6674</c:v>
                </c:pt>
                <c:pt idx="21">
                  <c:v>5740</c:v>
                </c:pt>
                <c:pt idx="22">
                  <c:v>3139</c:v>
                </c:pt>
                <c:pt idx="23">
                  <c:v>7497</c:v>
                </c:pt>
                <c:pt idx="24">
                  <c:v>10728</c:v>
                </c:pt>
                <c:pt idx="25">
                  <c:v>13437</c:v>
                </c:pt>
                <c:pt idx="26">
                  <c:v>13816</c:v>
                </c:pt>
                <c:pt idx="27">
                  <c:v>14560</c:v>
                </c:pt>
                <c:pt idx="28">
                  <c:v>11559</c:v>
                </c:pt>
                <c:pt idx="29">
                  <c:v>8277</c:v>
                </c:pt>
                <c:pt idx="30">
                  <c:v>9603</c:v>
                </c:pt>
                <c:pt idx="31">
                  <c:v>10078</c:v>
                </c:pt>
                <c:pt idx="32">
                  <c:v>12034</c:v>
                </c:pt>
                <c:pt idx="33">
                  <c:v>13862</c:v>
                </c:pt>
                <c:pt idx="34">
                  <c:v>11950</c:v>
                </c:pt>
                <c:pt idx="35">
                  <c:v>11994</c:v>
                </c:pt>
                <c:pt idx="36">
                  <c:v>12277</c:v>
                </c:pt>
                <c:pt idx="37">
                  <c:v>17218</c:v>
                </c:pt>
                <c:pt idx="38">
                  <c:v>11398</c:v>
                </c:pt>
                <c:pt idx="39">
                  <c:v>12932</c:v>
                </c:pt>
                <c:pt idx="40">
                  <c:v>11644</c:v>
                </c:pt>
                <c:pt idx="41">
                  <c:v>11121</c:v>
                </c:pt>
                <c:pt idx="42">
                  <c:v>9953</c:v>
                </c:pt>
                <c:pt idx="43">
                  <c:v>11664</c:v>
                </c:pt>
                <c:pt idx="44">
                  <c:v>11298</c:v>
                </c:pt>
                <c:pt idx="45">
                  <c:v>11305</c:v>
                </c:pt>
                <c:pt idx="46">
                  <c:v>6749</c:v>
                </c:pt>
                <c:pt idx="47">
                  <c:v>5322</c:v>
                </c:pt>
                <c:pt idx="48">
                  <c:v>6029</c:v>
                </c:pt>
                <c:pt idx="49">
                  <c:v>6828</c:v>
                </c:pt>
                <c:pt idx="50">
                  <c:v>5685</c:v>
                </c:pt>
                <c:pt idx="51">
                  <c:v>6314</c:v>
                </c:pt>
                <c:pt idx="52">
                  <c:v>7214</c:v>
                </c:pt>
                <c:pt idx="53">
                  <c:v>9470</c:v>
                </c:pt>
                <c:pt idx="54">
                  <c:v>4550</c:v>
                </c:pt>
                <c:pt idx="55">
                  <c:v>4805</c:v>
                </c:pt>
                <c:pt idx="56">
                  <c:v>4977</c:v>
                </c:pt>
                <c:pt idx="57">
                  <c:v>4213</c:v>
                </c:pt>
                <c:pt idx="58">
                  <c:v>4668</c:v>
                </c:pt>
                <c:pt idx="59">
                  <c:v>5257</c:v>
                </c:pt>
                <c:pt idx="60">
                  <c:v>5624</c:v>
                </c:pt>
                <c:pt idx="61">
                  <c:v>6400</c:v>
                </c:pt>
                <c:pt idx="62">
                  <c:v>7687</c:v>
                </c:pt>
                <c:pt idx="63">
                  <c:v>7900</c:v>
                </c:pt>
                <c:pt idx="64">
                  <c:v>6900</c:v>
                </c:pt>
                <c:pt idx="65">
                  <c:v>7390</c:v>
                </c:pt>
                <c:pt idx="66">
                  <c:v>6943</c:v>
                </c:pt>
                <c:pt idx="67">
                  <c:v>7684</c:v>
                </c:pt>
                <c:pt idx="68">
                  <c:v>8497</c:v>
                </c:pt>
                <c:pt idx="69">
                  <c:v>8562</c:v>
                </c:pt>
                <c:pt idx="70">
                  <c:v>4900</c:v>
                </c:pt>
                <c:pt idx="71">
                  <c:v>4948</c:v>
                </c:pt>
                <c:pt idx="72">
                  <c:v>4816</c:v>
                </c:pt>
                <c:pt idx="73">
                  <c:v>3955</c:v>
                </c:pt>
                <c:pt idx="74">
                  <c:v>5210</c:v>
                </c:pt>
                <c:pt idx="75">
                  <c:v>5187</c:v>
                </c:pt>
                <c:pt idx="76">
                  <c:v>4814</c:v>
                </c:pt>
                <c:pt idx="77">
                  <c:v>3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1E29-3342-A2AA-0E5784E973CA}"/>
            </c:ext>
          </c:extLst>
        </c:ser>
        <c:ser>
          <c:idx val="31"/>
          <c:order val="31"/>
          <c:tx>
            <c:strRef>
              <c:f>Neat!$A$35</c:f>
              <c:strCache>
                <c:ptCount val="1"/>
                <c:pt idx="0">
                  <c:v>B48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5:$CA$35</c:f>
              <c:numCache>
                <c:formatCode>General</c:formatCode>
                <c:ptCount val="78"/>
                <c:pt idx="0">
                  <c:v>11634</c:v>
                </c:pt>
                <c:pt idx="1">
                  <c:v>10061</c:v>
                </c:pt>
                <c:pt idx="2">
                  <c:v>10501</c:v>
                </c:pt>
                <c:pt idx="3">
                  <c:v>11452</c:v>
                </c:pt>
                <c:pt idx="4">
                  <c:v>8585</c:v>
                </c:pt>
                <c:pt idx="5">
                  <c:v>5367</c:v>
                </c:pt>
                <c:pt idx="6">
                  <c:v>8790</c:v>
                </c:pt>
                <c:pt idx="7">
                  <c:v>9477</c:v>
                </c:pt>
                <c:pt idx="8">
                  <c:v>5472</c:v>
                </c:pt>
                <c:pt idx="9">
                  <c:v>9840</c:v>
                </c:pt>
                <c:pt idx="10">
                  <c:v>4805</c:v>
                </c:pt>
                <c:pt idx="11">
                  <c:v>5377</c:v>
                </c:pt>
                <c:pt idx="12">
                  <c:v>5270</c:v>
                </c:pt>
                <c:pt idx="13">
                  <c:v>3381</c:v>
                </c:pt>
                <c:pt idx="14">
                  <c:v>2292</c:v>
                </c:pt>
                <c:pt idx="15">
                  <c:v>0</c:v>
                </c:pt>
                <c:pt idx="16">
                  <c:v>0</c:v>
                </c:pt>
                <c:pt idx="17">
                  <c:v>1877</c:v>
                </c:pt>
                <c:pt idx="18">
                  <c:v>1465</c:v>
                </c:pt>
                <c:pt idx="19">
                  <c:v>2039</c:v>
                </c:pt>
                <c:pt idx="20">
                  <c:v>3103</c:v>
                </c:pt>
                <c:pt idx="21">
                  <c:v>2610</c:v>
                </c:pt>
                <c:pt idx="22">
                  <c:v>1614</c:v>
                </c:pt>
                <c:pt idx="23">
                  <c:v>5736</c:v>
                </c:pt>
                <c:pt idx="24">
                  <c:v>8222</c:v>
                </c:pt>
                <c:pt idx="25">
                  <c:v>10568</c:v>
                </c:pt>
                <c:pt idx="26">
                  <c:v>10662</c:v>
                </c:pt>
                <c:pt idx="27">
                  <c:v>11457</c:v>
                </c:pt>
                <c:pt idx="28">
                  <c:v>9113</c:v>
                </c:pt>
                <c:pt idx="29">
                  <c:v>6746</c:v>
                </c:pt>
                <c:pt idx="30">
                  <c:v>7582</c:v>
                </c:pt>
                <c:pt idx="31">
                  <c:v>8016</c:v>
                </c:pt>
                <c:pt idx="32">
                  <c:v>10423</c:v>
                </c:pt>
                <c:pt idx="33">
                  <c:v>11851</c:v>
                </c:pt>
                <c:pt idx="34">
                  <c:v>10193</c:v>
                </c:pt>
                <c:pt idx="35">
                  <c:v>9715</c:v>
                </c:pt>
                <c:pt idx="36">
                  <c:v>9993</c:v>
                </c:pt>
                <c:pt idx="37">
                  <c:v>14982</c:v>
                </c:pt>
                <c:pt idx="38">
                  <c:v>9269</c:v>
                </c:pt>
                <c:pt idx="39">
                  <c:v>10896</c:v>
                </c:pt>
                <c:pt idx="40">
                  <c:v>9480</c:v>
                </c:pt>
                <c:pt idx="41">
                  <c:v>8883</c:v>
                </c:pt>
                <c:pt idx="42">
                  <c:v>8040</c:v>
                </c:pt>
                <c:pt idx="43">
                  <c:v>9387</c:v>
                </c:pt>
                <c:pt idx="44">
                  <c:v>8997</c:v>
                </c:pt>
                <c:pt idx="45">
                  <c:v>9388</c:v>
                </c:pt>
                <c:pt idx="46">
                  <c:v>5303</c:v>
                </c:pt>
                <c:pt idx="47">
                  <c:v>4095</c:v>
                </c:pt>
                <c:pt idx="48">
                  <c:v>4346</c:v>
                </c:pt>
                <c:pt idx="49">
                  <c:v>4868</c:v>
                </c:pt>
                <c:pt idx="50">
                  <c:v>4115</c:v>
                </c:pt>
                <c:pt idx="51">
                  <c:v>4499</c:v>
                </c:pt>
                <c:pt idx="52">
                  <c:v>5247</c:v>
                </c:pt>
                <c:pt idx="53">
                  <c:v>7502</c:v>
                </c:pt>
                <c:pt idx="54">
                  <c:v>3762</c:v>
                </c:pt>
                <c:pt idx="55">
                  <c:v>3461</c:v>
                </c:pt>
                <c:pt idx="56">
                  <c:v>3503</c:v>
                </c:pt>
                <c:pt idx="57">
                  <c:v>2882</c:v>
                </c:pt>
                <c:pt idx="58">
                  <c:v>2972</c:v>
                </c:pt>
                <c:pt idx="59">
                  <c:v>3462</c:v>
                </c:pt>
                <c:pt idx="60">
                  <c:v>3708</c:v>
                </c:pt>
                <c:pt idx="61">
                  <c:v>3994</c:v>
                </c:pt>
                <c:pt idx="62">
                  <c:v>4864</c:v>
                </c:pt>
                <c:pt idx="63">
                  <c:v>5116</c:v>
                </c:pt>
                <c:pt idx="64">
                  <c:v>4110</c:v>
                </c:pt>
                <c:pt idx="65">
                  <c:v>4422</c:v>
                </c:pt>
                <c:pt idx="66">
                  <c:v>3965</c:v>
                </c:pt>
                <c:pt idx="67">
                  <c:v>4675</c:v>
                </c:pt>
                <c:pt idx="68">
                  <c:v>5258</c:v>
                </c:pt>
                <c:pt idx="69">
                  <c:v>5269</c:v>
                </c:pt>
                <c:pt idx="70">
                  <c:v>4387</c:v>
                </c:pt>
                <c:pt idx="71">
                  <c:v>4119</c:v>
                </c:pt>
                <c:pt idx="72">
                  <c:v>4125</c:v>
                </c:pt>
                <c:pt idx="73">
                  <c:v>3189</c:v>
                </c:pt>
                <c:pt idx="74">
                  <c:v>4046</c:v>
                </c:pt>
                <c:pt idx="75">
                  <c:v>4032</c:v>
                </c:pt>
                <c:pt idx="76">
                  <c:v>3953</c:v>
                </c:pt>
                <c:pt idx="77">
                  <c:v>24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1E29-3342-A2AA-0E5784E973CA}"/>
            </c:ext>
          </c:extLst>
        </c:ser>
        <c:ser>
          <c:idx val="32"/>
          <c:order val="32"/>
          <c:tx>
            <c:strRef>
              <c:f>Neat!$A$36</c:f>
              <c:strCache>
                <c:ptCount val="1"/>
                <c:pt idx="0">
                  <c:v>B50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accent3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6:$CA$36</c:f>
              <c:numCache>
                <c:formatCode>General</c:formatCode>
                <c:ptCount val="78"/>
                <c:pt idx="0">
                  <c:v>13737</c:v>
                </c:pt>
                <c:pt idx="1">
                  <c:v>10959</c:v>
                </c:pt>
                <c:pt idx="2">
                  <c:v>10767</c:v>
                </c:pt>
                <c:pt idx="3">
                  <c:v>10589</c:v>
                </c:pt>
                <c:pt idx="4">
                  <c:v>7964</c:v>
                </c:pt>
                <c:pt idx="5">
                  <c:v>5182</c:v>
                </c:pt>
                <c:pt idx="6">
                  <c:v>9005</c:v>
                </c:pt>
                <c:pt idx="7">
                  <c:v>10105</c:v>
                </c:pt>
                <c:pt idx="8">
                  <c:v>4526</c:v>
                </c:pt>
                <c:pt idx="9">
                  <c:v>8693</c:v>
                </c:pt>
                <c:pt idx="10">
                  <c:v>4033</c:v>
                </c:pt>
                <c:pt idx="11">
                  <c:v>4800</c:v>
                </c:pt>
                <c:pt idx="12">
                  <c:v>4753</c:v>
                </c:pt>
                <c:pt idx="13">
                  <c:v>3223</c:v>
                </c:pt>
                <c:pt idx="14">
                  <c:v>2113</c:v>
                </c:pt>
                <c:pt idx="15">
                  <c:v>0</c:v>
                </c:pt>
                <c:pt idx="16">
                  <c:v>129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795</c:v>
                </c:pt>
                <c:pt idx="26">
                  <c:v>1925</c:v>
                </c:pt>
                <c:pt idx="27">
                  <c:v>2004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1E29-3342-A2AA-0E5784E973CA}"/>
            </c:ext>
          </c:extLst>
        </c:ser>
        <c:ser>
          <c:idx val="33"/>
          <c:order val="33"/>
          <c:tx>
            <c:strRef>
              <c:f>Neat!$A$37</c:f>
              <c:strCache>
                <c:ptCount val="1"/>
                <c:pt idx="0">
                  <c:v>B51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7:$CA$37</c:f>
              <c:numCache>
                <c:formatCode>General</c:formatCode>
                <c:ptCount val="78"/>
                <c:pt idx="0">
                  <c:v>5046</c:v>
                </c:pt>
                <c:pt idx="1">
                  <c:v>3284</c:v>
                </c:pt>
                <c:pt idx="2">
                  <c:v>3466</c:v>
                </c:pt>
                <c:pt idx="3">
                  <c:v>3475</c:v>
                </c:pt>
                <c:pt idx="4">
                  <c:v>2487</c:v>
                </c:pt>
                <c:pt idx="5">
                  <c:v>1311</c:v>
                </c:pt>
                <c:pt idx="6">
                  <c:v>2709</c:v>
                </c:pt>
                <c:pt idx="7">
                  <c:v>2934</c:v>
                </c:pt>
                <c:pt idx="8">
                  <c:v>1378</c:v>
                </c:pt>
                <c:pt idx="9">
                  <c:v>2960</c:v>
                </c:pt>
                <c:pt idx="10">
                  <c:v>1206</c:v>
                </c:pt>
                <c:pt idx="11">
                  <c:v>132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757</c:v>
                </c:pt>
                <c:pt idx="24">
                  <c:v>2392</c:v>
                </c:pt>
                <c:pt idx="25">
                  <c:v>3646</c:v>
                </c:pt>
                <c:pt idx="26">
                  <c:v>2431</c:v>
                </c:pt>
                <c:pt idx="27">
                  <c:v>2843</c:v>
                </c:pt>
                <c:pt idx="28">
                  <c:v>1733</c:v>
                </c:pt>
                <c:pt idx="29">
                  <c:v>1484</c:v>
                </c:pt>
                <c:pt idx="30">
                  <c:v>1788</c:v>
                </c:pt>
                <c:pt idx="31">
                  <c:v>1854</c:v>
                </c:pt>
                <c:pt idx="32">
                  <c:v>1613</c:v>
                </c:pt>
                <c:pt idx="33">
                  <c:v>2302</c:v>
                </c:pt>
                <c:pt idx="34">
                  <c:v>2767</c:v>
                </c:pt>
                <c:pt idx="35">
                  <c:v>1485</c:v>
                </c:pt>
                <c:pt idx="36">
                  <c:v>2641</c:v>
                </c:pt>
                <c:pt idx="37">
                  <c:v>2452</c:v>
                </c:pt>
                <c:pt idx="38">
                  <c:v>2519</c:v>
                </c:pt>
                <c:pt idx="39">
                  <c:v>1750</c:v>
                </c:pt>
                <c:pt idx="40">
                  <c:v>2497</c:v>
                </c:pt>
                <c:pt idx="41">
                  <c:v>1922</c:v>
                </c:pt>
                <c:pt idx="42">
                  <c:v>1980</c:v>
                </c:pt>
                <c:pt idx="43">
                  <c:v>1477</c:v>
                </c:pt>
                <c:pt idx="44">
                  <c:v>1750</c:v>
                </c:pt>
                <c:pt idx="45">
                  <c:v>1809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1356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1181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1E29-3342-A2AA-0E5784E973CA}"/>
            </c:ext>
          </c:extLst>
        </c:ser>
        <c:ser>
          <c:idx val="34"/>
          <c:order val="34"/>
          <c:tx>
            <c:strRef>
              <c:f>Neat!$A$38</c:f>
              <c:strCache>
                <c:ptCount val="1"/>
                <c:pt idx="0">
                  <c:v>B52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</a:schemeClr>
              </a:solidFill>
              <a:ln w="9525">
                <a:solidFill>
                  <a:schemeClr val="accent5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8:$CA$38</c:f>
              <c:numCache>
                <c:formatCode>General</c:formatCode>
                <c:ptCount val="78"/>
                <c:pt idx="0">
                  <c:v>3345</c:v>
                </c:pt>
                <c:pt idx="1">
                  <c:v>2013</c:v>
                </c:pt>
                <c:pt idx="2">
                  <c:v>2232</c:v>
                </c:pt>
                <c:pt idx="3">
                  <c:v>2261</c:v>
                </c:pt>
                <c:pt idx="4">
                  <c:v>1556</c:v>
                </c:pt>
                <c:pt idx="5">
                  <c:v>0</c:v>
                </c:pt>
                <c:pt idx="6">
                  <c:v>1740</c:v>
                </c:pt>
                <c:pt idx="7">
                  <c:v>1827</c:v>
                </c:pt>
                <c:pt idx="8">
                  <c:v>0</c:v>
                </c:pt>
                <c:pt idx="9">
                  <c:v>220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1E29-3342-A2AA-0E5784E973CA}"/>
            </c:ext>
          </c:extLst>
        </c:ser>
        <c:ser>
          <c:idx val="35"/>
          <c:order val="35"/>
          <c:tx>
            <c:strRef>
              <c:f>Neat!$A$39</c:f>
              <c:strCache>
                <c:ptCount val="1"/>
                <c:pt idx="0">
                  <c:v>B54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39:$CA$39</c:f>
              <c:numCache>
                <c:formatCode>General</c:formatCode>
                <c:ptCount val="78"/>
                <c:pt idx="0">
                  <c:v>15077</c:v>
                </c:pt>
                <c:pt idx="1">
                  <c:v>13272</c:v>
                </c:pt>
                <c:pt idx="2">
                  <c:v>13454</c:v>
                </c:pt>
                <c:pt idx="3">
                  <c:v>12281</c:v>
                </c:pt>
                <c:pt idx="4">
                  <c:v>9660</c:v>
                </c:pt>
                <c:pt idx="5">
                  <c:v>6716</c:v>
                </c:pt>
                <c:pt idx="6">
                  <c:v>10355</c:v>
                </c:pt>
                <c:pt idx="7">
                  <c:v>11158</c:v>
                </c:pt>
                <c:pt idx="8">
                  <c:v>5481</c:v>
                </c:pt>
                <c:pt idx="9">
                  <c:v>9937</c:v>
                </c:pt>
                <c:pt idx="10">
                  <c:v>5286</c:v>
                </c:pt>
                <c:pt idx="11">
                  <c:v>5769</c:v>
                </c:pt>
                <c:pt idx="12">
                  <c:v>5474</c:v>
                </c:pt>
                <c:pt idx="13">
                  <c:v>3848</c:v>
                </c:pt>
                <c:pt idx="14">
                  <c:v>2508</c:v>
                </c:pt>
                <c:pt idx="15">
                  <c:v>0</c:v>
                </c:pt>
                <c:pt idx="16">
                  <c:v>1398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507</c:v>
                </c:pt>
                <c:pt idx="21">
                  <c:v>1521</c:v>
                </c:pt>
                <c:pt idx="22">
                  <c:v>1225</c:v>
                </c:pt>
                <c:pt idx="23">
                  <c:v>2437</c:v>
                </c:pt>
                <c:pt idx="24">
                  <c:v>3434</c:v>
                </c:pt>
                <c:pt idx="25">
                  <c:v>5794</c:v>
                </c:pt>
                <c:pt idx="26">
                  <c:v>5315</c:v>
                </c:pt>
                <c:pt idx="27">
                  <c:v>5991</c:v>
                </c:pt>
                <c:pt idx="28">
                  <c:v>3854</c:v>
                </c:pt>
                <c:pt idx="29">
                  <c:v>3453</c:v>
                </c:pt>
                <c:pt idx="30">
                  <c:v>2517</c:v>
                </c:pt>
                <c:pt idx="31">
                  <c:v>2382</c:v>
                </c:pt>
                <c:pt idx="32">
                  <c:v>3004</c:v>
                </c:pt>
                <c:pt idx="33">
                  <c:v>3696</c:v>
                </c:pt>
                <c:pt idx="34">
                  <c:v>2804</c:v>
                </c:pt>
                <c:pt idx="35">
                  <c:v>2772</c:v>
                </c:pt>
                <c:pt idx="36">
                  <c:v>2529</c:v>
                </c:pt>
                <c:pt idx="37">
                  <c:v>4338</c:v>
                </c:pt>
                <c:pt idx="38">
                  <c:v>2133</c:v>
                </c:pt>
                <c:pt idx="39">
                  <c:v>2502</c:v>
                </c:pt>
                <c:pt idx="40">
                  <c:v>2115</c:v>
                </c:pt>
                <c:pt idx="41">
                  <c:v>2014</c:v>
                </c:pt>
                <c:pt idx="42">
                  <c:v>1675</c:v>
                </c:pt>
                <c:pt idx="43">
                  <c:v>1779</c:v>
                </c:pt>
                <c:pt idx="44">
                  <c:v>1593</c:v>
                </c:pt>
                <c:pt idx="45">
                  <c:v>1508</c:v>
                </c:pt>
                <c:pt idx="46">
                  <c:v>1372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1227</c:v>
                </c:pt>
                <c:pt idx="53">
                  <c:v>1479</c:v>
                </c:pt>
                <c:pt idx="54">
                  <c:v>1185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1E29-3342-A2AA-0E5784E973CA}"/>
            </c:ext>
          </c:extLst>
        </c:ser>
        <c:ser>
          <c:idx val="36"/>
          <c:order val="36"/>
          <c:tx>
            <c:strRef>
              <c:f>Neat!$A$40</c:f>
              <c:strCache>
                <c:ptCount val="1"/>
                <c:pt idx="0">
                  <c:v>B55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  <a:lumOff val="30000"/>
                </a:schemeClr>
              </a:solidFill>
              <a:ln w="9525">
                <a:solidFill>
                  <a:schemeClr val="accent1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0:$CA$40</c:f>
              <c:numCache>
                <c:formatCode>General</c:formatCode>
                <c:ptCount val="78"/>
                <c:pt idx="0">
                  <c:v>13222</c:v>
                </c:pt>
                <c:pt idx="1">
                  <c:v>12669</c:v>
                </c:pt>
                <c:pt idx="2">
                  <c:v>13129</c:v>
                </c:pt>
                <c:pt idx="3">
                  <c:v>12212</c:v>
                </c:pt>
                <c:pt idx="4">
                  <c:v>9545</c:v>
                </c:pt>
                <c:pt idx="5">
                  <c:v>6692</c:v>
                </c:pt>
                <c:pt idx="6">
                  <c:v>10290</c:v>
                </c:pt>
                <c:pt idx="7">
                  <c:v>10686</c:v>
                </c:pt>
                <c:pt idx="8">
                  <c:v>5282</c:v>
                </c:pt>
                <c:pt idx="9">
                  <c:v>9608</c:v>
                </c:pt>
                <c:pt idx="10">
                  <c:v>5114</c:v>
                </c:pt>
                <c:pt idx="11">
                  <c:v>5699</c:v>
                </c:pt>
                <c:pt idx="12">
                  <c:v>5187</c:v>
                </c:pt>
                <c:pt idx="13">
                  <c:v>3709</c:v>
                </c:pt>
                <c:pt idx="14">
                  <c:v>2446</c:v>
                </c:pt>
                <c:pt idx="15">
                  <c:v>0</c:v>
                </c:pt>
                <c:pt idx="16">
                  <c:v>1322</c:v>
                </c:pt>
                <c:pt idx="17">
                  <c:v>0</c:v>
                </c:pt>
                <c:pt idx="18">
                  <c:v>0</c:v>
                </c:pt>
                <c:pt idx="19">
                  <c:v>1384</c:v>
                </c:pt>
                <c:pt idx="20">
                  <c:v>1753</c:v>
                </c:pt>
                <c:pt idx="21">
                  <c:v>1703</c:v>
                </c:pt>
                <c:pt idx="22">
                  <c:v>0</c:v>
                </c:pt>
                <c:pt idx="23">
                  <c:v>2346</c:v>
                </c:pt>
                <c:pt idx="24">
                  <c:v>3119</c:v>
                </c:pt>
                <c:pt idx="25">
                  <c:v>5113</c:v>
                </c:pt>
                <c:pt idx="26">
                  <c:v>4253</c:v>
                </c:pt>
                <c:pt idx="27">
                  <c:v>4548</c:v>
                </c:pt>
                <c:pt idx="28">
                  <c:v>2720</c:v>
                </c:pt>
                <c:pt idx="29">
                  <c:v>3029</c:v>
                </c:pt>
                <c:pt idx="30">
                  <c:v>2072</c:v>
                </c:pt>
                <c:pt idx="31">
                  <c:v>1973</c:v>
                </c:pt>
                <c:pt idx="32">
                  <c:v>2702</c:v>
                </c:pt>
                <c:pt idx="33">
                  <c:v>3384</c:v>
                </c:pt>
                <c:pt idx="34">
                  <c:v>2662</c:v>
                </c:pt>
                <c:pt idx="35">
                  <c:v>2407</c:v>
                </c:pt>
                <c:pt idx="36">
                  <c:v>2282</c:v>
                </c:pt>
                <c:pt idx="37">
                  <c:v>4102</c:v>
                </c:pt>
                <c:pt idx="38">
                  <c:v>2090</c:v>
                </c:pt>
                <c:pt idx="39">
                  <c:v>2414</c:v>
                </c:pt>
                <c:pt idx="40">
                  <c:v>2062</c:v>
                </c:pt>
                <c:pt idx="41">
                  <c:v>1974</c:v>
                </c:pt>
                <c:pt idx="42">
                  <c:v>1769</c:v>
                </c:pt>
                <c:pt idx="43">
                  <c:v>1840</c:v>
                </c:pt>
                <c:pt idx="44">
                  <c:v>1659</c:v>
                </c:pt>
                <c:pt idx="45">
                  <c:v>1538</c:v>
                </c:pt>
                <c:pt idx="46">
                  <c:v>1502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1252</c:v>
                </c:pt>
                <c:pt idx="53">
                  <c:v>1538</c:v>
                </c:pt>
                <c:pt idx="54">
                  <c:v>1368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1107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1090</c:v>
                </c:pt>
                <c:pt idx="69">
                  <c:v>1061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1E29-3342-A2AA-0E5784E973CA}"/>
            </c:ext>
          </c:extLst>
        </c:ser>
        <c:ser>
          <c:idx val="37"/>
          <c:order val="37"/>
          <c:tx>
            <c:strRef>
              <c:f>Neat!$A$41</c:f>
              <c:strCache>
                <c:ptCount val="1"/>
                <c:pt idx="0">
                  <c:v>B56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1:$CA$41</c:f>
              <c:numCache>
                <c:formatCode>General</c:formatCode>
                <c:ptCount val="78"/>
                <c:pt idx="0">
                  <c:v>15300</c:v>
                </c:pt>
                <c:pt idx="1">
                  <c:v>14644</c:v>
                </c:pt>
                <c:pt idx="2">
                  <c:v>15057</c:v>
                </c:pt>
                <c:pt idx="3">
                  <c:v>13520</c:v>
                </c:pt>
                <c:pt idx="4">
                  <c:v>10952</c:v>
                </c:pt>
                <c:pt idx="5">
                  <c:v>7325</c:v>
                </c:pt>
                <c:pt idx="6">
                  <c:v>11814</c:v>
                </c:pt>
                <c:pt idx="7">
                  <c:v>12510</c:v>
                </c:pt>
                <c:pt idx="8">
                  <c:v>5995</c:v>
                </c:pt>
                <c:pt idx="9">
                  <c:v>10708</c:v>
                </c:pt>
                <c:pt idx="10">
                  <c:v>5974</c:v>
                </c:pt>
                <c:pt idx="11">
                  <c:v>6636</c:v>
                </c:pt>
                <c:pt idx="12">
                  <c:v>5924</c:v>
                </c:pt>
                <c:pt idx="13">
                  <c:v>4285</c:v>
                </c:pt>
                <c:pt idx="14">
                  <c:v>2783</c:v>
                </c:pt>
                <c:pt idx="15">
                  <c:v>0</c:v>
                </c:pt>
                <c:pt idx="16">
                  <c:v>1665</c:v>
                </c:pt>
                <c:pt idx="17">
                  <c:v>1298</c:v>
                </c:pt>
                <c:pt idx="18">
                  <c:v>0</c:v>
                </c:pt>
                <c:pt idx="19">
                  <c:v>1424</c:v>
                </c:pt>
                <c:pt idx="20">
                  <c:v>1814</c:v>
                </c:pt>
                <c:pt idx="21">
                  <c:v>1881</c:v>
                </c:pt>
                <c:pt idx="22">
                  <c:v>1422</c:v>
                </c:pt>
                <c:pt idx="23">
                  <c:v>2781</c:v>
                </c:pt>
                <c:pt idx="24">
                  <c:v>3544</c:v>
                </c:pt>
                <c:pt idx="25">
                  <c:v>6044</c:v>
                </c:pt>
                <c:pt idx="26">
                  <c:v>5081</c:v>
                </c:pt>
                <c:pt idx="27">
                  <c:v>5694</c:v>
                </c:pt>
                <c:pt idx="28">
                  <c:v>3319</c:v>
                </c:pt>
                <c:pt idx="29">
                  <c:v>2735</c:v>
                </c:pt>
                <c:pt idx="30">
                  <c:v>1696</c:v>
                </c:pt>
                <c:pt idx="31">
                  <c:v>1693</c:v>
                </c:pt>
                <c:pt idx="32">
                  <c:v>2323</c:v>
                </c:pt>
                <c:pt idx="33">
                  <c:v>2800</c:v>
                </c:pt>
                <c:pt idx="34">
                  <c:v>2214</c:v>
                </c:pt>
                <c:pt idx="35">
                  <c:v>1993</c:v>
                </c:pt>
                <c:pt idx="36">
                  <c:v>1772</c:v>
                </c:pt>
                <c:pt idx="37">
                  <c:v>3396</c:v>
                </c:pt>
                <c:pt idx="38">
                  <c:v>1627</c:v>
                </c:pt>
                <c:pt idx="39">
                  <c:v>1880</c:v>
                </c:pt>
                <c:pt idx="40">
                  <c:v>1677</c:v>
                </c:pt>
                <c:pt idx="41">
                  <c:v>1613</c:v>
                </c:pt>
                <c:pt idx="42">
                  <c:v>1380</c:v>
                </c:pt>
                <c:pt idx="43">
                  <c:v>1443</c:v>
                </c:pt>
                <c:pt idx="44">
                  <c:v>1296</c:v>
                </c:pt>
                <c:pt idx="45">
                  <c:v>1178</c:v>
                </c:pt>
                <c:pt idx="46">
                  <c:v>1169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302</c:v>
                </c:pt>
                <c:pt idx="54">
                  <c:v>1132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1E29-3342-A2AA-0E5784E973CA}"/>
            </c:ext>
          </c:extLst>
        </c:ser>
        <c:ser>
          <c:idx val="38"/>
          <c:order val="38"/>
          <c:tx>
            <c:strRef>
              <c:f>Neat!$A$42</c:f>
              <c:strCache>
                <c:ptCount val="1"/>
                <c:pt idx="0">
                  <c:v>B57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  <a:lumOff val="30000"/>
                </a:schemeClr>
              </a:solidFill>
              <a:ln w="9525">
                <a:solidFill>
                  <a:schemeClr val="accent3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2:$CA$42</c:f>
              <c:numCache>
                <c:formatCode>General</c:formatCode>
                <c:ptCount val="78"/>
                <c:pt idx="0">
                  <c:v>13963</c:v>
                </c:pt>
                <c:pt idx="1">
                  <c:v>13365</c:v>
                </c:pt>
                <c:pt idx="2">
                  <c:v>14161</c:v>
                </c:pt>
                <c:pt idx="3">
                  <c:v>12977</c:v>
                </c:pt>
                <c:pt idx="4">
                  <c:v>10229</c:v>
                </c:pt>
                <c:pt idx="5">
                  <c:v>6860</c:v>
                </c:pt>
                <c:pt idx="6">
                  <c:v>9902</c:v>
                </c:pt>
                <c:pt idx="7">
                  <c:v>10525</c:v>
                </c:pt>
                <c:pt idx="8">
                  <c:v>5589</c:v>
                </c:pt>
                <c:pt idx="9">
                  <c:v>9404</c:v>
                </c:pt>
                <c:pt idx="10">
                  <c:v>4986</c:v>
                </c:pt>
                <c:pt idx="11">
                  <c:v>5653</c:v>
                </c:pt>
                <c:pt idx="12">
                  <c:v>3733</c:v>
                </c:pt>
                <c:pt idx="13">
                  <c:v>2233</c:v>
                </c:pt>
                <c:pt idx="14">
                  <c:v>1343</c:v>
                </c:pt>
                <c:pt idx="15">
                  <c:v>0</c:v>
                </c:pt>
                <c:pt idx="16">
                  <c:v>0</c:v>
                </c:pt>
                <c:pt idx="17">
                  <c:v>1405</c:v>
                </c:pt>
                <c:pt idx="18">
                  <c:v>1021</c:v>
                </c:pt>
                <c:pt idx="19">
                  <c:v>1441</c:v>
                </c:pt>
                <c:pt idx="20">
                  <c:v>1957</c:v>
                </c:pt>
                <c:pt idx="21">
                  <c:v>1815</c:v>
                </c:pt>
                <c:pt idx="22">
                  <c:v>0</c:v>
                </c:pt>
                <c:pt idx="23">
                  <c:v>1931</c:v>
                </c:pt>
                <c:pt idx="24">
                  <c:v>2843</c:v>
                </c:pt>
                <c:pt idx="25">
                  <c:v>4165</c:v>
                </c:pt>
                <c:pt idx="26">
                  <c:v>4226</c:v>
                </c:pt>
                <c:pt idx="27">
                  <c:v>5244</c:v>
                </c:pt>
                <c:pt idx="28">
                  <c:v>2865</c:v>
                </c:pt>
                <c:pt idx="29">
                  <c:v>1749</c:v>
                </c:pt>
                <c:pt idx="30">
                  <c:v>1985</c:v>
                </c:pt>
                <c:pt idx="31">
                  <c:v>2349</c:v>
                </c:pt>
                <c:pt idx="32">
                  <c:v>3242</c:v>
                </c:pt>
                <c:pt idx="33">
                  <c:v>3813</c:v>
                </c:pt>
                <c:pt idx="34">
                  <c:v>2898</c:v>
                </c:pt>
                <c:pt idx="35">
                  <c:v>2889</c:v>
                </c:pt>
                <c:pt idx="36">
                  <c:v>2837</c:v>
                </c:pt>
                <c:pt idx="37">
                  <c:v>4809</c:v>
                </c:pt>
                <c:pt idx="38">
                  <c:v>2608</c:v>
                </c:pt>
                <c:pt idx="39">
                  <c:v>3118</c:v>
                </c:pt>
                <c:pt idx="40">
                  <c:v>2515</c:v>
                </c:pt>
                <c:pt idx="41">
                  <c:v>2520</c:v>
                </c:pt>
                <c:pt idx="42">
                  <c:v>2112</c:v>
                </c:pt>
                <c:pt idx="43">
                  <c:v>2332</c:v>
                </c:pt>
                <c:pt idx="44">
                  <c:v>2237</c:v>
                </c:pt>
                <c:pt idx="45">
                  <c:v>2051</c:v>
                </c:pt>
                <c:pt idx="46">
                  <c:v>1314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1E29-3342-A2AA-0E5784E973CA}"/>
            </c:ext>
          </c:extLst>
        </c:ser>
        <c:ser>
          <c:idx val="39"/>
          <c:order val="39"/>
          <c:tx>
            <c:strRef>
              <c:f>Neat!$A$43</c:f>
              <c:strCache>
                <c:ptCount val="1"/>
                <c:pt idx="0">
                  <c:v>B59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3:$CA$43</c:f>
              <c:numCache>
                <c:formatCode>General</c:formatCode>
                <c:ptCount val="78"/>
                <c:pt idx="0">
                  <c:v>6553</c:v>
                </c:pt>
                <c:pt idx="1">
                  <c:v>4247</c:v>
                </c:pt>
                <c:pt idx="2">
                  <c:v>3829</c:v>
                </c:pt>
                <c:pt idx="3">
                  <c:v>3303</c:v>
                </c:pt>
                <c:pt idx="4">
                  <c:v>2235</c:v>
                </c:pt>
                <c:pt idx="5">
                  <c:v>1235</c:v>
                </c:pt>
                <c:pt idx="6">
                  <c:v>2496</c:v>
                </c:pt>
                <c:pt idx="7">
                  <c:v>2662</c:v>
                </c:pt>
                <c:pt idx="8">
                  <c:v>0</c:v>
                </c:pt>
                <c:pt idx="9">
                  <c:v>2839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297</c:v>
                </c:pt>
                <c:pt idx="25">
                  <c:v>3588</c:v>
                </c:pt>
                <c:pt idx="26">
                  <c:v>3384</c:v>
                </c:pt>
                <c:pt idx="27">
                  <c:v>4124</c:v>
                </c:pt>
                <c:pt idx="28">
                  <c:v>1890</c:v>
                </c:pt>
                <c:pt idx="29">
                  <c:v>1176</c:v>
                </c:pt>
                <c:pt idx="30">
                  <c:v>0</c:v>
                </c:pt>
                <c:pt idx="31">
                  <c:v>0</c:v>
                </c:pt>
                <c:pt idx="32">
                  <c:v>1361</c:v>
                </c:pt>
                <c:pt idx="33">
                  <c:v>1433</c:v>
                </c:pt>
                <c:pt idx="34">
                  <c:v>1079</c:v>
                </c:pt>
                <c:pt idx="35">
                  <c:v>0</c:v>
                </c:pt>
                <c:pt idx="36">
                  <c:v>0</c:v>
                </c:pt>
                <c:pt idx="37">
                  <c:v>1828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1E29-3342-A2AA-0E5784E973CA}"/>
            </c:ext>
          </c:extLst>
        </c:ser>
        <c:ser>
          <c:idx val="40"/>
          <c:order val="40"/>
          <c:tx>
            <c:strRef>
              <c:f>Neat!$A$44</c:f>
              <c:strCache>
                <c:ptCount val="1"/>
                <c:pt idx="0">
                  <c:v>B60</c:v>
                </c:pt>
              </c:strCache>
            </c:strRef>
          </c:tx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70000"/>
                  <a:lumOff val="30000"/>
                </a:schemeClr>
              </a:solidFill>
              <a:ln w="9525">
                <a:solidFill>
                  <a:schemeClr val="accent5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4:$CA$44</c:f>
              <c:numCache>
                <c:formatCode>General</c:formatCode>
                <c:ptCount val="78"/>
                <c:pt idx="0">
                  <c:v>13912</c:v>
                </c:pt>
                <c:pt idx="1">
                  <c:v>16903</c:v>
                </c:pt>
                <c:pt idx="2">
                  <c:v>16346</c:v>
                </c:pt>
                <c:pt idx="3">
                  <c:v>15510</c:v>
                </c:pt>
                <c:pt idx="4">
                  <c:v>12429</c:v>
                </c:pt>
                <c:pt idx="5">
                  <c:v>8812</c:v>
                </c:pt>
                <c:pt idx="6">
                  <c:v>12136</c:v>
                </c:pt>
                <c:pt idx="7">
                  <c:v>12957</c:v>
                </c:pt>
                <c:pt idx="8">
                  <c:v>7820</c:v>
                </c:pt>
                <c:pt idx="9">
                  <c:v>12761</c:v>
                </c:pt>
                <c:pt idx="10">
                  <c:v>7042</c:v>
                </c:pt>
                <c:pt idx="11">
                  <c:v>8587</c:v>
                </c:pt>
                <c:pt idx="12">
                  <c:v>7932</c:v>
                </c:pt>
                <c:pt idx="13">
                  <c:v>5680</c:v>
                </c:pt>
                <c:pt idx="14">
                  <c:v>3868</c:v>
                </c:pt>
                <c:pt idx="15">
                  <c:v>0</c:v>
                </c:pt>
                <c:pt idx="16">
                  <c:v>2133</c:v>
                </c:pt>
                <c:pt idx="17">
                  <c:v>4021</c:v>
                </c:pt>
                <c:pt idx="18">
                  <c:v>3061</c:v>
                </c:pt>
                <c:pt idx="19">
                  <c:v>3716</c:v>
                </c:pt>
                <c:pt idx="20">
                  <c:v>4806</c:v>
                </c:pt>
                <c:pt idx="21">
                  <c:v>3747</c:v>
                </c:pt>
                <c:pt idx="22">
                  <c:v>2020</c:v>
                </c:pt>
                <c:pt idx="23">
                  <c:v>5818</c:v>
                </c:pt>
                <c:pt idx="24">
                  <c:v>8633</c:v>
                </c:pt>
                <c:pt idx="25">
                  <c:v>11175</c:v>
                </c:pt>
                <c:pt idx="26">
                  <c:v>12161</c:v>
                </c:pt>
                <c:pt idx="27">
                  <c:v>13015</c:v>
                </c:pt>
                <c:pt idx="28">
                  <c:v>9601</c:v>
                </c:pt>
                <c:pt idx="29">
                  <c:v>6783</c:v>
                </c:pt>
                <c:pt idx="30">
                  <c:v>7656</c:v>
                </c:pt>
                <c:pt idx="31">
                  <c:v>7997</c:v>
                </c:pt>
                <c:pt idx="32">
                  <c:v>10395</c:v>
                </c:pt>
                <c:pt idx="33">
                  <c:v>11459</c:v>
                </c:pt>
                <c:pt idx="34">
                  <c:v>10054</c:v>
                </c:pt>
                <c:pt idx="35">
                  <c:v>9680</c:v>
                </c:pt>
                <c:pt idx="36">
                  <c:v>9931</c:v>
                </c:pt>
                <c:pt idx="37">
                  <c:v>14599</c:v>
                </c:pt>
                <c:pt idx="38">
                  <c:v>9218</c:v>
                </c:pt>
                <c:pt idx="39">
                  <c:v>10576</c:v>
                </c:pt>
                <c:pt idx="40">
                  <c:v>9305</c:v>
                </c:pt>
                <c:pt idx="41">
                  <c:v>8743</c:v>
                </c:pt>
                <c:pt idx="42">
                  <c:v>8179</c:v>
                </c:pt>
                <c:pt idx="43">
                  <c:v>9287</c:v>
                </c:pt>
                <c:pt idx="44">
                  <c:v>9122</c:v>
                </c:pt>
                <c:pt idx="45">
                  <c:v>9114</c:v>
                </c:pt>
                <c:pt idx="46">
                  <c:v>5724</c:v>
                </c:pt>
                <c:pt idx="47">
                  <c:v>4062</c:v>
                </c:pt>
                <c:pt idx="48">
                  <c:v>4433</c:v>
                </c:pt>
                <c:pt idx="49">
                  <c:v>5124</c:v>
                </c:pt>
                <c:pt idx="50">
                  <c:v>4166</c:v>
                </c:pt>
                <c:pt idx="51">
                  <c:v>4678</c:v>
                </c:pt>
                <c:pt idx="52">
                  <c:v>5506</c:v>
                </c:pt>
                <c:pt idx="53">
                  <c:v>7521</c:v>
                </c:pt>
                <c:pt idx="54">
                  <c:v>3897</c:v>
                </c:pt>
                <c:pt idx="55">
                  <c:v>3728</c:v>
                </c:pt>
                <c:pt idx="56">
                  <c:v>3805</c:v>
                </c:pt>
                <c:pt idx="57">
                  <c:v>3162</c:v>
                </c:pt>
                <c:pt idx="58">
                  <c:v>3290</c:v>
                </c:pt>
                <c:pt idx="59">
                  <c:v>3481</c:v>
                </c:pt>
                <c:pt idx="60">
                  <c:v>4030</c:v>
                </c:pt>
                <c:pt idx="61">
                  <c:v>4474</c:v>
                </c:pt>
                <c:pt idx="62">
                  <c:v>5379</c:v>
                </c:pt>
                <c:pt idx="63">
                  <c:v>5667</c:v>
                </c:pt>
                <c:pt idx="64">
                  <c:v>4514</c:v>
                </c:pt>
                <c:pt idx="65">
                  <c:v>4757</c:v>
                </c:pt>
                <c:pt idx="66">
                  <c:v>4563</c:v>
                </c:pt>
                <c:pt idx="67">
                  <c:v>5088</c:v>
                </c:pt>
                <c:pt idx="68">
                  <c:v>5772</c:v>
                </c:pt>
                <c:pt idx="69">
                  <c:v>5633</c:v>
                </c:pt>
                <c:pt idx="70">
                  <c:v>4417</c:v>
                </c:pt>
                <c:pt idx="71">
                  <c:v>4401</c:v>
                </c:pt>
                <c:pt idx="72">
                  <c:v>4268</c:v>
                </c:pt>
                <c:pt idx="73">
                  <c:v>3552</c:v>
                </c:pt>
                <c:pt idx="74">
                  <c:v>4247</c:v>
                </c:pt>
                <c:pt idx="75">
                  <c:v>4326</c:v>
                </c:pt>
                <c:pt idx="76">
                  <c:v>3925</c:v>
                </c:pt>
                <c:pt idx="77">
                  <c:v>2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1E29-3342-A2AA-0E5784E973CA}"/>
            </c:ext>
          </c:extLst>
        </c:ser>
        <c:ser>
          <c:idx val="41"/>
          <c:order val="41"/>
          <c:tx>
            <c:strRef>
              <c:f>Neat!$A$45</c:f>
              <c:strCache>
                <c:ptCount val="1"/>
                <c:pt idx="0">
                  <c:v>B61</c:v>
                </c:pt>
              </c:strCache>
            </c:strRef>
          </c:tx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0000"/>
                  <a:lumOff val="30000"/>
                </a:schemeClr>
              </a:solidFill>
              <a:ln w="9525">
                <a:solidFill>
                  <a:schemeClr val="accent6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5:$CA$45</c:f>
              <c:numCache>
                <c:formatCode>General</c:formatCode>
                <c:ptCount val="78"/>
                <c:pt idx="0">
                  <c:v>14788</c:v>
                </c:pt>
                <c:pt idx="1">
                  <c:v>17384</c:v>
                </c:pt>
                <c:pt idx="2">
                  <c:v>17848</c:v>
                </c:pt>
                <c:pt idx="3">
                  <c:v>17158</c:v>
                </c:pt>
                <c:pt idx="4">
                  <c:v>14610</c:v>
                </c:pt>
                <c:pt idx="5">
                  <c:v>10330</c:v>
                </c:pt>
                <c:pt idx="6">
                  <c:v>14370</c:v>
                </c:pt>
                <c:pt idx="7">
                  <c:v>15341</c:v>
                </c:pt>
                <c:pt idx="8">
                  <c:v>8778</c:v>
                </c:pt>
                <c:pt idx="9">
                  <c:v>14488</c:v>
                </c:pt>
                <c:pt idx="10">
                  <c:v>8048</c:v>
                </c:pt>
                <c:pt idx="11">
                  <c:v>9166</c:v>
                </c:pt>
                <c:pt idx="12">
                  <c:v>8886</c:v>
                </c:pt>
                <c:pt idx="13">
                  <c:v>6496</c:v>
                </c:pt>
                <c:pt idx="14">
                  <c:v>4352</c:v>
                </c:pt>
                <c:pt idx="15">
                  <c:v>1126</c:v>
                </c:pt>
                <c:pt idx="16">
                  <c:v>2736</c:v>
                </c:pt>
                <c:pt idx="17">
                  <c:v>4588</c:v>
                </c:pt>
                <c:pt idx="18">
                  <c:v>3555</c:v>
                </c:pt>
                <c:pt idx="19">
                  <c:v>4201</c:v>
                </c:pt>
                <c:pt idx="20">
                  <c:v>5305</c:v>
                </c:pt>
                <c:pt idx="21">
                  <c:v>4591</c:v>
                </c:pt>
                <c:pt idx="22">
                  <c:v>2954</c:v>
                </c:pt>
                <c:pt idx="23">
                  <c:v>7479</c:v>
                </c:pt>
                <c:pt idx="24">
                  <c:v>10506</c:v>
                </c:pt>
                <c:pt idx="25">
                  <c:v>14204</c:v>
                </c:pt>
                <c:pt idx="26">
                  <c:v>15345</c:v>
                </c:pt>
                <c:pt idx="27">
                  <c:v>16427</c:v>
                </c:pt>
                <c:pt idx="28">
                  <c:v>11796</c:v>
                </c:pt>
                <c:pt idx="29">
                  <c:v>7710</c:v>
                </c:pt>
                <c:pt idx="30">
                  <c:v>8490</c:v>
                </c:pt>
                <c:pt idx="31">
                  <c:v>8740</c:v>
                </c:pt>
                <c:pt idx="32">
                  <c:v>11748</c:v>
                </c:pt>
                <c:pt idx="33">
                  <c:v>12557</c:v>
                </c:pt>
                <c:pt idx="34">
                  <c:v>11085</c:v>
                </c:pt>
                <c:pt idx="35">
                  <c:v>10489</c:v>
                </c:pt>
                <c:pt idx="36">
                  <c:v>10884</c:v>
                </c:pt>
                <c:pt idx="37">
                  <c:v>15811</c:v>
                </c:pt>
                <c:pt idx="38">
                  <c:v>10505</c:v>
                </c:pt>
                <c:pt idx="39">
                  <c:v>11606</c:v>
                </c:pt>
                <c:pt idx="40">
                  <c:v>10468</c:v>
                </c:pt>
                <c:pt idx="41">
                  <c:v>9696</c:v>
                </c:pt>
                <c:pt idx="42">
                  <c:v>8763</c:v>
                </c:pt>
                <c:pt idx="43">
                  <c:v>10223</c:v>
                </c:pt>
                <c:pt idx="44">
                  <c:v>9949</c:v>
                </c:pt>
                <c:pt idx="45">
                  <c:v>9886</c:v>
                </c:pt>
                <c:pt idx="46">
                  <c:v>6033</c:v>
                </c:pt>
                <c:pt idx="47">
                  <c:v>4454</c:v>
                </c:pt>
                <c:pt idx="48">
                  <c:v>4978</c:v>
                </c:pt>
                <c:pt idx="49">
                  <c:v>5419</c:v>
                </c:pt>
                <c:pt idx="50">
                  <c:v>4589</c:v>
                </c:pt>
                <c:pt idx="51">
                  <c:v>5042</c:v>
                </c:pt>
                <c:pt idx="52">
                  <c:v>5940</c:v>
                </c:pt>
                <c:pt idx="53">
                  <c:v>8181</c:v>
                </c:pt>
                <c:pt idx="54">
                  <c:v>4045</c:v>
                </c:pt>
                <c:pt idx="55">
                  <c:v>3920</c:v>
                </c:pt>
                <c:pt idx="56">
                  <c:v>3962</c:v>
                </c:pt>
                <c:pt idx="57">
                  <c:v>3472</c:v>
                </c:pt>
                <c:pt idx="58">
                  <c:v>3411</c:v>
                </c:pt>
                <c:pt idx="59">
                  <c:v>3874</c:v>
                </c:pt>
                <c:pt idx="60">
                  <c:v>4257</c:v>
                </c:pt>
                <c:pt idx="61">
                  <c:v>4642</c:v>
                </c:pt>
                <c:pt idx="62">
                  <c:v>5574</c:v>
                </c:pt>
                <c:pt idx="63">
                  <c:v>5767</c:v>
                </c:pt>
                <c:pt idx="64">
                  <c:v>4884</c:v>
                </c:pt>
                <c:pt idx="65">
                  <c:v>5154</c:v>
                </c:pt>
                <c:pt idx="66">
                  <c:v>4852</c:v>
                </c:pt>
                <c:pt idx="67">
                  <c:v>5362</c:v>
                </c:pt>
                <c:pt idx="68">
                  <c:v>6331</c:v>
                </c:pt>
                <c:pt idx="69">
                  <c:v>6112</c:v>
                </c:pt>
                <c:pt idx="70">
                  <c:v>4736</c:v>
                </c:pt>
                <c:pt idx="71">
                  <c:v>4660</c:v>
                </c:pt>
                <c:pt idx="72">
                  <c:v>4461</c:v>
                </c:pt>
                <c:pt idx="73">
                  <c:v>3689</c:v>
                </c:pt>
                <c:pt idx="74">
                  <c:v>4470</c:v>
                </c:pt>
                <c:pt idx="75">
                  <c:v>4539</c:v>
                </c:pt>
                <c:pt idx="76">
                  <c:v>4315</c:v>
                </c:pt>
                <c:pt idx="77">
                  <c:v>26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1E29-3342-A2AA-0E5784E973CA}"/>
            </c:ext>
          </c:extLst>
        </c:ser>
        <c:ser>
          <c:idx val="42"/>
          <c:order val="42"/>
          <c:tx>
            <c:strRef>
              <c:f>Neat!$A$46</c:f>
              <c:strCache>
                <c:ptCount val="1"/>
                <c:pt idx="0">
                  <c:v>B62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6:$CA$46</c:f>
              <c:numCache>
                <c:formatCode>General</c:formatCode>
                <c:ptCount val="78"/>
                <c:pt idx="0">
                  <c:v>15542</c:v>
                </c:pt>
                <c:pt idx="1">
                  <c:v>19498</c:v>
                </c:pt>
                <c:pt idx="2">
                  <c:v>20264</c:v>
                </c:pt>
                <c:pt idx="3">
                  <c:v>18764</c:v>
                </c:pt>
                <c:pt idx="4">
                  <c:v>16410</c:v>
                </c:pt>
                <c:pt idx="5">
                  <c:v>11748</c:v>
                </c:pt>
                <c:pt idx="6">
                  <c:v>16181</c:v>
                </c:pt>
                <c:pt idx="7">
                  <c:v>16876</c:v>
                </c:pt>
                <c:pt idx="8">
                  <c:v>9556</c:v>
                </c:pt>
                <c:pt idx="9">
                  <c:v>15099</c:v>
                </c:pt>
                <c:pt idx="10">
                  <c:v>9057</c:v>
                </c:pt>
                <c:pt idx="11">
                  <c:v>9902</c:v>
                </c:pt>
                <c:pt idx="12">
                  <c:v>8064</c:v>
                </c:pt>
                <c:pt idx="13">
                  <c:v>5447</c:v>
                </c:pt>
                <c:pt idx="14">
                  <c:v>3461</c:v>
                </c:pt>
                <c:pt idx="15">
                  <c:v>0</c:v>
                </c:pt>
                <c:pt idx="16">
                  <c:v>2210</c:v>
                </c:pt>
                <c:pt idx="17">
                  <c:v>2410</c:v>
                </c:pt>
                <c:pt idx="18">
                  <c:v>1657</c:v>
                </c:pt>
                <c:pt idx="19">
                  <c:v>1814</c:v>
                </c:pt>
                <c:pt idx="20">
                  <c:v>2513</c:v>
                </c:pt>
                <c:pt idx="21">
                  <c:v>2483</c:v>
                </c:pt>
                <c:pt idx="22">
                  <c:v>1531</c:v>
                </c:pt>
                <c:pt idx="23">
                  <c:v>2966</c:v>
                </c:pt>
                <c:pt idx="24">
                  <c:v>4331</c:v>
                </c:pt>
                <c:pt idx="25">
                  <c:v>6809</c:v>
                </c:pt>
                <c:pt idx="26">
                  <c:v>6541</c:v>
                </c:pt>
                <c:pt idx="27">
                  <c:v>7615</c:v>
                </c:pt>
                <c:pt idx="28">
                  <c:v>4337</c:v>
                </c:pt>
                <c:pt idx="29">
                  <c:v>2813</c:v>
                </c:pt>
                <c:pt idx="30">
                  <c:v>2887</c:v>
                </c:pt>
                <c:pt idx="31">
                  <c:v>3166</c:v>
                </c:pt>
                <c:pt idx="32">
                  <c:v>4661</c:v>
                </c:pt>
                <c:pt idx="33">
                  <c:v>5344</c:v>
                </c:pt>
                <c:pt idx="34">
                  <c:v>4300</c:v>
                </c:pt>
                <c:pt idx="35">
                  <c:v>4243</c:v>
                </c:pt>
                <c:pt idx="36">
                  <c:v>4158</c:v>
                </c:pt>
                <c:pt idx="37">
                  <c:v>6718</c:v>
                </c:pt>
                <c:pt idx="38">
                  <c:v>3603</c:v>
                </c:pt>
                <c:pt idx="39">
                  <c:v>4558</c:v>
                </c:pt>
                <c:pt idx="40">
                  <c:v>3725</c:v>
                </c:pt>
                <c:pt idx="41">
                  <c:v>3629</c:v>
                </c:pt>
                <c:pt idx="42">
                  <c:v>2998</c:v>
                </c:pt>
                <c:pt idx="43">
                  <c:v>3391</c:v>
                </c:pt>
                <c:pt idx="44">
                  <c:v>3255</c:v>
                </c:pt>
                <c:pt idx="45">
                  <c:v>3002</c:v>
                </c:pt>
                <c:pt idx="46">
                  <c:v>1687</c:v>
                </c:pt>
                <c:pt idx="47">
                  <c:v>1106</c:v>
                </c:pt>
                <c:pt idx="48">
                  <c:v>1343</c:v>
                </c:pt>
                <c:pt idx="49">
                  <c:v>1430</c:v>
                </c:pt>
                <c:pt idx="50">
                  <c:v>1135</c:v>
                </c:pt>
                <c:pt idx="51">
                  <c:v>1190</c:v>
                </c:pt>
                <c:pt idx="52">
                  <c:v>1510</c:v>
                </c:pt>
                <c:pt idx="53">
                  <c:v>1583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1089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1E29-3342-A2AA-0E5784E973CA}"/>
            </c:ext>
          </c:extLst>
        </c:ser>
        <c:ser>
          <c:idx val="43"/>
          <c:order val="43"/>
          <c:tx>
            <c:strRef>
              <c:f>Neat!$A$47</c:f>
              <c:strCache>
                <c:ptCount val="1"/>
                <c:pt idx="0">
                  <c:v>B63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7:$CA$47</c:f>
              <c:numCache>
                <c:formatCode>General</c:formatCode>
                <c:ptCount val="78"/>
                <c:pt idx="0">
                  <c:v>13065</c:v>
                </c:pt>
                <c:pt idx="1">
                  <c:v>12793</c:v>
                </c:pt>
                <c:pt idx="2">
                  <c:v>13388</c:v>
                </c:pt>
                <c:pt idx="3">
                  <c:v>12018</c:v>
                </c:pt>
                <c:pt idx="4">
                  <c:v>9554</c:v>
                </c:pt>
                <c:pt idx="5">
                  <c:v>6220</c:v>
                </c:pt>
                <c:pt idx="6">
                  <c:v>9236</c:v>
                </c:pt>
                <c:pt idx="7">
                  <c:v>10375</c:v>
                </c:pt>
                <c:pt idx="8">
                  <c:v>4999</c:v>
                </c:pt>
                <c:pt idx="9">
                  <c:v>8797</c:v>
                </c:pt>
                <c:pt idx="10">
                  <c:v>4546</c:v>
                </c:pt>
                <c:pt idx="11">
                  <c:v>4960</c:v>
                </c:pt>
                <c:pt idx="12">
                  <c:v>3185</c:v>
                </c:pt>
                <c:pt idx="13">
                  <c:v>1916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1289</c:v>
                </c:pt>
                <c:pt idx="18">
                  <c:v>0</c:v>
                </c:pt>
                <c:pt idx="19">
                  <c:v>0</c:v>
                </c:pt>
                <c:pt idx="20">
                  <c:v>1823</c:v>
                </c:pt>
                <c:pt idx="21">
                  <c:v>1677</c:v>
                </c:pt>
                <c:pt idx="22">
                  <c:v>0</c:v>
                </c:pt>
                <c:pt idx="23">
                  <c:v>1738</c:v>
                </c:pt>
                <c:pt idx="24">
                  <c:v>2500</c:v>
                </c:pt>
                <c:pt idx="25">
                  <c:v>3941</c:v>
                </c:pt>
                <c:pt idx="26">
                  <c:v>3872</c:v>
                </c:pt>
                <c:pt idx="27">
                  <c:v>4714</c:v>
                </c:pt>
                <c:pt idx="28">
                  <c:v>2459</c:v>
                </c:pt>
                <c:pt idx="29">
                  <c:v>1764</c:v>
                </c:pt>
                <c:pt idx="30">
                  <c:v>2058</c:v>
                </c:pt>
                <c:pt idx="31">
                  <c:v>2290</c:v>
                </c:pt>
                <c:pt idx="32">
                  <c:v>3245</c:v>
                </c:pt>
                <c:pt idx="33">
                  <c:v>3769</c:v>
                </c:pt>
                <c:pt idx="34">
                  <c:v>2806</c:v>
                </c:pt>
                <c:pt idx="35">
                  <c:v>3072</c:v>
                </c:pt>
                <c:pt idx="36">
                  <c:v>2947</c:v>
                </c:pt>
                <c:pt idx="37">
                  <c:v>5066</c:v>
                </c:pt>
                <c:pt idx="38">
                  <c:v>2669</c:v>
                </c:pt>
                <c:pt idx="39">
                  <c:v>3222</c:v>
                </c:pt>
                <c:pt idx="40">
                  <c:v>2655</c:v>
                </c:pt>
                <c:pt idx="41">
                  <c:v>2540</c:v>
                </c:pt>
                <c:pt idx="42">
                  <c:v>2202</c:v>
                </c:pt>
                <c:pt idx="43">
                  <c:v>2484</c:v>
                </c:pt>
                <c:pt idx="44">
                  <c:v>2415</c:v>
                </c:pt>
                <c:pt idx="45">
                  <c:v>2161</c:v>
                </c:pt>
                <c:pt idx="46">
                  <c:v>137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1E29-3342-A2AA-0E5784E973CA}"/>
            </c:ext>
          </c:extLst>
        </c:ser>
        <c:ser>
          <c:idx val="44"/>
          <c:order val="44"/>
          <c:tx>
            <c:strRef>
              <c:f>Neat!$A$48</c:f>
              <c:strCache>
                <c:ptCount val="1"/>
                <c:pt idx="0">
                  <c:v>B64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</a:schemeClr>
              </a:solidFill>
              <a:ln w="9525">
                <a:solidFill>
                  <a:schemeClr val="accent3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8:$CA$48</c:f>
              <c:numCache>
                <c:formatCode>General</c:formatCode>
                <c:ptCount val="78"/>
                <c:pt idx="0">
                  <c:v>14050</c:v>
                </c:pt>
                <c:pt idx="1">
                  <c:v>11412</c:v>
                </c:pt>
                <c:pt idx="2">
                  <c:v>11619</c:v>
                </c:pt>
                <c:pt idx="3">
                  <c:v>11049</c:v>
                </c:pt>
                <c:pt idx="4">
                  <c:v>8344</c:v>
                </c:pt>
                <c:pt idx="5">
                  <c:v>5382</c:v>
                </c:pt>
                <c:pt idx="6">
                  <c:v>9113</c:v>
                </c:pt>
                <c:pt idx="7">
                  <c:v>9867</c:v>
                </c:pt>
                <c:pt idx="8">
                  <c:v>4422</c:v>
                </c:pt>
                <c:pt idx="9">
                  <c:v>8419</c:v>
                </c:pt>
                <c:pt idx="10">
                  <c:v>4250</c:v>
                </c:pt>
                <c:pt idx="11">
                  <c:v>4858</c:v>
                </c:pt>
                <c:pt idx="12">
                  <c:v>4510</c:v>
                </c:pt>
                <c:pt idx="13">
                  <c:v>3023</c:v>
                </c:pt>
                <c:pt idx="14">
                  <c:v>1914</c:v>
                </c:pt>
                <c:pt idx="15">
                  <c:v>0</c:v>
                </c:pt>
                <c:pt idx="16">
                  <c:v>1116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2256</c:v>
                </c:pt>
                <c:pt idx="24">
                  <c:v>3741</c:v>
                </c:pt>
                <c:pt idx="25">
                  <c:v>5378</c:v>
                </c:pt>
                <c:pt idx="26">
                  <c:v>5117</c:v>
                </c:pt>
                <c:pt idx="27">
                  <c:v>5814</c:v>
                </c:pt>
                <c:pt idx="28">
                  <c:v>3612</c:v>
                </c:pt>
                <c:pt idx="29">
                  <c:v>3350</c:v>
                </c:pt>
                <c:pt idx="30">
                  <c:v>2265</c:v>
                </c:pt>
                <c:pt idx="31">
                  <c:v>2203</c:v>
                </c:pt>
                <c:pt idx="32">
                  <c:v>2746</c:v>
                </c:pt>
                <c:pt idx="33">
                  <c:v>3378</c:v>
                </c:pt>
                <c:pt idx="34">
                  <c:v>2496</c:v>
                </c:pt>
                <c:pt idx="35">
                  <c:v>2363</c:v>
                </c:pt>
                <c:pt idx="36">
                  <c:v>2187</c:v>
                </c:pt>
                <c:pt idx="37">
                  <c:v>3732</c:v>
                </c:pt>
                <c:pt idx="38">
                  <c:v>1861</c:v>
                </c:pt>
                <c:pt idx="39">
                  <c:v>2113</c:v>
                </c:pt>
                <c:pt idx="40">
                  <c:v>1830</c:v>
                </c:pt>
                <c:pt idx="41">
                  <c:v>1773</c:v>
                </c:pt>
                <c:pt idx="42">
                  <c:v>1446</c:v>
                </c:pt>
                <c:pt idx="43">
                  <c:v>1449</c:v>
                </c:pt>
                <c:pt idx="44">
                  <c:v>1345</c:v>
                </c:pt>
                <c:pt idx="45">
                  <c:v>1276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362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1E29-3342-A2AA-0E5784E973CA}"/>
            </c:ext>
          </c:extLst>
        </c:ser>
        <c:ser>
          <c:idx val="45"/>
          <c:order val="45"/>
          <c:tx>
            <c:strRef>
              <c:f>Neat!$A$49</c:f>
              <c:strCache>
                <c:ptCount val="1"/>
                <c:pt idx="0">
                  <c:v>B65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</a:schemeClr>
              </a:solidFill>
              <a:ln w="9525">
                <a:solidFill>
                  <a:schemeClr val="accent4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49:$CA$49</c:f>
              <c:numCache>
                <c:formatCode>General</c:formatCode>
                <c:ptCount val="78"/>
                <c:pt idx="0">
                  <c:v>11789</c:v>
                </c:pt>
                <c:pt idx="1">
                  <c:v>8944</c:v>
                </c:pt>
                <c:pt idx="2">
                  <c:v>9278</c:v>
                </c:pt>
                <c:pt idx="3">
                  <c:v>8868</c:v>
                </c:pt>
                <c:pt idx="4">
                  <c:v>6453</c:v>
                </c:pt>
                <c:pt idx="5">
                  <c:v>3970</c:v>
                </c:pt>
                <c:pt idx="6">
                  <c:v>7162</c:v>
                </c:pt>
                <c:pt idx="7">
                  <c:v>7767</c:v>
                </c:pt>
                <c:pt idx="8">
                  <c:v>3391</c:v>
                </c:pt>
                <c:pt idx="9">
                  <c:v>6870</c:v>
                </c:pt>
                <c:pt idx="10">
                  <c:v>3318</c:v>
                </c:pt>
                <c:pt idx="11">
                  <c:v>3675</c:v>
                </c:pt>
                <c:pt idx="12">
                  <c:v>3247</c:v>
                </c:pt>
                <c:pt idx="13">
                  <c:v>2213</c:v>
                </c:pt>
                <c:pt idx="14">
                  <c:v>1377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809</c:v>
                </c:pt>
                <c:pt idx="24">
                  <c:v>2951</c:v>
                </c:pt>
                <c:pt idx="25">
                  <c:v>4489</c:v>
                </c:pt>
                <c:pt idx="26">
                  <c:v>3916</c:v>
                </c:pt>
                <c:pt idx="27">
                  <c:v>4478</c:v>
                </c:pt>
                <c:pt idx="28">
                  <c:v>2579</c:v>
                </c:pt>
                <c:pt idx="29">
                  <c:v>2309</c:v>
                </c:pt>
                <c:pt idx="30">
                  <c:v>1470</c:v>
                </c:pt>
                <c:pt idx="31">
                  <c:v>1466</c:v>
                </c:pt>
                <c:pt idx="32">
                  <c:v>1842</c:v>
                </c:pt>
                <c:pt idx="33">
                  <c:v>2153</c:v>
                </c:pt>
                <c:pt idx="34">
                  <c:v>1629</c:v>
                </c:pt>
                <c:pt idx="35">
                  <c:v>1482</c:v>
                </c:pt>
                <c:pt idx="36">
                  <c:v>1342</c:v>
                </c:pt>
                <c:pt idx="37">
                  <c:v>2329</c:v>
                </c:pt>
                <c:pt idx="38">
                  <c:v>1227</c:v>
                </c:pt>
                <c:pt idx="39">
                  <c:v>1400</c:v>
                </c:pt>
                <c:pt idx="40">
                  <c:v>1184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1E29-3342-A2AA-0E5784E973CA}"/>
            </c:ext>
          </c:extLst>
        </c:ser>
        <c:ser>
          <c:idx val="46"/>
          <c:order val="46"/>
          <c:tx>
            <c:strRef>
              <c:f>Neat!$A$50</c:f>
              <c:strCache>
                <c:ptCount val="1"/>
                <c:pt idx="0">
                  <c:v>B67</c:v>
                </c:pt>
              </c:strCache>
            </c:strRef>
          </c:tx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70000"/>
                </a:schemeClr>
              </a:solidFill>
              <a:ln w="9525">
                <a:solidFill>
                  <a:schemeClr val="accent5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0:$CA$50</c:f>
              <c:numCache>
                <c:formatCode>General</c:formatCode>
                <c:ptCount val="78"/>
                <c:pt idx="0">
                  <c:v>13502</c:v>
                </c:pt>
                <c:pt idx="1">
                  <c:v>20221</c:v>
                </c:pt>
                <c:pt idx="2">
                  <c:v>20451</c:v>
                </c:pt>
                <c:pt idx="3">
                  <c:v>19845</c:v>
                </c:pt>
                <c:pt idx="4">
                  <c:v>17147</c:v>
                </c:pt>
                <c:pt idx="5">
                  <c:v>13473</c:v>
                </c:pt>
                <c:pt idx="6">
                  <c:v>17617</c:v>
                </c:pt>
                <c:pt idx="7">
                  <c:v>18383</c:v>
                </c:pt>
                <c:pt idx="8">
                  <c:v>11018</c:v>
                </c:pt>
                <c:pt idx="9">
                  <c:v>16517</c:v>
                </c:pt>
                <c:pt idx="10">
                  <c:v>10952</c:v>
                </c:pt>
                <c:pt idx="11">
                  <c:v>12328</c:v>
                </c:pt>
                <c:pt idx="12">
                  <c:v>11110</c:v>
                </c:pt>
                <c:pt idx="13">
                  <c:v>7900</c:v>
                </c:pt>
                <c:pt idx="14">
                  <c:v>5753</c:v>
                </c:pt>
                <c:pt idx="15">
                  <c:v>2219</c:v>
                </c:pt>
                <c:pt idx="16">
                  <c:v>3814</c:v>
                </c:pt>
                <c:pt idx="17">
                  <c:v>4293</c:v>
                </c:pt>
                <c:pt idx="18">
                  <c:v>3643</c:v>
                </c:pt>
                <c:pt idx="19">
                  <c:v>5121</c:v>
                </c:pt>
                <c:pt idx="20">
                  <c:v>6919</c:v>
                </c:pt>
                <c:pt idx="21">
                  <c:v>6614</c:v>
                </c:pt>
                <c:pt idx="22">
                  <c:v>5009</c:v>
                </c:pt>
                <c:pt idx="23">
                  <c:v>10063</c:v>
                </c:pt>
                <c:pt idx="24">
                  <c:v>14099</c:v>
                </c:pt>
                <c:pt idx="25">
                  <c:v>17239</c:v>
                </c:pt>
                <c:pt idx="26">
                  <c:v>17502</c:v>
                </c:pt>
                <c:pt idx="27">
                  <c:v>17786</c:v>
                </c:pt>
                <c:pt idx="28">
                  <c:v>14733</c:v>
                </c:pt>
                <c:pt idx="29">
                  <c:v>10940</c:v>
                </c:pt>
                <c:pt idx="30">
                  <c:v>10963</c:v>
                </c:pt>
                <c:pt idx="31">
                  <c:v>10583</c:v>
                </c:pt>
                <c:pt idx="32">
                  <c:v>13049</c:v>
                </c:pt>
                <c:pt idx="33">
                  <c:v>15592</c:v>
                </c:pt>
                <c:pt idx="34">
                  <c:v>13106</c:v>
                </c:pt>
                <c:pt idx="35">
                  <c:v>13732</c:v>
                </c:pt>
                <c:pt idx="36">
                  <c:v>13505</c:v>
                </c:pt>
                <c:pt idx="37">
                  <c:v>16603</c:v>
                </c:pt>
                <c:pt idx="38">
                  <c:v>13075</c:v>
                </c:pt>
                <c:pt idx="39">
                  <c:v>13407</c:v>
                </c:pt>
                <c:pt idx="40">
                  <c:v>12924</c:v>
                </c:pt>
                <c:pt idx="41">
                  <c:v>13797</c:v>
                </c:pt>
                <c:pt idx="42">
                  <c:v>11038</c:v>
                </c:pt>
                <c:pt idx="43">
                  <c:v>12233</c:v>
                </c:pt>
                <c:pt idx="44">
                  <c:v>11672</c:v>
                </c:pt>
                <c:pt idx="45">
                  <c:v>11606</c:v>
                </c:pt>
                <c:pt idx="46">
                  <c:v>7938</c:v>
                </c:pt>
                <c:pt idx="47">
                  <c:v>6584</c:v>
                </c:pt>
                <c:pt idx="48">
                  <c:v>6854</c:v>
                </c:pt>
                <c:pt idx="49">
                  <c:v>7185</c:v>
                </c:pt>
                <c:pt idx="50">
                  <c:v>6043</c:v>
                </c:pt>
                <c:pt idx="51">
                  <c:v>6815</c:v>
                </c:pt>
                <c:pt idx="52">
                  <c:v>8326</c:v>
                </c:pt>
                <c:pt idx="53">
                  <c:v>10819</c:v>
                </c:pt>
                <c:pt idx="54">
                  <c:v>5530</c:v>
                </c:pt>
                <c:pt idx="55">
                  <c:v>5658</c:v>
                </c:pt>
                <c:pt idx="56">
                  <c:v>6145</c:v>
                </c:pt>
                <c:pt idx="57">
                  <c:v>5205</c:v>
                </c:pt>
                <c:pt idx="58">
                  <c:v>5190</c:v>
                </c:pt>
                <c:pt idx="59">
                  <c:v>5758</c:v>
                </c:pt>
                <c:pt idx="60">
                  <c:v>5894</c:v>
                </c:pt>
                <c:pt idx="61">
                  <c:v>6965</c:v>
                </c:pt>
                <c:pt idx="62">
                  <c:v>8056</c:v>
                </c:pt>
                <c:pt idx="63">
                  <c:v>8605</c:v>
                </c:pt>
                <c:pt idx="64">
                  <c:v>6882</c:v>
                </c:pt>
                <c:pt idx="65">
                  <c:v>7265</c:v>
                </c:pt>
                <c:pt idx="66">
                  <c:v>6873</c:v>
                </c:pt>
                <c:pt idx="67">
                  <c:v>7015</c:v>
                </c:pt>
                <c:pt idx="68">
                  <c:v>7934</c:v>
                </c:pt>
                <c:pt idx="69">
                  <c:v>8066</c:v>
                </c:pt>
                <c:pt idx="70">
                  <c:v>7279</c:v>
                </c:pt>
                <c:pt idx="71">
                  <c:v>6552</c:v>
                </c:pt>
                <c:pt idx="72">
                  <c:v>7437</c:v>
                </c:pt>
                <c:pt idx="73">
                  <c:v>6097</c:v>
                </c:pt>
                <c:pt idx="74">
                  <c:v>6863</c:v>
                </c:pt>
                <c:pt idx="75">
                  <c:v>6354</c:v>
                </c:pt>
                <c:pt idx="76">
                  <c:v>6657</c:v>
                </c:pt>
                <c:pt idx="77">
                  <c:v>48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1E29-3342-A2AA-0E5784E973CA}"/>
            </c:ext>
          </c:extLst>
        </c:ser>
        <c:ser>
          <c:idx val="47"/>
          <c:order val="47"/>
          <c:tx>
            <c:strRef>
              <c:f>Neat!$A$51</c:f>
              <c:strCache>
                <c:ptCount val="1"/>
                <c:pt idx="0">
                  <c:v>B7</c:v>
                </c:pt>
              </c:strCache>
            </c:strRef>
          </c:tx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0000"/>
                </a:schemeClr>
              </a:solidFill>
              <a:ln w="9525">
                <a:solidFill>
                  <a:schemeClr val="accent6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1:$CA$51</c:f>
              <c:numCache>
                <c:formatCode>General</c:formatCode>
                <c:ptCount val="78"/>
                <c:pt idx="0">
                  <c:v>12670</c:v>
                </c:pt>
                <c:pt idx="1">
                  <c:v>20172</c:v>
                </c:pt>
                <c:pt idx="2">
                  <c:v>20721</c:v>
                </c:pt>
                <c:pt idx="3">
                  <c:v>20684</c:v>
                </c:pt>
                <c:pt idx="4">
                  <c:v>18744</c:v>
                </c:pt>
                <c:pt idx="5">
                  <c:v>13949</c:v>
                </c:pt>
                <c:pt idx="6">
                  <c:v>18776</c:v>
                </c:pt>
                <c:pt idx="7">
                  <c:v>19553</c:v>
                </c:pt>
                <c:pt idx="8">
                  <c:v>12231</c:v>
                </c:pt>
                <c:pt idx="9">
                  <c:v>17569</c:v>
                </c:pt>
                <c:pt idx="10">
                  <c:v>11501</c:v>
                </c:pt>
                <c:pt idx="11">
                  <c:v>12925</c:v>
                </c:pt>
                <c:pt idx="12">
                  <c:v>11834</c:v>
                </c:pt>
                <c:pt idx="13">
                  <c:v>8834</c:v>
                </c:pt>
                <c:pt idx="14">
                  <c:v>6185</c:v>
                </c:pt>
                <c:pt idx="15">
                  <c:v>1924</c:v>
                </c:pt>
                <c:pt idx="16">
                  <c:v>3789</c:v>
                </c:pt>
                <c:pt idx="17">
                  <c:v>5976</c:v>
                </c:pt>
                <c:pt idx="18">
                  <c:v>4926</c:v>
                </c:pt>
                <c:pt idx="19">
                  <c:v>5627</c:v>
                </c:pt>
                <c:pt idx="20">
                  <c:v>7160</c:v>
                </c:pt>
                <c:pt idx="21">
                  <c:v>6110</c:v>
                </c:pt>
                <c:pt idx="22">
                  <c:v>3856</c:v>
                </c:pt>
                <c:pt idx="23">
                  <c:v>8512</c:v>
                </c:pt>
                <c:pt idx="24">
                  <c:v>11932</c:v>
                </c:pt>
                <c:pt idx="25">
                  <c:v>16098</c:v>
                </c:pt>
                <c:pt idx="26">
                  <c:v>17245</c:v>
                </c:pt>
                <c:pt idx="27">
                  <c:v>18339</c:v>
                </c:pt>
                <c:pt idx="28">
                  <c:v>13144</c:v>
                </c:pt>
                <c:pt idx="29">
                  <c:v>9766</c:v>
                </c:pt>
                <c:pt idx="30">
                  <c:v>9836</c:v>
                </c:pt>
                <c:pt idx="31">
                  <c:v>10073</c:v>
                </c:pt>
                <c:pt idx="32">
                  <c:v>13339</c:v>
                </c:pt>
                <c:pt idx="33">
                  <c:v>14742</c:v>
                </c:pt>
                <c:pt idx="34">
                  <c:v>12728</c:v>
                </c:pt>
                <c:pt idx="35">
                  <c:v>12528</c:v>
                </c:pt>
                <c:pt idx="36">
                  <c:v>12752</c:v>
                </c:pt>
                <c:pt idx="37">
                  <c:v>17405</c:v>
                </c:pt>
                <c:pt idx="38">
                  <c:v>12223</c:v>
                </c:pt>
                <c:pt idx="39">
                  <c:v>13268</c:v>
                </c:pt>
                <c:pt idx="40">
                  <c:v>12025</c:v>
                </c:pt>
                <c:pt idx="41">
                  <c:v>11665</c:v>
                </c:pt>
                <c:pt idx="42">
                  <c:v>10353</c:v>
                </c:pt>
                <c:pt idx="43">
                  <c:v>11853</c:v>
                </c:pt>
                <c:pt idx="44">
                  <c:v>11805</c:v>
                </c:pt>
                <c:pt idx="45">
                  <c:v>11457</c:v>
                </c:pt>
                <c:pt idx="46">
                  <c:v>7173</c:v>
                </c:pt>
                <c:pt idx="47">
                  <c:v>5409</c:v>
                </c:pt>
                <c:pt idx="48">
                  <c:v>5895</c:v>
                </c:pt>
                <c:pt idx="49">
                  <c:v>6915</c:v>
                </c:pt>
                <c:pt idx="50">
                  <c:v>5762</c:v>
                </c:pt>
                <c:pt idx="51">
                  <c:v>6152</c:v>
                </c:pt>
                <c:pt idx="52">
                  <c:v>7060</c:v>
                </c:pt>
                <c:pt idx="53">
                  <c:v>9783</c:v>
                </c:pt>
                <c:pt idx="54">
                  <c:v>5406</c:v>
                </c:pt>
                <c:pt idx="55">
                  <c:v>5039</c:v>
                </c:pt>
                <c:pt idx="56">
                  <c:v>5037</c:v>
                </c:pt>
                <c:pt idx="57">
                  <c:v>4323</c:v>
                </c:pt>
                <c:pt idx="58">
                  <c:v>4347</c:v>
                </c:pt>
                <c:pt idx="59">
                  <c:v>4710</c:v>
                </c:pt>
                <c:pt idx="60">
                  <c:v>5178</c:v>
                </c:pt>
                <c:pt idx="61">
                  <c:v>5817</c:v>
                </c:pt>
                <c:pt idx="62">
                  <c:v>6766</c:v>
                </c:pt>
                <c:pt idx="63">
                  <c:v>7284</c:v>
                </c:pt>
                <c:pt idx="64">
                  <c:v>6075</c:v>
                </c:pt>
                <c:pt idx="65">
                  <c:v>6400</c:v>
                </c:pt>
                <c:pt idx="66">
                  <c:v>5907</c:v>
                </c:pt>
                <c:pt idx="67">
                  <c:v>6562</c:v>
                </c:pt>
                <c:pt idx="68">
                  <c:v>7263</c:v>
                </c:pt>
                <c:pt idx="69">
                  <c:v>7484</c:v>
                </c:pt>
                <c:pt idx="70">
                  <c:v>6267</c:v>
                </c:pt>
                <c:pt idx="71">
                  <c:v>6258</c:v>
                </c:pt>
                <c:pt idx="72">
                  <c:v>6543</c:v>
                </c:pt>
                <c:pt idx="73">
                  <c:v>5598</c:v>
                </c:pt>
                <c:pt idx="74">
                  <c:v>6471</c:v>
                </c:pt>
                <c:pt idx="75">
                  <c:v>6150</c:v>
                </c:pt>
                <c:pt idx="76">
                  <c:v>6006</c:v>
                </c:pt>
                <c:pt idx="77">
                  <c:v>37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1E29-3342-A2AA-0E5784E973CA}"/>
            </c:ext>
          </c:extLst>
        </c:ser>
        <c:ser>
          <c:idx val="48"/>
          <c:order val="48"/>
          <c:tx>
            <c:strRef>
              <c:f>Neat!$A$52</c:f>
              <c:strCache>
                <c:ptCount val="1"/>
                <c:pt idx="0">
                  <c:v>B71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  <a:lumOff val="50000"/>
                </a:schemeClr>
              </a:solidFill>
              <a:ln w="9525">
                <a:solidFill>
                  <a:schemeClr val="accent1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2:$CA$52</c:f>
              <c:numCache>
                <c:formatCode>General</c:formatCode>
                <c:ptCount val="78"/>
                <c:pt idx="0">
                  <c:v>12650</c:v>
                </c:pt>
                <c:pt idx="1">
                  <c:v>10641</c:v>
                </c:pt>
                <c:pt idx="2">
                  <c:v>10771</c:v>
                </c:pt>
                <c:pt idx="3">
                  <c:v>10051</c:v>
                </c:pt>
                <c:pt idx="4">
                  <c:v>7491</c:v>
                </c:pt>
                <c:pt idx="5">
                  <c:v>5130</c:v>
                </c:pt>
                <c:pt idx="6">
                  <c:v>8585</c:v>
                </c:pt>
                <c:pt idx="7">
                  <c:v>9366</c:v>
                </c:pt>
                <c:pt idx="8">
                  <c:v>4144</c:v>
                </c:pt>
                <c:pt idx="9">
                  <c:v>8428</c:v>
                </c:pt>
                <c:pt idx="10">
                  <c:v>4177</c:v>
                </c:pt>
                <c:pt idx="11">
                  <c:v>4622</c:v>
                </c:pt>
                <c:pt idx="12">
                  <c:v>4408</c:v>
                </c:pt>
                <c:pt idx="13">
                  <c:v>3064</c:v>
                </c:pt>
                <c:pt idx="14">
                  <c:v>1946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484</c:v>
                </c:pt>
                <c:pt idx="24">
                  <c:v>2065</c:v>
                </c:pt>
                <c:pt idx="25">
                  <c:v>3430</c:v>
                </c:pt>
                <c:pt idx="26">
                  <c:v>2545</c:v>
                </c:pt>
                <c:pt idx="27">
                  <c:v>2833</c:v>
                </c:pt>
                <c:pt idx="28">
                  <c:v>1754</c:v>
                </c:pt>
                <c:pt idx="29">
                  <c:v>2085</c:v>
                </c:pt>
                <c:pt idx="30">
                  <c:v>1143</c:v>
                </c:pt>
                <c:pt idx="31">
                  <c:v>1206</c:v>
                </c:pt>
                <c:pt idx="32">
                  <c:v>1460</c:v>
                </c:pt>
                <c:pt idx="33">
                  <c:v>1843</c:v>
                </c:pt>
                <c:pt idx="34">
                  <c:v>1507</c:v>
                </c:pt>
                <c:pt idx="35">
                  <c:v>1325</c:v>
                </c:pt>
                <c:pt idx="36">
                  <c:v>1105</c:v>
                </c:pt>
                <c:pt idx="37">
                  <c:v>2088</c:v>
                </c:pt>
                <c:pt idx="38">
                  <c:v>1001</c:v>
                </c:pt>
                <c:pt idx="39">
                  <c:v>1141</c:v>
                </c:pt>
                <c:pt idx="40">
                  <c:v>0</c:v>
                </c:pt>
                <c:pt idx="41">
                  <c:v>1073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1E29-3342-A2AA-0E5784E973CA}"/>
            </c:ext>
          </c:extLst>
        </c:ser>
        <c:ser>
          <c:idx val="49"/>
          <c:order val="49"/>
          <c:tx>
            <c:strRef>
              <c:f>Neat!$A$53</c:f>
              <c:strCache>
                <c:ptCount val="1"/>
                <c:pt idx="0">
                  <c:v>B72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  <a:lumOff val="50000"/>
                </a:schemeClr>
              </a:solidFill>
              <a:ln w="9525">
                <a:solidFill>
                  <a:schemeClr val="accent2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3:$CA$53</c:f>
              <c:numCache>
                <c:formatCode>General</c:formatCode>
                <c:ptCount val="78"/>
                <c:pt idx="0">
                  <c:v>14948</c:v>
                </c:pt>
                <c:pt idx="1">
                  <c:v>12331</c:v>
                </c:pt>
                <c:pt idx="2">
                  <c:v>12624</c:v>
                </c:pt>
                <c:pt idx="3">
                  <c:v>11591</c:v>
                </c:pt>
                <c:pt idx="4">
                  <c:v>8738</c:v>
                </c:pt>
                <c:pt idx="5">
                  <c:v>5898</c:v>
                </c:pt>
                <c:pt idx="6">
                  <c:v>10044</c:v>
                </c:pt>
                <c:pt idx="7">
                  <c:v>11141</c:v>
                </c:pt>
                <c:pt idx="8">
                  <c:v>4947</c:v>
                </c:pt>
                <c:pt idx="9">
                  <c:v>9457</c:v>
                </c:pt>
                <c:pt idx="10">
                  <c:v>4704</c:v>
                </c:pt>
                <c:pt idx="11">
                  <c:v>5239</c:v>
                </c:pt>
                <c:pt idx="12">
                  <c:v>5239</c:v>
                </c:pt>
                <c:pt idx="13">
                  <c:v>3455</c:v>
                </c:pt>
                <c:pt idx="14">
                  <c:v>2229</c:v>
                </c:pt>
                <c:pt idx="15">
                  <c:v>0</c:v>
                </c:pt>
                <c:pt idx="16">
                  <c:v>1538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437</c:v>
                </c:pt>
                <c:pt idx="24">
                  <c:v>2106</c:v>
                </c:pt>
                <c:pt idx="25">
                  <c:v>3670</c:v>
                </c:pt>
                <c:pt idx="26">
                  <c:v>2816</c:v>
                </c:pt>
                <c:pt idx="27">
                  <c:v>3279</c:v>
                </c:pt>
                <c:pt idx="28">
                  <c:v>1877</c:v>
                </c:pt>
                <c:pt idx="29">
                  <c:v>1659</c:v>
                </c:pt>
                <c:pt idx="30">
                  <c:v>0</c:v>
                </c:pt>
                <c:pt idx="31">
                  <c:v>0</c:v>
                </c:pt>
                <c:pt idx="32">
                  <c:v>1216</c:v>
                </c:pt>
                <c:pt idx="33">
                  <c:v>1489</c:v>
                </c:pt>
                <c:pt idx="34">
                  <c:v>1190</c:v>
                </c:pt>
                <c:pt idx="35">
                  <c:v>1037</c:v>
                </c:pt>
                <c:pt idx="36">
                  <c:v>0</c:v>
                </c:pt>
                <c:pt idx="37">
                  <c:v>1599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1E29-3342-A2AA-0E5784E973CA}"/>
            </c:ext>
          </c:extLst>
        </c:ser>
        <c:ser>
          <c:idx val="50"/>
          <c:order val="50"/>
          <c:tx>
            <c:strRef>
              <c:f>Neat!$A$54</c:f>
              <c:strCache>
                <c:ptCount val="1"/>
                <c:pt idx="0">
                  <c:v>B73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4:$CA$54</c:f>
              <c:numCache>
                <c:formatCode>General</c:formatCode>
                <c:ptCount val="78"/>
                <c:pt idx="0">
                  <c:v>13526</c:v>
                </c:pt>
                <c:pt idx="1">
                  <c:v>13051</c:v>
                </c:pt>
                <c:pt idx="2">
                  <c:v>13111</c:v>
                </c:pt>
                <c:pt idx="3">
                  <c:v>11684</c:v>
                </c:pt>
                <c:pt idx="4">
                  <c:v>8778</c:v>
                </c:pt>
                <c:pt idx="5">
                  <c:v>5901</c:v>
                </c:pt>
                <c:pt idx="6">
                  <c:v>9751</c:v>
                </c:pt>
                <c:pt idx="7">
                  <c:v>10557</c:v>
                </c:pt>
                <c:pt idx="8">
                  <c:v>4788</c:v>
                </c:pt>
                <c:pt idx="9">
                  <c:v>9122</c:v>
                </c:pt>
                <c:pt idx="10">
                  <c:v>4786</c:v>
                </c:pt>
                <c:pt idx="11">
                  <c:v>5586</c:v>
                </c:pt>
                <c:pt idx="12">
                  <c:v>4624</c:v>
                </c:pt>
                <c:pt idx="13">
                  <c:v>3311</c:v>
                </c:pt>
                <c:pt idx="14">
                  <c:v>1943</c:v>
                </c:pt>
                <c:pt idx="15">
                  <c:v>0</c:v>
                </c:pt>
                <c:pt idx="16">
                  <c:v>1675</c:v>
                </c:pt>
                <c:pt idx="17">
                  <c:v>3100</c:v>
                </c:pt>
                <c:pt idx="18">
                  <c:v>2373</c:v>
                </c:pt>
                <c:pt idx="19">
                  <c:v>2982</c:v>
                </c:pt>
                <c:pt idx="20">
                  <c:v>3781</c:v>
                </c:pt>
                <c:pt idx="21">
                  <c:v>2781</c:v>
                </c:pt>
                <c:pt idx="22">
                  <c:v>0</c:v>
                </c:pt>
                <c:pt idx="23">
                  <c:v>2708</c:v>
                </c:pt>
                <c:pt idx="24">
                  <c:v>4034</c:v>
                </c:pt>
                <c:pt idx="25">
                  <c:v>6692</c:v>
                </c:pt>
                <c:pt idx="26">
                  <c:v>5421</c:v>
                </c:pt>
                <c:pt idx="27">
                  <c:v>5890</c:v>
                </c:pt>
                <c:pt idx="28">
                  <c:v>3565</c:v>
                </c:pt>
                <c:pt idx="29">
                  <c:v>2928</c:v>
                </c:pt>
                <c:pt idx="30">
                  <c:v>2768</c:v>
                </c:pt>
                <c:pt idx="31">
                  <c:v>2941</c:v>
                </c:pt>
                <c:pt idx="32">
                  <c:v>3760</c:v>
                </c:pt>
                <c:pt idx="33">
                  <c:v>4504</c:v>
                </c:pt>
                <c:pt idx="34">
                  <c:v>3813</c:v>
                </c:pt>
                <c:pt idx="35">
                  <c:v>3392</c:v>
                </c:pt>
                <c:pt idx="36">
                  <c:v>3690</c:v>
                </c:pt>
                <c:pt idx="37">
                  <c:v>6291</c:v>
                </c:pt>
                <c:pt idx="38">
                  <c:v>3220</c:v>
                </c:pt>
                <c:pt idx="39">
                  <c:v>3786</c:v>
                </c:pt>
                <c:pt idx="40">
                  <c:v>3441</c:v>
                </c:pt>
                <c:pt idx="41">
                  <c:v>3527</c:v>
                </c:pt>
                <c:pt idx="42">
                  <c:v>3022</c:v>
                </c:pt>
                <c:pt idx="43">
                  <c:v>3213</c:v>
                </c:pt>
                <c:pt idx="44">
                  <c:v>2940</c:v>
                </c:pt>
                <c:pt idx="45">
                  <c:v>2721</c:v>
                </c:pt>
                <c:pt idx="46">
                  <c:v>2141</c:v>
                </c:pt>
                <c:pt idx="47">
                  <c:v>1558</c:v>
                </c:pt>
                <c:pt idx="48">
                  <c:v>1646</c:v>
                </c:pt>
                <c:pt idx="49">
                  <c:v>1679</c:v>
                </c:pt>
                <c:pt idx="50">
                  <c:v>1440</c:v>
                </c:pt>
                <c:pt idx="51">
                  <c:v>1477</c:v>
                </c:pt>
                <c:pt idx="52">
                  <c:v>2186</c:v>
                </c:pt>
                <c:pt idx="53">
                  <c:v>3188</c:v>
                </c:pt>
                <c:pt idx="54">
                  <c:v>1732</c:v>
                </c:pt>
                <c:pt idx="55">
                  <c:v>1489</c:v>
                </c:pt>
                <c:pt idx="56">
                  <c:v>1605</c:v>
                </c:pt>
                <c:pt idx="57">
                  <c:v>1349</c:v>
                </c:pt>
                <c:pt idx="58">
                  <c:v>1211</c:v>
                </c:pt>
                <c:pt idx="59">
                  <c:v>1371</c:v>
                </c:pt>
                <c:pt idx="60">
                  <c:v>1461</c:v>
                </c:pt>
                <c:pt idx="61">
                  <c:v>1481</c:v>
                </c:pt>
                <c:pt idx="62">
                  <c:v>2009</c:v>
                </c:pt>
                <c:pt idx="63">
                  <c:v>2168</c:v>
                </c:pt>
                <c:pt idx="64">
                  <c:v>1699</c:v>
                </c:pt>
                <c:pt idx="65">
                  <c:v>1865</c:v>
                </c:pt>
                <c:pt idx="66">
                  <c:v>1934</c:v>
                </c:pt>
                <c:pt idx="67">
                  <c:v>1722</c:v>
                </c:pt>
                <c:pt idx="68">
                  <c:v>1897</c:v>
                </c:pt>
                <c:pt idx="69">
                  <c:v>1914</c:v>
                </c:pt>
                <c:pt idx="70">
                  <c:v>1810</c:v>
                </c:pt>
                <c:pt idx="71">
                  <c:v>1512</c:v>
                </c:pt>
                <c:pt idx="72">
                  <c:v>1702</c:v>
                </c:pt>
                <c:pt idx="73">
                  <c:v>1306</c:v>
                </c:pt>
                <c:pt idx="74">
                  <c:v>1635</c:v>
                </c:pt>
                <c:pt idx="75">
                  <c:v>1573</c:v>
                </c:pt>
                <c:pt idx="76">
                  <c:v>1598</c:v>
                </c:pt>
                <c:pt idx="77">
                  <c:v>11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1E29-3342-A2AA-0E5784E973CA}"/>
            </c:ext>
          </c:extLst>
        </c:ser>
        <c:ser>
          <c:idx val="51"/>
          <c:order val="51"/>
          <c:tx>
            <c:strRef>
              <c:f>Neat!$A$55</c:f>
              <c:strCache>
                <c:ptCount val="1"/>
                <c:pt idx="0">
                  <c:v>B75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  <a:lumOff val="50000"/>
                </a:schemeClr>
              </a:solidFill>
              <a:ln w="9525">
                <a:solidFill>
                  <a:schemeClr val="accent4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5:$CA$55</c:f>
              <c:numCache>
                <c:formatCode>General</c:formatCode>
                <c:ptCount val="78"/>
                <c:pt idx="0">
                  <c:v>13928</c:v>
                </c:pt>
                <c:pt idx="1">
                  <c:v>15440</c:v>
                </c:pt>
                <c:pt idx="2">
                  <c:v>16017</c:v>
                </c:pt>
                <c:pt idx="3">
                  <c:v>15131</c:v>
                </c:pt>
                <c:pt idx="4">
                  <c:v>12306</c:v>
                </c:pt>
                <c:pt idx="5">
                  <c:v>8794</c:v>
                </c:pt>
                <c:pt idx="6">
                  <c:v>12667</c:v>
                </c:pt>
                <c:pt idx="7">
                  <c:v>13473</c:v>
                </c:pt>
                <c:pt idx="8">
                  <c:v>7232</c:v>
                </c:pt>
                <c:pt idx="9">
                  <c:v>12185</c:v>
                </c:pt>
                <c:pt idx="10">
                  <c:v>6860</c:v>
                </c:pt>
                <c:pt idx="11">
                  <c:v>7671</c:v>
                </c:pt>
                <c:pt idx="12">
                  <c:v>6165</c:v>
                </c:pt>
                <c:pt idx="13">
                  <c:v>4010</c:v>
                </c:pt>
                <c:pt idx="14">
                  <c:v>2594</c:v>
                </c:pt>
                <c:pt idx="15">
                  <c:v>0</c:v>
                </c:pt>
                <c:pt idx="16">
                  <c:v>1335</c:v>
                </c:pt>
                <c:pt idx="17">
                  <c:v>1619</c:v>
                </c:pt>
                <c:pt idx="18">
                  <c:v>1374</c:v>
                </c:pt>
                <c:pt idx="19">
                  <c:v>1411</c:v>
                </c:pt>
                <c:pt idx="20">
                  <c:v>2054</c:v>
                </c:pt>
                <c:pt idx="21">
                  <c:v>1945</c:v>
                </c:pt>
                <c:pt idx="22">
                  <c:v>1321</c:v>
                </c:pt>
                <c:pt idx="23">
                  <c:v>2501</c:v>
                </c:pt>
                <c:pt idx="24">
                  <c:v>3698</c:v>
                </c:pt>
                <c:pt idx="25">
                  <c:v>5825</c:v>
                </c:pt>
                <c:pt idx="26">
                  <c:v>5372</c:v>
                </c:pt>
                <c:pt idx="27">
                  <c:v>6319</c:v>
                </c:pt>
                <c:pt idx="28">
                  <c:v>3646</c:v>
                </c:pt>
                <c:pt idx="29">
                  <c:v>2896</c:v>
                </c:pt>
                <c:pt idx="30">
                  <c:v>2761</c:v>
                </c:pt>
                <c:pt idx="31">
                  <c:v>3112</c:v>
                </c:pt>
                <c:pt idx="32">
                  <c:v>3786</c:v>
                </c:pt>
                <c:pt idx="33">
                  <c:v>4925</c:v>
                </c:pt>
                <c:pt idx="34">
                  <c:v>3655</c:v>
                </c:pt>
                <c:pt idx="35">
                  <c:v>3788</c:v>
                </c:pt>
                <c:pt idx="36">
                  <c:v>3792</c:v>
                </c:pt>
                <c:pt idx="37">
                  <c:v>6258</c:v>
                </c:pt>
                <c:pt idx="38">
                  <c:v>3428</c:v>
                </c:pt>
                <c:pt idx="39">
                  <c:v>4081</c:v>
                </c:pt>
                <c:pt idx="40">
                  <c:v>3441</c:v>
                </c:pt>
                <c:pt idx="41">
                  <c:v>3439</c:v>
                </c:pt>
                <c:pt idx="42">
                  <c:v>2916</c:v>
                </c:pt>
                <c:pt idx="43">
                  <c:v>3077</c:v>
                </c:pt>
                <c:pt idx="44">
                  <c:v>2954</c:v>
                </c:pt>
                <c:pt idx="45">
                  <c:v>2804</c:v>
                </c:pt>
                <c:pt idx="46">
                  <c:v>1687</c:v>
                </c:pt>
                <c:pt idx="47">
                  <c:v>1427</c:v>
                </c:pt>
                <c:pt idx="48">
                  <c:v>1540</c:v>
                </c:pt>
                <c:pt idx="49">
                  <c:v>1655</c:v>
                </c:pt>
                <c:pt idx="50">
                  <c:v>1257</c:v>
                </c:pt>
                <c:pt idx="51">
                  <c:v>1099</c:v>
                </c:pt>
                <c:pt idx="52">
                  <c:v>1539</c:v>
                </c:pt>
                <c:pt idx="53">
                  <c:v>1866</c:v>
                </c:pt>
                <c:pt idx="54">
                  <c:v>1211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1348</c:v>
                </c:pt>
                <c:pt idx="64">
                  <c:v>1115</c:v>
                </c:pt>
                <c:pt idx="65">
                  <c:v>1196</c:v>
                </c:pt>
                <c:pt idx="66">
                  <c:v>1130</c:v>
                </c:pt>
                <c:pt idx="67">
                  <c:v>1105</c:v>
                </c:pt>
                <c:pt idx="68">
                  <c:v>1239</c:v>
                </c:pt>
                <c:pt idx="69">
                  <c:v>1141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3-1E29-3342-A2AA-0E5784E973CA}"/>
            </c:ext>
          </c:extLst>
        </c:ser>
        <c:ser>
          <c:idx val="52"/>
          <c:order val="52"/>
          <c:tx>
            <c:strRef>
              <c:f>Neat!$A$56</c:f>
              <c:strCache>
                <c:ptCount val="1"/>
                <c:pt idx="0">
                  <c:v>B76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  <a:lumOff val="50000"/>
                </a:schemeClr>
              </a:solidFill>
              <a:ln w="9525">
                <a:solidFill>
                  <a:schemeClr val="accent5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6:$CA$56</c:f>
              <c:numCache>
                <c:formatCode>General</c:formatCode>
                <c:ptCount val="78"/>
                <c:pt idx="0">
                  <c:v>8256</c:v>
                </c:pt>
                <c:pt idx="1">
                  <c:v>17739</c:v>
                </c:pt>
                <c:pt idx="2">
                  <c:v>14792</c:v>
                </c:pt>
                <c:pt idx="3">
                  <c:v>10063</c:v>
                </c:pt>
                <c:pt idx="4">
                  <c:v>19301</c:v>
                </c:pt>
                <c:pt idx="5">
                  <c:v>21674</c:v>
                </c:pt>
                <c:pt idx="6">
                  <c:v>17188</c:v>
                </c:pt>
                <c:pt idx="7">
                  <c:v>20605</c:v>
                </c:pt>
                <c:pt idx="8">
                  <c:v>21894</c:v>
                </c:pt>
                <c:pt idx="9">
                  <c:v>14411</c:v>
                </c:pt>
                <c:pt idx="10">
                  <c:v>19606</c:v>
                </c:pt>
                <c:pt idx="11">
                  <c:v>17263</c:v>
                </c:pt>
                <c:pt idx="12">
                  <c:v>17043</c:v>
                </c:pt>
                <c:pt idx="13">
                  <c:v>19229</c:v>
                </c:pt>
                <c:pt idx="14">
                  <c:v>23873</c:v>
                </c:pt>
                <c:pt idx="15">
                  <c:v>13782</c:v>
                </c:pt>
                <c:pt idx="16">
                  <c:v>18551</c:v>
                </c:pt>
                <c:pt idx="17">
                  <c:v>20294</c:v>
                </c:pt>
                <c:pt idx="18">
                  <c:v>17638</c:v>
                </c:pt>
                <c:pt idx="19">
                  <c:v>19725</c:v>
                </c:pt>
                <c:pt idx="20">
                  <c:v>21367</c:v>
                </c:pt>
                <c:pt idx="21">
                  <c:v>20511</c:v>
                </c:pt>
                <c:pt idx="22">
                  <c:v>10736</c:v>
                </c:pt>
                <c:pt idx="23">
                  <c:v>16398</c:v>
                </c:pt>
                <c:pt idx="24">
                  <c:v>19174</c:v>
                </c:pt>
                <c:pt idx="25">
                  <c:v>22256</c:v>
                </c:pt>
                <c:pt idx="26">
                  <c:v>25167</c:v>
                </c:pt>
                <c:pt idx="27">
                  <c:v>22300</c:v>
                </c:pt>
                <c:pt idx="28">
                  <c:v>20673</c:v>
                </c:pt>
                <c:pt idx="29">
                  <c:v>12957</c:v>
                </c:pt>
                <c:pt idx="30">
                  <c:v>16094</c:v>
                </c:pt>
                <c:pt idx="31">
                  <c:v>17097</c:v>
                </c:pt>
                <c:pt idx="32">
                  <c:v>20970</c:v>
                </c:pt>
                <c:pt idx="33">
                  <c:v>22235</c:v>
                </c:pt>
                <c:pt idx="34">
                  <c:v>21047</c:v>
                </c:pt>
                <c:pt idx="35">
                  <c:v>22440</c:v>
                </c:pt>
                <c:pt idx="36">
                  <c:v>22022</c:v>
                </c:pt>
                <c:pt idx="37">
                  <c:v>23342</c:v>
                </c:pt>
                <c:pt idx="38">
                  <c:v>21701</c:v>
                </c:pt>
                <c:pt idx="39">
                  <c:v>21897</c:v>
                </c:pt>
                <c:pt idx="40">
                  <c:v>21771</c:v>
                </c:pt>
                <c:pt idx="41">
                  <c:v>22322</c:v>
                </c:pt>
                <c:pt idx="42">
                  <c:v>19869</c:v>
                </c:pt>
                <c:pt idx="43">
                  <c:v>20712</c:v>
                </c:pt>
                <c:pt idx="44">
                  <c:v>19770</c:v>
                </c:pt>
                <c:pt idx="45">
                  <c:v>20537</c:v>
                </c:pt>
                <c:pt idx="46">
                  <c:v>19075</c:v>
                </c:pt>
                <c:pt idx="47">
                  <c:v>16678</c:v>
                </c:pt>
                <c:pt idx="48">
                  <c:v>19324</c:v>
                </c:pt>
                <c:pt idx="49">
                  <c:v>20109</c:v>
                </c:pt>
                <c:pt idx="50">
                  <c:v>17311</c:v>
                </c:pt>
                <c:pt idx="51">
                  <c:v>19758</c:v>
                </c:pt>
                <c:pt idx="52">
                  <c:v>19105</c:v>
                </c:pt>
                <c:pt idx="53">
                  <c:v>19720</c:v>
                </c:pt>
                <c:pt idx="54">
                  <c:v>13847</c:v>
                </c:pt>
                <c:pt idx="55">
                  <c:v>17817</c:v>
                </c:pt>
                <c:pt idx="56">
                  <c:v>19914</c:v>
                </c:pt>
                <c:pt idx="57">
                  <c:v>18129</c:v>
                </c:pt>
                <c:pt idx="58">
                  <c:v>19086</c:v>
                </c:pt>
                <c:pt idx="59">
                  <c:v>19746</c:v>
                </c:pt>
                <c:pt idx="60">
                  <c:v>19951</c:v>
                </c:pt>
                <c:pt idx="61">
                  <c:v>22996</c:v>
                </c:pt>
                <c:pt idx="62">
                  <c:v>23848</c:v>
                </c:pt>
                <c:pt idx="63">
                  <c:v>24432</c:v>
                </c:pt>
                <c:pt idx="64">
                  <c:v>23558</c:v>
                </c:pt>
                <c:pt idx="65">
                  <c:v>23990</c:v>
                </c:pt>
                <c:pt idx="66">
                  <c:v>22122</c:v>
                </c:pt>
                <c:pt idx="67">
                  <c:v>24042</c:v>
                </c:pt>
                <c:pt idx="68">
                  <c:v>24731</c:v>
                </c:pt>
                <c:pt idx="69">
                  <c:v>23035</c:v>
                </c:pt>
                <c:pt idx="70">
                  <c:v>19012</c:v>
                </c:pt>
                <c:pt idx="71">
                  <c:v>25274</c:v>
                </c:pt>
                <c:pt idx="72">
                  <c:v>25472</c:v>
                </c:pt>
                <c:pt idx="73">
                  <c:v>23543</c:v>
                </c:pt>
                <c:pt idx="74">
                  <c:v>24148</c:v>
                </c:pt>
                <c:pt idx="75">
                  <c:v>25473</c:v>
                </c:pt>
                <c:pt idx="76">
                  <c:v>25093</c:v>
                </c:pt>
                <c:pt idx="77">
                  <c:v>195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4-1E29-3342-A2AA-0E5784E973CA}"/>
            </c:ext>
          </c:extLst>
        </c:ser>
        <c:ser>
          <c:idx val="53"/>
          <c:order val="53"/>
          <c:tx>
            <c:strRef>
              <c:f>Neat!$A$57</c:f>
              <c:strCache>
                <c:ptCount val="1"/>
                <c:pt idx="0">
                  <c:v>B77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  <a:lumOff val="50000"/>
                </a:schemeClr>
              </a:solidFill>
              <a:ln w="9525">
                <a:solidFill>
                  <a:schemeClr val="accent6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7:$CA$57</c:f>
              <c:numCache>
                <c:formatCode>General</c:formatCode>
                <c:ptCount val="78"/>
                <c:pt idx="0">
                  <c:v>11833</c:v>
                </c:pt>
                <c:pt idx="1">
                  <c:v>12684</c:v>
                </c:pt>
                <c:pt idx="2">
                  <c:v>13710</c:v>
                </c:pt>
                <c:pt idx="3">
                  <c:v>12752</c:v>
                </c:pt>
                <c:pt idx="4">
                  <c:v>10105</c:v>
                </c:pt>
                <c:pt idx="5">
                  <c:v>7013</c:v>
                </c:pt>
                <c:pt idx="6">
                  <c:v>10020</c:v>
                </c:pt>
                <c:pt idx="7">
                  <c:v>10640</c:v>
                </c:pt>
                <c:pt idx="8">
                  <c:v>5380</c:v>
                </c:pt>
                <c:pt idx="9">
                  <c:v>9356</c:v>
                </c:pt>
                <c:pt idx="10">
                  <c:v>4875</c:v>
                </c:pt>
                <c:pt idx="11">
                  <c:v>5647</c:v>
                </c:pt>
                <c:pt idx="12">
                  <c:v>3796</c:v>
                </c:pt>
                <c:pt idx="13">
                  <c:v>2165</c:v>
                </c:pt>
                <c:pt idx="14">
                  <c:v>1234</c:v>
                </c:pt>
                <c:pt idx="15">
                  <c:v>0</c:v>
                </c:pt>
                <c:pt idx="16">
                  <c:v>0</c:v>
                </c:pt>
                <c:pt idx="17">
                  <c:v>1369</c:v>
                </c:pt>
                <c:pt idx="18">
                  <c:v>0</c:v>
                </c:pt>
                <c:pt idx="19">
                  <c:v>0</c:v>
                </c:pt>
                <c:pt idx="20">
                  <c:v>1894</c:v>
                </c:pt>
                <c:pt idx="21">
                  <c:v>1774</c:v>
                </c:pt>
                <c:pt idx="22">
                  <c:v>0</c:v>
                </c:pt>
                <c:pt idx="23">
                  <c:v>1882</c:v>
                </c:pt>
                <c:pt idx="24">
                  <c:v>2786</c:v>
                </c:pt>
                <c:pt idx="25">
                  <c:v>4325</c:v>
                </c:pt>
                <c:pt idx="26">
                  <c:v>4488</c:v>
                </c:pt>
                <c:pt idx="27">
                  <c:v>5411</c:v>
                </c:pt>
                <c:pt idx="28">
                  <c:v>2994</c:v>
                </c:pt>
                <c:pt idx="29">
                  <c:v>1844</c:v>
                </c:pt>
                <c:pt idx="30">
                  <c:v>2083</c:v>
                </c:pt>
                <c:pt idx="31">
                  <c:v>2416</c:v>
                </c:pt>
                <c:pt idx="32">
                  <c:v>3254</c:v>
                </c:pt>
                <c:pt idx="33">
                  <c:v>4028</c:v>
                </c:pt>
                <c:pt idx="34">
                  <c:v>3021</c:v>
                </c:pt>
                <c:pt idx="35">
                  <c:v>3258</c:v>
                </c:pt>
                <c:pt idx="36">
                  <c:v>3170</c:v>
                </c:pt>
                <c:pt idx="37">
                  <c:v>5276</c:v>
                </c:pt>
                <c:pt idx="38">
                  <c:v>2935</c:v>
                </c:pt>
                <c:pt idx="39">
                  <c:v>3414</c:v>
                </c:pt>
                <c:pt idx="40">
                  <c:v>2842</c:v>
                </c:pt>
                <c:pt idx="41">
                  <c:v>2851</c:v>
                </c:pt>
                <c:pt idx="42">
                  <c:v>2373</c:v>
                </c:pt>
                <c:pt idx="43">
                  <c:v>2673</c:v>
                </c:pt>
                <c:pt idx="44">
                  <c:v>2516</c:v>
                </c:pt>
                <c:pt idx="45">
                  <c:v>2391</c:v>
                </c:pt>
                <c:pt idx="46">
                  <c:v>1264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155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5-1E29-3342-A2AA-0E5784E973CA}"/>
            </c:ext>
          </c:extLst>
        </c:ser>
        <c:ser>
          <c:idx val="54"/>
          <c:order val="54"/>
          <c:tx>
            <c:strRef>
              <c:f>Neat!$A$58</c:f>
              <c:strCache>
                <c:ptCount val="1"/>
                <c:pt idx="0">
                  <c:v>B7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8:$CA$58</c:f>
              <c:numCache>
                <c:formatCode>General</c:formatCode>
                <c:ptCount val="78"/>
                <c:pt idx="0">
                  <c:v>11701</c:v>
                </c:pt>
                <c:pt idx="1">
                  <c:v>9383</c:v>
                </c:pt>
                <c:pt idx="2">
                  <c:v>9722</c:v>
                </c:pt>
                <c:pt idx="3">
                  <c:v>8711</c:v>
                </c:pt>
                <c:pt idx="4">
                  <c:v>6602</c:v>
                </c:pt>
                <c:pt idx="5">
                  <c:v>4288</c:v>
                </c:pt>
                <c:pt idx="6">
                  <c:v>7233</c:v>
                </c:pt>
                <c:pt idx="7">
                  <c:v>8124</c:v>
                </c:pt>
                <c:pt idx="8">
                  <c:v>3550</c:v>
                </c:pt>
                <c:pt idx="9">
                  <c:v>7158</c:v>
                </c:pt>
                <c:pt idx="10">
                  <c:v>3430</c:v>
                </c:pt>
                <c:pt idx="11">
                  <c:v>3905</c:v>
                </c:pt>
                <c:pt idx="12">
                  <c:v>3394</c:v>
                </c:pt>
                <c:pt idx="13">
                  <c:v>2368</c:v>
                </c:pt>
                <c:pt idx="14">
                  <c:v>145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582</c:v>
                </c:pt>
                <c:pt idx="24">
                  <c:v>2368</c:v>
                </c:pt>
                <c:pt idx="25">
                  <c:v>3928</c:v>
                </c:pt>
                <c:pt idx="26">
                  <c:v>3020</c:v>
                </c:pt>
                <c:pt idx="27">
                  <c:v>3479</c:v>
                </c:pt>
                <c:pt idx="28">
                  <c:v>2010</c:v>
                </c:pt>
                <c:pt idx="29">
                  <c:v>1943</c:v>
                </c:pt>
                <c:pt idx="30">
                  <c:v>0</c:v>
                </c:pt>
                <c:pt idx="31">
                  <c:v>0</c:v>
                </c:pt>
                <c:pt idx="32">
                  <c:v>1417</c:v>
                </c:pt>
                <c:pt idx="33">
                  <c:v>1773</c:v>
                </c:pt>
                <c:pt idx="34">
                  <c:v>1315</c:v>
                </c:pt>
                <c:pt idx="35">
                  <c:v>1186</c:v>
                </c:pt>
                <c:pt idx="36">
                  <c:v>0</c:v>
                </c:pt>
                <c:pt idx="37">
                  <c:v>1818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6-1E29-3342-A2AA-0E5784E973CA}"/>
            </c:ext>
          </c:extLst>
        </c:ser>
        <c:ser>
          <c:idx val="55"/>
          <c:order val="55"/>
          <c:tx>
            <c:strRef>
              <c:f>Neat!$A$59</c:f>
              <c:strCache>
                <c:ptCount val="1"/>
                <c:pt idx="0">
                  <c:v>B8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59:$CA$59</c:f>
              <c:numCache>
                <c:formatCode>General</c:formatCode>
                <c:ptCount val="78"/>
                <c:pt idx="0">
                  <c:v>14822</c:v>
                </c:pt>
                <c:pt idx="1">
                  <c:v>18790</c:v>
                </c:pt>
                <c:pt idx="2">
                  <c:v>19642</c:v>
                </c:pt>
                <c:pt idx="3">
                  <c:v>17759</c:v>
                </c:pt>
                <c:pt idx="4">
                  <c:v>14935</c:v>
                </c:pt>
                <c:pt idx="5">
                  <c:v>11224</c:v>
                </c:pt>
                <c:pt idx="6">
                  <c:v>15568</c:v>
                </c:pt>
                <c:pt idx="7">
                  <c:v>16441</c:v>
                </c:pt>
                <c:pt idx="8">
                  <c:v>9422</c:v>
                </c:pt>
                <c:pt idx="9">
                  <c:v>14822</c:v>
                </c:pt>
                <c:pt idx="10">
                  <c:v>9217</c:v>
                </c:pt>
                <c:pt idx="11">
                  <c:v>9951</c:v>
                </c:pt>
                <c:pt idx="12">
                  <c:v>9168</c:v>
                </c:pt>
                <c:pt idx="13">
                  <c:v>6637</c:v>
                </c:pt>
                <c:pt idx="14">
                  <c:v>4528</c:v>
                </c:pt>
                <c:pt idx="15">
                  <c:v>1921</c:v>
                </c:pt>
                <c:pt idx="16">
                  <c:v>3188</c:v>
                </c:pt>
                <c:pt idx="17">
                  <c:v>2583</c:v>
                </c:pt>
                <c:pt idx="18">
                  <c:v>1912</c:v>
                </c:pt>
                <c:pt idx="19">
                  <c:v>2597</c:v>
                </c:pt>
                <c:pt idx="20">
                  <c:v>3477</c:v>
                </c:pt>
                <c:pt idx="21">
                  <c:v>3331</c:v>
                </c:pt>
                <c:pt idx="22">
                  <c:v>2502</c:v>
                </c:pt>
                <c:pt idx="23">
                  <c:v>5609</c:v>
                </c:pt>
                <c:pt idx="24">
                  <c:v>9236</c:v>
                </c:pt>
                <c:pt idx="25">
                  <c:v>13069</c:v>
                </c:pt>
                <c:pt idx="26">
                  <c:v>13999</c:v>
                </c:pt>
                <c:pt idx="27">
                  <c:v>15348</c:v>
                </c:pt>
                <c:pt idx="28">
                  <c:v>10839</c:v>
                </c:pt>
                <c:pt idx="29">
                  <c:v>8638</c:v>
                </c:pt>
                <c:pt idx="30">
                  <c:v>7879</c:v>
                </c:pt>
                <c:pt idx="31">
                  <c:v>7746</c:v>
                </c:pt>
                <c:pt idx="32">
                  <c:v>9186</c:v>
                </c:pt>
                <c:pt idx="33">
                  <c:v>11128</c:v>
                </c:pt>
                <c:pt idx="34">
                  <c:v>9407</c:v>
                </c:pt>
                <c:pt idx="35">
                  <c:v>9236</c:v>
                </c:pt>
                <c:pt idx="36">
                  <c:v>9286</c:v>
                </c:pt>
                <c:pt idx="37">
                  <c:v>13479</c:v>
                </c:pt>
                <c:pt idx="38">
                  <c:v>8318</c:v>
                </c:pt>
                <c:pt idx="39">
                  <c:v>9338</c:v>
                </c:pt>
                <c:pt idx="40">
                  <c:v>7944</c:v>
                </c:pt>
                <c:pt idx="41">
                  <c:v>8199</c:v>
                </c:pt>
                <c:pt idx="42">
                  <c:v>7060</c:v>
                </c:pt>
                <c:pt idx="43">
                  <c:v>7459</c:v>
                </c:pt>
                <c:pt idx="44">
                  <c:v>7544</c:v>
                </c:pt>
                <c:pt idx="45">
                  <c:v>6927</c:v>
                </c:pt>
                <c:pt idx="46">
                  <c:v>4980</c:v>
                </c:pt>
                <c:pt idx="47">
                  <c:v>3623</c:v>
                </c:pt>
                <c:pt idx="48">
                  <c:v>3945</c:v>
                </c:pt>
                <c:pt idx="49">
                  <c:v>4101</c:v>
                </c:pt>
                <c:pt idx="50">
                  <c:v>3386</c:v>
                </c:pt>
                <c:pt idx="51">
                  <c:v>3683</c:v>
                </c:pt>
                <c:pt idx="52">
                  <c:v>4852</c:v>
                </c:pt>
                <c:pt idx="53">
                  <c:v>6724</c:v>
                </c:pt>
                <c:pt idx="54">
                  <c:v>3343</c:v>
                </c:pt>
                <c:pt idx="55">
                  <c:v>3333</c:v>
                </c:pt>
                <c:pt idx="56">
                  <c:v>3400</c:v>
                </c:pt>
                <c:pt idx="57">
                  <c:v>2859</c:v>
                </c:pt>
                <c:pt idx="58">
                  <c:v>2944</c:v>
                </c:pt>
                <c:pt idx="59">
                  <c:v>3133</c:v>
                </c:pt>
                <c:pt idx="60">
                  <c:v>3421</c:v>
                </c:pt>
                <c:pt idx="61">
                  <c:v>3999</c:v>
                </c:pt>
                <c:pt idx="62">
                  <c:v>4754</c:v>
                </c:pt>
                <c:pt idx="63">
                  <c:v>5018</c:v>
                </c:pt>
                <c:pt idx="64">
                  <c:v>3916</c:v>
                </c:pt>
                <c:pt idx="65">
                  <c:v>4335</c:v>
                </c:pt>
                <c:pt idx="66">
                  <c:v>4231</c:v>
                </c:pt>
                <c:pt idx="67">
                  <c:v>4432</c:v>
                </c:pt>
                <c:pt idx="68">
                  <c:v>5081</c:v>
                </c:pt>
                <c:pt idx="69">
                  <c:v>4880</c:v>
                </c:pt>
                <c:pt idx="70">
                  <c:v>4128</c:v>
                </c:pt>
                <c:pt idx="71">
                  <c:v>3903</c:v>
                </c:pt>
                <c:pt idx="72">
                  <c:v>4160</c:v>
                </c:pt>
                <c:pt idx="73">
                  <c:v>3480</c:v>
                </c:pt>
                <c:pt idx="74">
                  <c:v>3788</c:v>
                </c:pt>
                <c:pt idx="75">
                  <c:v>3837</c:v>
                </c:pt>
                <c:pt idx="76">
                  <c:v>3876</c:v>
                </c:pt>
                <c:pt idx="77">
                  <c:v>26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7-1E29-3342-A2AA-0E5784E973CA}"/>
            </c:ext>
          </c:extLst>
        </c:ser>
        <c:ser>
          <c:idx val="56"/>
          <c:order val="56"/>
          <c:tx>
            <c:strRef>
              <c:f>Neat!$A$60</c:f>
              <c:strCache>
                <c:ptCount val="1"/>
                <c:pt idx="0">
                  <c:v>B8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0:$CA$60</c:f>
              <c:numCache>
                <c:formatCode>General</c:formatCode>
                <c:ptCount val="78"/>
                <c:pt idx="0">
                  <c:v>13510</c:v>
                </c:pt>
                <c:pt idx="1">
                  <c:v>14873</c:v>
                </c:pt>
                <c:pt idx="2">
                  <c:v>15912</c:v>
                </c:pt>
                <c:pt idx="3">
                  <c:v>15839</c:v>
                </c:pt>
                <c:pt idx="4">
                  <c:v>13199</c:v>
                </c:pt>
                <c:pt idx="5">
                  <c:v>9399</c:v>
                </c:pt>
                <c:pt idx="6">
                  <c:v>13572</c:v>
                </c:pt>
                <c:pt idx="7">
                  <c:v>14228</c:v>
                </c:pt>
                <c:pt idx="8">
                  <c:v>8444</c:v>
                </c:pt>
                <c:pt idx="9">
                  <c:v>13844</c:v>
                </c:pt>
                <c:pt idx="10">
                  <c:v>7945</c:v>
                </c:pt>
                <c:pt idx="11">
                  <c:v>8722</c:v>
                </c:pt>
                <c:pt idx="12">
                  <c:v>8312</c:v>
                </c:pt>
                <c:pt idx="13">
                  <c:v>5951</c:v>
                </c:pt>
                <c:pt idx="14">
                  <c:v>3999</c:v>
                </c:pt>
                <c:pt idx="15">
                  <c:v>0</c:v>
                </c:pt>
                <c:pt idx="16">
                  <c:v>2026</c:v>
                </c:pt>
                <c:pt idx="17">
                  <c:v>4040</c:v>
                </c:pt>
                <c:pt idx="18">
                  <c:v>3184</c:v>
                </c:pt>
                <c:pt idx="19">
                  <c:v>3917</c:v>
                </c:pt>
                <c:pt idx="20">
                  <c:v>5370</c:v>
                </c:pt>
                <c:pt idx="21">
                  <c:v>4553</c:v>
                </c:pt>
                <c:pt idx="22">
                  <c:v>2578</c:v>
                </c:pt>
                <c:pt idx="23">
                  <c:v>7105</c:v>
                </c:pt>
                <c:pt idx="24">
                  <c:v>10162</c:v>
                </c:pt>
                <c:pt idx="25">
                  <c:v>13358</c:v>
                </c:pt>
                <c:pt idx="26">
                  <c:v>14024</c:v>
                </c:pt>
                <c:pt idx="27">
                  <c:v>15086</c:v>
                </c:pt>
                <c:pt idx="28">
                  <c:v>11290</c:v>
                </c:pt>
                <c:pt idx="29">
                  <c:v>9446</c:v>
                </c:pt>
                <c:pt idx="30">
                  <c:v>10545</c:v>
                </c:pt>
                <c:pt idx="31">
                  <c:v>10988</c:v>
                </c:pt>
                <c:pt idx="32">
                  <c:v>13841</c:v>
                </c:pt>
                <c:pt idx="33">
                  <c:v>15955</c:v>
                </c:pt>
                <c:pt idx="34">
                  <c:v>13826</c:v>
                </c:pt>
                <c:pt idx="35">
                  <c:v>13455</c:v>
                </c:pt>
                <c:pt idx="36">
                  <c:v>14014</c:v>
                </c:pt>
                <c:pt idx="37">
                  <c:v>19261</c:v>
                </c:pt>
                <c:pt idx="38">
                  <c:v>13190</c:v>
                </c:pt>
                <c:pt idx="39">
                  <c:v>14649</c:v>
                </c:pt>
                <c:pt idx="40">
                  <c:v>12832</c:v>
                </c:pt>
                <c:pt idx="41">
                  <c:v>12371</c:v>
                </c:pt>
                <c:pt idx="42">
                  <c:v>11443</c:v>
                </c:pt>
                <c:pt idx="43">
                  <c:v>12566</c:v>
                </c:pt>
                <c:pt idx="44">
                  <c:v>12974</c:v>
                </c:pt>
                <c:pt idx="45">
                  <c:v>12836</c:v>
                </c:pt>
                <c:pt idx="46">
                  <c:v>8149</c:v>
                </c:pt>
                <c:pt idx="47">
                  <c:v>6327</c:v>
                </c:pt>
                <c:pt idx="48">
                  <c:v>6663</c:v>
                </c:pt>
                <c:pt idx="49">
                  <c:v>7519</c:v>
                </c:pt>
                <c:pt idx="50">
                  <c:v>6329</c:v>
                </c:pt>
                <c:pt idx="51">
                  <c:v>6780</c:v>
                </c:pt>
                <c:pt idx="52">
                  <c:v>7827</c:v>
                </c:pt>
                <c:pt idx="53">
                  <c:v>10662</c:v>
                </c:pt>
                <c:pt idx="54">
                  <c:v>5767</c:v>
                </c:pt>
                <c:pt idx="55">
                  <c:v>5557</c:v>
                </c:pt>
                <c:pt idx="56">
                  <c:v>5429</c:v>
                </c:pt>
                <c:pt idx="57">
                  <c:v>4435</c:v>
                </c:pt>
                <c:pt idx="58">
                  <c:v>4742</c:v>
                </c:pt>
                <c:pt idx="59">
                  <c:v>5129</c:v>
                </c:pt>
                <c:pt idx="60">
                  <c:v>5721</c:v>
                </c:pt>
                <c:pt idx="61">
                  <c:v>6404</c:v>
                </c:pt>
                <c:pt idx="62">
                  <c:v>7520</c:v>
                </c:pt>
                <c:pt idx="63">
                  <c:v>8038</c:v>
                </c:pt>
                <c:pt idx="64">
                  <c:v>6591</c:v>
                </c:pt>
                <c:pt idx="65">
                  <c:v>7005</c:v>
                </c:pt>
                <c:pt idx="66">
                  <c:v>6521</c:v>
                </c:pt>
                <c:pt idx="67">
                  <c:v>7515</c:v>
                </c:pt>
                <c:pt idx="68">
                  <c:v>8051</c:v>
                </c:pt>
                <c:pt idx="69">
                  <c:v>8320</c:v>
                </c:pt>
                <c:pt idx="70">
                  <c:v>6658</c:v>
                </c:pt>
                <c:pt idx="71">
                  <c:v>6838</c:v>
                </c:pt>
                <c:pt idx="72">
                  <c:v>6777</c:v>
                </c:pt>
                <c:pt idx="73">
                  <c:v>5651</c:v>
                </c:pt>
                <c:pt idx="74">
                  <c:v>6525</c:v>
                </c:pt>
                <c:pt idx="75">
                  <c:v>6542</c:v>
                </c:pt>
                <c:pt idx="76">
                  <c:v>6329</c:v>
                </c:pt>
                <c:pt idx="77">
                  <c:v>37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8-1E29-3342-A2AA-0E5784E973CA}"/>
            </c:ext>
          </c:extLst>
        </c:ser>
        <c:ser>
          <c:idx val="57"/>
          <c:order val="57"/>
          <c:tx>
            <c:strRef>
              <c:f>Neat!$A$61</c:f>
              <c:strCache>
                <c:ptCount val="1"/>
                <c:pt idx="0">
                  <c:v>B82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1:$CA$61</c:f>
              <c:numCache>
                <c:formatCode>General</c:formatCode>
                <c:ptCount val="78"/>
                <c:pt idx="0">
                  <c:v>11049</c:v>
                </c:pt>
                <c:pt idx="1">
                  <c:v>11958</c:v>
                </c:pt>
                <c:pt idx="2">
                  <c:v>12274</c:v>
                </c:pt>
                <c:pt idx="3">
                  <c:v>12502</c:v>
                </c:pt>
                <c:pt idx="4">
                  <c:v>11206</c:v>
                </c:pt>
                <c:pt idx="5">
                  <c:v>8611</c:v>
                </c:pt>
                <c:pt idx="6">
                  <c:v>12407</c:v>
                </c:pt>
                <c:pt idx="7">
                  <c:v>12972</c:v>
                </c:pt>
                <c:pt idx="8">
                  <c:v>7688</c:v>
                </c:pt>
                <c:pt idx="9">
                  <c:v>12523</c:v>
                </c:pt>
                <c:pt idx="10">
                  <c:v>8155</c:v>
                </c:pt>
                <c:pt idx="11">
                  <c:v>8400</c:v>
                </c:pt>
                <c:pt idx="12">
                  <c:v>7908</c:v>
                </c:pt>
                <c:pt idx="13">
                  <c:v>6447</c:v>
                </c:pt>
                <c:pt idx="14">
                  <c:v>4905</c:v>
                </c:pt>
                <c:pt idx="15">
                  <c:v>1804</c:v>
                </c:pt>
                <c:pt idx="16">
                  <c:v>2414</c:v>
                </c:pt>
                <c:pt idx="17">
                  <c:v>2503</c:v>
                </c:pt>
                <c:pt idx="18">
                  <c:v>2371</c:v>
                </c:pt>
                <c:pt idx="19">
                  <c:v>2896</c:v>
                </c:pt>
                <c:pt idx="20">
                  <c:v>3893</c:v>
                </c:pt>
                <c:pt idx="21">
                  <c:v>3433</c:v>
                </c:pt>
                <c:pt idx="22">
                  <c:v>2079</c:v>
                </c:pt>
                <c:pt idx="23">
                  <c:v>3591</c:v>
                </c:pt>
                <c:pt idx="24">
                  <c:v>4537</c:v>
                </c:pt>
                <c:pt idx="25">
                  <c:v>6425</c:v>
                </c:pt>
                <c:pt idx="26">
                  <c:v>5543</c:v>
                </c:pt>
                <c:pt idx="27">
                  <c:v>5628</c:v>
                </c:pt>
                <c:pt idx="28">
                  <c:v>3787</c:v>
                </c:pt>
                <c:pt idx="29">
                  <c:v>3140</c:v>
                </c:pt>
                <c:pt idx="30">
                  <c:v>2425</c:v>
                </c:pt>
                <c:pt idx="31">
                  <c:v>2689</c:v>
                </c:pt>
                <c:pt idx="32">
                  <c:v>3471</c:v>
                </c:pt>
                <c:pt idx="33">
                  <c:v>4305</c:v>
                </c:pt>
                <c:pt idx="34">
                  <c:v>3080</c:v>
                </c:pt>
                <c:pt idx="35">
                  <c:v>3283</c:v>
                </c:pt>
                <c:pt idx="36">
                  <c:v>3199</c:v>
                </c:pt>
                <c:pt idx="37">
                  <c:v>5252</c:v>
                </c:pt>
                <c:pt idx="38">
                  <c:v>3085</c:v>
                </c:pt>
                <c:pt idx="39">
                  <c:v>3561</c:v>
                </c:pt>
                <c:pt idx="40">
                  <c:v>3704</c:v>
                </c:pt>
                <c:pt idx="41">
                  <c:v>4015</c:v>
                </c:pt>
                <c:pt idx="42">
                  <c:v>3213</c:v>
                </c:pt>
                <c:pt idx="43">
                  <c:v>3482</c:v>
                </c:pt>
                <c:pt idx="44">
                  <c:v>3356</c:v>
                </c:pt>
                <c:pt idx="45">
                  <c:v>3476</c:v>
                </c:pt>
                <c:pt idx="46">
                  <c:v>2920</c:v>
                </c:pt>
                <c:pt idx="47">
                  <c:v>2040</c:v>
                </c:pt>
                <c:pt idx="48">
                  <c:v>2527</c:v>
                </c:pt>
                <c:pt idx="49">
                  <c:v>2545</c:v>
                </c:pt>
                <c:pt idx="50">
                  <c:v>2194</c:v>
                </c:pt>
                <c:pt idx="51">
                  <c:v>2278</c:v>
                </c:pt>
                <c:pt idx="52">
                  <c:v>3241</c:v>
                </c:pt>
                <c:pt idx="53">
                  <c:v>3737</c:v>
                </c:pt>
                <c:pt idx="54">
                  <c:v>2645</c:v>
                </c:pt>
                <c:pt idx="55">
                  <c:v>2619</c:v>
                </c:pt>
                <c:pt idx="56">
                  <c:v>3152</c:v>
                </c:pt>
                <c:pt idx="57">
                  <c:v>2870</c:v>
                </c:pt>
                <c:pt idx="58">
                  <c:v>2327</c:v>
                </c:pt>
                <c:pt idx="59">
                  <c:v>2748</c:v>
                </c:pt>
                <c:pt idx="60">
                  <c:v>2710</c:v>
                </c:pt>
                <c:pt idx="61">
                  <c:v>2856</c:v>
                </c:pt>
                <c:pt idx="62">
                  <c:v>3872</c:v>
                </c:pt>
                <c:pt idx="63">
                  <c:v>3894</c:v>
                </c:pt>
                <c:pt idx="64">
                  <c:v>3544</c:v>
                </c:pt>
                <c:pt idx="65">
                  <c:v>3652</c:v>
                </c:pt>
                <c:pt idx="66">
                  <c:v>3466</c:v>
                </c:pt>
                <c:pt idx="67">
                  <c:v>3246</c:v>
                </c:pt>
                <c:pt idx="68">
                  <c:v>3342</c:v>
                </c:pt>
                <c:pt idx="69">
                  <c:v>3344</c:v>
                </c:pt>
                <c:pt idx="70">
                  <c:v>5673</c:v>
                </c:pt>
                <c:pt idx="71">
                  <c:v>4905</c:v>
                </c:pt>
                <c:pt idx="72">
                  <c:v>5339</c:v>
                </c:pt>
                <c:pt idx="73">
                  <c:v>4762</c:v>
                </c:pt>
                <c:pt idx="74">
                  <c:v>5957</c:v>
                </c:pt>
                <c:pt idx="75">
                  <c:v>5233</c:v>
                </c:pt>
                <c:pt idx="76">
                  <c:v>5407</c:v>
                </c:pt>
                <c:pt idx="77">
                  <c:v>52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9-1E29-3342-A2AA-0E5784E973CA}"/>
            </c:ext>
          </c:extLst>
        </c:ser>
        <c:ser>
          <c:idx val="58"/>
          <c:order val="58"/>
          <c:tx>
            <c:strRef>
              <c:f>Neat!$A$62</c:f>
              <c:strCache>
                <c:ptCount val="1"/>
                <c:pt idx="0">
                  <c:v>Cw1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2:$CA$62</c:f>
              <c:numCache>
                <c:formatCode>General</c:formatCode>
                <c:ptCount val="78"/>
                <c:pt idx="0">
                  <c:v>6519</c:v>
                </c:pt>
                <c:pt idx="1">
                  <c:v>4732</c:v>
                </c:pt>
                <c:pt idx="2">
                  <c:v>4544</c:v>
                </c:pt>
                <c:pt idx="3">
                  <c:v>4311</c:v>
                </c:pt>
                <c:pt idx="4">
                  <c:v>3055</c:v>
                </c:pt>
                <c:pt idx="5">
                  <c:v>0</c:v>
                </c:pt>
                <c:pt idx="6">
                  <c:v>3414</c:v>
                </c:pt>
                <c:pt idx="7">
                  <c:v>3640</c:v>
                </c:pt>
                <c:pt idx="8">
                  <c:v>0</c:v>
                </c:pt>
                <c:pt idx="9">
                  <c:v>4124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3431</c:v>
                </c:pt>
                <c:pt idx="26">
                  <c:v>2756</c:v>
                </c:pt>
                <c:pt idx="27">
                  <c:v>3162</c:v>
                </c:pt>
                <c:pt idx="28">
                  <c:v>0</c:v>
                </c:pt>
                <c:pt idx="29">
                  <c:v>2049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A-1E29-3342-A2AA-0E5784E973CA}"/>
            </c:ext>
          </c:extLst>
        </c:ser>
        <c:ser>
          <c:idx val="59"/>
          <c:order val="59"/>
          <c:tx>
            <c:strRef>
              <c:f>Neat!$A$63</c:f>
              <c:strCache>
                <c:ptCount val="1"/>
                <c:pt idx="0">
                  <c:v>Cw10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3:$CA$63</c:f>
              <c:numCache>
                <c:formatCode>General</c:formatCode>
                <c:ptCount val="78"/>
                <c:pt idx="0">
                  <c:v>11284</c:v>
                </c:pt>
                <c:pt idx="1">
                  <c:v>9845</c:v>
                </c:pt>
                <c:pt idx="2">
                  <c:v>10266</c:v>
                </c:pt>
                <c:pt idx="3">
                  <c:v>8890</c:v>
                </c:pt>
                <c:pt idx="4">
                  <c:v>6793</c:v>
                </c:pt>
                <c:pt idx="5">
                  <c:v>4522</c:v>
                </c:pt>
                <c:pt idx="6">
                  <c:v>7533</c:v>
                </c:pt>
                <c:pt idx="7">
                  <c:v>8078</c:v>
                </c:pt>
                <c:pt idx="8">
                  <c:v>3786</c:v>
                </c:pt>
                <c:pt idx="9">
                  <c:v>7438</c:v>
                </c:pt>
                <c:pt idx="10">
                  <c:v>3540</c:v>
                </c:pt>
                <c:pt idx="11">
                  <c:v>4017</c:v>
                </c:pt>
                <c:pt idx="12">
                  <c:v>3495</c:v>
                </c:pt>
                <c:pt idx="13">
                  <c:v>2198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1211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690</c:v>
                </c:pt>
                <c:pt idx="25">
                  <c:v>4642</c:v>
                </c:pt>
                <c:pt idx="26">
                  <c:v>4465</c:v>
                </c:pt>
                <c:pt idx="27">
                  <c:v>5298</c:v>
                </c:pt>
                <c:pt idx="28">
                  <c:v>3675</c:v>
                </c:pt>
                <c:pt idx="29">
                  <c:v>3149</c:v>
                </c:pt>
                <c:pt idx="30">
                  <c:v>2217</c:v>
                </c:pt>
                <c:pt idx="31">
                  <c:v>2230</c:v>
                </c:pt>
                <c:pt idx="32">
                  <c:v>2848</c:v>
                </c:pt>
                <c:pt idx="33">
                  <c:v>3335</c:v>
                </c:pt>
                <c:pt idx="34">
                  <c:v>2511</c:v>
                </c:pt>
                <c:pt idx="35">
                  <c:v>2550</c:v>
                </c:pt>
                <c:pt idx="36">
                  <c:v>2359</c:v>
                </c:pt>
                <c:pt idx="37">
                  <c:v>4212</c:v>
                </c:pt>
                <c:pt idx="38">
                  <c:v>2053</c:v>
                </c:pt>
                <c:pt idx="39">
                  <c:v>2481</c:v>
                </c:pt>
                <c:pt idx="40">
                  <c:v>2192</c:v>
                </c:pt>
                <c:pt idx="41">
                  <c:v>2086</c:v>
                </c:pt>
                <c:pt idx="42">
                  <c:v>0</c:v>
                </c:pt>
                <c:pt idx="43">
                  <c:v>0</c:v>
                </c:pt>
                <c:pt idx="44">
                  <c:v>1895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B-1E29-3342-A2AA-0E5784E973CA}"/>
            </c:ext>
          </c:extLst>
        </c:ser>
        <c:ser>
          <c:idx val="60"/>
          <c:order val="60"/>
          <c:tx>
            <c:strRef>
              <c:f>Neat!$A$64</c:f>
              <c:strCache>
                <c:ptCount val="1"/>
                <c:pt idx="0">
                  <c:v>Cw12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4:$CA$64</c:f>
              <c:numCache>
                <c:formatCode>General</c:formatCode>
                <c:ptCount val="78"/>
                <c:pt idx="0">
                  <c:v>7228</c:v>
                </c:pt>
                <c:pt idx="1">
                  <c:v>4683</c:v>
                </c:pt>
                <c:pt idx="2">
                  <c:v>4584</c:v>
                </c:pt>
                <c:pt idx="3">
                  <c:v>4197</c:v>
                </c:pt>
                <c:pt idx="4">
                  <c:v>2862</c:v>
                </c:pt>
                <c:pt idx="5">
                  <c:v>0</c:v>
                </c:pt>
                <c:pt idx="6">
                  <c:v>3532</c:v>
                </c:pt>
                <c:pt idx="7">
                  <c:v>3695</c:v>
                </c:pt>
                <c:pt idx="8">
                  <c:v>0</c:v>
                </c:pt>
                <c:pt idx="9">
                  <c:v>3767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C-1E29-3342-A2AA-0E5784E973CA}"/>
            </c:ext>
          </c:extLst>
        </c:ser>
        <c:ser>
          <c:idx val="61"/>
          <c:order val="61"/>
          <c:tx>
            <c:strRef>
              <c:f>Neat!$A$65</c:f>
              <c:strCache>
                <c:ptCount val="1"/>
                <c:pt idx="0">
                  <c:v>Cw14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5:$CA$65</c:f>
              <c:numCache>
                <c:formatCode>General</c:formatCode>
                <c:ptCount val="78"/>
                <c:pt idx="0">
                  <c:v>357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66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D-1E29-3342-A2AA-0E5784E973CA}"/>
            </c:ext>
          </c:extLst>
        </c:ser>
        <c:ser>
          <c:idx val="62"/>
          <c:order val="62"/>
          <c:tx>
            <c:strRef>
              <c:f>Neat!$A$66</c:f>
              <c:strCache>
                <c:ptCount val="1"/>
                <c:pt idx="0">
                  <c:v>Cw15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6:$CA$66</c:f>
              <c:numCache>
                <c:formatCode>General</c:formatCode>
                <c:ptCount val="78"/>
                <c:pt idx="0">
                  <c:v>262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E-1E29-3342-A2AA-0E5784E973CA}"/>
            </c:ext>
          </c:extLst>
        </c:ser>
        <c:ser>
          <c:idx val="63"/>
          <c:order val="63"/>
          <c:tx>
            <c:strRef>
              <c:f>Neat!$A$67</c:f>
              <c:strCache>
                <c:ptCount val="1"/>
                <c:pt idx="0">
                  <c:v>Cw16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7:$CA$67</c:f>
              <c:numCache>
                <c:formatCode>General</c:formatCode>
                <c:ptCount val="78"/>
                <c:pt idx="0">
                  <c:v>5253</c:v>
                </c:pt>
                <c:pt idx="1">
                  <c:v>3411</c:v>
                </c:pt>
                <c:pt idx="2">
                  <c:v>3183</c:v>
                </c:pt>
                <c:pt idx="3">
                  <c:v>2998</c:v>
                </c:pt>
                <c:pt idx="4">
                  <c:v>2021</c:v>
                </c:pt>
                <c:pt idx="5">
                  <c:v>0</c:v>
                </c:pt>
                <c:pt idx="6">
                  <c:v>2455</c:v>
                </c:pt>
                <c:pt idx="7">
                  <c:v>265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F-1E29-3342-A2AA-0E5784E973CA}"/>
            </c:ext>
          </c:extLst>
        </c:ser>
        <c:ser>
          <c:idx val="64"/>
          <c:order val="64"/>
          <c:tx>
            <c:strRef>
              <c:f>Neat!$A$68</c:f>
              <c:strCache>
                <c:ptCount val="1"/>
                <c:pt idx="0">
                  <c:v>Cw8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8:$CA$68</c:f>
              <c:numCache>
                <c:formatCode>General</c:formatCode>
                <c:ptCount val="78"/>
                <c:pt idx="0">
                  <c:v>7965</c:v>
                </c:pt>
                <c:pt idx="1">
                  <c:v>5280</c:v>
                </c:pt>
                <c:pt idx="2">
                  <c:v>5215</c:v>
                </c:pt>
                <c:pt idx="3">
                  <c:v>4441</c:v>
                </c:pt>
                <c:pt idx="4">
                  <c:v>3126</c:v>
                </c:pt>
                <c:pt idx="5">
                  <c:v>0</c:v>
                </c:pt>
                <c:pt idx="6">
                  <c:v>3794</c:v>
                </c:pt>
                <c:pt idx="7">
                  <c:v>4170</c:v>
                </c:pt>
                <c:pt idx="8">
                  <c:v>0</c:v>
                </c:pt>
                <c:pt idx="9">
                  <c:v>3748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0-1E29-3342-A2AA-0E5784E973CA}"/>
            </c:ext>
          </c:extLst>
        </c:ser>
        <c:ser>
          <c:idx val="65"/>
          <c:order val="65"/>
          <c:tx>
            <c:strRef>
              <c:f>Neat!$A$69</c:f>
              <c:strCache>
                <c:ptCount val="1"/>
                <c:pt idx="0">
                  <c:v>Cw9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69:$CA$69</c:f>
              <c:numCache>
                <c:formatCode>General</c:formatCode>
                <c:ptCount val="78"/>
                <c:pt idx="0">
                  <c:v>13759</c:v>
                </c:pt>
                <c:pt idx="1">
                  <c:v>12551</c:v>
                </c:pt>
                <c:pt idx="2">
                  <c:v>12863</c:v>
                </c:pt>
                <c:pt idx="3">
                  <c:v>11583</c:v>
                </c:pt>
                <c:pt idx="4">
                  <c:v>8994</c:v>
                </c:pt>
                <c:pt idx="5">
                  <c:v>6225</c:v>
                </c:pt>
                <c:pt idx="6">
                  <c:v>9825</c:v>
                </c:pt>
                <c:pt idx="7">
                  <c:v>10716</c:v>
                </c:pt>
                <c:pt idx="8">
                  <c:v>5094</c:v>
                </c:pt>
                <c:pt idx="9">
                  <c:v>9513</c:v>
                </c:pt>
                <c:pt idx="10">
                  <c:v>4852</c:v>
                </c:pt>
                <c:pt idx="11">
                  <c:v>5424</c:v>
                </c:pt>
                <c:pt idx="12">
                  <c:v>4834</c:v>
                </c:pt>
                <c:pt idx="13">
                  <c:v>303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1837</c:v>
                </c:pt>
                <c:pt idx="18">
                  <c:v>0</c:v>
                </c:pt>
                <c:pt idx="19">
                  <c:v>0</c:v>
                </c:pt>
                <c:pt idx="20">
                  <c:v>2261</c:v>
                </c:pt>
                <c:pt idx="21">
                  <c:v>0</c:v>
                </c:pt>
                <c:pt idx="22">
                  <c:v>0</c:v>
                </c:pt>
                <c:pt idx="23">
                  <c:v>2542</c:v>
                </c:pt>
                <c:pt idx="24">
                  <c:v>3731</c:v>
                </c:pt>
                <c:pt idx="25">
                  <c:v>6308</c:v>
                </c:pt>
                <c:pt idx="26">
                  <c:v>6232</c:v>
                </c:pt>
                <c:pt idx="27">
                  <c:v>7130</c:v>
                </c:pt>
                <c:pt idx="28">
                  <c:v>4855</c:v>
                </c:pt>
                <c:pt idx="29">
                  <c:v>4391</c:v>
                </c:pt>
                <c:pt idx="30">
                  <c:v>3248</c:v>
                </c:pt>
                <c:pt idx="31">
                  <c:v>3192</c:v>
                </c:pt>
                <c:pt idx="32">
                  <c:v>3958</c:v>
                </c:pt>
                <c:pt idx="33">
                  <c:v>4615</c:v>
                </c:pt>
                <c:pt idx="34">
                  <c:v>3517</c:v>
                </c:pt>
                <c:pt idx="35">
                  <c:v>3784</c:v>
                </c:pt>
                <c:pt idx="36">
                  <c:v>3472</c:v>
                </c:pt>
                <c:pt idx="37">
                  <c:v>5870</c:v>
                </c:pt>
                <c:pt idx="38">
                  <c:v>2931</c:v>
                </c:pt>
                <c:pt idx="39">
                  <c:v>3624</c:v>
                </c:pt>
                <c:pt idx="40">
                  <c:v>3024</c:v>
                </c:pt>
                <c:pt idx="41">
                  <c:v>3136</c:v>
                </c:pt>
                <c:pt idx="42">
                  <c:v>2722</c:v>
                </c:pt>
                <c:pt idx="43">
                  <c:v>2725</c:v>
                </c:pt>
                <c:pt idx="44">
                  <c:v>2736</c:v>
                </c:pt>
                <c:pt idx="45">
                  <c:v>2458</c:v>
                </c:pt>
                <c:pt idx="46">
                  <c:v>2065</c:v>
                </c:pt>
                <c:pt idx="47">
                  <c:v>0</c:v>
                </c:pt>
                <c:pt idx="48">
                  <c:v>1551</c:v>
                </c:pt>
                <c:pt idx="49">
                  <c:v>0</c:v>
                </c:pt>
                <c:pt idx="50">
                  <c:v>1284</c:v>
                </c:pt>
                <c:pt idx="51">
                  <c:v>1463</c:v>
                </c:pt>
                <c:pt idx="52">
                  <c:v>0</c:v>
                </c:pt>
                <c:pt idx="53">
                  <c:v>2184</c:v>
                </c:pt>
                <c:pt idx="54">
                  <c:v>0</c:v>
                </c:pt>
                <c:pt idx="55">
                  <c:v>0</c:v>
                </c:pt>
                <c:pt idx="56">
                  <c:v>1382</c:v>
                </c:pt>
                <c:pt idx="57">
                  <c:v>1189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1-1E29-3342-A2AA-0E5784E973CA}"/>
            </c:ext>
          </c:extLst>
        </c:ser>
        <c:ser>
          <c:idx val="66"/>
          <c:order val="66"/>
          <c:tx>
            <c:strRef>
              <c:f>Neat!$A$70</c:f>
              <c:strCache>
                <c:ptCount val="1"/>
                <c:pt idx="0">
                  <c:v>DP1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0:$CA$70</c:f>
              <c:numCache>
                <c:formatCode>General</c:formatCode>
                <c:ptCount val="7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002</c:v>
                </c:pt>
                <c:pt idx="9">
                  <c:v>360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4186</c:v>
                </c:pt>
                <c:pt idx="26">
                  <c:v>3484</c:v>
                </c:pt>
                <c:pt idx="27">
                  <c:v>3804</c:v>
                </c:pt>
                <c:pt idx="28">
                  <c:v>0</c:v>
                </c:pt>
                <c:pt idx="29">
                  <c:v>226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2-1E29-3342-A2AA-0E5784E973CA}"/>
            </c:ext>
          </c:extLst>
        </c:ser>
        <c:ser>
          <c:idx val="67"/>
          <c:order val="67"/>
          <c:tx>
            <c:strRef>
              <c:f>Neat!$A$71</c:f>
              <c:strCache>
                <c:ptCount val="1"/>
                <c:pt idx="0">
                  <c:v>DP10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solidFill>
                  <a:schemeClr val="accent2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1:$CA$71</c:f>
              <c:numCache>
                <c:formatCode>General</c:formatCode>
                <c:ptCount val="78"/>
                <c:pt idx="0">
                  <c:v>364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3-1E29-3342-A2AA-0E5784E973CA}"/>
            </c:ext>
          </c:extLst>
        </c:ser>
        <c:ser>
          <c:idx val="68"/>
          <c:order val="68"/>
          <c:tx>
            <c:strRef>
              <c:f>Neat!$A$72</c:f>
              <c:strCache>
                <c:ptCount val="1"/>
                <c:pt idx="0">
                  <c:v>DP14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  <a:lumOff val="20000"/>
                </a:schemeClr>
              </a:solidFill>
              <a:ln w="9525">
                <a:solidFill>
                  <a:schemeClr val="accent3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2:$CA$72</c:f>
              <c:numCache>
                <c:formatCode>General</c:formatCode>
                <c:ptCount val="78"/>
                <c:pt idx="0">
                  <c:v>372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4-1E29-3342-A2AA-0E5784E973CA}"/>
            </c:ext>
          </c:extLst>
        </c:ser>
        <c:ser>
          <c:idx val="69"/>
          <c:order val="69"/>
          <c:tx>
            <c:strRef>
              <c:f>Neat!$A$73</c:f>
              <c:strCache>
                <c:ptCount val="1"/>
                <c:pt idx="0">
                  <c:v>DP15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  <a:lumOff val="20000"/>
                </a:schemeClr>
              </a:solidFill>
              <a:ln w="9525">
                <a:solidFill>
                  <a:schemeClr val="accent4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3:$CA$73</c:f>
              <c:numCache>
                <c:formatCode>General</c:formatCode>
                <c:ptCount val="78"/>
                <c:pt idx="0">
                  <c:v>7874</c:v>
                </c:pt>
                <c:pt idx="1">
                  <c:v>3426</c:v>
                </c:pt>
                <c:pt idx="2">
                  <c:v>3013</c:v>
                </c:pt>
                <c:pt idx="3">
                  <c:v>204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5-1E29-3342-A2AA-0E5784E973CA}"/>
            </c:ext>
          </c:extLst>
        </c:ser>
        <c:ser>
          <c:idx val="70"/>
          <c:order val="70"/>
          <c:tx>
            <c:strRef>
              <c:f>Neat!$A$74</c:f>
              <c:strCache>
                <c:ptCount val="1"/>
                <c:pt idx="0">
                  <c:v>DP17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  <a:lumOff val="20000"/>
                </a:schemeClr>
              </a:solidFill>
              <a:ln w="9525">
                <a:solidFill>
                  <a:schemeClr val="accent5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4:$CA$74</c:f>
              <c:numCache>
                <c:formatCode>General</c:formatCode>
                <c:ptCount val="78"/>
                <c:pt idx="0">
                  <c:v>381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6-1E29-3342-A2AA-0E5784E973CA}"/>
            </c:ext>
          </c:extLst>
        </c:ser>
        <c:ser>
          <c:idx val="71"/>
          <c:order val="71"/>
          <c:tx>
            <c:strRef>
              <c:f>Neat!$A$75</c:f>
              <c:strCache>
                <c:ptCount val="1"/>
                <c:pt idx="0">
                  <c:v>DP18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5:$CA$75</c:f>
              <c:numCache>
                <c:formatCode>General</c:formatCode>
                <c:ptCount val="78"/>
                <c:pt idx="0">
                  <c:v>18024</c:v>
                </c:pt>
                <c:pt idx="1">
                  <c:v>10861</c:v>
                </c:pt>
                <c:pt idx="2">
                  <c:v>9308</c:v>
                </c:pt>
                <c:pt idx="3">
                  <c:v>8220</c:v>
                </c:pt>
                <c:pt idx="4">
                  <c:v>6768</c:v>
                </c:pt>
                <c:pt idx="5">
                  <c:v>4764</c:v>
                </c:pt>
                <c:pt idx="6">
                  <c:v>5331</c:v>
                </c:pt>
                <c:pt idx="7">
                  <c:v>5233</c:v>
                </c:pt>
                <c:pt idx="8">
                  <c:v>4479</c:v>
                </c:pt>
                <c:pt idx="9">
                  <c:v>5211</c:v>
                </c:pt>
                <c:pt idx="10">
                  <c:v>0</c:v>
                </c:pt>
                <c:pt idx="11">
                  <c:v>0</c:v>
                </c:pt>
                <c:pt idx="12">
                  <c:v>3196</c:v>
                </c:pt>
                <c:pt idx="13">
                  <c:v>2709</c:v>
                </c:pt>
                <c:pt idx="14">
                  <c:v>2324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2154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2004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7-1E29-3342-A2AA-0E5784E973CA}"/>
            </c:ext>
          </c:extLst>
        </c:ser>
        <c:ser>
          <c:idx val="72"/>
          <c:order val="72"/>
          <c:tx>
            <c:strRef>
              <c:f>Neat!$A$76</c:f>
              <c:strCache>
                <c:ptCount val="1"/>
                <c:pt idx="0">
                  <c:v>DP19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</a:schemeClr>
              </a:solidFill>
              <a:ln w="9525">
                <a:solidFill>
                  <a:schemeClr val="accent1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6:$CA$76</c:f>
              <c:numCache>
                <c:formatCode>General</c:formatCode>
                <c:ptCount val="78"/>
                <c:pt idx="0">
                  <c:v>18851</c:v>
                </c:pt>
                <c:pt idx="1">
                  <c:v>10828</c:v>
                </c:pt>
                <c:pt idx="2">
                  <c:v>9519</c:v>
                </c:pt>
                <c:pt idx="3">
                  <c:v>8294</c:v>
                </c:pt>
                <c:pt idx="4">
                  <c:v>6742</c:v>
                </c:pt>
                <c:pt idx="5">
                  <c:v>4703</c:v>
                </c:pt>
                <c:pt idx="6">
                  <c:v>5444</c:v>
                </c:pt>
                <c:pt idx="7">
                  <c:v>5456</c:v>
                </c:pt>
                <c:pt idx="8">
                  <c:v>4773</c:v>
                </c:pt>
                <c:pt idx="9">
                  <c:v>5769</c:v>
                </c:pt>
                <c:pt idx="10">
                  <c:v>3858</c:v>
                </c:pt>
                <c:pt idx="11">
                  <c:v>4409</c:v>
                </c:pt>
                <c:pt idx="12">
                  <c:v>3572</c:v>
                </c:pt>
                <c:pt idx="13">
                  <c:v>2997</c:v>
                </c:pt>
                <c:pt idx="14">
                  <c:v>260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367</c:v>
                </c:pt>
                <c:pt idx="25">
                  <c:v>3728</c:v>
                </c:pt>
                <c:pt idx="26">
                  <c:v>3648</c:v>
                </c:pt>
                <c:pt idx="27">
                  <c:v>4864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8-1E29-3342-A2AA-0E5784E973CA}"/>
            </c:ext>
          </c:extLst>
        </c:ser>
        <c:ser>
          <c:idx val="73"/>
          <c:order val="73"/>
          <c:tx>
            <c:strRef>
              <c:f>Neat!$A$77</c:f>
              <c:strCache>
                <c:ptCount val="1"/>
                <c:pt idx="0">
                  <c:v>DP2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7:$CA$77</c:f>
              <c:numCache>
                <c:formatCode>General</c:formatCode>
                <c:ptCount val="78"/>
                <c:pt idx="0">
                  <c:v>21484</c:v>
                </c:pt>
                <c:pt idx="1">
                  <c:v>16479</c:v>
                </c:pt>
                <c:pt idx="2">
                  <c:v>14913</c:v>
                </c:pt>
                <c:pt idx="3">
                  <c:v>12690</c:v>
                </c:pt>
                <c:pt idx="4">
                  <c:v>10911</c:v>
                </c:pt>
                <c:pt idx="5">
                  <c:v>8214</c:v>
                </c:pt>
                <c:pt idx="6">
                  <c:v>8652</c:v>
                </c:pt>
                <c:pt idx="7">
                  <c:v>8739</c:v>
                </c:pt>
                <c:pt idx="8">
                  <c:v>7128</c:v>
                </c:pt>
                <c:pt idx="9">
                  <c:v>8376</c:v>
                </c:pt>
                <c:pt idx="10">
                  <c:v>6254</c:v>
                </c:pt>
                <c:pt idx="11">
                  <c:v>6837</c:v>
                </c:pt>
                <c:pt idx="12">
                  <c:v>5755</c:v>
                </c:pt>
                <c:pt idx="13">
                  <c:v>4662</c:v>
                </c:pt>
                <c:pt idx="14">
                  <c:v>407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2337</c:v>
                </c:pt>
                <c:pt idx="24">
                  <c:v>3795</c:v>
                </c:pt>
                <c:pt idx="25">
                  <c:v>5181</c:v>
                </c:pt>
                <c:pt idx="26">
                  <c:v>5447</c:v>
                </c:pt>
                <c:pt idx="27">
                  <c:v>7334</c:v>
                </c:pt>
                <c:pt idx="28">
                  <c:v>3461</c:v>
                </c:pt>
                <c:pt idx="29">
                  <c:v>3328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2117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9-1E29-3342-A2AA-0E5784E973CA}"/>
            </c:ext>
          </c:extLst>
        </c:ser>
        <c:ser>
          <c:idx val="74"/>
          <c:order val="74"/>
          <c:tx>
            <c:strRef>
              <c:f>Neat!$A$78</c:f>
              <c:strCache>
                <c:ptCount val="1"/>
                <c:pt idx="0">
                  <c:v>DP20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</a:schemeClr>
              </a:solidFill>
              <a:ln w="9525">
                <a:solidFill>
                  <a:schemeClr val="accent3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8:$CA$78</c:f>
              <c:numCache>
                <c:formatCode>General</c:formatCode>
                <c:ptCount val="78"/>
                <c:pt idx="0">
                  <c:v>17198</c:v>
                </c:pt>
                <c:pt idx="1">
                  <c:v>10105</c:v>
                </c:pt>
                <c:pt idx="2">
                  <c:v>8458</c:v>
                </c:pt>
                <c:pt idx="3">
                  <c:v>8476</c:v>
                </c:pt>
                <c:pt idx="4">
                  <c:v>7362</c:v>
                </c:pt>
                <c:pt idx="5">
                  <c:v>4829</c:v>
                </c:pt>
                <c:pt idx="6">
                  <c:v>5520</c:v>
                </c:pt>
                <c:pt idx="7">
                  <c:v>5644</c:v>
                </c:pt>
                <c:pt idx="8">
                  <c:v>4988</c:v>
                </c:pt>
                <c:pt idx="9">
                  <c:v>5813</c:v>
                </c:pt>
                <c:pt idx="10">
                  <c:v>4067</c:v>
                </c:pt>
                <c:pt idx="11">
                  <c:v>4524</c:v>
                </c:pt>
                <c:pt idx="12">
                  <c:v>3446</c:v>
                </c:pt>
                <c:pt idx="13">
                  <c:v>3149</c:v>
                </c:pt>
                <c:pt idx="14">
                  <c:v>263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3012</c:v>
                </c:pt>
                <c:pt idx="25">
                  <c:v>4525</c:v>
                </c:pt>
                <c:pt idx="26">
                  <c:v>4736</c:v>
                </c:pt>
                <c:pt idx="27">
                  <c:v>5842</c:v>
                </c:pt>
                <c:pt idx="28">
                  <c:v>2788</c:v>
                </c:pt>
                <c:pt idx="29">
                  <c:v>2816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A-1E29-3342-A2AA-0E5784E973CA}"/>
            </c:ext>
          </c:extLst>
        </c:ser>
        <c:ser>
          <c:idx val="75"/>
          <c:order val="75"/>
          <c:tx>
            <c:strRef>
              <c:f>Neat!$A$79</c:f>
              <c:strCache>
                <c:ptCount val="1"/>
                <c:pt idx="0">
                  <c:v>DP23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79:$CA$79</c:f>
              <c:numCache>
                <c:formatCode>General</c:formatCode>
                <c:ptCount val="78"/>
                <c:pt idx="0">
                  <c:v>18838</c:v>
                </c:pt>
                <c:pt idx="1">
                  <c:v>13046</c:v>
                </c:pt>
                <c:pt idx="2">
                  <c:v>11855</c:v>
                </c:pt>
                <c:pt idx="3">
                  <c:v>11557</c:v>
                </c:pt>
                <c:pt idx="4">
                  <c:v>9717</c:v>
                </c:pt>
                <c:pt idx="5">
                  <c:v>7089</c:v>
                </c:pt>
                <c:pt idx="6">
                  <c:v>7673</c:v>
                </c:pt>
                <c:pt idx="7">
                  <c:v>7662</c:v>
                </c:pt>
                <c:pt idx="8">
                  <c:v>6526</c:v>
                </c:pt>
                <c:pt idx="9">
                  <c:v>7623</c:v>
                </c:pt>
                <c:pt idx="10">
                  <c:v>5504</c:v>
                </c:pt>
                <c:pt idx="11">
                  <c:v>6368</c:v>
                </c:pt>
                <c:pt idx="12">
                  <c:v>4947</c:v>
                </c:pt>
                <c:pt idx="13">
                  <c:v>3986</c:v>
                </c:pt>
                <c:pt idx="14">
                  <c:v>3486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3295</c:v>
                </c:pt>
                <c:pt idx="25">
                  <c:v>4425</c:v>
                </c:pt>
                <c:pt idx="26">
                  <c:v>4728</c:v>
                </c:pt>
                <c:pt idx="27">
                  <c:v>6121</c:v>
                </c:pt>
                <c:pt idx="28">
                  <c:v>2992</c:v>
                </c:pt>
                <c:pt idx="29">
                  <c:v>3009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B-1E29-3342-A2AA-0E5784E973CA}"/>
            </c:ext>
          </c:extLst>
        </c:ser>
        <c:ser>
          <c:idx val="76"/>
          <c:order val="76"/>
          <c:tx>
            <c:strRef>
              <c:f>Neat!$A$80</c:f>
              <c:strCache>
                <c:ptCount val="1"/>
                <c:pt idx="0">
                  <c:v>DP28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</a:schemeClr>
              </a:solidFill>
              <a:ln w="9525">
                <a:solidFill>
                  <a:schemeClr val="accent5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0:$CA$80</c:f>
              <c:numCache>
                <c:formatCode>General</c:formatCode>
                <c:ptCount val="78"/>
                <c:pt idx="0">
                  <c:v>18550</c:v>
                </c:pt>
                <c:pt idx="1">
                  <c:v>12228</c:v>
                </c:pt>
                <c:pt idx="2">
                  <c:v>10577</c:v>
                </c:pt>
                <c:pt idx="3">
                  <c:v>9347</c:v>
                </c:pt>
                <c:pt idx="4">
                  <c:v>8010</c:v>
                </c:pt>
                <c:pt idx="5">
                  <c:v>5567</c:v>
                </c:pt>
                <c:pt idx="6">
                  <c:v>6051</c:v>
                </c:pt>
                <c:pt idx="7">
                  <c:v>6076</c:v>
                </c:pt>
                <c:pt idx="8">
                  <c:v>5078</c:v>
                </c:pt>
                <c:pt idx="9">
                  <c:v>6005</c:v>
                </c:pt>
                <c:pt idx="10">
                  <c:v>4191</c:v>
                </c:pt>
                <c:pt idx="11">
                  <c:v>4597</c:v>
                </c:pt>
                <c:pt idx="12">
                  <c:v>3587</c:v>
                </c:pt>
                <c:pt idx="13">
                  <c:v>2995</c:v>
                </c:pt>
                <c:pt idx="14">
                  <c:v>262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4262</c:v>
                </c:pt>
                <c:pt idx="26">
                  <c:v>4486</c:v>
                </c:pt>
                <c:pt idx="27">
                  <c:v>5965</c:v>
                </c:pt>
                <c:pt idx="28">
                  <c:v>0</c:v>
                </c:pt>
                <c:pt idx="29">
                  <c:v>251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2094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C-1E29-3342-A2AA-0E5784E973CA}"/>
            </c:ext>
          </c:extLst>
        </c:ser>
        <c:ser>
          <c:idx val="77"/>
          <c:order val="77"/>
          <c:tx>
            <c:strRef>
              <c:f>Neat!$A$81</c:f>
              <c:strCache>
                <c:ptCount val="1"/>
                <c:pt idx="0">
                  <c:v>DP3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</a:schemeClr>
              </a:solidFill>
              <a:ln w="9525">
                <a:solidFill>
                  <a:schemeClr val="accent6">
                    <a:lumMod val="8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1:$CA$81</c:f>
              <c:numCache>
                <c:formatCode>General</c:formatCode>
                <c:ptCount val="78"/>
                <c:pt idx="0">
                  <c:v>14330</c:v>
                </c:pt>
                <c:pt idx="1">
                  <c:v>7698</c:v>
                </c:pt>
                <c:pt idx="2">
                  <c:v>6875</c:v>
                </c:pt>
                <c:pt idx="3">
                  <c:v>624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D-1E29-3342-A2AA-0E5784E973CA}"/>
            </c:ext>
          </c:extLst>
        </c:ser>
        <c:ser>
          <c:idx val="78"/>
          <c:order val="78"/>
          <c:tx>
            <c:strRef>
              <c:f>Neat!$A$82</c:f>
              <c:strCache>
                <c:ptCount val="1"/>
                <c:pt idx="0">
                  <c:v>DP401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2:$CA$82</c:f>
              <c:numCache>
                <c:formatCode>General</c:formatCode>
                <c:ptCount val="78"/>
                <c:pt idx="0">
                  <c:v>21029</c:v>
                </c:pt>
                <c:pt idx="1">
                  <c:v>14898</c:v>
                </c:pt>
                <c:pt idx="2">
                  <c:v>13673</c:v>
                </c:pt>
                <c:pt idx="3">
                  <c:v>12083</c:v>
                </c:pt>
                <c:pt idx="4">
                  <c:v>9938</c:v>
                </c:pt>
                <c:pt idx="5">
                  <c:v>7234</c:v>
                </c:pt>
                <c:pt idx="6">
                  <c:v>7788</c:v>
                </c:pt>
                <c:pt idx="7">
                  <c:v>7839</c:v>
                </c:pt>
                <c:pt idx="8">
                  <c:v>6657</c:v>
                </c:pt>
                <c:pt idx="9">
                  <c:v>7800</c:v>
                </c:pt>
                <c:pt idx="10">
                  <c:v>5535</c:v>
                </c:pt>
                <c:pt idx="11">
                  <c:v>6192</c:v>
                </c:pt>
                <c:pt idx="12">
                  <c:v>5118</c:v>
                </c:pt>
                <c:pt idx="13">
                  <c:v>4199</c:v>
                </c:pt>
                <c:pt idx="14">
                  <c:v>362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3391</c:v>
                </c:pt>
                <c:pt idx="25">
                  <c:v>4657</c:v>
                </c:pt>
                <c:pt idx="26">
                  <c:v>4836</c:v>
                </c:pt>
                <c:pt idx="27">
                  <c:v>6130</c:v>
                </c:pt>
                <c:pt idx="28">
                  <c:v>2923</c:v>
                </c:pt>
                <c:pt idx="29">
                  <c:v>2961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E-1E29-3342-A2AA-0E5784E973CA}"/>
            </c:ext>
          </c:extLst>
        </c:ser>
        <c:ser>
          <c:idx val="79"/>
          <c:order val="79"/>
          <c:tx>
            <c:strRef>
              <c:f>Neat!$A$83</c:f>
              <c:strCache>
                <c:ptCount val="1"/>
                <c:pt idx="0">
                  <c:v>DP402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3:$CA$83</c:f>
              <c:numCache>
                <c:formatCode>General</c:formatCode>
                <c:ptCount val="78"/>
                <c:pt idx="0">
                  <c:v>20277</c:v>
                </c:pt>
                <c:pt idx="1">
                  <c:v>13974</c:v>
                </c:pt>
                <c:pt idx="2">
                  <c:v>12718</c:v>
                </c:pt>
                <c:pt idx="3">
                  <c:v>11626</c:v>
                </c:pt>
                <c:pt idx="4">
                  <c:v>9781</c:v>
                </c:pt>
                <c:pt idx="5">
                  <c:v>7200</c:v>
                </c:pt>
                <c:pt idx="6">
                  <c:v>7385</c:v>
                </c:pt>
                <c:pt idx="7">
                  <c:v>7468</c:v>
                </c:pt>
                <c:pt idx="8">
                  <c:v>6419</c:v>
                </c:pt>
                <c:pt idx="9">
                  <c:v>7340</c:v>
                </c:pt>
                <c:pt idx="10">
                  <c:v>5324</c:v>
                </c:pt>
                <c:pt idx="11">
                  <c:v>5932</c:v>
                </c:pt>
                <c:pt idx="12">
                  <c:v>4820</c:v>
                </c:pt>
                <c:pt idx="13">
                  <c:v>3961</c:v>
                </c:pt>
                <c:pt idx="14">
                  <c:v>331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2687</c:v>
                </c:pt>
                <c:pt idx="21">
                  <c:v>0</c:v>
                </c:pt>
                <c:pt idx="22">
                  <c:v>0</c:v>
                </c:pt>
                <c:pt idx="23">
                  <c:v>2508</c:v>
                </c:pt>
                <c:pt idx="24">
                  <c:v>3797</c:v>
                </c:pt>
                <c:pt idx="25">
                  <c:v>4841</c:v>
                </c:pt>
                <c:pt idx="26">
                  <c:v>5546</c:v>
                </c:pt>
                <c:pt idx="27">
                  <c:v>6620</c:v>
                </c:pt>
                <c:pt idx="28">
                  <c:v>3518</c:v>
                </c:pt>
                <c:pt idx="29">
                  <c:v>3234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F-1E29-3342-A2AA-0E5784E973CA}"/>
            </c:ext>
          </c:extLst>
        </c:ser>
        <c:ser>
          <c:idx val="80"/>
          <c:order val="80"/>
          <c:tx>
            <c:strRef>
              <c:f>Neat!$A$84</c:f>
              <c:strCache>
                <c:ptCount val="1"/>
                <c:pt idx="0">
                  <c:v>DP6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accent3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4:$CA$84</c:f>
              <c:numCache>
                <c:formatCode>General</c:formatCode>
                <c:ptCount val="78"/>
                <c:pt idx="0">
                  <c:v>10404</c:v>
                </c:pt>
                <c:pt idx="1">
                  <c:v>0</c:v>
                </c:pt>
                <c:pt idx="2">
                  <c:v>471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0-1E29-3342-A2AA-0E5784E973CA}"/>
            </c:ext>
          </c:extLst>
        </c:ser>
        <c:ser>
          <c:idx val="81"/>
          <c:order val="81"/>
          <c:tx>
            <c:strRef>
              <c:f>Neat!$A$85</c:f>
              <c:strCache>
                <c:ptCount val="1"/>
                <c:pt idx="0">
                  <c:v>DP9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5:$CA$85</c:f>
              <c:numCache>
                <c:formatCode>General</c:formatCode>
                <c:ptCount val="78"/>
                <c:pt idx="0">
                  <c:v>371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1-1E29-3342-A2AA-0E5784E973CA}"/>
            </c:ext>
          </c:extLst>
        </c:ser>
        <c:ser>
          <c:idx val="82"/>
          <c:order val="82"/>
          <c:tx>
            <c:strRef>
              <c:f>Neat!$A$86</c:f>
              <c:strCache>
                <c:ptCount val="1"/>
                <c:pt idx="0">
                  <c:v>DPA1*01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6:$CA$86</c:f>
              <c:numCache>
                <c:formatCode>General</c:formatCode>
                <c:ptCount val="78"/>
                <c:pt idx="0">
                  <c:v>15852</c:v>
                </c:pt>
                <c:pt idx="1">
                  <c:v>8518</c:v>
                </c:pt>
                <c:pt idx="2">
                  <c:v>7436</c:v>
                </c:pt>
                <c:pt idx="3">
                  <c:v>7513</c:v>
                </c:pt>
                <c:pt idx="4">
                  <c:v>7245</c:v>
                </c:pt>
                <c:pt idx="5">
                  <c:v>4807</c:v>
                </c:pt>
                <c:pt idx="6">
                  <c:v>5520</c:v>
                </c:pt>
                <c:pt idx="7">
                  <c:v>5507</c:v>
                </c:pt>
                <c:pt idx="8">
                  <c:v>4665</c:v>
                </c:pt>
                <c:pt idx="9">
                  <c:v>5504</c:v>
                </c:pt>
                <c:pt idx="10">
                  <c:v>4226</c:v>
                </c:pt>
                <c:pt idx="11">
                  <c:v>4607</c:v>
                </c:pt>
                <c:pt idx="12">
                  <c:v>3712</c:v>
                </c:pt>
                <c:pt idx="13">
                  <c:v>2910</c:v>
                </c:pt>
                <c:pt idx="14">
                  <c:v>261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869</c:v>
                </c:pt>
                <c:pt idx="25">
                  <c:v>3699</c:v>
                </c:pt>
                <c:pt idx="26">
                  <c:v>4034</c:v>
                </c:pt>
                <c:pt idx="27">
                  <c:v>5521</c:v>
                </c:pt>
                <c:pt idx="28">
                  <c:v>2951</c:v>
                </c:pt>
                <c:pt idx="29">
                  <c:v>2131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2-1E29-3342-A2AA-0E5784E973CA}"/>
            </c:ext>
          </c:extLst>
        </c:ser>
        <c:ser>
          <c:idx val="83"/>
          <c:order val="83"/>
          <c:tx>
            <c:strRef>
              <c:f>Neat!$A$87</c:f>
              <c:strCache>
                <c:ptCount val="1"/>
                <c:pt idx="0">
                  <c:v>DPA1*03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accent6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7:$CA$87</c:f>
              <c:numCache>
                <c:formatCode>General</c:formatCode>
                <c:ptCount val="78"/>
                <c:pt idx="0">
                  <c:v>16058</c:v>
                </c:pt>
                <c:pt idx="1">
                  <c:v>8099</c:v>
                </c:pt>
                <c:pt idx="2">
                  <c:v>6849</c:v>
                </c:pt>
                <c:pt idx="3">
                  <c:v>5836</c:v>
                </c:pt>
                <c:pt idx="4">
                  <c:v>4773</c:v>
                </c:pt>
                <c:pt idx="5">
                  <c:v>3221</c:v>
                </c:pt>
                <c:pt idx="6">
                  <c:v>3875</c:v>
                </c:pt>
                <c:pt idx="7">
                  <c:v>3765</c:v>
                </c:pt>
                <c:pt idx="8">
                  <c:v>3298</c:v>
                </c:pt>
                <c:pt idx="9">
                  <c:v>3992</c:v>
                </c:pt>
                <c:pt idx="10">
                  <c:v>2684</c:v>
                </c:pt>
                <c:pt idx="11">
                  <c:v>3005</c:v>
                </c:pt>
                <c:pt idx="12">
                  <c:v>2318</c:v>
                </c:pt>
                <c:pt idx="13">
                  <c:v>224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3095</c:v>
                </c:pt>
                <c:pt idx="26">
                  <c:v>3090</c:v>
                </c:pt>
                <c:pt idx="27">
                  <c:v>365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3-1E29-3342-A2AA-0E5784E973CA}"/>
            </c:ext>
          </c:extLst>
        </c:ser>
        <c:ser>
          <c:idx val="84"/>
          <c:order val="84"/>
          <c:tx>
            <c:strRef>
              <c:f>Neat!$A$88</c:f>
              <c:strCache>
                <c:ptCount val="1"/>
                <c:pt idx="0">
                  <c:v>DQ4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8:$CA$88</c:f>
              <c:numCache>
                <c:formatCode>General</c:formatCode>
                <c:ptCount val="78"/>
                <c:pt idx="0">
                  <c:v>6992</c:v>
                </c:pt>
                <c:pt idx="1">
                  <c:v>3604</c:v>
                </c:pt>
                <c:pt idx="2">
                  <c:v>3174</c:v>
                </c:pt>
                <c:pt idx="3">
                  <c:v>2505</c:v>
                </c:pt>
                <c:pt idx="4">
                  <c:v>1548</c:v>
                </c:pt>
                <c:pt idx="5">
                  <c:v>1099</c:v>
                </c:pt>
                <c:pt idx="6">
                  <c:v>1109</c:v>
                </c:pt>
                <c:pt idx="7">
                  <c:v>1173</c:v>
                </c:pt>
                <c:pt idx="8">
                  <c:v>0</c:v>
                </c:pt>
                <c:pt idx="9">
                  <c:v>1477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411</c:v>
                </c:pt>
                <c:pt idx="24">
                  <c:v>2658</c:v>
                </c:pt>
                <c:pt idx="25">
                  <c:v>5196</c:v>
                </c:pt>
                <c:pt idx="26">
                  <c:v>6351</c:v>
                </c:pt>
                <c:pt idx="27">
                  <c:v>9095</c:v>
                </c:pt>
                <c:pt idx="28">
                  <c:v>5298</c:v>
                </c:pt>
                <c:pt idx="29">
                  <c:v>387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4-1E29-3342-A2AA-0E5784E973CA}"/>
            </c:ext>
          </c:extLst>
        </c:ser>
        <c:ser>
          <c:idx val="85"/>
          <c:order val="85"/>
          <c:tx>
            <c:strRef>
              <c:f>Neat!$A$89</c:f>
              <c:strCache>
                <c:ptCount val="1"/>
                <c:pt idx="0">
                  <c:v>DQ5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89:$CA$89</c:f>
              <c:numCache>
                <c:formatCode>General</c:formatCode>
                <c:ptCount val="78"/>
                <c:pt idx="0">
                  <c:v>19217</c:v>
                </c:pt>
                <c:pt idx="1">
                  <c:v>15773</c:v>
                </c:pt>
                <c:pt idx="2">
                  <c:v>14986</c:v>
                </c:pt>
                <c:pt idx="3">
                  <c:v>12922</c:v>
                </c:pt>
                <c:pt idx="4">
                  <c:v>9456</c:v>
                </c:pt>
                <c:pt idx="5">
                  <c:v>7411</c:v>
                </c:pt>
                <c:pt idx="6">
                  <c:v>7668</c:v>
                </c:pt>
                <c:pt idx="7">
                  <c:v>7422</c:v>
                </c:pt>
                <c:pt idx="8">
                  <c:v>6327</c:v>
                </c:pt>
                <c:pt idx="9">
                  <c:v>7729</c:v>
                </c:pt>
                <c:pt idx="10">
                  <c:v>5354</c:v>
                </c:pt>
                <c:pt idx="11">
                  <c:v>5760</c:v>
                </c:pt>
                <c:pt idx="12">
                  <c:v>4223</c:v>
                </c:pt>
                <c:pt idx="13">
                  <c:v>3852</c:v>
                </c:pt>
                <c:pt idx="14">
                  <c:v>2695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915</c:v>
                </c:pt>
                <c:pt idx="21">
                  <c:v>1534</c:v>
                </c:pt>
                <c:pt idx="22">
                  <c:v>2361</c:v>
                </c:pt>
                <c:pt idx="23">
                  <c:v>6815</c:v>
                </c:pt>
                <c:pt idx="24">
                  <c:v>13096</c:v>
                </c:pt>
                <c:pt idx="25">
                  <c:v>16836</c:v>
                </c:pt>
                <c:pt idx="26">
                  <c:v>21063</c:v>
                </c:pt>
                <c:pt idx="27">
                  <c:v>21741</c:v>
                </c:pt>
                <c:pt idx="28">
                  <c:v>19406</c:v>
                </c:pt>
                <c:pt idx="29">
                  <c:v>15835</c:v>
                </c:pt>
                <c:pt idx="30">
                  <c:v>6832</c:v>
                </c:pt>
                <c:pt idx="31">
                  <c:v>3362</c:v>
                </c:pt>
                <c:pt idx="32">
                  <c:v>3809</c:v>
                </c:pt>
                <c:pt idx="33">
                  <c:v>3591</c:v>
                </c:pt>
                <c:pt idx="34">
                  <c:v>3983</c:v>
                </c:pt>
                <c:pt idx="35">
                  <c:v>3998</c:v>
                </c:pt>
                <c:pt idx="36">
                  <c:v>3010</c:v>
                </c:pt>
                <c:pt idx="37">
                  <c:v>3435</c:v>
                </c:pt>
                <c:pt idx="38">
                  <c:v>2594</c:v>
                </c:pt>
                <c:pt idx="39">
                  <c:v>2129</c:v>
                </c:pt>
                <c:pt idx="40">
                  <c:v>1836</c:v>
                </c:pt>
                <c:pt idx="41">
                  <c:v>1723</c:v>
                </c:pt>
                <c:pt idx="42">
                  <c:v>1601</c:v>
                </c:pt>
                <c:pt idx="43">
                  <c:v>1491</c:v>
                </c:pt>
                <c:pt idx="44">
                  <c:v>1620</c:v>
                </c:pt>
                <c:pt idx="45">
                  <c:v>1658</c:v>
                </c:pt>
                <c:pt idx="46">
                  <c:v>1769</c:v>
                </c:pt>
                <c:pt idx="47">
                  <c:v>2162</c:v>
                </c:pt>
                <c:pt idx="48">
                  <c:v>2097</c:v>
                </c:pt>
                <c:pt idx="49">
                  <c:v>2654</c:v>
                </c:pt>
                <c:pt idx="50">
                  <c:v>2102</c:v>
                </c:pt>
                <c:pt idx="51">
                  <c:v>1734</c:v>
                </c:pt>
                <c:pt idx="52">
                  <c:v>2204</c:v>
                </c:pt>
                <c:pt idx="53">
                  <c:v>3453</c:v>
                </c:pt>
                <c:pt idx="54">
                  <c:v>1688</c:v>
                </c:pt>
                <c:pt idx="55">
                  <c:v>2113</c:v>
                </c:pt>
                <c:pt idx="56">
                  <c:v>2200</c:v>
                </c:pt>
                <c:pt idx="57">
                  <c:v>2179</c:v>
                </c:pt>
                <c:pt idx="58">
                  <c:v>2165</c:v>
                </c:pt>
                <c:pt idx="59">
                  <c:v>2317</c:v>
                </c:pt>
                <c:pt idx="60">
                  <c:v>2616</c:v>
                </c:pt>
                <c:pt idx="61">
                  <c:v>2892</c:v>
                </c:pt>
                <c:pt idx="62">
                  <c:v>3459</c:v>
                </c:pt>
                <c:pt idx="63">
                  <c:v>3213</c:v>
                </c:pt>
                <c:pt idx="64">
                  <c:v>3015</c:v>
                </c:pt>
                <c:pt idx="65">
                  <c:v>3187</c:v>
                </c:pt>
                <c:pt idx="66">
                  <c:v>2678</c:v>
                </c:pt>
                <c:pt idx="67">
                  <c:v>3156</c:v>
                </c:pt>
                <c:pt idx="68">
                  <c:v>2662</c:v>
                </c:pt>
                <c:pt idx="69">
                  <c:v>2587</c:v>
                </c:pt>
                <c:pt idx="70">
                  <c:v>1970</c:v>
                </c:pt>
                <c:pt idx="71">
                  <c:v>1887</c:v>
                </c:pt>
                <c:pt idx="72">
                  <c:v>1757</c:v>
                </c:pt>
                <c:pt idx="73">
                  <c:v>1649</c:v>
                </c:pt>
                <c:pt idx="74">
                  <c:v>1793</c:v>
                </c:pt>
                <c:pt idx="75">
                  <c:v>1796</c:v>
                </c:pt>
                <c:pt idx="76">
                  <c:v>1867</c:v>
                </c:pt>
                <c:pt idx="77">
                  <c:v>12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5-1E29-3342-A2AA-0E5784E973CA}"/>
            </c:ext>
          </c:extLst>
        </c:ser>
        <c:ser>
          <c:idx val="86"/>
          <c:order val="86"/>
          <c:tx>
            <c:strRef>
              <c:f>Neat!$A$90</c:f>
              <c:strCache>
                <c:ptCount val="1"/>
                <c:pt idx="0">
                  <c:v>DQ6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accent3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0:$CA$90</c:f>
              <c:numCache>
                <c:formatCode>General</c:formatCode>
                <c:ptCount val="78"/>
                <c:pt idx="0">
                  <c:v>19116</c:v>
                </c:pt>
                <c:pt idx="1">
                  <c:v>16538</c:v>
                </c:pt>
                <c:pt idx="2">
                  <c:v>15793</c:v>
                </c:pt>
                <c:pt idx="3">
                  <c:v>13917</c:v>
                </c:pt>
                <c:pt idx="4">
                  <c:v>10110</c:v>
                </c:pt>
                <c:pt idx="5">
                  <c:v>8377</c:v>
                </c:pt>
                <c:pt idx="6">
                  <c:v>8664</c:v>
                </c:pt>
                <c:pt idx="7">
                  <c:v>8540</c:v>
                </c:pt>
                <c:pt idx="8">
                  <c:v>7274</c:v>
                </c:pt>
                <c:pt idx="9">
                  <c:v>8788</c:v>
                </c:pt>
                <c:pt idx="10">
                  <c:v>6142</c:v>
                </c:pt>
                <c:pt idx="11">
                  <c:v>6470</c:v>
                </c:pt>
                <c:pt idx="12">
                  <c:v>4920</c:v>
                </c:pt>
                <c:pt idx="13">
                  <c:v>4632</c:v>
                </c:pt>
                <c:pt idx="14">
                  <c:v>332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1385</c:v>
                </c:pt>
                <c:pt idx="20">
                  <c:v>2312</c:v>
                </c:pt>
                <c:pt idx="21">
                  <c:v>1805</c:v>
                </c:pt>
                <c:pt idx="22">
                  <c:v>2674</c:v>
                </c:pt>
                <c:pt idx="23">
                  <c:v>7643</c:v>
                </c:pt>
                <c:pt idx="24">
                  <c:v>14616</c:v>
                </c:pt>
                <c:pt idx="25">
                  <c:v>18138</c:v>
                </c:pt>
                <c:pt idx="26">
                  <c:v>22599</c:v>
                </c:pt>
                <c:pt idx="27">
                  <c:v>22345</c:v>
                </c:pt>
                <c:pt idx="28">
                  <c:v>20487</c:v>
                </c:pt>
                <c:pt idx="29">
                  <c:v>17026</c:v>
                </c:pt>
                <c:pt idx="30">
                  <c:v>7387</c:v>
                </c:pt>
                <c:pt idx="31">
                  <c:v>3572</c:v>
                </c:pt>
                <c:pt idx="32">
                  <c:v>4004</c:v>
                </c:pt>
                <c:pt idx="33">
                  <c:v>3661</c:v>
                </c:pt>
                <c:pt idx="34">
                  <c:v>4129</c:v>
                </c:pt>
                <c:pt idx="35">
                  <c:v>4184</c:v>
                </c:pt>
                <c:pt idx="36">
                  <c:v>3053</c:v>
                </c:pt>
                <c:pt idx="37">
                  <c:v>3641</c:v>
                </c:pt>
                <c:pt idx="38">
                  <c:v>2637</c:v>
                </c:pt>
                <c:pt idx="39">
                  <c:v>2054</c:v>
                </c:pt>
                <c:pt idx="40">
                  <c:v>1799</c:v>
                </c:pt>
                <c:pt idx="41">
                  <c:v>1551</c:v>
                </c:pt>
                <c:pt idx="42">
                  <c:v>1634</c:v>
                </c:pt>
                <c:pt idx="43">
                  <c:v>1333</c:v>
                </c:pt>
                <c:pt idx="44">
                  <c:v>1675</c:v>
                </c:pt>
                <c:pt idx="45">
                  <c:v>1703</c:v>
                </c:pt>
                <c:pt idx="46">
                  <c:v>1779</c:v>
                </c:pt>
                <c:pt idx="47">
                  <c:v>2027</c:v>
                </c:pt>
                <c:pt idx="48">
                  <c:v>2144</c:v>
                </c:pt>
                <c:pt idx="49">
                  <c:v>2763</c:v>
                </c:pt>
                <c:pt idx="50">
                  <c:v>2174</c:v>
                </c:pt>
                <c:pt idx="51">
                  <c:v>1248</c:v>
                </c:pt>
                <c:pt idx="52">
                  <c:v>1639</c:v>
                </c:pt>
                <c:pt idx="53">
                  <c:v>3338</c:v>
                </c:pt>
                <c:pt idx="54">
                  <c:v>1918</c:v>
                </c:pt>
                <c:pt idx="55">
                  <c:v>2185</c:v>
                </c:pt>
                <c:pt idx="56">
                  <c:v>2188</c:v>
                </c:pt>
                <c:pt idx="57">
                  <c:v>2136</c:v>
                </c:pt>
                <c:pt idx="58">
                  <c:v>2152</c:v>
                </c:pt>
                <c:pt idx="59">
                  <c:v>2250</c:v>
                </c:pt>
                <c:pt idx="60">
                  <c:v>2524</c:v>
                </c:pt>
                <c:pt idx="61">
                  <c:v>2768</c:v>
                </c:pt>
                <c:pt idx="62">
                  <c:v>3294</c:v>
                </c:pt>
                <c:pt idx="63">
                  <c:v>3199</c:v>
                </c:pt>
                <c:pt idx="64">
                  <c:v>2836</c:v>
                </c:pt>
                <c:pt idx="65">
                  <c:v>3026</c:v>
                </c:pt>
                <c:pt idx="66">
                  <c:v>2481</c:v>
                </c:pt>
                <c:pt idx="67">
                  <c:v>2978</c:v>
                </c:pt>
                <c:pt idx="68">
                  <c:v>2476</c:v>
                </c:pt>
                <c:pt idx="69">
                  <c:v>2464</c:v>
                </c:pt>
                <c:pt idx="70">
                  <c:v>1717</c:v>
                </c:pt>
                <c:pt idx="71">
                  <c:v>1792</c:v>
                </c:pt>
                <c:pt idx="72">
                  <c:v>1542</c:v>
                </c:pt>
                <c:pt idx="73">
                  <c:v>1630</c:v>
                </c:pt>
                <c:pt idx="74">
                  <c:v>1557</c:v>
                </c:pt>
                <c:pt idx="75">
                  <c:v>1819</c:v>
                </c:pt>
                <c:pt idx="76">
                  <c:v>2023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6-1E29-3342-A2AA-0E5784E973CA}"/>
            </c:ext>
          </c:extLst>
        </c:ser>
        <c:ser>
          <c:idx val="87"/>
          <c:order val="87"/>
          <c:tx>
            <c:strRef>
              <c:f>Neat!$A$91</c:f>
              <c:strCache>
                <c:ptCount val="1"/>
                <c:pt idx="0">
                  <c:v>DQA1*04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1:$CA$91</c:f>
              <c:numCache>
                <c:formatCode>General</c:formatCode>
                <c:ptCount val="7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59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7-1E29-3342-A2AA-0E5784E973CA}"/>
            </c:ext>
          </c:extLst>
        </c:ser>
        <c:ser>
          <c:idx val="88"/>
          <c:order val="88"/>
          <c:tx>
            <c:strRef>
              <c:f>Neat!$A$92</c:f>
              <c:strCache>
                <c:ptCount val="1"/>
                <c:pt idx="0">
                  <c:v>DR1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</a:schemeClr>
              </a:solidFill>
              <a:ln w="9525">
                <a:solidFill>
                  <a:schemeClr val="accent5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2:$CA$92</c:f>
              <c:numCache>
                <c:formatCode>General</c:formatCode>
                <c:ptCount val="78"/>
                <c:pt idx="0">
                  <c:v>4147</c:v>
                </c:pt>
                <c:pt idx="1">
                  <c:v>1609</c:v>
                </c:pt>
                <c:pt idx="2">
                  <c:v>1221</c:v>
                </c:pt>
                <c:pt idx="3">
                  <c:v>1257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858</c:v>
                </c:pt>
                <c:pt idx="27">
                  <c:v>169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8-1E29-3342-A2AA-0E5784E973CA}"/>
            </c:ext>
          </c:extLst>
        </c:ser>
        <c:ser>
          <c:idx val="89"/>
          <c:order val="89"/>
          <c:tx>
            <c:strRef>
              <c:f>Neat!$A$93</c:f>
              <c:strCache>
                <c:ptCount val="1"/>
                <c:pt idx="0">
                  <c:v>DR10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3:$CA$93</c:f>
              <c:numCache>
                <c:formatCode>General</c:formatCode>
                <c:ptCount val="78"/>
                <c:pt idx="0">
                  <c:v>7409</c:v>
                </c:pt>
                <c:pt idx="1">
                  <c:v>2599</c:v>
                </c:pt>
                <c:pt idx="2">
                  <c:v>2164</c:v>
                </c:pt>
                <c:pt idx="3">
                  <c:v>2064</c:v>
                </c:pt>
                <c:pt idx="4">
                  <c:v>1377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437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2152</c:v>
                </c:pt>
                <c:pt idx="27">
                  <c:v>207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121</c:v>
                </c:pt>
                <c:pt idx="58">
                  <c:v>1028</c:v>
                </c:pt>
                <c:pt idx="59">
                  <c:v>1082</c:v>
                </c:pt>
                <c:pt idx="60">
                  <c:v>1119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9-1E29-3342-A2AA-0E5784E973CA}"/>
            </c:ext>
          </c:extLst>
        </c:ser>
        <c:ser>
          <c:idx val="90"/>
          <c:order val="90"/>
          <c:tx>
            <c:strRef>
              <c:f>Neat!$A$94</c:f>
              <c:strCache>
                <c:ptCount val="1"/>
                <c:pt idx="0">
                  <c:v>DR103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  <a:lumOff val="30000"/>
                </a:schemeClr>
              </a:solidFill>
              <a:ln w="9525">
                <a:solidFill>
                  <a:schemeClr val="accent1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4:$CA$94</c:f>
              <c:numCache>
                <c:formatCode>General</c:formatCode>
                <c:ptCount val="78"/>
                <c:pt idx="0">
                  <c:v>3740</c:v>
                </c:pt>
                <c:pt idx="1">
                  <c:v>1496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A-1E29-3342-A2AA-0E5784E973CA}"/>
            </c:ext>
          </c:extLst>
        </c:ser>
        <c:ser>
          <c:idx val="91"/>
          <c:order val="91"/>
          <c:tx>
            <c:strRef>
              <c:f>Neat!$A$95</c:f>
              <c:strCache>
                <c:ptCount val="1"/>
                <c:pt idx="0">
                  <c:v>DR12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5:$CA$95</c:f>
              <c:numCache>
                <c:formatCode>General</c:formatCode>
                <c:ptCount val="78"/>
                <c:pt idx="0">
                  <c:v>2009</c:v>
                </c:pt>
                <c:pt idx="1">
                  <c:v>0</c:v>
                </c:pt>
                <c:pt idx="2">
                  <c:v>103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B-1E29-3342-A2AA-0E5784E973CA}"/>
            </c:ext>
          </c:extLst>
        </c:ser>
        <c:ser>
          <c:idx val="92"/>
          <c:order val="92"/>
          <c:tx>
            <c:strRef>
              <c:f>Neat!$A$96</c:f>
              <c:strCache>
                <c:ptCount val="1"/>
                <c:pt idx="0">
                  <c:v>DR15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  <a:lumOff val="30000"/>
                </a:schemeClr>
              </a:solidFill>
              <a:ln w="9525">
                <a:solidFill>
                  <a:schemeClr val="accent3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6:$CA$96</c:f>
              <c:numCache>
                <c:formatCode>General</c:formatCode>
                <c:ptCount val="78"/>
                <c:pt idx="0">
                  <c:v>21902</c:v>
                </c:pt>
                <c:pt idx="1">
                  <c:v>20670</c:v>
                </c:pt>
                <c:pt idx="2">
                  <c:v>19233</c:v>
                </c:pt>
                <c:pt idx="3">
                  <c:v>17244</c:v>
                </c:pt>
                <c:pt idx="4">
                  <c:v>13359</c:v>
                </c:pt>
                <c:pt idx="5">
                  <c:v>10605</c:v>
                </c:pt>
                <c:pt idx="6">
                  <c:v>10579</c:v>
                </c:pt>
                <c:pt idx="7">
                  <c:v>10044</c:v>
                </c:pt>
                <c:pt idx="8">
                  <c:v>8778</c:v>
                </c:pt>
                <c:pt idx="9">
                  <c:v>10065</c:v>
                </c:pt>
                <c:pt idx="10">
                  <c:v>7171</c:v>
                </c:pt>
                <c:pt idx="11">
                  <c:v>7909</c:v>
                </c:pt>
                <c:pt idx="12">
                  <c:v>5286</c:v>
                </c:pt>
                <c:pt idx="13">
                  <c:v>4458</c:v>
                </c:pt>
                <c:pt idx="14">
                  <c:v>3599</c:v>
                </c:pt>
                <c:pt idx="15">
                  <c:v>1575</c:v>
                </c:pt>
                <c:pt idx="16">
                  <c:v>2241</c:v>
                </c:pt>
                <c:pt idx="17">
                  <c:v>2492</c:v>
                </c:pt>
                <c:pt idx="18">
                  <c:v>1851</c:v>
                </c:pt>
                <c:pt idx="19">
                  <c:v>2391</c:v>
                </c:pt>
                <c:pt idx="20">
                  <c:v>3461</c:v>
                </c:pt>
                <c:pt idx="21">
                  <c:v>2136</c:v>
                </c:pt>
                <c:pt idx="22">
                  <c:v>0</c:v>
                </c:pt>
                <c:pt idx="23">
                  <c:v>1614</c:v>
                </c:pt>
                <c:pt idx="24">
                  <c:v>2378</c:v>
                </c:pt>
                <c:pt idx="25">
                  <c:v>3303</c:v>
                </c:pt>
                <c:pt idx="26">
                  <c:v>3961</c:v>
                </c:pt>
                <c:pt idx="27">
                  <c:v>4908</c:v>
                </c:pt>
                <c:pt idx="28">
                  <c:v>2119</c:v>
                </c:pt>
                <c:pt idx="29">
                  <c:v>1748</c:v>
                </c:pt>
                <c:pt idx="30">
                  <c:v>1450</c:v>
                </c:pt>
                <c:pt idx="31">
                  <c:v>1626</c:v>
                </c:pt>
                <c:pt idx="32">
                  <c:v>1997</c:v>
                </c:pt>
                <c:pt idx="33">
                  <c:v>1887</c:v>
                </c:pt>
                <c:pt idx="34">
                  <c:v>1820</c:v>
                </c:pt>
                <c:pt idx="35">
                  <c:v>2154</c:v>
                </c:pt>
                <c:pt idx="36">
                  <c:v>1930</c:v>
                </c:pt>
                <c:pt idx="37">
                  <c:v>2358</c:v>
                </c:pt>
                <c:pt idx="38">
                  <c:v>1922</c:v>
                </c:pt>
                <c:pt idx="39">
                  <c:v>2025</c:v>
                </c:pt>
                <c:pt idx="40">
                  <c:v>1954</c:v>
                </c:pt>
                <c:pt idx="41">
                  <c:v>1725</c:v>
                </c:pt>
                <c:pt idx="42">
                  <c:v>1772</c:v>
                </c:pt>
                <c:pt idx="43">
                  <c:v>1943</c:v>
                </c:pt>
                <c:pt idx="44">
                  <c:v>2230</c:v>
                </c:pt>
                <c:pt idx="45">
                  <c:v>2447</c:v>
                </c:pt>
                <c:pt idx="46">
                  <c:v>1664</c:v>
                </c:pt>
                <c:pt idx="47">
                  <c:v>1933</c:v>
                </c:pt>
                <c:pt idx="48">
                  <c:v>1899</c:v>
                </c:pt>
                <c:pt idx="49">
                  <c:v>2274</c:v>
                </c:pt>
                <c:pt idx="50">
                  <c:v>1804</c:v>
                </c:pt>
                <c:pt idx="51">
                  <c:v>1428</c:v>
                </c:pt>
                <c:pt idx="52">
                  <c:v>1591</c:v>
                </c:pt>
                <c:pt idx="53">
                  <c:v>3246</c:v>
                </c:pt>
                <c:pt idx="54">
                  <c:v>1981</c:v>
                </c:pt>
                <c:pt idx="55">
                  <c:v>3296</c:v>
                </c:pt>
                <c:pt idx="56">
                  <c:v>3326</c:v>
                </c:pt>
                <c:pt idx="57">
                  <c:v>3045</c:v>
                </c:pt>
                <c:pt idx="58">
                  <c:v>2840</c:v>
                </c:pt>
                <c:pt idx="59">
                  <c:v>3040</c:v>
                </c:pt>
                <c:pt idx="60">
                  <c:v>3412</c:v>
                </c:pt>
                <c:pt idx="61">
                  <c:v>2854</c:v>
                </c:pt>
                <c:pt idx="62">
                  <c:v>3491</c:v>
                </c:pt>
                <c:pt idx="63">
                  <c:v>3190</c:v>
                </c:pt>
                <c:pt idx="64">
                  <c:v>3042</c:v>
                </c:pt>
                <c:pt idx="65">
                  <c:v>3166</c:v>
                </c:pt>
                <c:pt idx="66">
                  <c:v>2193</c:v>
                </c:pt>
                <c:pt idx="67">
                  <c:v>2794</c:v>
                </c:pt>
                <c:pt idx="68">
                  <c:v>2466</c:v>
                </c:pt>
                <c:pt idx="69">
                  <c:v>2475</c:v>
                </c:pt>
                <c:pt idx="70">
                  <c:v>1939</c:v>
                </c:pt>
                <c:pt idx="71">
                  <c:v>2208</c:v>
                </c:pt>
                <c:pt idx="72">
                  <c:v>1926</c:v>
                </c:pt>
                <c:pt idx="73">
                  <c:v>1953</c:v>
                </c:pt>
                <c:pt idx="74">
                  <c:v>2193</c:v>
                </c:pt>
                <c:pt idx="75">
                  <c:v>2368</c:v>
                </c:pt>
                <c:pt idx="76">
                  <c:v>2425</c:v>
                </c:pt>
                <c:pt idx="77">
                  <c:v>12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C-1E29-3342-A2AA-0E5784E973CA}"/>
            </c:ext>
          </c:extLst>
        </c:ser>
        <c:ser>
          <c:idx val="93"/>
          <c:order val="93"/>
          <c:tx>
            <c:strRef>
              <c:f>Neat!$A$97</c:f>
              <c:strCache>
                <c:ptCount val="1"/>
                <c:pt idx="0">
                  <c:v>DR16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7:$CA$97</c:f>
              <c:numCache>
                <c:formatCode>General</c:formatCode>
                <c:ptCount val="78"/>
                <c:pt idx="0">
                  <c:v>21821</c:v>
                </c:pt>
                <c:pt idx="1">
                  <c:v>19909</c:v>
                </c:pt>
                <c:pt idx="2">
                  <c:v>18192</c:v>
                </c:pt>
                <c:pt idx="3">
                  <c:v>16475</c:v>
                </c:pt>
                <c:pt idx="4">
                  <c:v>12825</c:v>
                </c:pt>
                <c:pt idx="5">
                  <c:v>9987</c:v>
                </c:pt>
                <c:pt idx="6">
                  <c:v>9604</c:v>
                </c:pt>
                <c:pt idx="7">
                  <c:v>9300</c:v>
                </c:pt>
                <c:pt idx="8">
                  <c:v>8380</c:v>
                </c:pt>
                <c:pt idx="9">
                  <c:v>9183</c:v>
                </c:pt>
                <c:pt idx="10">
                  <c:v>6545</c:v>
                </c:pt>
                <c:pt idx="11">
                  <c:v>7241</c:v>
                </c:pt>
                <c:pt idx="12">
                  <c:v>4777</c:v>
                </c:pt>
                <c:pt idx="13">
                  <c:v>4175</c:v>
                </c:pt>
                <c:pt idx="14">
                  <c:v>3262</c:v>
                </c:pt>
                <c:pt idx="15">
                  <c:v>1394</c:v>
                </c:pt>
                <c:pt idx="16">
                  <c:v>2036</c:v>
                </c:pt>
                <c:pt idx="17">
                  <c:v>2309</c:v>
                </c:pt>
                <c:pt idx="18">
                  <c:v>1641</c:v>
                </c:pt>
                <c:pt idx="19">
                  <c:v>2258</c:v>
                </c:pt>
                <c:pt idx="20">
                  <c:v>3218</c:v>
                </c:pt>
                <c:pt idx="21">
                  <c:v>1984</c:v>
                </c:pt>
                <c:pt idx="22">
                  <c:v>0</c:v>
                </c:pt>
                <c:pt idx="23">
                  <c:v>1539</c:v>
                </c:pt>
                <c:pt idx="24">
                  <c:v>2230</c:v>
                </c:pt>
                <c:pt idx="25">
                  <c:v>3047</c:v>
                </c:pt>
                <c:pt idx="26">
                  <c:v>3727</c:v>
                </c:pt>
                <c:pt idx="27">
                  <c:v>4454</c:v>
                </c:pt>
                <c:pt idx="28">
                  <c:v>2091</c:v>
                </c:pt>
                <c:pt idx="29">
                  <c:v>1625</c:v>
                </c:pt>
                <c:pt idx="30">
                  <c:v>1527</c:v>
                </c:pt>
                <c:pt idx="31">
                  <c:v>1462</c:v>
                </c:pt>
                <c:pt idx="32">
                  <c:v>1863</c:v>
                </c:pt>
                <c:pt idx="33">
                  <c:v>1759</c:v>
                </c:pt>
                <c:pt idx="34">
                  <c:v>1640</c:v>
                </c:pt>
                <c:pt idx="35">
                  <c:v>1977</c:v>
                </c:pt>
                <c:pt idx="36">
                  <c:v>1744</c:v>
                </c:pt>
                <c:pt idx="37">
                  <c:v>1906</c:v>
                </c:pt>
                <c:pt idx="38">
                  <c:v>1713</c:v>
                </c:pt>
                <c:pt idx="39">
                  <c:v>1854</c:v>
                </c:pt>
                <c:pt idx="40">
                  <c:v>1813</c:v>
                </c:pt>
                <c:pt idx="41">
                  <c:v>1555</c:v>
                </c:pt>
                <c:pt idx="42">
                  <c:v>1602</c:v>
                </c:pt>
                <c:pt idx="43">
                  <c:v>1754</c:v>
                </c:pt>
                <c:pt idx="44">
                  <c:v>1972</c:v>
                </c:pt>
                <c:pt idx="45">
                  <c:v>2186</c:v>
                </c:pt>
                <c:pt idx="46">
                  <c:v>1575</c:v>
                </c:pt>
                <c:pt idx="47">
                  <c:v>1712</c:v>
                </c:pt>
                <c:pt idx="48">
                  <c:v>1664</c:v>
                </c:pt>
                <c:pt idx="49">
                  <c:v>1977</c:v>
                </c:pt>
                <c:pt idx="50">
                  <c:v>1548</c:v>
                </c:pt>
                <c:pt idx="51">
                  <c:v>1295</c:v>
                </c:pt>
                <c:pt idx="52">
                  <c:v>1360</c:v>
                </c:pt>
                <c:pt idx="53">
                  <c:v>2992</c:v>
                </c:pt>
                <c:pt idx="54">
                  <c:v>1883</c:v>
                </c:pt>
                <c:pt idx="55">
                  <c:v>2995</c:v>
                </c:pt>
                <c:pt idx="56">
                  <c:v>2943</c:v>
                </c:pt>
                <c:pt idx="57">
                  <c:v>2676</c:v>
                </c:pt>
                <c:pt idx="58">
                  <c:v>2471</c:v>
                </c:pt>
                <c:pt idx="59">
                  <c:v>2624</c:v>
                </c:pt>
                <c:pt idx="60">
                  <c:v>2933</c:v>
                </c:pt>
                <c:pt idx="61">
                  <c:v>2505</c:v>
                </c:pt>
                <c:pt idx="62">
                  <c:v>3129</c:v>
                </c:pt>
                <c:pt idx="63">
                  <c:v>2800</c:v>
                </c:pt>
                <c:pt idx="64">
                  <c:v>2674</c:v>
                </c:pt>
                <c:pt idx="65">
                  <c:v>2788</c:v>
                </c:pt>
                <c:pt idx="66">
                  <c:v>1894</c:v>
                </c:pt>
                <c:pt idx="67">
                  <c:v>2382</c:v>
                </c:pt>
                <c:pt idx="68">
                  <c:v>2130</c:v>
                </c:pt>
                <c:pt idx="69">
                  <c:v>2078</c:v>
                </c:pt>
                <c:pt idx="70">
                  <c:v>1684</c:v>
                </c:pt>
                <c:pt idx="71">
                  <c:v>1909</c:v>
                </c:pt>
                <c:pt idx="72">
                  <c:v>1683</c:v>
                </c:pt>
                <c:pt idx="73">
                  <c:v>1663</c:v>
                </c:pt>
                <c:pt idx="74">
                  <c:v>1841</c:v>
                </c:pt>
                <c:pt idx="75">
                  <c:v>2286</c:v>
                </c:pt>
                <c:pt idx="76">
                  <c:v>2313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D-1E29-3342-A2AA-0E5784E973CA}"/>
            </c:ext>
          </c:extLst>
        </c:ser>
        <c:ser>
          <c:idx val="94"/>
          <c:order val="94"/>
          <c:tx>
            <c:strRef>
              <c:f>Neat!$A$98</c:f>
              <c:strCache>
                <c:ptCount val="1"/>
                <c:pt idx="0">
                  <c:v>DR4</c:v>
                </c:pt>
              </c:strCache>
            </c:strRef>
          </c:tx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70000"/>
                  <a:lumOff val="30000"/>
                </a:schemeClr>
              </a:solidFill>
              <a:ln w="9525">
                <a:solidFill>
                  <a:schemeClr val="accent5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8:$CA$98</c:f>
              <c:numCache>
                <c:formatCode>General</c:formatCode>
                <c:ptCount val="78"/>
                <c:pt idx="0">
                  <c:v>18142</c:v>
                </c:pt>
                <c:pt idx="1">
                  <c:v>9940</c:v>
                </c:pt>
                <c:pt idx="2">
                  <c:v>8882</c:v>
                </c:pt>
                <c:pt idx="3">
                  <c:v>7392</c:v>
                </c:pt>
                <c:pt idx="4">
                  <c:v>5325</c:v>
                </c:pt>
                <c:pt idx="5">
                  <c:v>3894</c:v>
                </c:pt>
                <c:pt idx="6">
                  <c:v>4156</c:v>
                </c:pt>
                <c:pt idx="7">
                  <c:v>4057</c:v>
                </c:pt>
                <c:pt idx="8">
                  <c:v>3753</c:v>
                </c:pt>
                <c:pt idx="9">
                  <c:v>4601</c:v>
                </c:pt>
                <c:pt idx="10">
                  <c:v>3052</c:v>
                </c:pt>
                <c:pt idx="11">
                  <c:v>3301</c:v>
                </c:pt>
                <c:pt idx="12">
                  <c:v>2790</c:v>
                </c:pt>
                <c:pt idx="13">
                  <c:v>2565</c:v>
                </c:pt>
                <c:pt idx="14">
                  <c:v>1761</c:v>
                </c:pt>
                <c:pt idx="15">
                  <c:v>0</c:v>
                </c:pt>
                <c:pt idx="16">
                  <c:v>1533</c:v>
                </c:pt>
                <c:pt idx="17">
                  <c:v>3340</c:v>
                </c:pt>
                <c:pt idx="18">
                  <c:v>2228</c:v>
                </c:pt>
                <c:pt idx="19">
                  <c:v>2935</c:v>
                </c:pt>
                <c:pt idx="20">
                  <c:v>3883</c:v>
                </c:pt>
                <c:pt idx="21">
                  <c:v>2120</c:v>
                </c:pt>
                <c:pt idx="22">
                  <c:v>0</c:v>
                </c:pt>
                <c:pt idx="23">
                  <c:v>1391</c:v>
                </c:pt>
                <c:pt idx="24">
                  <c:v>1565</c:v>
                </c:pt>
                <c:pt idx="25">
                  <c:v>0</c:v>
                </c:pt>
                <c:pt idx="26">
                  <c:v>3021</c:v>
                </c:pt>
                <c:pt idx="27">
                  <c:v>3210</c:v>
                </c:pt>
                <c:pt idx="28">
                  <c:v>1320</c:v>
                </c:pt>
                <c:pt idx="29">
                  <c:v>157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1290</c:v>
                </c:pt>
                <c:pt idx="47">
                  <c:v>1338</c:v>
                </c:pt>
                <c:pt idx="48">
                  <c:v>0</c:v>
                </c:pt>
                <c:pt idx="49">
                  <c:v>1216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438</c:v>
                </c:pt>
                <c:pt idx="54">
                  <c:v>1663</c:v>
                </c:pt>
                <c:pt idx="55">
                  <c:v>1261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E-1E29-3342-A2AA-0E5784E973CA}"/>
            </c:ext>
          </c:extLst>
        </c:ser>
        <c:ser>
          <c:idx val="95"/>
          <c:order val="95"/>
          <c:tx>
            <c:strRef>
              <c:f>Neat!$A$99</c:f>
              <c:strCache>
                <c:ptCount val="1"/>
                <c:pt idx="0">
                  <c:v>DR51</c:v>
                </c:pt>
              </c:strCache>
            </c:strRef>
          </c:tx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0000"/>
                  <a:lumOff val="30000"/>
                </a:schemeClr>
              </a:solidFill>
              <a:ln w="9525">
                <a:solidFill>
                  <a:schemeClr val="accent6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99:$CA$99</c:f>
              <c:numCache>
                <c:formatCode>General</c:formatCode>
                <c:ptCount val="78"/>
                <c:pt idx="0">
                  <c:v>7758</c:v>
                </c:pt>
                <c:pt idx="1">
                  <c:v>3519</c:v>
                </c:pt>
                <c:pt idx="2">
                  <c:v>2998</c:v>
                </c:pt>
                <c:pt idx="3">
                  <c:v>2390</c:v>
                </c:pt>
                <c:pt idx="4">
                  <c:v>151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443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F-1E29-3342-A2AA-0E5784E973CA}"/>
            </c:ext>
          </c:extLst>
        </c:ser>
        <c:ser>
          <c:idx val="96"/>
          <c:order val="96"/>
          <c:tx>
            <c:strRef>
              <c:f>Neat!$A$100</c:f>
              <c:strCache>
                <c:ptCount val="1"/>
                <c:pt idx="0">
                  <c:v>DR53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00:$CA$100</c:f>
              <c:numCache>
                <c:formatCode>General</c:formatCode>
                <c:ptCount val="78"/>
                <c:pt idx="0">
                  <c:v>19270</c:v>
                </c:pt>
                <c:pt idx="1">
                  <c:v>12176</c:v>
                </c:pt>
                <c:pt idx="2">
                  <c:v>11737</c:v>
                </c:pt>
                <c:pt idx="3">
                  <c:v>10033</c:v>
                </c:pt>
                <c:pt idx="4">
                  <c:v>7007</c:v>
                </c:pt>
                <c:pt idx="5">
                  <c:v>5680</c:v>
                </c:pt>
                <c:pt idx="6">
                  <c:v>5910</c:v>
                </c:pt>
                <c:pt idx="7">
                  <c:v>5751</c:v>
                </c:pt>
                <c:pt idx="8">
                  <c:v>5204</c:v>
                </c:pt>
                <c:pt idx="9">
                  <c:v>6094</c:v>
                </c:pt>
                <c:pt idx="10">
                  <c:v>4274</c:v>
                </c:pt>
                <c:pt idx="11">
                  <c:v>4618</c:v>
                </c:pt>
                <c:pt idx="12">
                  <c:v>3281</c:v>
                </c:pt>
                <c:pt idx="13">
                  <c:v>2749</c:v>
                </c:pt>
                <c:pt idx="14">
                  <c:v>1845</c:v>
                </c:pt>
                <c:pt idx="15">
                  <c:v>0</c:v>
                </c:pt>
                <c:pt idx="16">
                  <c:v>0</c:v>
                </c:pt>
                <c:pt idx="17">
                  <c:v>1529</c:v>
                </c:pt>
                <c:pt idx="18">
                  <c:v>1073</c:v>
                </c:pt>
                <c:pt idx="19">
                  <c:v>2307</c:v>
                </c:pt>
                <c:pt idx="20">
                  <c:v>2867</c:v>
                </c:pt>
                <c:pt idx="21">
                  <c:v>1717</c:v>
                </c:pt>
                <c:pt idx="22">
                  <c:v>0</c:v>
                </c:pt>
                <c:pt idx="23">
                  <c:v>0</c:v>
                </c:pt>
                <c:pt idx="24">
                  <c:v>1852</c:v>
                </c:pt>
                <c:pt idx="25">
                  <c:v>0</c:v>
                </c:pt>
                <c:pt idx="26">
                  <c:v>3686</c:v>
                </c:pt>
                <c:pt idx="27">
                  <c:v>3976</c:v>
                </c:pt>
                <c:pt idx="28">
                  <c:v>1858</c:v>
                </c:pt>
                <c:pt idx="29">
                  <c:v>1752</c:v>
                </c:pt>
                <c:pt idx="30">
                  <c:v>1310</c:v>
                </c:pt>
                <c:pt idx="31">
                  <c:v>0</c:v>
                </c:pt>
                <c:pt idx="32">
                  <c:v>1506</c:v>
                </c:pt>
                <c:pt idx="33">
                  <c:v>1379</c:v>
                </c:pt>
                <c:pt idx="34">
                  <c:v>1503</c:v>
                </c:pt>
                <c:pt idx="35">
                  <c:v>1783</c:v>
                </c:pt>
                <c:pt idx="36">
                  <c:v>1565</c:v>
                </c:pt>
                <c:pt idx="37">
                  <c:v>1606</c:v>
                </c:pt>
                <c:pt idx="38">
                  <c:v>1505</c:v>
                </c:pt>
                <c:pt idx="39">
                  <c:v>1565</c:v>
                </c:pt>
                <c:pt idx="40">
                  <c:v>1574</c:v>
                </c:pt>
                <c:pt idx="41">
                  <c:v>1300</c:v>
                </c:pt>
                <c:pt idx="42">
                  <c:v>1367</c:v>
                </c:pt>
                <c:pt idx="43">
                  <c:v>1358</c:v>
                </c:pt>
                <c:pt idx="44">
                  <c:v>1465</c:v>
                </c:pt>
                <c:pt idx="45">
                  <c:v>1519</c:v>
                </c:pt>
                <c:pt idx="46">
                  <c:v>0</c:v>
                </c:pt>
                <c:pt idx="47">
                  <c:v>1430</c:v>
                </c:pt>
                <c:pt idx="48">
                  <c:v>0</c:v>
                </c:pt>
                <c:pt idx="49">
                  <c:v>1442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815</c:v>
                </c:pt>
                <c:pt idx="54">
                  <c:v>1752</c:v>
                </c:pt>
                <c:pt idx="55">
                  <c:v>2064</c:v>
                </c:pt>
                <c:pt idx="56">
                  <c:v>1990</c:v>
                </c:pt>
                <c:pt idx="57">
                  <c:v>1674</c:v>
                </c:pt>
                <c:pt idx="58">
                  <c:v>1625</c:v>
                </c:pt>
                <c:pt idx="59">
                  <c:v>1615</c:v>
                </c:pt>
                <c:pt idx="60">
                  <c:v>1754</c:v>
                </c:pt>
                <c:pt idx="61">
                  <c:v>1555</c:v>
                </c:pt>
                <c:pt idx="62">
                  <c:v>1846</c:v>
                </c:pt>
                <c:pt idx="63">
                  <c:v>1659</c:v>
                </c:pt>
                <c:pt idx="64">
                  <c:v>1632</c:v>
                </c:pt>
                <c:pt idx="65">
                  <c:v>1700</c:v>
                </c:pt>
                <c:pt idx="66">
                  <c:v>1438</c:v>
                </c:pt>
                <c:pt idx="67">
                  <c:v>1662</c:v>
                </c:pt>
                <c:pt idx="68">
                  <c:v>1434</c:v>
                </c:pt>
                <c:pt idx="69">
                  <c:v>1420</c:v>
                </c:pt>
                <c:pt idx="70">
                  <c:v>1136</c:v>
                </c:pt>
                <c:pt idx="71">
                  <c:v>1383</c:v>
                </c:pt>
                <c:pt idx="72">
                  <c:v>1158</c:v>
                </c:pt>
                <c:pt idx="73">
                  <c:v>1193</c:v>
                </c:pt>
                <c:pt idx="74">
                  <c:v>1256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60-1E29-3342-A2AA-0E5784E973CA}"/>
            </c:ext>
          </c:extLst>
        </c:ser>
        <c:ser>
          <c:idx val="97"/>
          <c:order val="97"/>
          <c:tx>
            <c:strRef>
              <c:f>Neat!$A$101</c:f>
              <c:strCache>
                <c:ptCount val="1"/>
                <c:pt idx="0">
                  <c:v>DR7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01:$CA$101</c:f>
              <c:numCache>
                <c:formatCode>General</c:formatCode>
                <c:ptCount val="78"/>
                <c:pt idx="0">
                  <c:v>7395</c:v>
                </c:pt>
                <c:pt idx="1">
                  <c:v>1676</c:v>
                </c:pt>
                <c:pt idx="2">
                  <c:v>1630</c:v>
                </c:pt>
                <c:pt idx="3">
                  <c:v>110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74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61-1E29-3342-A2AA-0E5784E973CA}"/>
            </c:ext>
          </c:extLst>
        </c:ser>
        <c:ser>
          <c:idx val="98"/>
          <c:order val="98"/>
          <c:tx>
            <c:strRef>
              <c:f>Neat!$A$102</c:f>
              <c:strCache>
                <c:ptCount val="1"/>
                <c:pt idx="0">
                  <c:v>DR9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</a:schemeClr>
              </a:solidFill>
              <a:ln w="9525">
                <a:solidFill>
                  <a:schemeClr val="accent3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02:$CA$102</c:f>
              <c:numCache>
                <c:formatCode>General</c:formatCode>
                <c:ptCount val="78"/>
                <c:pt idx="0">
                  <c:v>5517</c:v>
                </c:pt>
                <c:pt idx="1">
                  <c:v>2376</c:v>
                </c:pt>
                <c:pt idx="2">
                  <c:v>1876</c:v>
                </c:pt>
                <c:pt idx="3">
                  <c:v>160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902</c:v>
                </c:pt>
                <c:pt idx="27">
                  <c:v>1729</c:v>
                </c:pt>
                <c:pt idx="28">
                  <c:v>0</c:v>
                </c:pt>
                <c:pt idx="29">
                  <c:v>1306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62-1E29-3342-A2AA-0E5784E973CA}"/>
            </c:ext>
          </c:extLst>
        </c:ser>
        <c:ser>
          <c:idx val="99"/>
          <c:order val="99"/>
          <c:tx>
            <c:strRef>
              <c:f>Neat!$A$103</c:f>
              <c:strCache>
                <c:ptCount val="1"/>
                <c:pt idx="0">
                  <c:v>DRB1*14:01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</a:schemeClr>
              </a:solidFill>
              <a:ln w="9525">
                <a:solidFill>
                  <a:schemeClr val="accent4">
                    <a:lumMod val="70000"/>
                  </a:schemeClr>
                </a:solidFill>
              </a:ln>
              <a:effectLst/>
            </c:spPr>
          </c:marker>
          <c:cat>
            <c:numRef>
              <c:f>Neat!$B$3:$CA$3</c:f>
              <c:numCache>
                <c:formatCode>General</c:formatCode>
                <c:ptCount val="78"/>
                <c:pt idx="0">
                  <c:v>-19</c:v>
                </c:pt>
                <c:pt idx="1">
                  <c:v>7</c:v>
                </c:pt>
                <c:pt idx="2">
                  <c:v>24</c:v>
                </c:pt>
                <c:pt idx="3">
                  <c:v>45</c:v>
                </c:pt>
                <c:pt idx="4">
                  <c:v>56</c:v>
                </c:pt>
                <c:pt idx="5">
                  <c:v>66</c:v>
                </c:pt>
                <c:pt idx="6">
                  <c:v>80</c:v>
                </c:pt>
                <c:pt idx="7">
                  <c:v>87</c:v>
                </c:pt>
                <c:pt idx="8">
                  <c:v>94</c:v>
                </c:pt>
                <c:pt idx="9">
                  <c:v>101</c:v>
                </c:pt>
                <c:pt idx="10">
                  <c:v>108</c:v>
                </c:pt>
                <c:pt idx="11">
                  <c:v>115</c:v>
                </c:pt>
                <c:pt idx="12">
                  <c:v>191</c:v>
                </c:pt>
                <c:pt idx="13">
                  <c:v>227</c:v>
                </c:pt>
                <c:pt idx="14">
                  <c:v>241</c:v>
                </c:pt>
                <c:pt idx="15">
                  <c:v>251</c:v>
                </c:pt>
                <c:pt idx="16">
                  <c:v>254</c:v>
                </c:pt>
                <c:pt idx="17">
                  <c:v>258</c:v>
                </c:pt>
                <c:pt idx="18">
                  <c:v>261</c:v>
                </c:pt>
                <c:pt idx="19">
                  <c:v>265</c:v>
                </c:pt>
                <c:pt idx="20">
                  <c:v>268</c:v>
                </c:pt>
                <c:pt idx="21">
                  <c:v>272</c:v>
                </c:pt>
                <c:pt idx="22">
                  <c:v>279</c:v>
                </c:pt>
                <c:pt idx="23">
                  <c:v>286</c:v>
                </c:pt>
                <c:pt idx="24">
                  <c:v>293</c:v>
                </c:pt>
                <c:pt idx="25">
                  <c:v>296</c:v>
                </c:pt>
                <c:pt idx="26">
                  <c:v>300</c:v>
                </c:pt>
                <c:pt idx="27">
                  <c:v>307</c:v>
                </c:pt>
                <c:pt idx="28">
                  <c:v>321</c:v>
                </c:pt>
                <c:pt idx="29">
                  <c:v>328</c:v>
                </c:pt>
                <c:pt idx="30">
                  <c:v>336</c:v>
                </c:pt>
                <c:pt idx="31">
                  <c:v>344</c:v>
                </c:pt>
                <c:pt idx="32">
                  <c:v>349</c:v>
                </c:pt>
                <c:pt idx="33">
                  <c:v>352</c:v>
                </c:pt>
                <c:pt idx="34">
                  <c:v>358</c:v>
                </c:pt>
                <c:pt idx="35">
                  <c:v>364</c:v>
                </c:pt>
                <c:pt idx="36">
                  <c:v>371</c:v>
                </c:pt>
                <c:pt idx="37">
                  <c:v>378</c:v>
                </c:pt>
                <c:pt idx="38">
                  <c:v>380</c:v>
                </c:pt>
                <c:pt idx="39">
                  <c:v>385</c:v>
                </c:pt>
                <c:pt idx="40">
                  <c:v>392</c:v>
                </c:pt>
                <c:pt idx="41">
                  <c:v>394</c:v>
                </c:pt>
                <c:pt idx="42">
                  <c:v>399</c:v>
                </c:pt>
                <c:pt idx="43">
                  <c:v>406</c:v>
                </c:pt>
                <c:pt idx="44">
                  <c:v>412</c:v>
                </c:pt>
                <c:pt idx="45">
                  <c:v>413</c:v>
                </c:pt>
                <c:pt idx="46">
                  <c:v>429</c:v>
                </c:pt>
                <c:pt idx="47">
                  <c:v>432</c:v>
                </c:pt>
                <c:pt idx="48">
                  <c:v>440</c:v>
                </c:pt>
                <c:pt idx="49">
                  <c:v>446</c:v>
                </c:pt>
                <c:pt idx="50">
                  <c:v>460</c:v>
                </c:pt>
                <c:pt idx="51">
                  <c:v>468</c:v>
                </c:pt>
                <c:pt idx="52">
                  <c:v>474</c:v>
                </c:pt>
                <c:pt idx="53">
                  <c:v>503</c:v>
                </c:pt>
                <c:pt idx="54">
                  <c:v>517</c:v>
                </c:pt>
                <c:pt idx="55">
                  <c:v>528</c:v>
                </c:pt>
                <c:pt idx="56">
                  <c:v>538</c:v>
                </c:pt>
                <c:pt idx="57">
                  <c:v>542</c:v>
                </c:pt>
                <c:pt idx="58">
                  <c:v>556</c:v>
                </c:pt>
                <c:pt idx="59">
                  <c:v>566</c:v>
                </c:pt>
                <c:pt idx="60">
                  <c:v>569</c:v>
                </c:pt>
                <c:pt idx="61">
                  <c:v>584</c:v>
                </c:pt>
                <c:pt idx="62">
                  <c:v>592</c:v>
                </c:pt>
                <c:pt idx="63">
                  <c:v>598</c:v>
                </c:pt>
                <c:pt idx="64">
                  <c:v>612</c:v>
                </c:pt>
                <c:pt idx="65">
                  <c:v>622</c:v>
                </c:pt>
                <c:pt idx="66">
                  <c:v>645</c:v>
                </c:pt>
                <c:pt idx="67">
                  <c:v>657</c:v>
                </c:pt>
                <c:pt idx="68">
                  <c:v>685</c:v>
                </c:pt>
                <c:pt idx="69">
                  <c:v>737</c:v>
                </c:pt>
                <c:pt idx="70">
                  <c:v>771</c:v>
                </c:pt>
                <c:pt idx="71">
                  <c:v>811</c:v>
                </c:pt>
                <c:pt idx="72">
                  <c:v>846</c:v>
                </c:pt>
                <c:pt idx="73">
                  <c:v>883</c:v>
                </c:pt>
                <c:pt idx="74">
                  <c:v>897</c:v>
                </c:pt>
                <c:pt idx="75">
                  <c:v>947</c:v>
                </c:pt>
                <c:pt idx="76">
                  <c:v>975</c:v>
                </c:pt>
                <c:pt idx="77">
                  <c:v>1087</c:v>
                </c:pt>
              </c:numCache>
            </c:numRef>
          </c:cat>
          <c:val>
            <c:numRef>
              <c:f>Neat!$B$103:$CA$103</c:f>
              <c:numCache>
                <c:formatCode>General</c:formatCode>
                <c:ptCount val="78"/>
                <c:pt idx="0">
                  <c:v>259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63-1E29-3342-A2AA-0E5784E973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70195119"/>
        <c:axId val="1570209999"/>
      </c:lineChart>
      <c:catAx>
        <c:axId val="157019511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 Post-Daratumumab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0209999"/>
        <c:crosses val="autoZero"/>
        <c:auto val="1"/>
        <c:lblAlgn val="ctr"/>
        <c:lblOffset val="100"/>
        <c:noMultiLvlLbl val="0"/>
      </c:catAx>
      <c:valAx>
        <c:axId val="157020999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HLA Antibody MF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019511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/>
              <a:t>Case 3: All Antibodies</a:t>
            </a:r>
          </a:p>
        </c:rich>
      </c:tx>
      <c:overlay val="0"/>
      <c:spPr>
        <a:noFill/>
        <a:ln w="25400">
          <a:noFill/>
        </a:ln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Graphed!$A$4</c:f>
              <c:strCache>
                <c:ptCount val="1"/>
                <c:pt idx="0">
                  <c:v>A*33:03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:$N$4</c:f>
              <c:numCache>
                <c:formatCode>General</c:formatCode>
                <c:ptCount val="13"/>
                <c:pt idx="0">
                  <c:v>3320</c:v>
                </c:pt>
                <c:pt idx="1">
                  <c:v>1394</c:v>
                </c:pt>
                <c:pt idx="2">
                  <c:v>1575</c:v>
                </c:pt>
                <c:pt idx="3">
                  <c:v>166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C8-464C-AA8C-D74BED39F5C0}"/>
            </c:ext>
          </c:extLst>
        </c:ser>
        <c:ser>
          <c:idx val="1"/>
          <c:order val="1"/>
          <c:tx>
            <c:strRef>
              <c:f>Graphed!$A$5</c:f>
              <c:strCache>
                <c:ptCount val="1"/>
                <c:pt idx="0">
                  <c:v>A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:$N$5</c:f>
              <c:numCache>
                <c:formatCode>General</c:formatCode>
                <c:ptCount val="13"/>
                <c:pt idx="0">
                  <c:v>208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8C8-464C-AA8C-D74BED39F5C0}"/>
            </c:ext>
          </c:extLst>
        </c:ser>
        <c:ser>
          <c:idx val="2"/>
          <c:order val="2"/>
          <c:tx>
            <c:strRef>
              <c:f>Graphed!$A$6</c:f>
              <c:strCache>
                <c:ptCount val="1"/>
                <c:pt idx="0">
                  <c:v>A2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6:$N$6</c:f>
              <c:numCache>
                <c:formatCode>General</c:formatCode>
                <c:ptCount val="13"/>
                <c:pt idx="0">
                  <c:v>18528</c:v>
                </c:pt>
                <c:pt idx="1">
                  <c:v>10238</c:v>
                </c:pt>
                <c:pt idx="2">
                  <c:v>10011</c:v>
                </c:pt>
                <c:pt idx="3">
                  <c:v>9796</c:v>
                </c:pt>
                <c:pt idx="4">
                  <c:v>5240</c:v>
                </c:pt>
                <c:pt idx="5">
                  <c:v>4569</c:v>
                </c:pt>
                <c:pt idx="6">
                  <c:v>1587</c:v>
                </c:pt>
                <c:pt idx="7">
                  <c:v>172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8C8-464C-AA8C-D74BED39F5C0}"/>
            </c:ext>
          </c:extLst>
        </c:ser>
        <c:ser>
          <c:idx val="3"/>
          <c:order val="3"/>
          <c:tx>
            <c:strRef>
              <c:f>Graphed!$A$7</c:f>
              <c:strCache>
                <c:ptCount val="1"/>
                <c:pt idx="0">
                  <c:v>A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7:$N$7</c:f>
              <c:numCache>
                <c:formatCode>General</c:formatCode>
                <c:ptCount val="13"/>
                <c:pt idx="0">
                  <c:v>8379</c:v>
                </c:pt>
                <c:pt idx="1">
                  <c:v>4025</c:v>
                </c:pt>
                <c:pt idx="2">
                  <c:v>3969</c:v>
                </c:pt>
                <c:pt idx="3">
                  <c:v>3851</c:v>
                </c:pt>
                <c:pt idx="4">
                  <c:v>2283</c:v>
                </c:pt>
                <c:pt idx="5">
                  <c:v>2960</c:v>
                </c:pt>
                <c:pt idx="6">
                  <c:v>0</c:v>
                </c:pt>
                <c:pt idx="7">
                  <c:v>124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8C8-464C-AA8C-D74BED39F5C0}"/>
            </c:ext>
          </c:extLst>
        </c:ser>
        <c:ser>
          <c:idx val="4"/>
          <c:order val="4"/>
          <c:tx>
            <c:strRef>
              <c:f>Graphed!$A$8</c:f>
              <c:strCache>
                <c:ptCount val="1"/>
                <c:pt idx="0">
                  <c:v>A2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8:$N$8</c:f>
              <c:numCache>
                <c:formatCode>General</c:formatCode>
                <c:ptCount val="13"/>
                <c:pt idx="0">
                  <c:v>7461</c:v>
                </c:pt>
                <c:pt idx="1">
                  <c:v>3807</c:v>
                </c:pt>
                <c:pt idx="2">
                  <c:v>3464</c:v>
                </c:pt>
                <c:pt idx="3">
                  <c:v>3524</c:v>
                </c:pt>
                <c:pt idx="4">
                  <c:v>2031</c:v>
                </c:pt>
                <c:pt idx="5">
                  <c:v>2217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139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8C8-464C-AA8C-D74BED39F5C0}"/>
            </c:ext>
          </c:extLst>
        </c:ser>
        <c:ser>
          <c:idx val="5"/>
          <c:order val="5"/>
          <c:tx>
            <c:strRef>
              <c:f>Graphed!$A$9</c:f>
              <c:strCache>
                <c:ptCount val="1"/>
                <c:pt idx="0">
                  <c:v>A32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9:$N$9</c:f>
              <c:numCache>
                <c:formatCode>General</c:formatCode>
                <c:ptCount val="13"/>
                <c:pt idx="0">
                  <c:v>10192</c:v>
                </c:pt>
                <c:pt idx="1">
                  <c:v>5190</c:v>
                </c:pt>
                <c:pt idx="2">
                  <c:v>4923</c:v>
                </c:pt>
                <c:pt idx="3">
                  <c:v>4849</c:v>
                </c:pt>
                <c:pt idx="4">
                  <c:v>3109</c:v>
                </c:pt>
                <c:pt idx="5">
                  <c:v>2766</c:v>
                </c:pt>
                <c:pt idx="6">
                  <c:v>1199</c:v>
                </c:pt>
                <c:pt idx="7">
                  <c:v>1498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709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D8C8-464C-AA8C-D74BED39F5C0}"/>
            </c:ext>
          </c:extLst>
        </c:ser>
        <c:ser>
          <c:idx val="6"/>
          <c:order val="6"/>
          <c:tx>
            <c:strRef>
              <c:f>Graphed!$A$10</c:f>
              <c:strCache>
                <c:ptCount val="1"/>
                <c:pt idx="0">
                  <c:v>A68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0:$N$10</c:f>
              <c:numCache>
                <c:formatCode>General</c:formatCode>
                <c:ptCount val="13"/>
                <c:pt idx="0">
                  <c:v>132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D8C8-464C-AA8C-D74BED39F5C0}"/>
            </c:ext>
          </c:extLst>
        </c:ser>
        <c:ser>
          <c:idx val="7"/>
          <c:order val="7"/>
          <c:tx>
            <c:strRef>
              <c:f>Graphed!$A$11</c:f>
              <c:strCache>
                <c:ptCount val="1"/>
                <c:pt idx="0">
                  <c:v>A69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1:$N$11</c:f>
              <c:numCache>
                <c:formatCode>General</c:formatCode>
                <c:ptCount val="13"/>
                <c:pt idx="0">
                  <c:v>112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D8C8-464C-AA8C-D74BED39F5C0}"/>
            </c:ext>
          </c:extLst>
        </c:ser>
        <c:ser>
          <c:idx val="8"/>
          <c:order val="8"/>
          <c:tx>
            <c:strRef>
              <c:f>Graphed!$A$12</c:f>
              <c:strCache>
                <c:ptCount val="1"/>
                <c:pt idx="0">
                  <c:v>B27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2:$N$12</c:f>
              <c:numCache>
                <c:formatCode>General</c:formatCode>
                <c:ptCount val="13"/>
                <c:pt idx="0">
                  <c:v>6206</c:v>
                </c:pt>
                <c:pt idx="1">
                  <c:v>2815</c:v>
                </c:pt>
                <c:pt idx="2">
                  <c:v>2711</c:v>
                </c:pt>
                <c:pt idx="3">
                  <c:v>2712</c:v>
                </c:pt>
                <c:pt idx="4">
                  <c:v>1581</c:v>
                </c:pt>
                <c:pt idx="5">
                  <c:v>1821</c:v>
                </c:pt>
                <c:pt idx="6">
                  <c:v>0</c:v>
                </c:pt>
                <c:pt idx="7">
                  <c:v>110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D8C8-464C-AA8C-D74BED39F5C0}"/>
            </c:ext>
          </c:extLst>
        </c:ser>
        <c:ser>
          <c:idx val="9"/>
          <c:order val="9"/>
          <c:tx>
            <c:strRef>
              <c:f>Graphed!$A$13</c:f>
              <c:strCache>
                <c:ptCount val="1"/>
                <c:pt idx="0">
                  <c:v>B38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3:$N$13</c:f>
              <c:numCache>
                <c:formatCode>General</c:formatCode>
                <c:ptCount val="13"/>
                <c:pt idx="0">
                  <c:v>210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D8C8-464C-AA8C-D74BED39F5C0}"/>
            </c:ext>
          </c:extLst>
        </c:ser>
        <c:ser>
          <c:idx val="10"/>
          <c:order val="10"/>
          <c:tx>
            <c:strRef>
              <c:f>Graphed!$A$14</c:f>
              <c:strCache>
                <c:ptCount val="1"/>
                <c:pt idx="0">
                  <c:v>B44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4:$N$14</c:f>
              <c:numCache>
                <c:formatCode>General</c:formatCode>
                <c:ptCount val="13"/>
                <c:pt idx="0">
                  <c:v>9104</c:v>
                </c:pt>
                <c:pt idx="1">
                  <c:v>3892</c:v>
                </c:pt>
                <c:pt idx="2">
                  <c:v>3349</c:v>
                </c:pt>
                <c:pt idx="3">
                  <c:v>3411</c:v>
                </c:pt>
                <c:pt idx="4">
                  <c:v>1469</c:v>
                </c:pt>
                <c:pt idx="5">
                  <c:v>142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D8C8-464C-AA8C-D74BED39F5C0}"/>
            </c:ext>
          </c:extLst>
        </c:ser>
        <c:ser>
          <c:idx val="11"/>
          <c:order val="11"/>
          <c:tx>
            <c:strRef>
              <c:f>Graphed!$A$15</c:f>
              <c:strCache>
                <c:ptCount val="1"/>
                <c:pt idx="0">
                  <c:v>B45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5:$N$15</c:f>
              <c:numCache>
                <c:formatCode>General</c:formatCode>
                <c:ptCount val="13"/>
                <c:pt idx="0">
                  <c:v>12767</c:v>
                </c:pt>
                <c:pt idx="1">
                  <c:v>5907</c:v>
                </c:pt>
                <c:pt idx="2">
                  <c:v>4992</c:v>
                </c:pt>
                <c:pt idx="3">
                  <c:v>4977</c:v>
                </c:pt>
                <c:pt idx="4">
                  <c:v>2104</c:v>
                </c:pt>
                <c:pt idx="5">
                  <c:v>151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D8C8-464C-AA8C-D74BED39F5C0}"/>
            </c:ext>
          </c:extLst>
        </c:ser>
        <c:ser>
          <c:idx val="12"/>
          <c:order val="12"/>
          <c:tx>
            <c:strRef>
              <c:f>Graphed!$A$16</c:f>
              <c:strCache>
                <c:ptCount val="1"/>
                <c:pt idx="0">
                  <c:v>B49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6:$N$16</c:f>
              <c:numCache>
                <c:formatCode>General</c:formatCode>
                <c:ptCount val="13"/>
                <c:pt idx="0">
                  <c:v>255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D8C8-464C-AA8C-D74BED39F5C0}"/>
            </c:ext>
          </c:extLst>
        </c:ser>
        <c:ser>
          <c:idx val="13"/>
          <c:order val="13"/>
          <c:tx>
            <c:strRef>
              <c:f>Graphed!$A$17</c:f>
              <c:strCache>
                <c:ptCount val="1"/>
                <c:pt idx="0">
                  <c:v>B51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solidFill>
                  <a:schemeClr val="accent2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7:$N$17</c:f>
              <c:numCache>
                <c:formatCode>General</c:formatCode>
                <c:ptCount val="13"/>
                <c:pt idx="0">
                  <c:v>255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D8C8-464C-AA8C-D74BED39F5C0}"/>
            </c:ext>
          </c:extLst>
        </c:ser>
        <c:ser>
          <c:idx val="14"/>
          <c:order val="14"/>
          <c:tx>
            <c:strRef>
              <c:f>Graphed!$A$18</c:f>
              <c:strCache>
                <c:ptCount val="1"/>
                <c:pt idx="0">
                  <c:v>B52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  <a:lumOff val="20000"/>
                </a:schemeClr>
              </a:solidFill>
              <a:ln w="9525">
                <a:solidFill>
                  <a:schemeClr val="accent3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8:$N$18</c:f>
              <c:numCache>
                <c:formatCode>General</c:formatCode>
                <c:ptCount val="13"/>
                <c:pt idx="0">
                  <c:v>123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D8C8-464C-AA8C-D74BED39F5C0}"/>
            </c:ext>
          </c:extLst>
        </c:ser>
        <c:ser>
          <c:idx val="15"/>
          <c:order val="15"/>
          <c:tx>
            <c:strRef>
              <c:f>Graphed!$A$19</c:f>
              <c:strCache>
                <c:ptCount val="1"/>
                <c:pt idx="0">
                  <c:v>B53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  <a:lumOff val="20000"/>
                </a:schemeClr>
              </a:solidFill>
              <a:ln w="9525">
                <a:solidFill>
                  <a:schemeClr val="accent4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19:$N$19</c:f>
              <c:numCache>
                <c:formatCode>General</c:formatCode>
                <c:ptCount val="13"/>
                <c:pt idx="0">
                  <c:v>247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D8C8-464C-AA8C-D74BED39F5C0}"/>
            </c:ext>
          </c:extLst>
        </c:ser>
        <c:ser>
          <c:idx val="16"/>
          <c:order val="16"/>
          <c:tx>
            <c:strRef>
              <c:f>Graphed!$A$20</c:f>
              <c:strCache>
                <c:ptCount val="1"/>
                <c:pt idx="0">
                  <c:v>B57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  <a:lumOff val="20000"/>
                </a:schemeClr>
              </a:solidFill>
              <a:ln w="9525">
                <a:solidFill>
                  <a:schemeClr val="accent5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0:$N$20</c:f>
              <c:numCache>
                <c:formatCode>General</c:formatCode>
                <c:ptCount val="13"/>
                <c:pt idx="0">
                  <c:v>23331</c:v>
                </c:pt>
                <c:pt idx="1">
                  <c:v>20157</c:v>
                </c:pt>
                <c:pt idx="2">
                  <c:v>20803</c:v>
                </c:pt>
                <c:pt idx="3">
                  <c:v>20709</c:v>
                </c:pt>
                <c:pt idx="4">
                  <c:v>14298</c:v>
                </c:pt>
                <c:pt idx="5">
                  <c:v>8714</c:v>
                </c:pt>
                <c:pt idx="6">
                  <c:v>3700</c:v>
                </c:pt>
                <c:pt idx="7">
                  <c:v>3108</c:v>
                </c:pt>
                <c:pt idx="8">
                  <c:v>1474</c:v>
                </c:pt>
                <c:pt idx="9">
                  <c:v>1409</c:v>
                </c:pt>
                <c:pt idx="10">
                  <c:v>1308</c:v>
                </c:pt>
                <c:pt idx="11">
                  <c:v>2425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D8C8-464C-AA8C-D74BED39F5C0}"/>
            </c:ext>
          </c:extLst>
        </c:ser>
        <c:ser>
          <c:idx val="17"/>
          <c:order val="17"/>
          <c:tx>
            <c:strRef>
              <c:f>Graphed!$A$21</c:f>
              <c:strCache>
                <c:ptCount val="1"/>
                <c:pt idx="0">
                  <c:v>B58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1:$N$21</c:f>
              <c:numCache>
                <c:formatCode>General</c:formatCode>
                <c:ptCount val="13"/>
                <c:pt idx="0">
                  <c:v>21184</c:v>
                </c:pt>
                <c:pt idx="1">
                  <c:v>17261</c:v>
                </c:pt>
                <c:pt idx="2">
                  <c:v>16779</c:v>
                </c:pt>
                <c:pt idx="3">
                  <c:v>16371</c:v>
                </c:pt>
                <c:pt idx="4">
                  <c:v>10746</c:v>
                </c:pt>
                <c:pt idx="5">
                  <c:v>6490</c:v>
                </c:pt>
                <c:pt idx="6">
                  <c:v>2590</c:v>
                </c:pt>
                <c:pt idx="7">
                  <c:v>226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837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D8C8-464C-AA8C-D74BED39F5C0}"/>
            </c:ext>
          </c:extLst>
        </c:ser>
        <c:ser>
          <c:idx val="18"/>
          <c:order val="18"/>
          <c:tx>
            <c:strRef>
              <c:f>Graphed!$A$22</c:f>
              <c:strCache>
                <c:ptCount val="1"/>
                <c:pt idx="0">
                  <c:v>B59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</a:schemeClr>
              </a:solidFill>
              <a:ln w="9525">
                <a:solidFill>
                  <a:schemeClr val="accent1">
                    <a:lumMod val="8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2:$N$22</c:f>
              <c:numCache>
                <c:formatCode>General</c:formatCode>
                <c:ptCount val="13"/>
                <c:pt idx="0">
                  <c:v>21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D8C8-464C-AA8C-D74BED39F5C0}"/>
            </c:ext>
          </c:extLst>
        </c:ser>
        <c:ser>
          <c:idx val="19"/>
          <c:order val="19"/>
          <c:tx>
            <c:strRef>
              <c:f>Graphed!$A$23</c:f>
              <c:strCache>
                <c:ptCount val="1"/>
                <c:pt idx="0">
                  <c:v>B63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3:$N$23</c:f>
              <c:numCache>
                <c:formatCode>General</c:formatCode>
                <c:ptCount val="13"/>
                <c:pt idx="0">
                  <c:v>14845</c:v>
                </c:pt>
                <c:pt idx="1">
                  <c:v>7974</c:v>
                </c:pt>
                <c:pt idx="2">
                  <c:v>7523</c:v>
                </c:pt>
                <c:pt idx="3">
                  <c:v>7709</c:v>
                </c:pt>
                <c:pt idx="4">
                  <c:v>4689</c:v>
                </c:pt>
                <c:pt idx="5">
                  <c:v>3852</c:v>
                </c:pt>
                <c:pt idx="6">
                  <c:v>1809</c:v>
                </c:pt>
                <c:pt idx="7">
                  <c:v>2109</c:v>
                </c:pt>
                <c:pt idx="8">
                  <c:v>1229</c:v>
                </c:pt>
                <c:pt idx="9">
                  <c:v>1325</c:v>
                </c:pt>
                <c:pt idx="10">
                  <c:v>1304</c:v>
                </c:pt>
                <c:pt idx="11">
                  <c:v>2407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D8C8-464C-AA8C-D74BED39F5C0}"/>
            </c:ext>
          </c:extLst>
        </c:ser>
        <c:ser>
          <c:idx val="20"/>
          <c:order val="20"/>
          <c:tx>
            <c:strRef>
              <c:f>Graphed!$A$24</c:f>
              <c:strCache>
                <c:ptCount val="1"/>
                <c:pt idx="0">
                  <c:v>B76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</a:schemeClr>
              </a:solidFill>
              <a:ln w="9525">
                <a:solidFill>
                  <a:schemeClr val="accent3">
                    <a:lumMod val="8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4:$N$24</c:f>
              <c:numCache>
                <c:formatCode>General</c:formatCode>
                <c:ptCount val="13"/>
                <c:pt idx="0">
                  <c:v>10304</c:v>
                </c:pt>
                <c:pt idx="1">
                  <c:v>4691</c:v>
                </c:pt>
                <c:pt idx="2">
                  <c:v>4028</c:v>
                </c:pt>
                <c:pt idx="3">
                  <c:v>4205</c:v>
                </c:pt>
                <c:pt idx="4">
                  <c:v>170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D8C8-464C-AA8C-D74BED39F5C0}"/>
            </c:ext>
          </c:extLst>
        </c:ser>
        <c:ser>
          <c:idx val="21"/>
          <c:order val="21"/>
          <c:tx>
            <c:strRef>
              <c:f>Graphed!$A$25</c:f>
              <c:strCache>
                <c:ptCount val="1"/>
                <c:pt idx="0">
                  <c:v>B77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5:$N$25</c:f>
              <c:numCache>
                <c:formatCode>General</c:formatCode>
                <c:ptCount val="13"/>
                <c:pt idx="0">
                  <c:v>154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D8C8-464C-AA8C-D74BED39F5C0}"/>
            </c:ext>
          </c:extLst>
        </c:ser>
        <c:ser>
          <c:idx val="22"/>
          <c:order val="22"/>
          <c:tx>
            <c:strRef>
              <c:f>Graphed!$A$26</c:f>
              <c:strCache>
                <c:ptCount val="1"/>
                <c:pt idx="0">
                  <c:v>B8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</a:schemeClr>
              </a:solidFill>
              <a:ln w="9525">
                <a:solidFill>
                  <a:schemeClr val="accent5">
                    <a:lumMod val="8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6:$N$26</c:f>
              <c:numCache>
                <c:formatCode>General</c:formatCode>
                <c:ptCount val="13"/>
                <c:pt idx="0">
                  <c:v>2976</c:v>
                </c:pt>
                <c:pt idx="1">
                  <c:v>111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D8C8-464C-AA8C-D74BED39F5C0}"/>
            </c:ext>
          </c:extLst>
        </c:ser>
        <c:ser>
          <c:idx val="23"/>
          <c:order val="23"/>
          <c:tx>
            <c:strRef>
              <c:f>Graphed!$A$27</c:f>
              <c:strCache>
                <c:ptCount val="1"/>
                <c:pt idx="0">
                  <c:v>B82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</a:schemeClr>
              </a:solidFill>
              <a:ln w="9525">
                <a:solidFill>
                  <a:schemeClr val="accent6">
                    <a:lumMod val="8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7:$N$27</c:f>
              <c:numCache>
                <c:formatCode>General</c:formatCode>
                <c:ptCount val="13"/>
                <c:pt idx="0">
                  <c:v>5239</c:v>
                </c:pt>
                <c:pt idx="1">
                  <c:v>1994</c:v>
                </c:pt>
                <c:pt idx="2">
                  <c:v>1848</c:v>
                </c:pt>
                <c:pt idx="3">
                  <c:v>205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D8C8-464C-AA8C-D74BED39F5C0}"/>
            </c:ext>
          </c:extLst>
        </c:ser>
        <c:ser>
          <c:idx val="24"/>
          <c:order val="24"/>
          <c:tx>
            <c:strRef>
              <c:f>Graphed!$A$28</c:f>
              <c:strCache>
                <c:ptCount val="1"/>
                <c:pt idx="0">
                  <c:v>DP10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8:$N$28</c:f>
              <c:numCache>
                <c:formatCode>General</c:formatCode>
                <c:ptCount val="13"/>
                <c:pt idx="0">
                  <c:v>374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D8C8-464C-AA8C-D74BED39F5C0}"/>
            </c:ext>
          </c:extLst>
        </c:ser>
        <c:ser>
          <c:idx val="25"/>
          <c:order val="25"/>
          <c:tx>
            <c:strRef>
              <c:f>Graphed!$A$29</c:f>
              <c:strCache>
                <c:ptCount val="1"/>
                <c:pt idx="0">
                  <c:v>DP14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29:$N$29</c:f>
              <c:numCache>
                <c:formatCode>General</c:formatCode>
                <c:ptCount val="13"/>
                <c:pt idx="0">
                  <c:v>5993</c:v>
                </c:pt>
                <c:pt idx="1">
                  <c:v>2366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D8C8-464C-AA8C-D74BED39F5C0}"/>
            </c:ext>
          </c:extLst>
        </c:ser>
        <c:ser>
          <c:idx val="26"/>
          <c:order val="26"/>
          <c:tx>
            <c:strRef>
              <c:f>Graphed!$A$30</c:f>
              <c:strCache>
                <c:ptCount val="1"/>
                <c:pt idx="0">
                  <c:v>DP17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accent3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0:$N$30</c:f>
              <c:numCache>
                <c:formatCode>General</c:formatCode>
                <c:ptCount val="13"/>
                <c:pt idx="0">
                  <c:v>6831</c:v>
                </c:pt>
                <c:pt idx="1">
                  <c:v>2966</c:v>
                </c:pt>
                <c:pt idx="2">
                  <c:v>2055</c:v>
                </c:pt>
                <c:pt idx="3">
                  <c:v>220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D8C8-464C-AA8C-D74BED39F5C0}"/>
            </c:ext>
          </c:extLst>
        </c:ser>
        <c:ser>
          <c:idx val="27"/>
          <c:order val="27"/>
          <c:tx>
            <c:strRef>
              <c:f>Graphed!$A$31</c:f>
              <c:strCache>
                <c:ptCount val="1"/>
                <c:pt idx="0">
                  <c:v>DP18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1:$N$31</c:f>
              <c:numCache>
                <c:formatCode>General</c:formatCode>
                <c:ptCount val="13"/>
                <c:pt idx="0">
                  <c:v>12277</c:v>
                </c:pt>
                <c:pt idx="1">
                  <c:v>7710</c:v>
                </c:pt>
                <c:pt idx="2">
                  <c:v>7811</c:v>
                </c:pt>
                <c:pt idx="3">
                  <c:v>7394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D8C8-464C-AA8C-D74BED39F5C0}"/>
            </c:ext>
          </c:extLst>
        </c:ser>
        <c:ser>
          <c:idx val="28"/>
          <c:order val="28"/>
          <c:tx>
            <c:strRef>
              <c:f>Graphed!$A$32</c:f>
              <c:strCache>
                <c:ptCount val="1"/>
                <c:pt idx="0">
                  <c:v>DP19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2:$N$32</c:f>
              <c:numCache>
                <c:formatCode>General</c:formatCode>
                <c:ptCount val="13"/>
                <c:pt idx="0">
                  <c:v>17059</c:v>
                </c:pt>
                <c:pt idx="1">
                  <c:v>12972</c:v>
                </c:pt>
                <c:pt idx="2">
                  <c:v>13177</c:v>
                </c:pt>
                <c:pt idx="3">
                  <c:v>12676</c:v>
                </c:pt>
                <c:pt idx="4">
                  <c:v>7623</c:v>
                </c:pt>
                <c:pt idx="5">
                  <c:v>350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D8C8-464C-AA8C-D74BED39F5C0}"/>
            </c:ext>
          </c:extLst>
        </c:ser>
        <c:ser>
          <c:idx val="29"/>
          <c:order val="29"/>
          <c:tx>
            <c:strRef>
              <c:f>Graphed!$A$33</c:f>
              <c:strCache>
                <c:ptCount val="1"/>
                <c:pt idx="0">
                  <c:v>DP2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accent6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3:$N$33</c:f>
              <c:numCache>
                <c:formatCode>General</c:formatCode>
                <c:ptCount val="13"/>
                <c:pt idx="0">
                  <c:v>20263</c:v>
                </c:pt>
                <c:pt idx="1">
                  <c:v>14240</c:v>
                </c:pt>
                <c:pt idx="2">
                  <c:v>14794</c:v>
                </c:pt>
                <c:pt idx="3">
                  <c:v>14189</c:v>
                </c:pt>
                <c:pt idx="4">
                  <c:v>8545</c:v>
                </c:pt>
                <c:pt idx="5">
                  <c:v>371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D8C8-464C-AA8C-D74BED39F5C0}"/>
            </c:ext>
          </c:extLst>
        </c:ser>
        <c:ser>
          <c:idx val="30"/>
          <c:order val="30"/>
          <c:tx>
            <c:strRef>
              <c:f>Graphed!$A$34</c:f>
              <c:strCache>
                <c:ptCount val="1"/>
                <c:pt idx="0">
                  <c:v>DP20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4:$N$34</c:f>
              <c:numCache>
                <c:formatCode>General</c:formatCode>
                <c:ptCount val="13"/>
                <c:pt idx="0">
                  <c:v>20108</c:v>
                </c:pt>
                <c:pt idx="1">
                  <c:v>14828</c:v>
                </c:pt>
                <c:pt idx="2">
                  <c:v>14857</c:v>
                </c:pt>
                <c:pt idx="3">
                  <c:v>14761</c:v>
                </c:pt>
                <c:pt idx="4">
                  <c:v>9108</c:v>
                </c:pt>
                <c:pt idx="5">
                  <c:v>430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D8C8-464C-AA8C-D74BED39F5C0}"/>
            </c:ext>
          </c:extLst>
        </c:ser>
        <c:ser>
          <c:idx val="31"/>
          <c:order val="31"/>
          <c:tx>
            <c:strRef>
              <c:f>Graphed!$A$35</c:f>
              <c:strCache>
                <c:ptCount val="1"/>
                <c:pt idx="0">
                  <c:v>DP23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5:$N$35</c:f>
              <c:numCache>
                <c:formatCode>General</c:formatCode>
                <c:ptCount val="13"/>
                <c:pt idx="0">
                  <c:v>19003</c:v>
                </c:pt>
                <c:pt idx="1">
                  <c:v>13772</c:v>
                </c:pt>
                <c:pt idx="2">
                  <c:v>13983</c:v>
                </c:pt>
                <c:pt idx="3">
                  <c:v>13307</c:v>
                </c:pt>
                <c:pt idx="4">
                  <c:v>8095</c:v>
                </c:pt>
                <c:pt idx="5">
                  <c:v>3707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D8C8-464C-AA8C-D74BED39F5C0}"/>
            </c:ext>
          </c:extLst>
        </c:ser>
        <c:ser>
          <c:idx val="32"/>
          <c:order val="32"/>
          <c:tx>
            <c:strRef>
              <c:f>Graphed!$A$36</c:f>
              <c:strCache>
                <c:ptCount val="1"/>
                <c:pt idx="0">
                  <c:v>DP28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accent3">
                    <a:lumMod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6:$N$36</c:f>
              <c:numCache>
                <c:formatCode>General</c:formatCode>
                <c:ptCount val="13"/>
                <c:pt idx="0">
                  <c:v>14041</c:v>
                </c:pt>
                <c:pt idx="1">
                  <c:v>8721</c:v>
                </c:pt>
                <c:pt idx="2">
                  <c:v>9344</c:v>
                </c:pt>
                <c:pt idx="3">
                  <c:v>8954</c:v>
                </c:pt>
                <c:pt idx="4">
                  <c:v>4974</c:v>
                </c:pt>
                <c:pt idx="5">
                  <c:v>247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D8C8-464C-AA8C-D74BED39F5C0}"/>
            </c:ext>
          </c:extLst>
        </c:ser>
        <c:ser>
          <c:idx val="33"/>
          <c:order val="33"/>
          <c:tx>
            <c:strRef>
              <c:f>Graphed!$A$37</c:f>
              <c:strCache>
                <c:ptCount val="1"/>
                <c:pt idx="0">
                  <c:v>DP3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7:$N$37</c:f>
              <c:numCache>
                <c:formatCode>General</c:formatCode>
                <c:ptCount val="13"/>
                <c:pt idx="0">
                  <c:v>14719</c:v>
                </c:pt>
                <c:pt idx="1">
                  <c:v>9210</c:v>
                </c:pt>
                <c:pt idx="2">
                  <c:v>9194</c:v>
                </c:pt>
                <c:pt idx="3">
                  <c:v>880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D8C8-464C-AA8C-D74BED39F5C0}"/>
            </c:ext>
          </c:extLst>
        </c:ser>
        <c:ser>
          <c:idx val="34"/>
          <c:order val="34"/>
          <c:tx>
            <c:strRef>
              <c:f>Graphed!$A$38</c:f>
              <c:strCache>
                <c:ptCount val="1"/>
                <c:pt idx="0">
                  <c:v>DP401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</a:schemeClr>
              </a:solidFill>
              <a:ln w="9525">
                <a:solidFill>
                  <a:schemeClr val="accent5">
                    <a:lumMod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8:$N$38</c:f>
              <c:numCache>
                <c:formatCode>General</c:formatCode>
                <c:ptCount val="13"/>
                <c:pt idx="0">
                  <c:v>18890</c:v>
                </c:pt>
                <c:pt idx="1">
                  <c:v>14375</c:v>
                </c:pt>
                <c:pt idx="2">
                  <c:v>14801</c:v>
                </c:pt>
                <c:pt idx="3">
                  <c:v>14008</c:v>
                </c:pt>
                <c:pt idx="4">
                  <c:v>8598</c:v>
                </c:pt>
                <c:pt idx="5">
                  <c:v>395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D8C8-464C-AA8C-D74BED39F5C0}"/>
            </c:ext>
          </c:extLst>
        </c:ser>
        <c:ser>
          <c:idx val="35"/>
          <c:order val="35"/>
          <c:tx>
            <c:strRef>
              <c:f>Graphed!$A$39</c:f>
              <c:strCache>
                <c:ptCount val="1"/>
                <c:pt idx="0">
                  <c:v>DP402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39:$N$39</c:f>
              <c:numCache>
                <c:formatCode>General</c:formatCode>
                <c:ptCount val="13"/>
                <c:pt idx="0">
                  <c:v>19575</c:v>
                </c:pt>
                <c:pt idx="1">
                  <c:v>14768</c:v>
                </c:pt>
                <c:pt idx="2">
                  <c:v>14779</c:v>
                </c:pt>
                <c:pt idx="3">
                  <c:v>13765</c:v>
                </c:pt>
                <c:pt idx="4">
                  <c:v>8588</c:v>
                </c:pt>
                <c:pt idx="5">
                  <c:v>406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D8C8-464C-AA8C-D74BED39F5C0}"/>
            </c:ext>
          </c:extLst>
        </c:ser>
        <c:ser>
          <c:idx val="36"/>
          <c:order val="36"/>
          <c:tx>
            <c:strRef>
              <c:f>Graphed!$A$40</c:f>
              <c:strCache>
                <c:ptCount val="1"/>
                <c:pt idx="0">
                  <c:v>DP6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  <a:lumOff val="30000"/>
                </a:schemeClr>
              </a:solidFill>
              <a:ln w="9525">
                <a:solidFill>
                  <a:schemeClr val="accent1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0:$N$40</c:f>
              <c:numCache>
                <c:formatCode>General</c:formatCode>
                <c:ptCount val="13"/>
                <c:pt idx="0">
                  <c:v>13746</c:v>
                </c:pt>
                <c:pt idx="1">
                  <c:v>9146</c:v>
                </c:pt>
                <c:pt idx="2">
                  <c:v>8944</c:v>
                </c:pt>
                <c:pt idx="3">
                  <c:v>859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D8C8-464C-AA8C-D74BED39F5C0}"/>
            </c:ext>
          </c:extLst>
        </c:ser>
        <c:ser>
          <c:idx val="37"/>
          <c:order val="37"/>
          <c:tx>
            <c:strRef>
              <c:f>Graphed!$A$41</c:f>
              <c:strCache>
                <c:ptCount val="1"/>
                <c:pt idx="0">
                  <c:v>DP9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1:$N$41</c:f>
              <c:numCache>
                <c:formatCode>General</c:formatCode>
                <c:ptCount val="13"/>
                <c:pt idx="0">
                  <c:v>7175</c:v>
                </c:pt>
                <c:pt idx="1">
                  <c:v>2997</c:v>
                </c:pt>
                <c:pt idx="2">
                  <c:v>2127</c:v>
                </c:pt>
                <c:pt idx="3">
                  <c:v>223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D8C8-464C-AA8C-D74BED39F5C0}"/>
            </c:ext>
          </c:extLst>
        </c:ser>
        <c:ser>
          <c:idx val="38"/>
          <c:order val="38"/>
          <c:tx>
            <c:strRef>
              <c:f>Graphed!$A$42</c:f>
              <c:strCache>
                <c:ptCount val="1"/>
                <c:pt idx="0">
                  <c:v>DPA1*01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  <a:lumOff val="30000"/>
                </a:schemeClr>
              </a:solidFill>
              <a:ln w="9525">
                <a:solidFill>
                  <a:schemeClr val="accent3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2:$N$42</c:f>
              <c:numCache>
                <c:formatCode>General</c:formatCode>
                <c:ptCount val="13"/>
                <c:pt idx="0">
                  <c:v>19130</c:v>
                </c:pt>
                <c:pt idx="1">
                  <c:v>14390</c:v>
                </c:pt>
                <c:pt idx="2">
                  <c:v>14619</c:v>
                </c:pt>
                <c:pt idx="3">
                  <c:v>13872</c:v>
                </c:pt>
                <c:pt idx="4">
                  <c:v>7622</c:v>
                </c:pt>
                <c:pt idx="5">
                  <c:v>3367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D8C8-464C-AA8C-D74BED39F5C0}"/>
            </c:ext>
          </c:extLst>
        </c:ser>
        <c:ser>
          <c:idx val="39"/>
          <c:order val="39"/>
          <c:tx>
            <c:strRef>
              <c:f>Graphed!$A$43</c:f>
              <c:strCache>
                <c:ptCount val="1"/>
                <c:pt idx="0">
                  <c:v>DPA1*03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3:$N$43</c:f>
              <c:numCache>
                <c:formatCode>General</c:formatCode>
                <c:ptCount val="13"/>
                <c:pt idx="0">
                  <c:v>14250</c:v>
                </c:pt>
                <c:pt idx="1">
                  <c:v>10041</c:v>
                </c:pt>
                <c:pt idx="2">
                  <c:v>10645</c:v>
                </c:pt>
                <c:pt idx="3">
                  <c:v>10209</c:v>
                </c:pt>
                <c:pt idx="4">
                  <c:v>5695</c:v>
                </c:pt>
                <c:pt idx="5">
                  <c:v>267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D8C8-464C-AA8C-D74BED39F5C0}"/>
            </c:ext>
          </c:extLst>
        </c:ser>
        <c:ser>
          <c:idx val="40"/>
          <c:order val="40"/>
          <c:tx>
            <c:strRef>
              <c:f>Graphed!$A$44</c:f>
              <c:strCache>
                <c:ptCount val="1"/>
                <c:pt idx="0">
                  <c:v>DQ2</c:v>
                </c:pt>
              </c:strCache>
            </c:strRef>
          </c:tx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70000"/>
                  <a:lumOff val="30000"/>
                </a:schemeClr>
              </a:solidFill>
              <a:ln w="9525">
                <a:solidFill>
                  <a:schemeClr val="accent5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4:$N$44</c:f>
              <c:numCache>
                <c:formatCode>General</c:formatCode>
                <c:ptCount val="13"/>
                <c:pt idx="0">
                  <c:v>23168</c:v>
                </c:pt>
                <c:pt idx="1">
                  <c:v>19418</c:v>
                </c:pt>
                <c:pt idx="2">
                  <c:v>19585</c:v>
                </c:pt>
                <c:pt idx="3">
                  <c:v>19289</c:v>
                </c:pt>
                <c:pt idx="4">
                  <c:v>14478</c:v>
                </c:pt>
                <c:pt idx="5">
                  <c:v>7760</c:v>
                </c:pt>
                <c:pt idx="6">
                  <c:v>4655</c:v>
                </c:pt>
                <c:pt idx="7">
                  <c:v>3753</c:v>
                </c:pt>
                <c:pt idx="8">
                  <c:v>1663</c:v>
                </c:pt>
                <c:pt idx="9">
                  <c:v>1482</c:v>
                </c:pt>
                <c:pt idx="10">
                  <c:v>2152</c:v>
                </c:pt>
                <c:pt idx="11">
                  <c:v>5195</c:v>
                </c:pt>
                <c:pt idx="12">
                  <c:v>1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D8C8-464C-AA8C-D74BED39F5C0}"/>
            </c:ext>
          </c:extLst>
        </c:ser>
        <c:ser>
          <c:idx val="41"/>
          <c:order val="41"/>
          <c:tx>
            <c:strRef>
              <c:f>Graphed!$A$45</c:f>
              <c:strCache>
                <c:ptCount val="1"/>
                <c:pt idx="0">
                  <c:v>DQ4</c:v>
                </c:pt>
              </c:strCache>
            </c:strRef>
          </c:tx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0000"/>
                  <a:lumOff val="30000"/>
                </a:schemeClr>
              </a:solidFill>
              <a:ln w="9525">
                <a:solidFill>
                  <a:schemeClr val="accent6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5:$N$45</c:f>
              <c:numCache>
                <c:formatCode>General</c:formatCode>
                <c:ptCount val="13"/>
                <c:pt idx="0">
                  <c:v>11191</c:v>
                </c:pt>
                <c:pt idx="1">
                  <c:v>5779</c:v>
                </c:pt>
                <c:pt idx="2">
                  <c:v>4456</c:v>
                </c:pt>
                <c:pt idx="3">
                  <c:v>4468</c:v>
                </c:pt>
                <c:pt idx="4">
                  <c:v>248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D8C8-464C-AA8C-D74BED39F5C0}"/>
            </c:ext>
          </c:extLst>
        </c:ser>
        <c:ser>
          <c:idx val="42"/>
          <c:order val="42"/>
          <c:tx>
            <c:strRef>
              <c:f>Graphed!$A$46</c:f>
              <c:strCache>
                <c:ptCount val="1"/>
                <c:pt idx="0">
                  <c:v>DQ5</c:v>
                </c:pt>
              </c:strCache>
            </c:strRef>
          </c:tx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6:$N$46</c:f>
              <c:numCache>
                <c:formatCode>General</c:formatCode>
                <c:ptCount val="13"/>
                <c:pt idx="0">
                  <c:v>22235</c:v>
                </c:pt>
                <c:pt idx="1">
                  <c:v>18546</c:v>
                </c:pt>
                <c:pt idx="2">
                  <c:v>16302</c:v>
                </c:pt>
                <c:pt idx="3">
                  <c:v>16659</c:v>
                </c:pt>
                <c:pt idx="4">
                  <c:v>11243</c:v>
                </c:pt>
                <c:pt idx="5">
                  <c:v>6017</c:v>
                </c:pt>
                <c:pt idx="6">
                  <c:v>2801</c:v>
                </c:pt>
                <c:pt idx="7">
                  <c:v>2117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D8C8-464C-AA8C-D74BED39F5C0}"/>
            </c:ext>
          </c:extLst>
        </c:ser>
        <c:ser>
          <c:idx val="43"/>
          <c:order val="43"/>
          <c:tx>
            <c:strRef>
              <c:f>Graphed!$A$47</c:f>
              <c:strCache>
                <c:ptCount val="1"/>
                <c:pt idx="0">
                  <c:v>DQ6</c:v>
                </c:pt>
              </c:strCache>
            </c:strRef>
          </c:tx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7:$N$47</c:f>
              <c:numCache>
                <c:formatCode>General</c:formatCode>
                <c:ptCount val="13"/>
                <c:pt idx="0">
                  <c:v>20611</c:v>
                </c:pt>
                <c:pt idx="1">
                  <c:v>13035</c:v>
                </c:pt>
                <c:pt idx="2">
                  <c:v>9347</c:v>
                </c:pt>
                <c:pt idx="3">
                  <c:v>9814</c:v>
                </c:pt>
                <c:pt idx="4">
                  <c:v>5304</c:v>
                </c:pt>
                <c:pt idx="5">
                  <c:v>2738</c:v>
                </c:pt>
                <c:pt idx="6">
                  <c:v>1190</c:v>
                </c:pt>
                <c:pt idx="7">
                  <c:v>119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D8C8-464C-AA8C-D74BED39F5C0}"/>
            </c:ext>
          </c:extLst>
        </c:ser>
        <c:ser>
          <c:idx val="44"/>
          <c:order val="44"/>
          <c:tx>
            <c:strRef>
              <c:f>Graphed!$A$48</c:f>
              <c:strCache>
                <c:ptCount val="1"/>
                <c:pt idx="0">
                  <c:v>DQA1*02</c:v>
                </c:pt>
              </c:strCache>
            </c:strRef>
          </c:tx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0000"/>
                </a:schemeClr>
              </a:solidFill>
              <a:ln w="9525">
                <a:solidFill>
                  <a:schemeClr val="accent3">
                    <a:lumMod val="7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8:$N$48</c:f>
              <c:numCache>
                <c:formatCode>General</c:formatCode>
                <c:ptCount val="13"/>
                <c:pt idx="0">
                  <c:v>12033</c:v>
                </c:pt>
                <c:pt idx="1">
                  <c:v>6896</c:v>
                </c:pt>
                <c:pt idx="2">
                  <c:v>5790</c:v>
                </c:pt>
                <c:pt idx="3">
                  <c:v>5439</c:v>
                </c:pt>
                <c:pt idx="4">
                  <c:v>2854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D8C8-464C-AA8C-D74BED39F5C0}"/>
            </c:ext>
          </c:extLst>
        </c:ser>
        <c:ser>
          <c:idx val="45"/>
          <c:order val="45"/>
          <c:tx>
            <c:strRef>
              <c:f>Graphed!$A$49</c:f>
              <c:strCache>
                <c:ptCount val="1"/>
                <c:pt idx="0">
                  <c:v>DR1</c:v>
                </c:pt>
              </c:strCache>
            </c:strRef>
          </c:tx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</a:schemeClr>
              </a:solidFill>
              <a:ln w="9525">
                <a:solidFill>
                  <a:schemeClr val="accent4">
                    <a:lumMod val="7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49:$N$49</c:f>
              <c:numCache>
                <c:formatCode>General</c:formatCode>
                <c:ptCount val="13"/>
                <c:pt idx="0">
                  <c:v>119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D8C8-464C-AA8C-D74BED39F5C0}"/>
            </c:ext>
          </c:extLst>
        </c:ser>
        <c:ser>
          <c:idx val="46"/>
          <c:order val="46"/>
          <c:tx>
            <c:strRef>
              <c:f>Graphed!$A$50</c:f>
              <c:strCache>
                <c:ptCount val="1"/>
                <c:pt idx="0">
                  <c:v>DR11</c:v>
                </c:pt>
              </c:strCache>
            </c:strRef>
          </c:tx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70000"/>
                </a:schemeClr>
              </a:solidFill>
              <a:ln w="9525">
                <a:solidFill>
                  <a:schemeClr val="accent5">
                    <a:lumMod val="7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0:$N$50</c:f>
              <c:numCache>
                <c:formatCode>General</c:formatCode>
                <c:ptCount val="13"/>
                <c:pt idx="0">
                  <c:v>5480</c:v>
                </c:pt>
                <c:pt idx="1">
                  <c:v>2054</c:v>
                </c:pt>
                <c:pt idx="2">
                  <c:v>1602</c:v>
                </c:pt>
                <c:pt idx="3">
                  <c:v>168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D8C8-464C-AA8C-D74BED39F5C0}"/>
            </c:ext>
          </c:extLst>
        </c:ser>
        <c:ser>
          <c:idx val="47"/>
          <c:order val="47"/>
          <c:tx>
            <c:strRef>
              <c:f>Graphed!$A$51</c:f>
              <c:strCache>
                <c:ptCount val="1"/>
                <c:pt idx="0">
                  <c:v>DR13</c:v>
                </c:pt>
              </c:strCache>
            </c:strRef>
          </c:tx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0000"/>
                </a:schemeClr>
              </a:solidFill>
              <a:ln w="9525">
                <a:solidFill>
                  <a:schemeClr val="accent6">
                    <a:lumMod val="7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1:$N$51</c:f>
              <c:numCache>
                <c:formatCode>General</c:formatCode>
                <c:ptCount val="13"/>
                <c:pt idx="0">
                  <c:v>4092</c:v>
                </c:pt>
                <c:pt idx="1">
                  <c:v>2110</c:v>
                </c:pt>
                <c:pt idx="2">
                  <c:v>2550</c:v>
                </c:pt>
                <c:pt idx="3">
                  <c:v>280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D8C8-464C-AA8C-D74BED39F5C0}"/>
            </c:ext>
          </c:extLst>
        </c:ser>
        <c:ser>
          <c:idx val="48"/>
          <c:order val="48"/>
          <c:tx>
            <c:strRef>
              <c:f>Graphed!$A$52</c:f>
              <c:strCache>
                <c:ptCount val="1"/>
                <c:pt idx="0">
                  <c:v>DR14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  <a:lumOff val="50000"/>
                </a:schemeClr>
              </a:solidFill>
              <a:ln w="9525">
                <a:solidFill>
                  <a:schemeClr val="accent1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2:$N$52</c:f>
              <c:numCache>
                <c:formatCode>General</c:formatCode>
                <c:ptCount val="13"/>
                <c:pt idx="0">
                  <c:v>150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D8C8-464C-AA8C-D74BED39F5C0}"/>
            </c:ext>
          </c:extLst>
        </c:ser>
        <c:ser>
          <c:idx val="49"/>
          <c:order val="49"/>
          <c:tx>
            <c:strRef>
              <c:f>Graphed!$A$53</c:f>
              <c:strCache>
                <c:ptCount val="1"/>
                <c:pt idx="0">
                  <c:v>DR15</c:v>
                </c:pt>
              </c:strCache>
            </c:strRef>
          </c:tx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  <a:lumOff val="50000"/>
                </a:schemeClr>
              </a:solidFill>
              <a:ln w="9525">
                <a:solidFill>
                  <a:schemeClr val="accent2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3:$N$53</c:f>
              <c:numCache>
                <c:formatCode>General</c:formatCode>
                <c:ptCount val="13"/>
                <c:pt idx="0">
                  <c:v>25512</c:v>
                </c:pt>
                <c:pt idx="1">
                  <c:v>22963</c:v>
                </c:pt>
                <c:pt idx="2">
                  <c:v>24055</c:v>
                </c:pt>
                <c:pt idx="3">
                  <c:v>22955</c:v>
                </c:pt>
                <c:pt idx="4">
                  <c:v>16581</c:v>
                </c:pt>
                <c:pt idx="5">
                  <c:v>7401</c:v>
                </c:pt>
                <c:pt idx="6">
                  <c:v>4035</c:v>
                </c:pt>
                <c:pt idx="7">
                  <c:v>3064</c:v>
                </c:pt>
                <c:pt idx="8">
                  <c:v>1415</c:v>
                </c:pt>
                <c:pt idx="9">
                  <c:v>1378</c:v>
                </c:pt>
                <c:pt idx="10">
                  <c:v>1183</c:v>
                </c:pt>
                <c:pt idx="11">
                  <c:v>2038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D8C8-464C-AA8C-D74BED39F5C0}"/>
            </c:ext>
          </c:extLst>
        </c:ser>
        <c:ser>
          <c:idx val="50"/>
          <c:order val="50"/>
          <c:tx>
            <c:strRef>
              <c:f>Graphed!$A$54</c:f>
              <c:strCache>
                <c:ptCount val="1"/>
                <c:pt idx="0">
                  <c:v>DR16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4:$N$54</c:f>
              <c:numCache>
                <c:formatCode>General</c:formatCode>
                <c:ptCount val="13"/>
                <c:pt idx="0">
                  <c:v>25614</c:v>
                </c:pt>
                <c:pt idx="1">
                  <c:v>22889</c:v>
                </c:pt>
                <c:pt idx="2">
                  <c:v>23591</c:v>
                </c:pt>
                <c:pt idx="3">
                  <c:v>22426</c:v>
                </c:pt>
                <c:pt idx="4">
                  <c:v>15467</c:v>
                </c:pt>
                <c:pt idx="5">
                  <c:v>6615</c:v>
                </c:pt>
                <c:pt idx="6">
                  <c:v>3473</c:v>
                </c:pt>
                <c:pt idx="7">
                  <c:v>2648</c:v>
                </c:pt>
                <c:pt idx="8">
                  <c:v>1197</c:v>
                </c:pt>
                <c:pt idx="9">
                  <c:v>1165</c:v>
                </c:pt>
                <c:pt idx="10">
                  <c:v>0</c:v>
                </c:pt>
                <c:pt idx="11">
                  <c:v>1666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D8C8-464C-AA8C-D74BED39F5C0}"/>
            </c:ext>
          </c:extLst>
        </c:ser>
        <c:ser>
          <c:idx val="51"/>
          <c:order val="51"/>
          <c:tx>
            <c:strRef>
              <c:f>Graphed!$A$55</c:f>
              <c:strCache>
                <c:ptCount val="1"/>
                <c:pt idx="0">
                  <c:v>DR4</c:v>
                </c:pt>
              </c:strCache>
            </c:strRef>
          </c:tx>
          <c:spPr>
            <a:ln w="28575" cap="rnd">
              <a:solidFill>
                <a:schemeClr val="accent4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  <a:lumOff val="50000"/>
                </a:schemeClr>
              </a:solidFill>
              <a:ln w="9525">
                <a:solidFill>
                  <a:schemeClr val="accent4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5:$N$55</c:f>
              <c:numCache>
                <c:formatCode>General</c:formatCode>
                <c:ptCount val="13"/>
                <c:pt idx="0">
                  <c:v>10278</c:v>
                </c:pt>
                <c:pt idx="1">
                  <c:v>5387</c:v>
                </c:pt>
                <c:pt idx="2">
                  <c:v>4133</c:v>
                </c:pt>
                <c:pt idx="3">
                  <c:v>4446</c:v>
                </c:pt>
                <c:pt idx="4">
                  <c:v>197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3-D8C8-464C-AA8C-D74BED39F5C0}"/>
            </c:ext>
          </c:extLst>
        </c:ser>
        <c:ser>
          <c:idx val="52"/>
          <c:order val="52"/>
          <c:tx>
            <c:strRef>
              <c:f>Graphed!$A$56</c:f>
              <c:strCache>
                <c:ptCount val="1"/>
                <c:pt idx="0">
                  <c:v>DR51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  <a:lumOff val="50000"/>
                </a:schemeClr>
              </a:solidFill>
              <a:ln w="9525">
                <a:solidFill>
                  <a:schemeClr val="accent5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6:$N$56</c:f>
              <c:numCache>
                <c:formatCode>General</c:formatCode>
                <c:ptCount val="13"/>
                <c:pt idx="0">
                  <c:v>7850</c:v>
                </c:pt>
                <c:pt idx="1">
                  <c:v>4137</c:v>
                </c:pt>
                <c:pt idx="2">
                  <c:v>2839</c:v>
                </c:pt>
                <c:pt idx="3">
                  <c:v>2879</c:v>
                </c:pt>
                <c:pt idx="4">
                  <c:v>212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4-D8C8-464C-AA8C-D74BED39F5C0}"/>
            </c:ext>
          </c:extLst>
        </c:ser>
        <c:ser>
          <c:idx val="53"/>
          <c:order val="53"/>
          <c:tx>
            <c:strRef>
              <c:f>Graphed!$A$57</c:f>
              <c:strCache>
                <c:ptCount val="1"/>
                <c:pt idx="0">
                  <c:v>DR7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  <a:lumOff val="50000"/>
                </a:schemeClr>
              </a:solidFill>
              <a:ln w="9525">
                <a:solidFill>
                  <a:schemeClr val="accent6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7:$N$57</c:f>
              <c:numCache>
                <c:formatCode>General</c:formatCode>
                <c:ptCount val="13"/>
                <c:pt idx="0">
                  <c:v>23618</c:v>
                </c:pt>
                <c:pt idx="1">
                  <c:v>15780</c:v>
                </c:pt>
                <c:pt idx="2">
                  <c:v>22673</c:v>
                </c:pt>
                <c:pt idx="3">
                  <c:v>22925</c:v>
                </c:pt>
                <c:pt idx="4">
                  <c:v>25550</c:v>
                </c:pt>
                <c:pt idx="5">
                  <c:v>20700</c:v>
                </c:pt>
                <c:pt idx="6">
                  <c:v>14345</c:v>
                </c:pt>
                <c:pt idx="7">
                  <c:v>12794</c:v>
                </c:pt>
                <c:pt idx="8">
                  <c:v>6513</c:v>
                </c:pt>
                <c:pt idx="9">
                  <c:v>4002</c:v>
                </c:pt>
                <c:pt idx="10">
                  <c:v>7132</c:v>
                </c:pt>
                <c:pt idx="11">
                  <c:v>14298</c:v>
                </c:pt>
                <c:pt idx="12">
                  <c:v>25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5-D8C8-464C-AA8C-D74BED39F5C0}"/>
            </c:ext>
          </c:extLst>
        </c:ser>
        <c:ser>
          <c:idx val="54"/>
          <c:order val="54"/>
          <c:tx>
            <c:strRef>
              <c:f>Graphed!$A$58</c:f>
              <c:strCache>
                <c:ptCount val="1"/>
                <c:pt idx="0">
                  <c:v>DR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$B$58:$N$58</c:f>
              <c:numCache>
                <c:formatCode>General</c:formatCode>
                <c:ptCount val="13"/>
                <c:pt idx="0">
                  <c:v>140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6-D8C8-464C-AA8C-D74BED39F5C0}"/>
            </c:ext>
          </c:extLst>
        </c:ser>
        <c:ser>
          <c:idx val="55"/>
          <c:order val="55"/>
          <c:tx>
            <c:strRef>
              <c:f>Graphed!#REF!</c:f>
              <c:strCache>
                <c:ptCount val="1"/>
                <c:pt idx="0">
                  <c:v>#REF!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Graphed!$B$3:$N$3</c:f>
              <c:numCache>
                <c:formatCode>General</c:formatCode>
                <c:ptCount val="13"/>
                <c:pt idx="0">
                  <c:v>-3</c:v>
                </c:pt>
                <c:pt idx="1">
                  <c:v>12</c:v>
                </c:pt>
                <c:pt idx="2">
                  <c:v>26</c:v>
                </c:pt>
                <c:pt idx="3">
                  <c:v>27</c:v>
                </c:pt>
                <c:pt idx="4">
                  <c:v>40</c:v>
                </c:pt>
                <c:pt idx="5">
                  <c:v>54</c:v>
                </c:pt>
                <c:pt idx="6">
                  <c:v>72</c:v>
                </c:pt>
                <c:pt idx="7">
                  <c:v>86</c:v>
                </c:pt>
                <c:pt idx="8">
                  <c:v>98</c:v>
                </c:pt>
                <c:pt idx="9">
                  <c:v>113</c:v>
                </c:pt>
                <c:pt idx="10">
                  <c:v>126</c:v>
                </c:pt>
                <c:pt idx="11">
                  <c:v>140</c:v>
                </c:pt>
                <c:pt idx="12">
                  <c:v>142</c:v>
                </c:pt>
              </c:numCache>
            </c:numRef>
          </c:cat>
          <c:val>
            <c:numRef>
              <c:f>Graphed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7-D8C8-464C-AA8C-D74BED39F5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70164399"/>
        <c:axId val="1"/>
      </c:lineChart>
      <c:catAx>
        <c:axId val="157016439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 Post-Daratumumab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HLA Antibody MFI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0164399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egendEntry>
        <c:idx val="55"/>
        <c:delete val="1"/>
      </c:legendEntry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3854</cdr:x>
      <cdr:y>0.06993</cdr:y>
    </cdr:from>
    <cdr:to>
      <cdr:x>0.31379</cdr:x>
      <cdr:y>0.2374</cdr:y>
    </cdr:to>
    <cdr:grpSp>
      <cdr:nvGrpSpPr>
        <cdr:cNvPr id="6" name="Group 5">
          <a:extLst xmlns:a="http://schemas.openxmlformats.org/drawingml/2006/main">
            <a:ext uri="{FF2B5EF4-FFF2-40B4-BE49-F238E27FC236}">
              <a16:creationId xmlns:a16="http://schemas.microsoft.com/office/drawing/2014/main" id="{1A40560E-0ABE-D415-8D87-E62BCC24E642}"/>
            </a:ext>
          </a:extLst>
        </cdr:cNvPr>
        <cdr:cNvGrpSpPr/>
      </cdr:nvGrpSpPr>
      <cdr:grpSpPr>
        <a:xfrm xmlns:a="http://schemas.openxmlformats.org/drawingml/2006/main">
          <a:off x="2464814" y="369340"/>
          <a:ext cx="777552" cy="884505"/>
          <a:chOff x="2762321" y="496336"/>
          <a:chExt cx="914400" cy="1046921"/>
        </a:xfrm>
      </cdr:grpSpPr>
      <cdr:sp macro="" textlink="">
        <cdr:nvSpPr>
          <cdr:cNvPr id="2" name="TextBox 1">
            <a:extLst xmlns:a="http://schemas.openxmlformats.org/drawingml/2006/main">
              <a:ext uri="{FF2B5EF4-FFF2-40B4-BE49-F238E27FC236}">
                <a16:creationId xmlns:a16="http://schemas.microsoft.com/office/drawing/2014/main" id="{82D6DDFB-E41D-4EB3-1289-DF03A9FE44CF}"/>
              </a:ext>
            </a:extLst>
          </cdr:cNvPr>
          <cdr:cNvSpPr txBox="1"/>
        </cdr:nvSpPr>
        <cdr:spPr>
          <a:xfrm xmlns:a="http://schemas.openxmlformats.org/drawingml/2006/main">
            <a:off x="2762321" y="628857"/>
            <a:ext cx="914400" cy="9144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none" rtlCol="0"/>
          <a:lstStyle xmlns:a="http://schemas.openxmlformats.org/drawingml/2006/main"/>
          <a:p xmlns:a="http://schemas.openxmlformats.org/drawingml/2006/main">
            <a:r>
              <a:rPr lang="en-US" sz="1100" dirty="0"/>
              <a:t>OHT</a:t>
            </a:r>
          </a:p>
        </cdr:txBody>
      </cdr:sp>
      <cdr:sp macro="" textlink="">
        <cdr:nvSpPr>
          <cdr:cNvPr id="3" name="Heart 2">
            <a:extLst xmlns:a="http://schemas.openxmlformats.org/drawingml/2006/main">
              <a:ext uri="{FF2B5EF4-FFF2-40B4-BE49-F238E27FC236}">
                <a16:creationId xmlns:a16="http://schemas.microsoft.com/office/drawing/2014/main" id="{D8C68F84-A648-C597-B334-EFB4E8E07064}"/>
              </a:ext>
            </a:extLst>
          </cdr:cNvPr>
          <cdr:cNvSpPr/>
        </cdr:nvSpPr>
        <cdr:spPr>
          <a:xfrm xmlns:a="http://schemas.openxmlformats.org/drawingml/2006/main">
            <a:off x="2894842" y="496336"/>
            <a:ext cx="163443" cy="163443"/>
          </a:xfrm>
          <a:prstGeom xmlns:a="http://schemas.openxmlformats.org/drawingml/2006/main" prst="heart">
            <a:avLst/>
          </a:prstGeom>
          <a:solidFill xmlns:a="http://schemas.openxmlformats.org/drawingml/2006/main">
            <a:srgbClr val="FF0000"/>
          </a:solidFill>
        </cdr:spPr>
        <cdr:style>
          <a:lnRef xmlns:a="http://schemas.openxmlformats.org/drawingml/2006/main" idx="2">
            <a:schemeClr val="accent1">
              <a:shade val="15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 vertOverflow="clip"/>
          <a:lstStyle xmlns:a="http://schemas.openxmlformats.org/drawingml/2006/main"/>
          <a:p xmlns:a="http://schemas.openxmlformats.org/drawingml/2006/main">
            <a:endParaRPr lang="en-US"/>
          </a:p>
        </cdr:txBody>
      </cdr:sp>
      <cdr:cxnSp macro="">
        <cdr:nvCxnSpPr>
          <cdr:cNvPr id="5" name="Straight Arrow Connector 4">
            <a:extLst xmlns:a="http://schemas.openxmlformats.org/drawingml/2006/main">
              <a:ext uri="{FF2B5EF4-FFF2-40B4-BE49-F238E27FC236}">
                <a16:creationId xmlns:a16="http://schemas.microsoft.com/office/drawing/2014/main" id="{45915C43-2CE2-C069-D332-4FDCC090ABA8}"/>
              </a:ext>
            </a:extLst>
          </cdr:cNvPr>
          <cdr:cNvCxnSpPr/>
        </cdr:nvCxnSpPr>
        <cdr:spPr>
          <a:xfrm xmlns:a="http://schemas.openxmlformats.org/drawingml/2006/main">
            <a:off x="2969937" y="845310"/>
            <a:ext cx="0" cy="454991"/>
          </a:xfrm>
          <a:prstGeom xmlns:a="http://schemas.openxmlformats.org/drawingml/2006/main" prst="straightConnector1">
            <a:avLst/>
          </a:prstGeom>
          <a:ln xmlns:a="http://schemas.openxmlformats.org/drawingml/2006/main" w="12700">
            <a:solidFill>
              <a:schemeClr val="tx1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2992968"/>
            <a:ext cx="10104120" cy="6366933"/>
          </a:xfrm>
        </p:spPr>
        <p:txBody>
          <a:bodyPr anchor="b"/>
          <a:lstStyle>
            <a:lvl1pPr algn="ctr">
              <a:defRPr sz="7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9605435"/>
            <a:ext cx="8915400" cy="4415365"/>
          </a:xfrm>
        </p:spPr>
        <p:txBody>
          <a:bodyPr/>
          <a:lstStyle>
            <a:lvl1pPr marL="0" indent="0" algn="ctr">
              <a:buNone/>
              <a:defRPr sz="3120"/>
            </a:lvl1pPr>
            <a:lvl2pPr marL="594360" indent="0" algn="ctr">
              <a:buNone/>
              <a:defRPr sz="2600"/>
            </a:lvl2pPr>
            <a:lvl3pPr marL="1188720" indent="0" algn="ctr">
              <a:buNone/>
              <a:defRPr sz="2340"/>
            </a:lvl3pPr>
            <a:lvl4pPr marL="1783080" indent="0" algn="ctr">
              <a:buNone/>
              <a:defRPr sz="2080"/>
            </a:lvl4pPr>
            <a:lvl5pPr marL="2377440" indent="0" algn="ctr">
              <a:buNone/>
              <a:defRPr sz="2080"/>
            </a:lvl5pPr>
            <a:lvl6pPr marL="2971800" indent="0" algn="ctr">
              <a:buNone/>
              <a:defRPr sz="2080"/>
            </a:lvl6pPr>
            <a:lvl7pPr marL="3566160" indent="0" algn="ctr">
              <a:buNone/>
              <a:defRPr sz="2080"/>
            </a:lvl7pPr>
            <a:lvl8pPr marL="4160520" indent="0" algn="ctr">
              <a:buNone/>
              <a:defRPr sz="2080"/>
            </a:lvl8pPr>
            <a:lvl9pPr marL="4754880" indent="0" algn="ctr">
              <a:buNone/>
              <a:defRPr sz="20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770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87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8" y="973667"/>
            <a:ext cx="2563178" cy="154982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973667"/>
            <a:ext cx="7540943" cy="1549823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586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014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4559305"/>
            <a:ext cx="10252710" cy="7607299"/>
          </a:xfrm>
        </p:spPr>
        <p:txBody>
          <a:bodyPr anchor="b"/>
          <a:lstStyle>
            <a:lvl1pPr>
              <a:defRPr sz="7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12238572"/>
            <a:ext cx="10252710" cy="4000499"/>
          </a:xfrm>
        </p:spPr>
        <p:txBody>
          <a:bodyPr/>
          <a:lstStyle>
            <a:lvl1pPr marL="0" indent="0">
              <a:buNone/>
              <a:defRPr sz="3120">
                <a:solidFill>
                  <a:schemeClr val="tx1"/>
                </a:solidFill>
              </a:defRPr>
            </a:lvl1pPr>
            <a:lvl2pPr marL="59436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188720" indent="0">
              <a:buNone/>
              <a:defRPr sz="2340">
                <a:solidFill>
                  <a:schemeClr val="tx1">
                    <a:tint val="75000"/>
                  </a:schemeClr>
                </a:solidFill>
              </a:defRPr>
            </a:lvl3pPr>
            <a:lvl4pPr marL="17830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4pPr>
            <a:lvl5pPr marL="237744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5pPr>
            <a:lvl6pPr marL="297180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6pPr>
            <a:lvl7pPr marL="356616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7pPr>
            <a:lvl8pPr marL="416052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8pPr>
            <a:lvl9pPr marL="47548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336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4868333"/>
            <a:ext cx="5052060" cy="11603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4868333"/>
            <a:ext cx="5052060" cy="11603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449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973671"/>
            <a:ext cx="10252710" cy="353483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5" y="4483101"/>
            <a:ext cx="5028842" cy="219709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5" y="6680200"/>
            <a:ext cx="5028842" cy="9825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6" y="4483101"/>
            <a:ext cx="5053608" cy="219709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6" y="6680200"/>
            <a:ext cx="5053608" cy="9825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70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669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200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1219200"/>
            <a:ext cx="3833931" cy="42672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2633138"/>
            <a:ext cx="6017895" cy="12996333"/>
          </a:xfrm>
        </p:spPr>
        <p:txBody>
          <a:bodyPr/>
          <a:lstStyle>
            <a:lvl1pPr>
              <a:defRPr sz="4160"/>
            </a:lvl1pPr>
            <a:lvl2pPr>
              <a:defRPr sz="3640"/>
            </a:lvl2pPr>
            <a:lvl3pPr>
              <a:defRPr sz="312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5486400"/>
            <a:ext cx="3833931" cy="10164235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498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1219200"/>
            <a:ext cx="3833931" cy="42672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2633138"/>
            <a:ext cx="6017895" cy="12996333"/>
          </a:xfrm>
        </p:spPr>
        <p:txBody>
          <a:bodyPr anchor="t"/>
          <a:lstStyle>
            <a:lvl1pPr marL="0" indent="0">
              <a:buNone/>
              <a:defRPr sz="4160"/>
            </a:lvl1pPr>
            <a:lvl2pPr marL="594360" indent="0">
              <a:buNone/>
              <a:defRPr sz="3640"/>
            </a:lvl2pPr>
            <a:lvl3pPr marL="1188720" indent="0">
              <a:buNone/>
              <a:defRPr sz="3120"/>
            </a:lvl3pPr>
            <a:lvl4pPr marL="1783080" indent="0">
              <a:buNone/>
              <a:defRPr sz="2600"/>
            </a:lvl4pPr>
            <a:lvl5pPr marL="2377440" indent="0">
              <a:buNone/>
              <a:defRPr sz="2600"/>
            </a:lvl5pPr>
            <a:lvl6pPr marL="2971800" indent="0">
              <a:buNone/>
              <a:defRPr sz="2600"/>
            </a:lvl6pPr>
            <a:lvl7pPr marL="3566160" indent="0">
              <a:buNone/>
              <a:defRPr sz="2600"/>
            </a:lvl7pPr>
            <a:lvl8pPr marL="4160520" indent="0">
              <a:buNone/>
              <a:defRPr sz="2600"/>
            </a:lvl8pPr>
            <a:lvl9pPr marL="4754880" indent="0">
              <a:buNone/>
              <a:defRPr sz="2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5486400"/>
            <a:ext cx="3833931" cy="10164235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144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973671"/>
            <a:ext cx="10252710" cy="35348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4868333"/>
            <a:ext cx="10252710" cy="1160356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16950271"/>
            <a:ext cx="267462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C3307A-4834-234B-9B5D-65351DDE5A09}" type="datetimeFigureOut">
              <a:rPr lang="en-US" smtClean="0"/>
              <a:t>6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16950271"/>
            <a:ext cx="401193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16950271"/>
            <a:ext cx="267462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9A4EBF-4806-B245-BDE5-4D4ED4E4C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473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88720" rtl="0" eaLnBrk="1" latinLnBrk="0" hangingPunct="1">
        <a:lnSpc>
          <a:spcPct val="90000"/>
        </a:lnSpc>
        <a:spcBef>
          <a:spcPct val="0"/>
        </a:spcBef>
        <a:buNone/>
        <a:defRPr sz="57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180" indent="-297180" algn="l" defTabSz="118872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3640" kern="120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4859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802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326898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8633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4577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50520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887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3pPr>
      <a:lvl4pPr marL="17830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37744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297180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1605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47548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3B02A60D-FE8F-4660-0829-71EDBA0297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0487906"/>
              </p:ext>
            </p:extLst>
          </p:nvPr>
        </p:nvGraphicFramePr>
        <p:xfrm>
          <a:off x="1065212" y="733547"/>
          <a:ext cx="9756776" cy="59393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A8B889D3-471C-B484-5314-52E3322F8D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9637909"/>
              </p:ext>
            </p:extLst>
          </p:nvPr>
        </p:nvGraphicFramePr>
        <p:xfrm>
          <a:off x="777141" y="7047197"/>
          <a:ext cx="10332917" cy="52815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5" name="Group 14">
            <a:extLst>
              <a:ext uri="{FF2B5EF4-FFF2-40B4-BE49-F238E27FC236}">
                <a16:creationId xmlns:a16="http://schemas.microsoft.com/office/drawing/2014/main" id="{3F2C4067-A70A-7A49-E597-8A8604C9AF04}"/>
              </a:ext>
            </a:extLst>
          </p:cNvPr>
          <p:cNvGrpSpPr/>
          <p:nvPr/>
        </p:nvGrpSpPr>
        <p:grpSpPr>
          <a:xfrm>
            <a:off x="1622545" y="12703053"/>
            <a:ext cx="8890000" cy="4851400"/>
            <a:chOff x="1118565" y="1414201"/>
            <a:chExt cx="8890000" cy="4851400"/>
          </a:xfrm>
        </p:grpSpPr>
        <p:graphicFrame>
          <p:nvGraphicFramePr>
            <p:cNvPr id="16" name="Chart 15">
              <a:extLst>
                <a:ext uri="{FF2B5EF4-FFF2-40B4-BE49-F238E27FC236}">
                  <a16:creationId xmlns:a16="http://schemas.microsoft.com/office/drawing/2014/main" id="{F2715EA3-1575-1C54-6ED5-7FCC8A5A930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5851818"/>
                </p:ext>
              </p:extLst>
            </p:nvPr>
          </p:nvGraphicFramePr>
          <p:xfrm>
            <a:off x="1118565" y="1414201"/>
            <a:ext cx="8890000" cy="4851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7DAA005-149A-E8EB-1962-71E2913ACECE}"/>
                </a:ext>
              </a:extLst>
            </p:cNvPr>
            <p:cNvGrpSpPr/>
            <p:nvPr/>
          </p:nvGrpSpPr>
          <p:grpSpPr>
            <a:xfrm>
              <a:off x="8744749" y="2217511"/>
              <a:ext cx="914400" cy="1046921"/>
              <a:chOff x="2762321" y="496336"/>
              <a:chExt cx="914400" cy="1046921"/>
            </a:xfrm>
          </p:grpSpPr>
          <p:sp>
            <p:nvSpPr>
              <p:cNvPr id="18" name="TextBox 2">
                <a:extLst>
                  <a:ext uri="{FF2B5EF4-FFF2-40B4-BE49-F238E27FC236}">
                    <a16:creationId xmlns:a16="http://schemas.microsoft.com/office/drawing/2014/main" id="{3DE53C8D-D7B6-1F81-41F4-F85F0B5D25C9}"/>
                  </a:ext>
                </a:extLst>
              </p:cNvPr>
              <p:cNvSpPr txBox="1"/>
              <p:nvPr/>
            </p:nvSpPr>
            <p:spPr>
              <a:xfrm>
                <a:off x="2762321" y="628857"/>
                <a:ext cx="914400" cy="914400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/>
                  <a:t>OHT</a:t>
                </a:r>
              </a:p>
            </p:txBody>
          </p:sp>
          <p:sp>
            <p:nvSpPr>
              <p:cNvPr id="19" name="Heart 18">
                <a:extLst>
                  <a:ext uri="{FF2B5EF4-FFF2-40B4-BE49-F238E27FC236}">
                    <a16:creationId xmlns:a16="http://schemas.microsoft.com/office/drawing/2014/main" id="{7B99B5DE-A528-6872-AEFC-C0A0CCD127D9}"/>
                  </a:ext>
                </a:extLst>
              </p:cNvPr>
              <p:cNvSpPr/>
              <p:nvPr/>
            </p:nvSpPr>
            <p:spPr>
              <a:xfrm>
                <a:off x="2894842" y="496336"/>
                <a:ext cx="163443" cy="163443"/>
              </a:xfrm>
              <a:prstGeom prst="heart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0BF2DFCF-F1D4-E14E-A71B-9051E981CCE9}"/>
                  </a:ext>
                </a:extLst>
              </p:cNvPr>
              <p:cNvCxnSpPr/>
              <p:nvPr/>
            </p:nvCxnSpPr>
            <p:spPr>
              <a:xfrm>
                <a:off x="2969937" y="845310"/>
                <a:ext cx="0" cy="45499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797565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</TotalTime>
  <Words>32</Words>
  <Application>Microsoft Macintosh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ain, Majid</dc:creator>
  <cp:lastModifiedBy>Husain, Majid</cp:lastModifiedBy>
  <cp:revision>1</cp:revision>
  <dcterms:created xsi:type="dcterms:W3CDTF">2025-06-13T22:31:12Z</dcterms:created>
  <dcterms:modified xsi:type="dcterms:W3CDTF">2025-06-13T22:39:38Z</dcterms:modified>
</cp:coreProperties>
</file>